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4"/>
  </p:notesMasterIdLst>
  <p:sldIdLst>
    <p:sldId id="256" r:id="rId2"/>
    <p:sldId id="259" r:id="rId3"/>
    <p:sldId id="266" r:id="rId4"/>
    <p:sldId id="257" r:id="rId5"/>
    <p:sldId id="275" r:id="rId6"/>
    <p:sldId id="301" r:id="rId7"/>
    <p:sldId id="303" r:id="rId8"/>
    <p:sldId id="295" r:id="rId9"/>
    <p:sldId id="260" r:id="rId10"/>
    <p:sldId id="307" r:id="rId11"/>
    <p:sldId id="278" r:id="rId12"/>
    <p:sldId id="308" r:id="rId13"/>
    <p:sldId id="267" r:id="rId14"/>
    <p:sldId id="277" r:id="rId15"/>
    <p:sldId id="299" r:id="rId16"/>
    <p:sldId id="279" r:id="rId17"/>
    <p:sldId id="261" r:id="rId18"/>
    <p:sldId id="286" r:id="rId19"/>
    <p:sldId id="285" r:id="rId20"/>
    <p:sldId id="271" r:id="rId21"/>
    <p:sldId id="305" r:id="rId22"/>
    <p:sldId id="273"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CC8C795-F497-6A2F-65ED-C2BAC182903E}" name="Sherry Adkins" initials="SA" userId="S::sadkins@familyhealthservices.org::db142050-6f29-42bf-836a-9289cae2cea0"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Unknown User" initials="" lastIdx="0"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324282D-1257-18CA-50FE-A2A857AE6322}" v="144" dt="2024-05-01T15:58:15.214"/>
    <p1510:client id="{0C5759E8-1630-3ED1-FD51-8E4B640B22CB}" v="88" dt="2024-05-01T00:47:01.402"/>
    <p1510:client id="{8B4640EA-57EB-01A2-19D5-4DC141F212BD}" v="89" dt="2024-05-01T00:24:59.155"/>
    <p1510:client id="{9E432BA0-B9BC-5A64-83D0-883082210488}" v="1" dt="2024-04-30T23:45:42.565"/>
    <p1510:client id="{EC6E7909-1252-D161-3CAE-6DFC33753040}" v="6" dt="2024-04-30T21:35:13.86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2847" autoAdjust="0"/>
  </p:normalViewPr>
  <p:slideViewPr>
    <p:cSldViewPr snapToGrid="0">
      <p:cViewPr varScale="1">
        <p:scale>
          <a:sx n="65" d="100"/>
          <a:sy n="65" d="100"/>
        </p:scale>
        <p:origin x="470"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32"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dkins, Sherry Marie" userId="S::sherry.adkins@wright.edu::24362372-ca3c-4f9f-b38c-fc14581e8bc5" providerId="AD" clId="Web-{EC6E7909-1252-D161-3CAE-6DFC33753040}"/>
    <pc:docChg chg="modSld">
      <pc:chgData name="Adkins, Sherry Marie" userId="S::sherry.adkins@wright.edu::24362372-ca3c-4f9f-b38c-fc14581e8bc5" providerId="AD" clId="Web-{EC6E7909-1252-D161-3CAE-6DFC33753040}" dt="2024-04-30T21:35:12.689" v="33" actId="20577"/>
      <pc:docMkLst>
        <pc:docMk/>
      </pc:docMkLst>
      <pc:sldChg chg="modSp">
        <pc:chgData name="Adkins, Sherry Marie" userId="S::sherry.adkins@wright.edu::24362372-ca3c-4f9f-b38c-fc14581e8bc5" providerId="AD" clId="Web-{EC6E7909-1252-D161-3CAE-6DFC33753040}" dt="2024-04-30T21:35:12.689" v="33" actId="20577"/>
        <pc:sldMkLst>
          <pc:docMk/>
          <pc:sldMk cId="2646954914" sldId="278"/>
        </pc:sldMkLst>
        <pc:spChg chg="mod">
          <ac:chgData name="Adkins, Sherry Marie" userId="S::sherry.adkins@wright.edu::24362372-ca3c-4f9f-b38c-fc14581e8bc5" providerId="AD" clId="Web-{EC6E7909-1252-D161-3CAE-6DFC33753040}" dt="2024-04-30T21:35:12.689" v="33" actId="20577"/>
          <ac:spMkLst>
            <pc:docMk/>
            <pc:sldMk cId="2646954914" sldId="278"/>
            <ac:spMk id="3" creationId="{0FB2EB9C-1382-4DD3-8425-6057DCA19775}"/>
          </ac:spMkLst>
        </pc:spChg>
      </pc:sldChg>
      <pc:sldChg chg="modNotes">
        <pc:chgData name="Adkins, Sherry Marie" userId="S::sherry.adkins@wright.edu::24362372-ca3c-4f9f-b38c-fc14581e8bc5" providerId="AD" clId="Web-{EC6E7909-1252-D161-3CAE-6DFC33753040}" dt="2024-04-30T21:34:34.283" v="29"/>
        <pc:sldMkLst>
          <pc:docMk/>
          <pc:sldMk cId="3620247617" sldId="279"/>
        </pc:sldMkLst>
      </pc:sldChg>
    </pc:docChg>
  </pc:docChgLst>
  <pc:docChgLst>
    <pc:chgData name="Flowers, Stacy" userId="S::stacy.flowers@wright.edu::4a2efe78-54ae-4086-b211-fd8507b233eb" providerId="AD" clId="Web-{0324282D-1257-18CA-50FE-A2A857AE6322}"/>
    <pc:docChg chg="modSld">
      <pc:chgData name="Flowers, Stacy" userId="S::stacy.flowers@wright.edu::4a2efe78-54ae-4086-b211-fd8507b233eb" providerId="AD" clId="Web-{0324282D-1257-18CA-50FE-A2A857AE6322}" dt="2024-05-01T16:10:20.721" v="1612"/>
      <pc:docMkLst>
        <pc:docMk/>
      </pc:docMkLst>
      <pc:sldChg chg="modNotes">
        <pc:chgData name="Flowers, Stacy" userId="S::stacy.flowers@wright.edu::4a2efe78-54ae-4086-b211-fd8507b233eb" providerId="AD" clId="Web-{0324282D-1257-18CA-50FE-A2A857AE6322}" dt="2024-04-29T19:27:22.093" v="6"/>
        <pc:sldMkLst>
          <pc:docMk/>
          <pc:sldMk cId="1639528632" sldId="256"/>
        </pc:sldMkLst>
      </pc:sldChg>
      <pc:sldChg chg="modNotes">
        <pc:chgData name="Flowers, Stacy" userId="S::stacy.flowers@wright.edu::4a2efe78-54ae-4086-b211-fd8507b233eb" providerId="AD" clId="Web-{0324282D-1257-18CA-50FE-A2A857AE6322}" dt="2024-04-30T17:16:44.620" v="571"/>
        <pc:sldMkLst>
          <pc:docMk/>
          <pc:sldMk cId="2673644884" sldId="257"/>
        </pc:sldMkLst>
      </pc:sldChg>
      <pc:sldChg chg="modSp modNotes">
        <pc:chgData name="Flowers, Stacy" userId="S::stacy.flowers@wright.edu::4a2efe78-54ae-4086-b211-fd8507b233eb" providerId="AD" clId="Web-{0324282D-1257-18CA-50FE-A2A857AE6322}" dt="2024-04-29T19:30:04.691" v="65"/>
        <pc:sldMkLst>
          <pc:docMk/>
          <pc:sldMk cId="1850530206" sldId="259"/>
        </pc:sldMkLst>
        <pc:spChg chg="mod">
          <ac:chgData name="Flowers, Stacy" userId="S::stacy.flowers@wright.edu::4a2efe78-54ae-4086-b211-fd8507b233eb" providerId="AD" clId="Web-{0324282D-1257-18CA-50FE-A2A857AE6322}" dt="2024-04-29T19:27:37.578" v="9" actId="14100"/>
          <ac:spMkLst>
            <pc:docMk/>
            <pc:sldMk cId="1850530206" sldId="259"/>
            <ac:spMk id="2" creationId="{EF474AF9-C42D-4BA6-8D35-CC05307B4360}"/>
          </ac:spMkLst>
        </pc:spChg>
        <pc:spChg chg="mod">
          <ac:chgData name="Flowers, Stacy" userId="S::stacy.flowers@wright.edu::4a2efe78-54ae-4086-b211-fd8507b233eb" providerId="AD" clId="Web-{0324282D-1257-18CA-50FE-A2A857AE6322}" dt="2024-04-29T19:28:08.328" v="14" actId="20577"/>
          <ac:spMkLst>
            <pc:docMk/>
            <pc:sldMk cId="1850530206" sldId="259"/>
            <ac:spMk id="3" creationId="{369AE72C-8C05-4B2F-8AE7-5D5038B1A83F}"/>
          </ac:spMkLst>
        </pc:spChg>
      </pc:sldChg>
      <pc:sldChg chg="modNotes">
        <pc:chgData name="Flowers, Stacy" userId="S::stacy.flowers@wright.edu::4a2efe78-54ae-4086-b211-fd8507b233eb" providerId="AD" clId="Web-{0324282D-1257-18CA-50FE-A2A857AE6322}" dt="2024-04-30T17:22:21.527" v="624"/>
        <pc:sldMkLst>
          <pc:docMk/>
          <pc:sldMk cId="2976952133" sldId="260"/>
        </pc:sldMkLst>
      </pc:sldChg>
      <pc:sldChg chg="modSp modNotes">
        <pc:chgData name="Flowers, Stacy" userId="S::stacy.flowers@wright.edu::4a2efe78-54ae-4086-b211-fd8507b233eb" providerId="AD" clId="Web-{0324282D-1257-18CA-50FE-A2A857AE6322}" dt="2024-04-30T18:58:09.476" v="1128"/>
        <pc:sldMkLst>
          <pc:docMk/>
          <pc:sldMk cId="4065104849" sldId="261"/>
        </pc:sldMkLst>
        <pc:spChg chg="mod">
          <ac:chgData name="Flowers, Stacy" userId="S::stacy.flowers@wright.edu::4a2efe78-54ae-4086-b211-fd8507b233eb" providerId="AD" clId="Web-{0324282D-1257-18CA-50FE-A2A857AE6322}" dt="2024-04-30T18:57:31.178" v="1097" actId="20577"/>
          <ac:spMkLst>
            <pc:docMk/>
            <pc:sldMk cId="4065104849" sldId="261"/>
            <ac:spMk id="3" creationId="{C56349CC-610D-4B5D-910F-AEBE137B1783}"/>
          </ac:spMkLst>
        </pc:spChg>
      </pc:sldChg>
      <pc:sldChg chg="modNotes">
        <pc:chgData name="Flowers, Stacy" userId="S::stacy.flowers@wright.edu::4a2efe78-54ae-4086-b211-fd8507b233eb" providerId="AD" clId="Web-{0324282D-1257-18CA-50FE-A2A857AE6322}" dt="2024-05-01T15:55:25.400" v="1484"/>
        <pc:sldMkLst>
          <pc:docMk/>
          <pc:sldMk cId="1234032126" sldId="266"/>
        </pc:sldMkLst>
      </pc:sldChg>
      <pc:sldChg chg="modNotes">
        <pc:chgData name="Flowers, Stacy" userId="S::stacy.flowers@wright.edu::4a2efe78-54ae-4086-b211-fd8507b233eb" providerId="AD" clId="Web-{0324282D-1257-18CA-50FE-A2A857AE6322}" dt="2024-04-30T18:35:49.502" v="886"/>
        <pc:sldMkLst>
          <pc:docMk/>
          <pc:sldMk cId="548783499" sldId="267"/>
        </pc:sldMkLst>
      </pc:sldChg>
      <pc:sldChg chg="modNotes">
        <pc:chgData name="Flowers, Stacy" userId="S::stacy.flowers@wright.edu::4a2efe78-54ae-4086-b211-fd8507b233eb" providerId="AD" clId="Web-{0324282D-1257-18CA-50FE-A2A857AE6322}" dt="2024-04-30T19:16:21.989" v="1463"/>
        <pc:sldMkLst>
          <pc:docMk/>
          <pc:sldMk cId="2830924806" sldId="271"/>
        </pc:sldMkLst>
      </pc:sldChg>
      <pc:sldChg chg="modSp modNotes">
        <pc:chgData name="Flowers, Stacy" userId="S::stacy.flowers@wright.edu::4a2efe78-54ae-4086-b211-fd8507b233eb" providerId="AD" clId="Web-{0324282D-1257-18CA-50FE-A2A857AE6322}" dt="2024-05-01T15:58:13.308" v="1511"/>
        <pc:sldMkLst>
          <pc:docMk/>
          <pc:sldMk cId="2204150374" sldId="275"/>
        </pc:sldMkLst>
        <pc:graphicFrameChg chg="mod modGraphic">
          <ac:chgData name="Flowers, Stacy" userId="S::stacy.flowers@wright.edu::4a2efe78-54ae-4086-b211-fd8507b233eb" providerId="AD" clId="Web-{0324282D-1257-18CA-50FE-A2A857AE6322}" dt="2024-05-01T15:57:28.698" v="1496"/>
          <ac:graphicFrameMkLst>
            <pc:docMk/>
            <pc:sldMk cId="2204150374" sldId="275"/>
            <ac:graphicFrameMk id="5" creationId="{BCF9D60E-535F-6DC2-BB28-B3888308394B}"/>
          </ac:graphicFrameMkLst>
        </pc:graphicFrameChg>
      </pc:sldChg>
      <pc:sldChg chg="modSp modNotes">
        <pc:chgData name="Flowers, Stacy" userId="S::stacy.flowers@wright.edu::4a2efe78-54ae-4086-b211-fd8507b233eb" providerId="AD" clId="Web-{0324282D-1257-18CA-50FE-A2A857AE6322}" dt="2024-04-30T18:42:34.982" v="967"/>
        <pc:sldMkLst>
          <pc:docMk/>
          <pc:sldMk cId="3510474974" sldId="277"/>
        </pc:sldMkLst>
        <pc:spChg chg="mod">
          <ac:chgData name="Flowers, Stacy" userId="S::stacy.flowers@wright.edu::4a2efe78-54ae-4086-b211-fd8507b233eb" providerId="AD" clId="Web-{0324282D-1257-18CA-50FE-A2A857AE6322}" dt="2024-04-30T18:41:04.683" v="924" actId="20577"/>
          <ac:spMkLst>
            <pc:docMk/>
            <pc:sldMk cId="3510474974" sldId="277"/>
            <ac:spMk id="3" creationId="{B26DCF6B-B3FB-42D6-96C8-995C85FCBB54}"/>
          </ac:spMkLst>
        </pc:spChg>
      </pc:sldChg>
      <pc:sldChg chg="modSp modNotes">
        <pc:chgData name="Flowers, Stacy" userId="S::stacy.flowers@wright.edu::4a2efe78-54ae-4086-b211-fd8507b233eb" providerId="AD" clId="Web-{0324282D-1257-18CA-50FE-A2A857AE6322}" dt="2024-05-01T15:53:36.602" v="1473"/>
        <pc:sldMkLst>
          <pc:docMk/>
          <pc:sldMk cId="2646954914" sldId="278"/>
        </pc:sldMkLst>
        <pc:spChg chg="mod">
          <ac:chgData name="Flowers, Stacy" userId="S::stacy.flowers@wright.edu::4a2efe78-54ae-4086-b211-fd8507b233eb" providerId="AD" clId="Web-{0324282D-1257-18CA-50FE-A2A857AE6322}" dt="2024-04-30T19:08:46.727" v="1381" actId="20577"/>
          <ac:spMkLst>
            <pc:docMk/>
            <pc:sldMk cId="2646954914" sldId="278"/>
            <ac:spMk id="3" creationId="{0FB2EB9C-1382-4DD3-8425-6057DCA19775}"/>
          </ac:spMkLst>
        </pc:spChg>
      </pc:sldChg>
      <pc:sldChg chg="modNotes">
        <pc:chgData name="Flowers, Stacy" userId="S::stacy.flowers@wright.edu::4a2efe78-54ae-4086-b211-fd8507b233eb" providerId="AD" clId="Web-{0324282D-1257-18CA-50FE-A2A857AE6322}" dt="2024-05-01T16:08:56.782" v="1609"/>
        <pc:sldMkLst>
          <pc:docMk/>
          <pc:sldMk cId="3620247617" sldId="279"/>
        </pc:sldMkLst>
      </pc:sldChg>
      <pc:sldChg chg="modNotes">
        <pc:chgData name="Flowers, Stacy" userId="S::stacy.flowers@wright.edu::4a2efe78-54ae-4086-b211-fd8507b233eb" providerId="AD" clId="Web-{0324282D-1257-18CA-50FE-A2A857AE6322}" dt="2024-05-01T16:10:20.721" v="1612"/>
        <pc:sldMkLst>
          <pc:docMk/>
          <pc:sldMk cId="2595251053" sldId="285"/>
        </pc:sldMkLst>
      </pc:sldChg>
      <pc:sldChg chg="modSp modNotes">
        <pc:chgData name="Flowers, Stacy" userId="S::stacy.flowers@wright.edu::4a2efe78-54ae-4086-b211-fd8507b233eb" providerId="AD" clId="Web-{0324282D-1257-18CA-50FE-A2A857AE6322}" dt="2024-04-30T19:01:43.763" v="1287"/>
        <pc:sldMkLst>
          <pc:docMk/>
          <pc:sldMk cId="2684983826" sldId="286"/>
        </pc:sldMkLst>
        <pc:spChg chg="mod">
          <ac:chgData name="Flowers, Stacy" userId="S::stacy.flowers@wright.edu::4a2efe78-54ae-4086-b211-fd8507b233eb" providerId="AD" clId="Web-{0324282D-1257-18CA-50FE-A2A857AE6322}" dt="2024-04-30T19:00:54.918" v="1224" actId="20577"/>
          <ac:spMkLst>
            <pc:docMk/>
            <pc:sldMk cId="2684983826" sldId="286"/>
            <ac:spMk id="3" creationId="{C56349CC-610D-4B5D-910F-AEBE137B1783}"/>
          </ac:spMkLst>
        </pc:spChg>
      </pc:sldChg>
      <pc:sldChg chg="modNotes">
        <pc:chgData name="Flowers, Stacy" userId="S::stacy.flowers@wright.edu::4a2efe78-54ae-4086-b211-fd8507b233eb" providerId="AD" clId="Web-{0324282D-1257-18CA-50FE-A2A857AE6322}" dt="2024-04-30T18:14:42.890" v="722"/>
        <pc:sldMkLst>
          <pc:docMk/>
          <pc:sldMk cId="1068099844" sldId="295"/>
        </pc:sldMkLst>
      </pc:sldChg>
      <pc:sldChg chg="modSp modNotes">
        <pc:chgData name="Flowers, Stacy" userId="S::stacy.flowers@wright.edu::4a2efe78-54ae-4086-b211-fd8507b233eb" providerId="AD" clId="Web-{0324282D-1257-18CA-50FE-A2A857AE6322}" dt="2024-05-01T16:06:55.953" v="1581"/>
        <pc:sldMkLst>
          <pc:docMk/>
          <pc:sldMk cId="3574560037" sldId="299"/>
        </pc:sldMkLst>
        <pc:spChg chg="mod">
          <ac:chgData name="Flowers, Stacy" userId="S::stacy.flowers@wright.edu::4a2efe78-54ae-4086-b211-fd8507b233eb" providerId="AD" clId="Web-{0324282D-1257-18CA-50FE-A2A857AE6322}" dt="2024-04-30T18:42:47.061" v="968" actId="20577"/>
          <ac:spMkLst>
            <pc:docMk/>
            <pc:sldMk cId="3574560037" sldId="299"/>
            <ac:spMk id="3" creationId="{A743669D-2CCD-45CC-A053-2AAD0E7546D3}"/>
          </ac:spMkLst>
        </pc:spChg>
      </pc:sldChg>
      <pc:sldChg chg="modNotes">
        <pc:chgData name="Flowers, Stacy" userId="S::stacy.flowers@wright.edu::4a2efe78-54ae-4086-b211-fd8507b233eb" providerId="AD" clId="Web-{0324282D-1257-18CA-50FE-A2A857AE6322}" dt="2024-05-01T15:59:22.308" v="1526"/>
        <pc:sldMkLst>
          <pc:docMk/>
          <pc:sldMk cId="3223323265" sldId="301"/>
        </pc:sldMkLst>
      </pc:sldChg>
      <pc:sldChg chg="modSp modNotes">
        <pc:chgData name="Flowers, Stacy" userId="S::stacy.flowers@wright.edu::4a2efe78-54ae-4086-b211-fd8507b233eb" providerId="AD" clId="Web-{0324282D-1257-18CA-50FE-A2A857AE6322}" dt="2024-05-01T16:01:43.310" v="1549"/>
        <pc:sldMkLst>
          <pc:docMk/>
          <pc:sldMk cId="3288749026" sldId="303"/>
        </pc:sldMkLst>
        <pc:graphicFrameChg chg="modGraphic">
          <ac:chgData name="Flowers, Stacy" userId="S::stacy.flowers@wright.edu::4a2efe78-54ae-4086-b211-fd8507b233eb" providerId="AD" clId="Web-{0324282D-1257-18CA-50FE-A2A857AE6322}" dt="2024-04-30T17:19:40.808" v="589" actId="20577"/>
          <ac:graphicFrameMkLst>
            <pc:docMk/>
            <pc:sldMk cId="3288749026" sldId="303"/>
            <ac:graphicFrameMk id="5" creationId="{032E14EF-4141-DE29-F741-0040BD9E4401}"/>
          </ac:graphicFrameMkLst>
        </pc:graphicFrameChg>
      </pc:sldChg>
      <pc:sldChg chg="modNotes">
        <pc:chgData name="Flowers, Stacy" userId="S::stacy.flowers@wright.edu::4a2efe78-54ae-4086-b211-fd8507b233eb" providerId="AD" clId="Web-{0324282D-1257-18CA-50FE-A2A857AE6322}" dt="2024-04-30T19:16:50.100" v="1467"/>
        <pc:sldMkLst>
          <pc:docMk/>
          <pc:sldMk cId="795110550" sldId="305"/>
        </pc:sldMkLst>
      </pc:sldChg>
      <pc:sldChg chg="modSp modNotes">
        <pc:chgData name="Flowers, Stacy" userId="S::stacy.flowers@wright.edu::4a2efe78-54ae-4086-b211-fd8507b233eb" providerId="AD" clId="Web-{0324282D-1257-18CA-50FE-A2A857AE6322}" dt="2024-05-01T16:04:18.873" v="1552"/>
        <pc:sldMkLst>
          <pc:docMk/>
          <pc:sldMk cId="2463546661" sldId="307"/>
        </pc:sldMkLst>
        <pc:spChg chg="mod">
          <ac:chgData name="Flowers, Stacy" userId="S::stacy.flowers@wright.edu::4a2efe78-54ae-4086-b211-fd8507b233eb" providerId="AD" clId="Web-{0324282D-1257-18CA-50FE-A2A857AE6322}" dt="2024-04-30T17:25:30.731" v="674" actId="20577"/>
          <ac:spMkLst>
            <pc:docMk/>
            <pc:sldMk cId="2463546661" sldId="307"/>
            <ac:spMk id="3" creationId="{0FB2EB9C-1382-4DD3-8425-6057DCA19775}"/>
          </ac:spMkLst>
        </pc:spChg>
      </pc:sldChg>
      <pc:sldChg chg="modNotes">
        <pc:chgData name="Flowers, Stacy" userId="S::stacy.flowers@wright.edu::4a2efe78-54ae-4086-b211-fd8507b233eb" providerId="AD" clId="Web-{0324282D-1257-18CA-50FE-A2A857AE6322}" dt="2024-05-01T16:05:35.484" v="1580"/>
        <pc:sldMkLst>
          <pc:docMk/>
          <pc:sldMk cId="165018141" sldId="308"/>
        </pc:sldMkLst>
      </pc:sldChg>
    </pc:docChg>
  </pc:docChgLst>
  <pc:docChgLst>
    <pc:chgData name="Adkins, Sherry Marie" userId="S::sherry.adkins@wright.edu::24362372-ca3c-4f9f-b38c-fc14581e8bc5" providerId="AD" clId="Web-{9E432BA0-B9BC-5A64-83D0-883082210488}"/>
    <pc:docChg chg="addSld">
      <pc:chgData name="Adkins, Sherry Marie" userId="S::sherry.adkins@wright.edu::24362372-ca3c-4f9f-b38c-fc14581e8bc5" providerId="AD" clId="Web-{9E432BA0-B9BC-5A64-83D0-883082210488}" dt="2024-04-30T23:45:42.565" v="0"/>
      <pc:docMkLst>
        <pc:docMk/>
      </pc:docMkLst>
      <pc:sldChg chg="new">
        <pc:chgData name="Adkins, Sherry Marie" userId="S::sherry.adkins@wright.edu::24362372-ca3c-4f9f-b38c-fc14581e8bc5" providerId="AD" clId="Web-{9E432BA0-B9BC-5A64-83D0-883082210488}" dt="2024-04-30T23:45:42.565" v="0"/>
        <pc:sldMkLst>
          <pc:docMk/>
          <pc:sldMk cId="165018141" sldId="308"/>
        </pc:sldMkLst>
      </pc:sldChg>
    </pc:docChg>
  </pc:docChgLst>
  <pc:docChgLst>
    <pc:chgData name="Adkins, Sherry Marie" userId="S::sherry.adkins@wright.edu::24362372-ca3c-4f9f-b38c-fc14581e8bc5" providerId="AD" clId="Web-{0C5759E8-1630-3ED1-FD51-8E4B640B22CB}"/>
    <pc:docChg chg="modSld">
      <pc:chgData name="Adkins, Sherry Marie" userId="S::sherry.adkins@wright.edu::24362372-ca3c-4f9f-b38c-fc14581e8bc5" providerId="AD" clId="Web-{0C5759E8-1630-3ED1-FD51-8E4B640B22CB}" dt="2024-05-01T00:47:01.199" v="332" actId="20577"/>
      <pc:docMkLst>
        <pc:docMk/>
      </pc:docMkLst>
      <pc:sldChg chg="modSp modNotes">
        <pc:chgData name="Adkins, Sherry Marie" userId="S::sherry.adkins@wright.edu::24362372-ca3c-4f9f-b38c-fc14581e8bc5" providerId="AD" clId="Web-{0C5759E8-1630-3ED1-FD51-8E4B640B22CB}" dt="2024-05-01T00:44:15.036" v="290"/>
        <pc:sldMkLst>
          <pc:docMk/>
          <pc:sldMk cId="2673644884" sldId="257"/>
        </pc:sldMkLst>
        <pc:graphicFrameChg chg="modGraphic">
          <ac:chgData name="Adkins, Sherry Marie" userId="S::sherry.adkins@wright.edu::24362372-ca3c-4f9f-b38c-fc14581e8bc5" providerId="AD" clId="Web-{0C5759E8-1630-3ED1-FD51-8E4B640B22CB}" dt="2024-05-01T00:38:05.396" v="79" actId="20577"/>
          <ac:graphicFrameMkLst>
            <pc:docMk/>
            <pc:sldMk cId="2673644884" sldId="257"/>
            <ac:graphicFrameMk id="5" creationId="{032E14EF-4141-DE29-F741-0040BD9E4401}"/>
          </ac:graphicFrameMkLst>
        </pc:graphicFrameChg>
      </pc:sldChg>
      <pc:sldChg chg="modNotes">
        <pc:chgData name="Adkins, Sherry Marie" userId="S::sherry.adkins@wright.edu::24362372-ca3c-4f9f-b38c-fc14581e8bc5" providerId="AD" clId="Web-{0C5759E8-1630-3ED1-FD51-8E4B640B22CB}" dt="2024-05-01T00:44:41.771" v="330"/>
        <pc:sldMkLst>
          <pc:docMk/>
          <pc:sldMk cId="1234032126" sldId="266"/>
        </pc:sldMkLst>
      </pc:sldChg>
      <pc:sldChg chg="addSp delSp modSp">
        <pc:chgData name="Adkins, Sherry Marie" userId="S::sherry.adkins@wright.edu::24362372-ca3c-4f9f-b38c-fc14581e8bc5" providerId="AD" clId="Web-{0C5759E8-1630-3ED1-FD51-8E4B640B22CB}" dt="2024-05-01T00:34:37.199" v="43" actId="1076"/>
        <pc:sldMkLst>
          <pc:docMk/>
          <pc:sldMk cId="2830924806" sldId="271"/>
        </pc:sldMkLst>
        <pc:spChg chg="del mod">
          <ac:chgData name="Adkins, Sherry Marie" userId="S::sherry.adkins@wright.edu::24362372-ca3c-4f9f-b38c-fc14581e8bc5" providerId="AD" clId="Web-{0C5759E8-1630-3ED1-FD51-8E4B640B22CB}" dt="2024-05-01T00:33:02.992" v="39"/>
          <ac:spMkLst>
            <pc:docMk/>
            <pc:sldMk cId="2830924806" sldId="271"/>
            <ac:spMk id="5" creationId="{D8B6E7D9-E250-BC7D-3B10-B65C0C00FB3C}"/>
          </ac:spMkLst>
        </pc:spChg>
        <pc:spChg chg="add mod">
          <ac:chgData name="Adkins, Sherry Marie" userId="S::sherry.adkins@wright.edu::24362372-ca3c-4f9f-b38c-fc14581e8bc5" providerId="AD" clId="Web-{0C5759E8-1630-3ED1-FD51-8E4B640B22CB}" dt="2024-05-01T00:34:37.199" v="43" actId="1076"/>
          <ac:spMkLst>
            <pc:docMk/>
            <pc:sldMk cId="2830924806" sldId="271"/>
            <ac:spMk id="7" creationId="{372CEA2E-CF8D-0BCE-4269-B4F0D5CCD608}"/>
          </ac:spMkLst>
        </pc:spChg>
        <pc:picChg chg="del">
          <ac:chgData name="Adkins, Sherry Marie" userId="S::sherry.adkins@wright.edu::24362372-ca3c-4f9f-b38c-fc14581e8bc5" providerId="AD" clId="Web-{0C5759E8-1630-3ED1-FD51-8E4B640B22CB}" dt="2024-05-01T00:32:53.664" v="36"/>
          <ac:picMkLst>
            <pc:docMk/>
            <pc:sldMk cId="2830924806" sldId="271"/>
            <ac:picMk id="4" creationId="{CFD847AA-3778-E580-D04B-FE517634E0BA}"/>
          </ac:picMkLst>
        </pc:picChg>
        <pc:picChg chg="add mod">
          <ac:chgData name="Adkins, Sherry Marie" userId="S::sherry.adkins@wright.edu::24362372-ca3c-4f9f-b38c-fc14581e8bc5" providerId="AD" clId="Web-{0C5759E8-1630-3ED1-FD51-8E4B640B22CB}" dt="2024-05-01T00:33:52.229" v="41" actId="1076"/>
          <ac:picMkLst>
            <pc:docMk/>
            <pc:sldMk cId="2830924806" sldId="271"/>
            <ac:picMk id="6" creationId="{D26D43E2-91F7-E4A9-E2C1-FFB13EF30BB1}"/>
          </ac:picMkLst>
        </pc:picChg>
      </pc:sldChg>
      <pc:sldChg chg="modNotes">
        <pc:chgData name="Adkins, Sherry Marie" userId="S::sherry.adkins@wright.edu::24362372-ca3c-4f9f-b38c-fc14581e8bc5" providerId="AD" clId="Web-{0C5759E8-1630-3ED1-FD51-8E4B640B22CB}" dt="2024-05-01T00:42:53.079" v="276"/>
        <pc:sldMkLst>
          <pc:docMk/>
          <pc:sldMk cId="2204150374" sldId="275"/>
        </pc:sldMkLst>
      </pc:sldChg>
      <pc:sldChg chg="modNotes">
        <pc:chgData name="Adkins, Sherry Marie" userId="S::sherry.adkins@wright.edu::24362372-ca3c-4f9f-b38c-fc14581e8bc5" providerId="AD" clId="Web-{0C5759E8-1630-3ED1-FD51-8E4B640B22CB}" dt="2024-05-01T00:46:04.228" v="331"/>
        <pc:sldMkLst>
          <pc:docMk/>
          <pc:sldMk cId="2646954914" sldId="278"/>
        </pc:sldMkLst>
      </pc:sldChg>
      <pc:sldChg chg="addSp delSp modSp mod setBg modNotes">
        <pc:chgData name="Adkins, Sherry Marie" userId="S::sherry.adkins@wright.edu::24362372-ca3c-4f9f-b38c-fc14581e8bc5" providerId="AD" clId="Web-{0C5759E8-1630-3ED1-FD51-8E4B640B22CB}" dt="2024-05-01T00:47:01.199" v="332" actId="20577"/>
        <pc:sldMkLst>
          <pc:docMk/>
          <pc:sldMk cId="2595251053" sldId="285"/>
        </pc:sldMkLst>
        <pc:spChg chg="mod">
          <ac:chgData name="Adkins, Sherry Marie" userId="S::sherry.adkins@wright.edu::24362372-ca3c-4f9f-b38c-fc14581e8bc5" providerId="AD" clId="Web-{0C5759E8-1630-3ED1-FD51-8E4B640B22CB}" dt="2024-05-01T00:47:01.199" v="332" actId="20577"/>
          <ac:spMkLst>
            <pc:docMk/>
            <pc:sldMk cId="2595251053" sldId="285"/>
            <ac:spMk id="2" creationId="{9591A292-4F23-E563-FD70-5EBDC024EADF}"/>
          </ac:spMkLst>
        </pc:spChg>
        <pc:spChg chg="add mod">
          <ac:chgData name="Adkins, Sherry Marie" userId="S::sherry.adkins@wright.edu::24362372-ca3c-4f9f-b38c-fc14581e8bc5" providerId="AD" clId="Web-{0C5759E8-1630-3ED1-FD51-8E4B640B22CB}" dt="2024-05-01T00:36:52.471" v="77"/>
          <ac:spMkLst>
            <pc:docMk/>
            <pc:sldMk cId="2595251053" sldId="285"/>
            <ac:spMk id="5" creationId="{5D84C0CA-17AF-B099-83E1-C6317BC86683}"/>
          </ac:spMkLst>
        </pc:spChg>
        <pc:spChg chg="add">
          <ac:chgData name="Adkins, Sherry Marie" userId="S::sherry.adkins@wright.edu::24362372-ca3c-4f9f-b38c-fc14581e8bc5" providerId="AD" clId="Web-{0C5759E8-1630-3ED1-FD51-8E4B640B22CB}" dt="2024-05-01T00:36:52.471" v="77"/>
          <ac:spMkLst>
            <pc:docMk/>
            <pc:sldMk cId="2595251053" sldId="285"/>
            <ac:spMk id="10" creationId="{100EDD19-6802-4EC3-95CE-CFFAB042CFD6}"/>
          </ac:spMkLst>
        </pc:spChg>
        <pc:spChg chg="add">
          <ac:chgData name="Adkins, Sherry Marie" userId="S::sherry.adkins@wright.edu::24362372-ca3c-4f9f-b38c-fc14581e8bc5" providerId="AD" clId="Web-{0C5759E8-1630-3ED1-FD51-8E4B640B22CB}" dt="2024-05-01T00:36:52.471" v="77"/>
          <ac:spMkLst>
            <pc:docMk/>
            <pc:sldMk cId="2595251053" sldId="285"/>
            <ac:spMk id="12" creationId="{DB17E863-922E-4C26-BD64-E8FD41D28661}"/>
          </ac:spMkLst>
        </pc:spChg>
        <pc:picChg chg="del mod">
          <ac:chgData name="Adkins, Sherry Marie" userId="S::sherry.adkins@wright.edu::24362372-ca3c-4f9f-b38c-fc14581e8bc5" providerId="AD" clId="Web-{0C5759E8-1630-3ED1-FD51-8E4B640B22CB}" dt="2024-05-01T00:35:01.732" v="44"/>
          <ac:picMkLst>
            <pc:docMk/>
            <pc:sldMk cId="2595251053" sldId="285"/>
            <ac:picMk id="4" creationId="{1AB119A3-7848-2D2C-E468-48D5864AC077}"/>
          </ac:picMkLst>
        </pc:picChg>
      </pc:sldChg>
      <pc:sldChg chg="modNotes">
        <pc:chgData name="Adkins, Sherry Marie" userId="S::sherry.adkins@wright.edu::24362372-ca3c-4f9f-b38c-fc14581e8bc5" providerId="AD" clId="Web-{0C5759E8-1630-3ED1-FD51-8E4B640B22CB}" dt="2024-05-01T00:42:06.343" v="204"/>
        <pc:sldMkLst>
          <pc:docMk/>
          <pc:sldMk cId="3288749026" sldId="303"/>
        </pc:sldMkLst>
      </pc:sldChg>
    </pc:docChg>
  </pc:docChgLst>
  <pc:docChgLst>
    <pc:chgData name="Flowers, Stacy" userId="S::stacy.flowers@wright.edu::4a2efe78-54ae-4086-b211-fd8507b233eb" providerId="AD" clId="Web-{EA1B42AC-7566-500E-48AC-2CBE600E6AFB}"/>
    <pc:docChg chg="modSld">
      <pc:chgData name="Flowers, Stacy" userId="S::stacy.flowers@wright.edu::4a2efe78-54ae-4086-b211-fd8507b233eb" providerId="AD" clId="Web-{EA1B42AC-7566-500E-48AC-2CBE600E6AFB}" dt="2024-05-02T15:09:21.616" v="88"/>
      <pc:docMkLst>
        <pc:docMk/>
      </pc:docMkLst>
      <pc:sldChg chg="modNotes">
        <pc:chgData name="Flowers, Stacy" userId="S::stacy.flowers@wright.edu::4a2efe78-54ae-4086-b211-fd8507b233eb" providerId="AD" clId="Web-{EA1B42AC-7566-500E-48AC-2CBE600E6AFB}" dt="2024-05-02T15:09:21.616" v="88"/>
        <pc:sldMkLst>
          <pc:docMk/>
          <pc:sldMk cId="2646954914" sldId="278"/>
        </pc:sldMkLst>
      </pc:sldChg>
    </pc:docChg>
  </pc:docChgLst>
  <pc:docChgLst>
    <pc:chgData name="Sherry Adkins" userId="24362372-ca3c-4f9f-b38c-fc14581e8bc5" providerId="ADAL" clId="{65908409-C232-4914-9339-DFC301EC2F4A}"/>
    <pc:docChg chg="undo custSel modSld">
      <pc:chgData name="Sherry Adkins" userId="24362372-ca3c-4f9f-b38c-fc14581e8bc5" providerId="ADAL" clId="{65908409-C232-4914-9339-DFC301EC2F4A}" dt="2024-05-01T00:07:53.206" v="481" actId="20577"/>
      <pc:docMkLst>
        <pc:docMk/>
      </pc:docMkLst>
      <pc:sldChg chg="modSp">
        <pc:chgData name="Sherry Adkins" userId="24362372-ca3c-4f9f-b38c-fc14581e8bc5" providerId="ADAL" clId="{65908409-C232-4914-9339-DFC301EC2F4A}" dt="2024-04-30T23:46:36.340" v="0"/>
        <pc:sldMkLst>
          <pc:docMk/>
          <pc:sldMk cId="2646954914" sldId="278"/>
        </pc:sldMkLst>
        <pc:spChg chg="mod">
          <ac:chgData name="Sherry Adkins" userId="24362372-ca3c-4f9f-b38c-fc14581e8bc5" providerId="ADAL" clId="{65908409-C232-4914-9339-DFC301EC2F4A}" dt="2024-04-30T23:46:36.340" v="0"/>
          <ac:spMkLst>
            <pc:docMk/>
            <pc:sldMk cId="2646954914" sldId="278"/>
            <ac:spMk id="3" creationId="{0FB2EB9C-1382-4DD3-8425-6057DCA19775}"/>
          </ac:spMkLst>
        </pc:spChg>
      </pc:sldChg>
      <pc:sldChg chg="addSp delSp modSp modNotesTx">
        <pc:chgData name="Sherry Adkins" userId="24362372-ca3c-4f9f-b38c-fc14581e8bc5" providerId="ADAL" clId="{65908409-C232-4914-9339-DFC301EC2F4A}" dt="2024-05-01T00:07:53.206" v="481" actId="20577"/>
        <pc:sldMkLst>
          <pc:docMk/>
          <pc:sldMk cId="165018141" sldId="308"/>
        </pc:sldMkLst>
        <pc:spChg chg="mod">
          <ac:chgData name="Sherry Adkins" userId="24362372-ca3c-4f9f-b38c-fc14581e8bc5" providerId="ADAL" clId="{65908409-C232-4914-9339-DFC301EC2F4A}" dt="2024-04-30T23:48:10.174" v="15" actId="20577"/>
          <ac:spMkLst>
            <pc:docMk/>
            <pc:sldMk cId="165018141" sldId="308"/>
            <ac:spMk id="2" creationId="{88CAB1F8-7DA0-A658-152E-C4C2077EE81F}"/>
          </ac:spMkLst>
        </pc:spChg>
        <pc:spChg chg="mod">
          <ac:chgData name="Sherry Adkins" userId="24362372-ca3c-4f9f-b38c-fc14581e8bc5" providerId="ADAL" clId="{65908409-C232-4914-9339-DFC301EC2F4A}" dt="2024-04-30T23:46:46.633" v="3" actId="5793"/>
          <ac:spMkLst>
            <pc:docMk/>
            <pc:sldMk cId="165018141" sldId="308"/>
            <ac:spMk id="3" creationId="{EEB24FEF-C993-269E-5795-A76334C7D78B}"/>
          </ac:spMkLst>
        </pc:spChg>
        <pc:spChg chg="add del mod">
          <ac:chgData name="Sherry Adkins" userId="24362372-ca3c-4f9f-b38c-fc14581e8bc5" providerId="ADAL" clId="{65908409-C232-4914-9339-DFC301EC2F4A}" dt="2024-04-30T23:54:25.491" v="16" actId="478"/>
          <ac:spMkLst>
            <pc:docMk/>
            <pc:sldMk cId="165018141" sldId="308"/>
            <ac:spMk id="4" creationId="{C0B1B720-2EE0-40F0-AC13-9373D20515FC}"/>
          </ac:spMkLst>
        </pc:spChg>
      </pc:sldChg>
    </pc:docChg>
  </pc:docChgLst>
  <pc:docChgLst>
    <pc:chgData name="Adkins, Sherry Marie" userId="S::sherry.adkins@wright.edu::24362372-ca3c-4f9f-b38c-fc14581e8bc5" providerId="AD" clId="Web-{8B4640EA-57EB-01A2-19D5-4DC141F212BD}"/>
    <pc:docChg chg="modSld">
      <pc:chgData name="Adkins, Sherry Marie" userId="S::sherry.adkins@wright.edu::24362372-ca3c-4f9f-b38c-fc14581e8bc5" providerId="AD" clId="Web-{8B4640EA-57EB-01A2-19D5-4DC141F212BD}" dt="2024-05-01T00:24:59.155" v="106" actId="14100"/>
      <pc:docMkLst>
        <pc:docMk/>
      </pc:docMkLst>
      <pc:sldChg chg="modSp">
        <pc:chgData name="Adkins, Sherry Marie" userId="S::sherry.adkins@wright.edu::24362372-ca3c-4f9f-b38c-fc14581e8bc5" providerId="AD" clId="Web-{8B4640EA-57EB-01A2-19D5-4DC141F212BD}" dt="2024-05-01T00:24:59.155" v="106" actId="14100"/>
        <pc:sldMkLst>
          <pc:docMk/>
          <pc:sldMk cId="2830924806" sldId="271"/>
        </pc:sldMkLst>
        <pc:spChg chg="mod">
          <ac:chgData name="Adkins, Sherry Marie" userId="S::sherry.adkins@wright.edu::24362372-ca3c-4f9f-b38c-fc14581e8bc5" providerId="AD" clId="Web-{8B4640EA-57EB-01A2-19D5-4DC141F212BD}" dt="2024-05-01T00:24:59.155" v="106" actId="14100"/>
          <ac:spMkLst>
            <pc:docMk/>
            <pc:sldMk cId="2830924806" sldId="271"/>
            <ac:spMk id="5" creationId="{D8B6E7D9-E250-BC7D-3B10-B65C0C00FB3C}"/>
          </ac:spMkLst>
        </pc:spChg>
      </pc:sldChg>
      <pc:sldChg chg="modSp">
        <pc:chgData name="Adkins, Sherry Marie" userId="S::sherry.adkins@wright.edu::24362372-ca3c-4f9f-b38c-fc14581e8bc5" providerId="AD" clId="Web-{8B4640EA-57EB-01A2-19D5-4DC141F212BD}" dt="2024-05-01T00:20:36.023" v="104" actId="20577"/>
        <pc:sldMkLst>
          <pc:docMk/>
          <pc:sldMk cId="1688032901" sldId="273"/>
        </pc:sldMkLst>
        <pc:spChg chg="mod">
          <ac:chgData name="Adkins, Sherry Marie" userId="S::sherry.adkins@wright.edu::24362372-ca3c-4f9f-b38c-fc14581e8bc5" providerId="AD" clId="Web-{8B4640EA-57EB-01A2-19D5-4DC141F212BD}" dt="2024-05-01T00:20:36.023" v="104" actId="20577"/>
          <ac:spMkLst>
            <pc:docMk/>
            <pc:sldMk cId="1688032901" sldId="273"/>
            <ac:spMk id="3" creationId="{D89E9CA7-6514-1DF9-5585-7A97DA025800}"/>
          </ac:spMkLst>
        </pc:spChg>
      </pc:sldChg>
      <pc:sldChg chg="addSp delSp modSp modNotes">
        <pc:chgData name="Adkins, Sherry Marie" userId="S::sherry.adkins@wright.edu::24362372-ca3c-4f9f-b38c-fc14581e8bc5" providerId="AD" clId="Web-{8B4640EA-57EB-01A2-19D5-4DC141F212BD}" dt="2024-05-01T00:19:40.991" v="74" actId="1076"/>
        <pc:sldMkLst>
          <pc:docMk/>
          <pc:sldMk cId="165018141" sldId="308"/>
        </pc:sldMkLst>
        <pc:spChg chg="mod">
          <ac:chgData name="Adkins, Sherry Marie" userId="S::sherry.adkins@wright.edu::24362372-ca3c-4f9f-b38c-fc14581e8bc5" providerId="AD" clId="Web-{8B4640EA-57EB-01A2-19D5-4DC141F212BD}" dt="2024-05-01T00:19:40.991" v="74" actId="1076"/>
          <ac:spMkLst>
            <pc:docMk/>
            <pc:sldMk cId="165018141" sldId="308"/>
            <ac:spMk id="2" creationId="{88CAB1F8-7DA0-A658-152E-C4C2077EE81F}"/>
          </ac:spMkLst>
        </pc:spChg>
        <pc:spChg chg="add del">
          <ac:chgData name="Adkins, Sherry Marie" userId="S::sherry.adkins@wright.edu::24362372-ca3c-4f9f-b38c-fc14581e8bc5" providerId="AD" clId="Web-{8B4640EA-57EB-01A2-19D5-4DC141F212BD}" dt="2024-05-01T00:14:30.967" v="4"/>
          <ac:spMkLst>
            <pc:docMk/>
            <pc:sldMk cId="165018141" sldId="308"/>
            <ac:spMk id="3" creationId="{EEB24FEF-C993-269E-5795-A76334C7D78B}"/>
          </ac:spMkLst>
        </pc:spChg>
        <pc:picChg chg="add del mod ord">
          <ac:chgData name="Adkins, Sherry Marie" userId="S::sherry.adkins@wright.edu::24362372-ca3c-4f9f-b38c-fc14581e8bc5" providerId="AD" clId="Web-{8B4640EA-57EB-01A2-19D5-4DC141F212BD}" dt="2024-05-01T00:13:02.511" v="3"/>
          <ac:picMkLst>
            <pc:docMk/>
            <pc:sldMk cId="165018141" sldId="308"/>
            <ac:picMk id="4" creationId="{01E651A3-CD49-D08E-02EB-51684A40EF57}"/>
          </ac:picMkLst>
        </pc:picChg>
        <pc:picChg chg="add mod ord">
          <ac:chgData name="Adkins, Sherry Marie" userId="S::sherry.adkins@wright.edu::24362372-ca3c-4f9f-b38c-fc14581e8bc5" providerId="AD" clId="Web-{8B4640EA-57EB-01A2-19D5-4DC141F212BD}" dt="2024-05-01T00:14:30.982" v="5"/>
          <ac:picMkLst>
            <pc:docMk/>
            <pc:sldMk cId="165018141" sldId="308"/>
            <ac:picMk id="5" creationId="{2206E6E4-C516-A8C8-9BA3-E02AFFB1F34E}"/>
          </ac:picMkLst>
        </pc:pic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39ED8DD-AAD3-4294-AA39-A3005F475A8C}" type="doc">
      <dgm:prSet loTypeId="urn:microsoft.com/office/officeart/2008/layout/LinedList" loCatId="list" qsTypeId="urn:microsoft.com/office/officeart/2005/8/quickstyle/simple1" qsCatId="simple" csTypeId="urn:microsoft.com/office/officeart/2005/8/colors/colorful1" csCatId="colorful"/>
      <dgm:spPr/>
      <dgm:t>
        <a:bodyPr/>
        <a:lstStyle/>
        <a:p>
          <a:endParaRPr lang="en-US"/>
        </a:p>
      </dgm:t>
    </dgm:pt>
    <dgm:pt modelId="{642D99A1-EFF5-4F5E-A1EE-1B6F116CE395}">
      <dgm:prSet/>
      <dgm:spPr/>
      <dgm:t>
        <a:bodyPr/>
        <a:lstStyle/>
        <a:p>
          <a:r>
            <a:rPr lang="en-US"/>
            <a:t>Human beings make errors, even smart and hard working doctors</a:t>
          </a:r>
        </a:p>
      </dgm:t>
    </dgm:pt>
    <dgm:pt modelId="{2E622614-9E83-4281-A2E5-08E51EEF6510}" type="parTrans" cxnId="{FD8543D9-C10B-4103-81F3-EB560D9D818F}">
      <dgm:prSet/>
      <dgm:spPr/>
      <dgm:t>
        <a:bodyPr/>
        <a:lstStyle/>
        <a:p>
          <a:endParaRPr lang="en-US"/>
        </a:p>
      </dgm:t>
    </dgm:pt>
    <dgm:pt modelId="{FFD93257-6BCE-445A-B77B-8B6B23A5C760}" type="sibTrans" cxnId="{FD8543D9-C10B-4103-81F3-EB560D9D818F}">
      <dgm:prSet/>
      <dgm:spPr/>
      <dgm:t>
        <a:bodyPr/>
        <a:lstStyle/>
        <a:p>
          <a:endParaRPr lang="en-US"/>
        </a:p>
      </dgm:t>
    </dgm:pt>
    <dgm:pt modelId="{929E8259-2C8E-4980-B494-775E3E169DB0}">
      <dgm:prSet/>
      <dgm:spPr/>
      <dgm:t>
        <a:bodyPr/>
        <a:lstStyle/>
        <a:p>
          <a:r>
            <a:rPr lang="en-US"/>
            <a:t>We are aware of ourselves and our environment, anticipating when we and our colleagues are at higher risk for error</a:t>
          </a:r>
        </a:p>
      </dgm:t>
    </dgm:pt>
    <dgm:pt modelId="{D37AEA24-D8A5-4222-BB19-0782CBD5FD73}" type="parTrans" cxnId="{4552474B-C3FB-42D1-8AB3-B71CC62EB281}">
      <dgm:prSet/>
      <dgm:spPr/>
      <dgm:t>
        <a:bodyPr/>
        <a:lstStyle/>
        <a:p>
          <a:endParaRPr lang="en-US"/>
        </a:p>
      </dgm:t>
    </dgm:pt>
    <dgm:pt modelId="{52DCFF20-E0B0-4EC5-B7A7-2FED36225F61}" type="sibTrans" cxnId="{4552474B-C3FB-42D1-8AB3-B71CC62EB281}">
      <dgm:prSet/>
      <dgm:spPr/>
      <dgm:t>
        <a:bodyPr/>
        <a:lstStyle/>
        <a:p>
          <a:endParaRPr lang="en-US"/>
        </a:p>
      </dgm:t>
    </dgm:pt>
    <dgm:pt modelId="{A142A9A8-E687-47E5-9E67-A4603AA51D5D}">
      <dgm:prSet/>
      <dgm:spPr/>
      <dgm:t>
        <a:bodyPr/>
        <a:lstStyle/>
        <a:p>
          <a:r>
            <a:rPr lang="en-US"/>
            <a:t>In spite of the barriers, we will be honest and learn from our errors</a:t>
          </a:r>
        </a:p>
      </dgm:t>
    </dgm:pt>
    <dgm:pt modelId="{666F566C-E3B6-4E37-A6DC-E5D3BDC6B3E1}" type="parTrans" cxnId="{CC3830A0-C62F-4A02-AA2C-E8A6FFE4257B}">
      <dgm:prSet/>
      <dgm:spPr/>
      <dgm:t>
        <a:bodyPr/>
        <a:lstStyle/>
        <a:p>
          <a:endParaRPr lang="en-US"/>
        </a:p>
      </dgm:t>
    </dgm:pt>
    <dgm:pt modelId="{8C2FCA9C-6566-4664-B5E3-1805399DC42D}" type="sibTrans" cxnId="{CC3830A0-C62F-4A02-AA2C-E8A6FFE4257B}">
      <dgm:prSet/>
      <dgm:spPr/>
      <dgm:t>
        <a:bodyPr/>
        <a:lstStyle/>
        <a:p>
          <a:endParaRPr lang="en-US"/>
        </a:p>
      </dgm:t>
    </dgm:pt>
    <dgm:pt modelId="{75373E01-3239-44C0-9108-FF7407BA44C1}">
      <dgm:prSet/>
      <dgm:spPr/>
      <dgm:t>
        <a:bodyPr/>
        <a:lstStyle/>
        <a:p>
          <a:r>
            <a:rPr lang="en-US"/>
            <a:t>We will not abandon our patients or our colleagues after error</a:t>
          </a:r>
        </a:p>
      </dgm:t>
    </dgm:pt>
    <dgm:pt modelId="{00718990-02D7-482E-AB6F-1F9B3CE5EEAF}" type="parTrans" cxnId="{67A1DEB3-CB5F-4939-BE96-57BCC1205AC2}">
      <dgm:prSet/>
      <dgm:spPr/>
      <dgm:t>
        <a:bodyPr/>
        <a:lstStyle/>
        <a:p>
          <a:endParaRPr lang="en-US"/>
        </a:p>
      </dgm:t>
    </dgm:pt>
    <dgm:pt modelId="{50C1F5E9-6840-452A-B8C1-1EEB81E28BB4}" type="sibTrans" cxnId="{67A1DEB3-CB5F-4939-BE96-57BCC1205AC2}">
      <dgm:prSet/>
      <dgm:spPr/>
      <dgm:t>
        <a:bodyPr/>
        <a:lstStyle/>
        <a:p>
          <a:endParaRPr lang="en-US"/>
        </a:p>
      </dgm:t>
    </dgm:pt>
    <dgm:pt modelId="{F734FDA1-5CE5-429C-A054-5BCD332D42BA}">
      <dgm:prSet/>
      <dgm:spPr/>
      <dgm:t>
        <a:bodyPr/>
        <a:lstStyle/>
        <a:p>
          <a:r>
            <a:rPr lang="en-US"/>
            <a:t>We will practice self care after an error and get help when we need it</a:t>
          </a:r>
        </a:p>
      </dgm:t>
    </dgm:pt>
    <dgm:pt modelId="{05002B61-F662-4159-BCF4-2623647B6D90}" type="parTrans" cxnId="{4019D6FF-4AFA-4DB0-8665-E4424D4232B7}">
      <dgm:prSet/>
      <dgm:spPr/>
      <dgm:t>
        <a:bodyPr/>
        <a:lstStyle/>
        <a:p>
          <a:endParaRPr lang="en-US"/>
        </a:p>
      </dgm:t>
    </dgm:pt>
    <dgm:pt modelId="{80B3265A-8E89-44C2-905E-44566E7D3C16}" type="sibTrans" cxnId="{4019D6FF-4AFA-4DB0-8665-E4424D4232B7}">
      <dgm:prSet/>
      <dgm:spPr/>
      <dgm:t>
        <a:bodyPr/>
        <a:lstStyle/>
        <a:p>
          <a:endParaRPr lang="en-US"/>
        </a:p>
      </dgm:t>
    </dgm:pt>
    <dgm:pt modelId="{AAC6CEF1-E2D3-403E-A40A-1B6D392F50D9}">
      <dgm:prSet/>
      <dgm:spPr/>
      <dgm:t>
        <a:bodyPr/>
        <a:lstStyle/>
        <a:p>
          <a:r>
            <a:rPr lang="en-US"/>
            <a:t>Practice makes better </a:t>
          </a:r>
        </a:p>
      </dgm:t>
    </dgm:pt>
    <dgm:pt modelId="{FE1F04F8-0235-44BD-8894-924513331725}" type="parTrans" cxnId="{1841AA71-AA31-40E3-98D4-8D11BB445CE8}">
      <dgm:prSet/>
      <dgm:spPr/>
      <dgm:t>
        <a:bodyPr/>
        <a:lstStyle/>
        <a:p>
          <a:endParaRPr lang="en-US"/>
        </a:p>
      </dgm:t>
    </dgm:pt>
    <dgm:pt modelId="{1323289B-AA1E-44C9-A6DD-16AF1523FE01}" type="sibTrans" cxnId="{1841AA71-AA31-40E3-98D4-8D11BB445CE8}">
      <dgm:prSet/>
      <dgm:spPr/>
      <dgm:t>
        <a:bodyPr/>
        <a:lstStyle/>
        <a:p>
          <a:endParaRPr lang="en-US"/>
        </a:p>
      </dgm:t>
    </dgm:pt>
    <dgm:pt modelId="{4478794F-FD18-414C-A671-C1EA6B9C942C}" type="pres">
      <dgm:prSet presAssocID="{A39ED8DD-AAD3-4294-AA39-A3005F475A8C}" presName="vert0" presStyleCnt="0">
        <dgm:presLayoutVars>
          <dgm:dir/>
          <dgm:animOne val="branch"/>
          <dgm:animLvl val="lvl"/>
        </dgm:presLayoutVars>
      </dgm:prSet>
      <dgm:spPr/>
    </dgm:pt>
    <dgm:pt modelId="{7C8AEEB1-28A9-4D51-89D5-79BAE4DAC0BD}" type="pres">
      <dgm:prSet presAssocID="{642D99A1-EFF5-4F5E-A1EE-1B6F116CE395}" presName="thickLine" presStyleLbl="alignNode1" presStyleIdx="0" presStyleCnt="6"/>
      <dgm:spPr/>
    </dgm:pt>
    <dgm:pt modelId="{A1D3E5BF-C851-4B95-9DE5-E1E984CE7E8D}" type="pres">
      <dgm:prSet presAssocID="{642D99A1-EFF5-4F5E-A1EE-1B6F116CE395}" presName="horz1" presStyleCnt="0"/>
      <dgm:spPr/>
    </dgm:pt>
    <dgm:pt modelId="{54D363EB-2DE4-49D1-876A-175330170708}" type="pres">
      <dgm:prSet presAssocID="{642D99A1-EFF5-4F5E-A1EE-1B6F116CE395}" presName="tx1" presStyleLbl="revTx" presStyleIdx="0" presStyleCnt="6"/>
      <dgm:spPr/>
    </dgm:pt>
    <dgm:pt modelId="{16159877-97E3-4D04-8D3F-56A2956DEAFA}" type="pres">
      <dgm:prSet presAssocID="{642D99A1-EFF5-4F5E-A1EE-1B6F116CE395}" presName="vert1" presStyleCnt="0"/>
      <dgm:spPr/>
    </dgm:pt>
    <dgm:pt modelId="{5B50099E-807B-4377-93BB-92B961EF3B75}" type="pres">
      <dgm:prSet presAssocID="{929E8259-2C8E-4980-B494-775E3E169DB0}" presName="thickLine" presStyleLbl="alignNode1" presStyleIdx="1" presStyleCnt="6"/>
      <dgm:spPr/>
    </dgm:pt>
    <dgm:pt modelId="{60FF215E-1FAC-4A0A-8F08-238C27463850}" type="pres">
      <dgm:prSet presAssocID="{929E8259-2C8E-4980-B494-775E3E169DB0}" presName="horz1" presStyleCnt="0"/>
      <dgm:spPr/>
    </dgm:pt>
    <dgm:pt modelId="{33A8D523-1BE5-4B4E-905F-9029A944C8A2}" type="pres">
      <dgm:prSet presAssocID="{929E8259-2C8E-4980-B494-775E3E169DB0}" presName="tx1" presStyleLbl="revTx" presStyleIdx="1" presStyleCnt="6"/>
      <dgm:spPr/>
    </dgm:pt>
    <dgm:pt modelId="{12EB0571-A8B1-4332-AEDD-A575C18C66B7}" type="pres">
      <dgm:prSet presAssocID="{929E8259-2C8E-4980-B494-775E3E169DB0}" presName="vert1" presStyleCnt="0"/>
      <dgm:spPr/>
    </dgm:pt>
    <dgm:pt modelId="{E8E566AD-7254-4DC9-810F-D4D017AFFB1C}" type="pres">
      <dgm:prSet presAssocID="{A142A9A8-E687-47E5-9E67-A4603AA51D5D}" presName="thickLine" presStyleLbl="alignNode1" presStyleIdx="2" presStyleCnt="6"/>
      <dgm:spPr/>
    </dgm:pt>
    <dgm:pt modelId="{EF0E72FE-5DA2-4379-880B-5C5B7D8C99C2}" type="pres">
      <dgm:prSet presAssocID="{A142A9A8-E687-47E5-9E67-A4603AA51D5D}" presName="horz1" presStyleCnt="0"/>
      <dgm:spPr/>
    </dgm:pt>
    <dgm:pt modelId="{F5F9F068-96EA-49E3-8A26-FE93186D4A06}" type="pres">
      <dgm:prSet presAssocID="{A142A9A8-E687-47E5-9E67-A4603AA51D5D}" presName="tx1" presStyleLbl="revTx" presStyleIdx="2" presStyleCnt="6"/>
      <dgm:spPr/>
    </dgm:pt>
    <dgm:pt modelId="{AC16EB42-5F91-4D86-A7FA-3B44A4FD9CB0}" type="pres">
      <dgm:prSet presAssocID="{A142A9A8-E687-47E5-9E67-A4603AA51D5D}" presName="vert1" presStyleCnt="0"/>
      <dgm:spPr/>
    </dgm:pt>
    <dgm:pt modelId="{728EA669-9A6F-4E39-BED2-A116F0069B57}" type="pres">
      <dgm:prSet presAssocID="{75373E01-3239-44C0-9108-FF7407BA44C1}" presName="thickLine" presStyleLbl="alignNode1" presStyleIdx="3" presStyleCnt="6"/>
      <dgm:spPr/>
    </dgm:pt>
    <dgm:pt modelId="{F056BED2-0E6F-4221-B2CB-2EE1F3C69DCD}" type="pres">
      <dgm:prSet presAssocID="{75373E01-3239-44C0-9108-FF7407BA44C1}" presName="horz1" presStyleCnt="0"/>
      <dgm:spPr/>
    </dgm:pt>
    <dgm:pt modelId="{DB9A711E-D076-44D1-A977-575038F7CA29}" type="pres">
      <dgm:prSet presAssocID="{75373E01-3239-44C0-9108-FF7407BA44C1}" presName="tx1" presStyleLbl="revTx" presStyleIdx="3" presStyleCnt="6"/>
      <dgm:spPr/>
    </dgm:pt>
    <dgm:pt modelId="{5BACEC71-6A6F-43E0-AB5B-8CE9BB9B7477}" type="pres">
      <dgm:prSet presAssocID="{75373E01-3239-44C0-9108-FF7407BA44C1}" presName="vert1" presStyleCnt="0"/>
      <dgm:spPr/>
    </dgm:pt>
    <dgm:pt modelId="{F8C3E15E-3E20-4FA7-844E-F936D7B52763}" type="pres">
      <dgm:prSet presAssocID="{F734FDA1-5CE5-429C-A054-5BCD332D42BA}" presName="thickLine" presStyleLbl="alignNode1" presStyleIdx="4" presStyleCnt="6"/>
      <dgm:spPr/>
    </dgm:pt>
    <dgm:pt modelId="{F84BF6F4-D02C-4D58-91EA-3D10F731FC87}" type="pres">
      <dgm:prSet presAssocID="{F734FDA1-5CE5-429C-A054-5BCD332D42BA}" presName="horz1" presStyleCnt="0"/>
      <dgm:spPr/>
    </dgm:pt>
    <dgm:pt modelId="{2C6ECA73-84B0-44BC-9382-C0DB02353EF3}" type="pres">
      <dgm:prSet presAssocID="{F734FDA1-5CE5-429C-A054-5BCD332D42BA}" presName="tx1" presStyleLbl="revTx" presStyleIdx="4" presStyleCnt="6"/>
      <dgm:spPr/>
    </dgm:pt>
    <dgm:pt modelId="{ED2ED846-FDEB-4AD6-9A40-F1C63ACB7846}" type="pres">
      <dgm:prSet presAssocID="{F734FDA1-5CE5-429C-A054-5BCD332D42BA}" presName="vert1" presStyleCnt="0"/>
      <dgm:spPr/>
    </dgm:pt>
    <dgm:pt modelId="{0FF6F41B-232A-4A73-8AA3-3285316BB415}" type="pres">
      <dgm:prSet presAssocID="{AAC6CEF1-E2D3-403E-A40A-1B6D392F50D9}" presName="thickLine" presStyleLbl="alignNode1" presStyleIdx="5" presStyleCnt="6"/>
      <dgm:spPr/>
    </dgm:pt>
    <dgm:pt modelId="{A9F7584A-A7EA-4AE3-A6CE-DCA432D31291}" type="pres">
      <dgm:prSet presAssocID="{AAC6CEF1-E2D3-403E-A40A-1B6D392F50D9}" presName="horz1" presStyleCnt="0"/>
      <dgm:spPr/>
    </dgm:pt>
    <dgm:pt modelId="{46AC37CA-006D-4063-8B2E-3917376F50A9}" type="pres">
      <dgm:prSet presAssocID="{AAC6CEF1-E2D3-403E-A40A-1B6D392F50D9}" presName="tx1" presStyleLbl="revTx" presStyleIdx="5" presStyleCnt="6"/>
      <dgm:spPr/>
    </dgm:pt>
    <dgm:pt modelId="{A17BE26E-E231-4489-8A0C-C3AAAA6B26BB}" type="pres">
      <dgm:prSet presAssocID="{AAC6CEF1-E2D3-403E-A40A-1B6D392F50D9}" presName="vert1" presStyleCnt="0"/>
      <dgm:spPr/>
    </dgm:pt>
  </dgm:ptLst>
  <dgm:cxnLst>
    <dgm:cxn modelId="{A5AE4A0A-1820-47F3-8C48-77473F2EEE79}" type="presOf" srcId="{642D99A1-EFF5-4F5E-A1EE-1B6F116CE395}" destId="{54D363EB-2DE4-49D1-876A-175330170708}" srcOrd="0" destOrd="0" presId="urn:microsoft.com/office/officeart/2008/layout/LinedList"/>
    <dgm:cxn modelId="{F4C60319-AB23-45BF-B2DF-CE14B3AE6EC2}" type="presOf" srcId="{929E8259-2C8E-4980-B494-775E3E169DB0}" destId="{33A8D523-1BE5-4B4E-905F-9029A944C8A2}" srcOrd="0" destOrd="0" presId="urn:microsoft.com/office/officeart/2008/layout/LinedList"/>
    <dgm:cxn modelId="{DE32163D-C7C5-4644-9884-5159BD82EDB9}" type="presOf" srcId="{F734FDA1-5CE5-429C-A054-5BCD332D42BA}" destId="{2C6ECA73-84B0-44BC-9382-C0DB02353EF3}" srcOrd="0" destOrd="0" presId="urn:microsoft.com/office/officeart/2008/layout/LinedList"/>
    <dgm:cxn modelId="{E1FCB55B-3CF6-46E9-9A3E-E6178CD2F97D}" type="presOf" srcId="{A142A9A8-E687-47E5-9E67-A4603AA51D5D}" destId="{F5F9F068-96EA-49E3-8A26-FE93186D4A06}" srcOrd="0" destOrd="0" presId="urn:microsoft.com/office/officeart/2008/layout/LinedList"/>
    <dgm:cxn modelId="{4552474B-C3FB-42D1-8AB3-B71CC62EB281}" srcId="{A39ED8DD-AAD3-4294-AA39-A3005F475A8C}" destId="{929E8259-2C8E-4980-B494-775E3E169DB0}" srcOrd="1" destOrd="0" parTransId="{D37AEA24-D8A5-4222-BB19-0782CBD5FD73}" sibTransId="{52DCFF20-E0B0-4EC5-B7A7-2FED36225F61}"/>
    <dgm:cxn modelId="{5548754E-8368-4596-A357-B535118CFFF4}" type="presOf" srcId="{75373E01-3239-44C0-9108-FF7407BA44C1}" destId="{DB9A711E-D076-44D1-A977-575038F7CA29}" srcOrd="0" destOrd="0" presId="urn:microsoft.com/office/officeart/2008/layout/LinedList"/>
    <dgm:cxn modelId="{1841AA71-AA31-40E3-98D4-8D11BB445CE8}" srcId="{A39ED8DD-AAD3-4294-AA39-A3005F475A8C}" destId="{AAC6CEF1-E2D3-403E-A40A-1B6D392F50D9}" srcOrd="5" destOrd="0" parTransId="{FE1F04F8-0235-44BD-8894-924513331725}" sibTransId="{1323289B-AA1E-44C9-A6DD-16AF1523FE01}"/>
    <dgm:cxn modelId="{D3DDB09C-069A-4530-BF4F-453A20AD928A}" type="presOf" srcId="{A39ED8DD-AAD3-4294-AA39-A3005F475A8C}" destId="{4478794F-FD18-414C-A671-C1EA6B9C942C}" srcOrd="0" destOrd="0" presId="urn:microsoft.com/office/officeart/2008/layout/LinedList"/>
    <dgm:cxn modelId="{CC3830A0-C62F-4A02-AA2C-E8A6FFE4257B}" srcId="{A39ED8DD-AAD3-4294-AA39-A3005F475A8C}" destId="{A142A9A8-E687-47E5-9E67-A4603AA51D5D}" srcOrd="2" destOrd="0" parTransId="{666F566C-E3B6-4E37-A6DC-E5D3BDC6B3E1}" sibTransId="{8C2FCA9C-6566-4664-B5E3-1805399DC42D}"/>
    <dgm:cxn modelId="{67A1DEB3-CB5F-4939-BE96-57BCC1205AC2}" srcId="{A39ED8DD-AAD3-4294-AA39-A3005F475A8C}" destId="{75373E01-3239-44C0-9108-FF7407BA44C1}" srcOrd="3" destOrd="0" parTransId="{00718990-02D7-482E-AB6F-1F9B3CE5EEAF}" sibTransId="{50C1F5E9-6840-452A-B8C1-1EEB81E28BB4}"/>
    <dgm:cxn modelId="{6D59EAC1-CD33-43C0-A0BB-64758ED7FD46}" type="presOf" srcId="{AAC6CEF1-E2D3-403E-A40A-1B6D392F50D9}" destId="{46AC37CA-006D-4063-8B2E-3917376F50A9}" srcOrd="0" destOrd="0" presId="urn:microsoft.com/office/officeart/2008/layout/LinedList"/>
    <dgm:cxn modelId="{FD8543D9-C10B-4103-81F3-EB560D9D818F}" srcId="{A39ED8DD-AAD3-4294-AA39-A3005F475A8C}" destId="{642D99A1-EFF5-4F5E-A1EE-1B6F116CE395}" srcOrd="0" destOrd="0" parTransId="{2E622614-9E83-4281-A2E5-08E51EEF6510}" sibTransId="{FFD93257-6BCE-445A-B77B-8B6B23A5C760}"/>
    <dgm:cxn modelId="{4019D6FF-4AFA-4DB0-8665-E4424D4232B7}" srcId="{A39ED8DD-AAD3-4294-AA39-A3005F475A8C}" destId="{F734FDA1-5CE5-429C-A054-5BCD332D42BA}" srcOrd="4" destOrd="0" parTransId="{05002B61-F662-4159-BCF4-2623647B6D90}" sibTransId="{80B3265A-8E89-44C2-905E-44566E7D3C16}"/>
    <dgm:cxn modelId="{B1EF4D0E-71E7-4AC4-A86F-993672E54C3A}" type="presParOf" srcId="{4478794F-FD18-414C-A671-C1EA6B9C942C}" destId="{7C8AEEB1-28A9-4D51-89D5-79BAE4DAC0BD}" srcOrd="0" destOrd="0" presId="urn:microsoft.com/office/officeart/2008/layout/LinedList"/>
    <dgm:cxn modelId="{1BA46747-1551-4FF4-8555-85C27564D45D}" type="presParOf" srcId="{4478794F-FD18-414C-A671-C1EA6B9C942C}" destId="{A1D3E5BF-C851-4B95-9DE5-E1E984CE7E8D}" srcOrd="1" destOrd="0" presId="urn:microsoft.com/office/officeart/2008/layout/LinedList"/>
    <dgm:cxn modelId="{D983A659-9319-46EC-8F10-0858F8CB8179}" type="presParOf" srcId="{A1D3E5BF-C851-4B95-9DE5-E1E984CE7E8D}" destId="{54D363EB-2DE4-49D1-876A-175330170708}" srcOrd="0" destOrd="0" presId="urn:microsoft.com/office/officeart/2008/layout/LinedList"/>
    <dgm:cxn modelId="{E2C28132-E888-45C9-AC8C-FC48673FED2B}" type="presParOf" srcId="{A1D3E5BF-C851-4B95-9DE5-E1E984CE7E8D}" destId="{16159877-97E3-4D04-8D3F-56A2956DEAFA}" srcOrd="1" destOrd="0" presId="urn:microsoft.com/office/officeart/2008/layout/LinedList"/>
    <dgm:cxn modelId="{F54EAA1C-E766-4091-AFF7-7002563DC8D5}" type="presParOf" srcId="{4478794F-FD18-414C-A671-C1EA6B9C942C}" destId="{5B50099E-807B-4377-93BB-92B961EF3B75}" srcOrd="2" destOrd="0" presId="urn:microsoft.com/office/officeart/2008/layout/LinedList"/>
    <dgm:cxn modelId="{733AF91A-646E-4F6C-AC09-0DEEF43DF93C}" type="presParOf" srcId="{4478794F-FD18-414C-A671-C1EA6B9C942C}" destId="{60FF215E-1FAC-4A0A-8F08-238C27463850}" srcOrd="3" destOrd="0" presId="urn:microsoft.com/office/officeart/2008/layout/LinedList"/>
    <dgm:cxn modelId="{93EBC4DC-5D4F-475A-ACC3-F62FBC0B4F7C}" type="presParOf" srcId="{60FF215E-1FAC-4A0A-8F08-238C27463850}" destId="{33A8D523-1BE5-4B4E-905F-9029A944C8A2}" srcOrd="0" destOrd="0" presId="urn:microsoft.com/office/officeart/2008/layout/LinedList"/>
    <dgm:cxn modelId="{93177F24-62AC-4254-8802-627A740C9501}" type="presParOf" srcId="{60FF215E-1FAC-4A0A-8F08-238C27463850}" destId="{12EB0571-A8B1-4332-AEDD-A575C18C66B7}" srcOrd="1" destOrd="0" presId="urn:microsoft.com/office/officeart/2008/layout/LinedList"/>
    <dgm:cxn modelId="{96498D6E-5D0A-4897-BEB2-A4382F98AA38}" type="presParOf" srcId="{4478794F-FD18-414C-A671-C1EA6B9C942C}" destId="{E8E566AD-7254-4DC9-810F-D4D017AFFB1C}" srcOrd="4" destOrd="0" presId="urn:microsoft.com/office/officeart/2008/layout/LinedList"/>
    <dgm:cxn modelId="{18133AEE-AD2E-424D-B7BA-7DA9AA4B9507}" type="presParOf" srcId="{4478794F-FD18-414C-A671-C1EA6B9C942C}" destId="{EF0E72FE-5DA2-4379-880B-5C5B7D8C99C2}" srcOrd="5" destOrd="0" presId="urn:microsoft.com/office/officeart/2008/layout/LinedList"/>
    <dgm:cxn modelId="{83C5D32D-73CE-4A81-B85F-F91D7E905168}" type="presParOf" srcId="{EF0E72FE-5DA2-4379-880B-5C5B7D8C99C2}" destId="{F5F9F068-96EA-49E3-8A26-FE93186D4A06}" srcOrd="0" destOrd="0" presId="urn:microsoft.com/office/officeart/2008/layout/LinedList"/>
    <dgm:cxn modelId="{71B4838D-6DDE-47A3-835B-B6D2183A6B34}" type="presParOf" srcId="{EF0E72FE-5DA2-4379-880B-5C5B7D8C99C2}" destId="{AC16EB42-5F91-4D86-A7FA-3B44A4FD9CB0}" srcOrd="1" destOrd="0" presId="urn:microsoft.com/office/officeart/2008/layout/LinedList"/>
    <dgm:cxn modelId="{9EB69F54-2271-4512-9349-93822A0DFC2C}" type="presParOf" srcId="{4478794F-FD18-414C-A671-C1EA6B9C942C}" destId="{728EA669-9A6F-4E39-BED2-A116F0069B57}" srcOrd="6" destOrd="0" presId="urn:microsoft.com/office/officeart/2008/layout/LinedList"/>
    <dgm:cxn modelId="{2A999028-991F-425F-AB6C-C6552F7E04D3}" type="presParOf" srcId="{4478794F-FD18-414C-A671-C1EA6B9C942C}" destId="{F056BED2-0E6F-4221-B2CB-2EE1F3C69DCD}" srcOrd="7" destOrd="0" presId="urn:microsoft.com/office/officeart/2008/layout/LinedList"/>
    <dgm:cxn modelId="{59CE9C0D-910C-452F-8F15-A2C648183F9B}" type="presParOf" srcId="{F056BED2-0E6F-4221-B2CB-2EE1F3C69DCD}" destId="{DB9A711E-D076-44D1-A977-575038F7CA29}" srcOrd="0" destOrd="0" presId="urn:microsoft.com/office/officeart/2008/layout/LinedList"/>
    <dgm:cxn modelId="{D9B1CD93-19F3-40E2-81BD-92A708A0E270}" type="presParOf" srcId="{F056BED2-0E6F-4221-B2CB-2EE1F3C69DCD}" destId="{5BACEC71-6A6F-43E0-AB5B-8CE9BB9B7477}" srcOrd="1" destOrd="0" presId="urn:microsoft.com/office/officeart/2008/layout/LinedList"/>
    <dgm:cxn modelId="{D05B5F38-176B-47EE-B7C7-20BC97120066}" type="presParOf" srcId="{4478794F-FD18-414C-A671-C1EA6B9C942C}" destId="{F8C3E15E-3E20-4FA7-844E-F936D7B52763}" srcOrd="8" destOrd="0" presId="urn:microsoft.com/office/officeart/2008/layout/LinedList"/>
    <dgm:cxn modelId="{440D1038-AD8E-41B1-9BB2-0A93F3F4CEDE}" type="presParOf" srcId="{4478794F-FD18-414C-A671-C1EA6B9C942C}" destId="{F84BF6F4-D02C-4D58-91EA-3D10F731FC87}" srcOrd="9" destOrd="0" presId="urn:microsoft.com/office/officeart/2008/layout/LinedList"/>
    <dgm:cxn modelId="{D253C0C0-870D-4A54-8B46-10DC7D572DEC}" type="presParOf" srcId="{F84BF6F4-D02C-4D58-91EA-3D10F731FC87}" destId="{2C6ECA73-84B0-44BC-9382-C0DB02353EF3}" srcOrd="0" destOrd="0" presId="urn:microsoft.com/office/officeart/2008/layout/LinedList"/>
    <dgm:cxn modelId="{37495AF5-EEE3-4D74-9DB0-295F66B08DFE}" type="presParOf" srcId="{F84BF6F4-D02C-4D58-91EA-3D10F731FC87}" destId="{ED2ED846-FDEB-4AD6-9A40-F1C63ACB7846}" srcOrd="1" destOrd="0" presId="urn:microsoft.com/office/officeart/2008/layout/LinedList"/>
    <dgm:cxn modelId="{42E83D04-18B3-40B1-A146-AF687DEE3DAD}" type="presParOf" srcId="{4478794F-FD18-414C-A671-C1EA6B9C942C}" destId="{0FF6F41B-232A-4A73-8AA3-3285316BB415}" srcOrd="10" destOrd="0" presId="urn:microsoft.com/office/officeart/2008/layout/LinedList"/>
    <dgm:cxn modelId="{5A24C729-8B5D-4084-A1A7-C46CD3434C89}" type="presParOf" srcId="{4478794F-FD18-414C-A671-C1EA6B9C942C}" destId="{A9F7584A-A7EA-4AE3-A6CE-DCA432D31291}" srcOrd="11" destOrd="0" presId="urn:microsoft.com/office/officeart/2008/layout/LinedList"/>
    <dgm:cxn modelId="{54D6D044-A5EC-477D-8530-5C8D7D03C0A1}" type="presParOf" srcId="{A9F7584A-A7EA-4AE3-A6CE-DCA432D31291}" destId="{46AC37CA-006D-4063-8B2E-3917376F50A9}" srcOrd="0" destOrd="0" presId="urn:microsoft.com/office/officeart/2008/layout/LinedList"/>
    <dgm:cxn modelId="{02117F17-0AFD-4AE8-829F-23F41ED1E5AF}" type="presParOf" srcId="{A9F7584A-A7EA-4AE3-A6CE-DCA432D31291}" destId="{A17BE26E-E231-4489-8A0C-C3AAAA6B26BB}"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5BA44DDC-56A1-4957-8361-8B2CC232F3D2}"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4AAD5682-305A-4176-885B-F9E42F88200E}">
      <dgm:prSet/>
      <dgm:spPr/>
      <dgm:t>
        <a:bodyPr/>
        <a:lstStyle/>
        <a:p>
          <a:r>
            <a:rPr lang="en-US" dirty="0"/>
            <a:t>Sponsoring institution GME - [Policy ]</a:t>
          </a:r>
        </a:p>
      </dgm:t>
    </dgm:pt>
    <dgm:pt modelId="{0C93F693-B375-4B72-9D5F-0EADCA914128}" type="parTrans" cxnId="{7F2327C3-09F3-43EA-B0FD-49AA8B31888B}">
      <dgm:prSet/>
      <dgm:spPr/>
      <dgm:t>
        <a:bodyPr/>
        <a:lstStyle/>
        <a:p>
          <a:endParaRPr lang="en-US"/>
        </a:p>
      </dgm:t>
    </dgm:pt>
    <dgm:pt modelId="{B00B0479-8A2E-4EFF-AB2B-24E38B5855AE}" type="sibTrans" cxnId="{7F2327C3-09F3-43EA-B0FD-49AA8B31888B}">
      <dgm:prSet/>
      <dgm:spPr/>
      <dgm:t>
        <a:bodyPr/>
        <a:lstStyle/>
        <a:p>
          <a:endParaRPr lang="en-US"/>
        </a:p>
      </dgm:t>
    </dgm:pt>
    <dgm:pt modelId="{E31DB772-F974-4422-B871-1DF29E6BA238}">
      <dgm:prSet/>
      <dgm:spPr/>
      <dgm:t>
        <a:bodyPr/>
        <a:lstStyle/>
        <a:p>
          <a:r>
            <a:rPr lang="en-US" dirty="0"/>
            <a:t>Primary care center- [Policy</a:t>
          </a:r>
          <a:r>
            <a:rPr lang="en-US" dirty="0">
              <a:latin typeface="Calibri Light" panose="020F0302020204030204"/>
            </a:rPr>
            <a:t>]</a:t>
          </a:r>
          <a:endParaRPr lang="en-US" dirty="0"/>
        </a:p>
      </dgm:t>
    </dgm:pt>
    <dgm:pt modelId="{A0A87C7E-A6FA-4F8F-AE27-25B570B9DD0A}" type="parTrans" cxnId="{B0D97B8D-4711-4EB2-842B-03EA1C30DD0E}">
      <dgm:prSet/>
      <dgm:spPr/>
      <dgm:t>
        <a:bodyPr/>
        <a:lstStyle/>
        <a:p>
          <a:endParaRPr lang="en-US"/>
        </a:p>
      </dgm:t>
    </dgm:pt>
    <dgm:pt modelId="{1BCC2AC2-CCFC-4AB1-A4D5-C7EA0782FD39}" type="sibTrans" cxnId="{B0D97B8D-4711-4EB2-842B-03EA1C30DD0E}">
      <dgm:prSet/>
      <dgm:spPr/>
      <dgm:t>
        <a:bodyPr/>
        <a:lstStyle/>
        <a:p>
          <a:endParaRPr lang="en-US"/>
        </a:p>
      </dgm:t>
    </dgm:pt>
    <dgm:pt modelId="{218ABB54-6DE5-4B95-9A7C-4770B8364B03}">
      <dgm:prSet/>
      <dgm:spPr/>
      <dgm:t>
        <a:bodyPr/>
        <a:lstStyle/>
        <a:p>
          <a:r>
            <a:rPr lang="en-US" dirty="0"/>
            <a:t>Primary adult hospital – [Policy ]</a:t>
          </a:r>
        </a:p>
      </dgm:t>
    </dgm:pt>
    <dgm:pt modelId="{48E1CE32-38C3-4FA5-A950-A375CB9B4F26}" type="parTrans" cxnId="{0FD8D3E9-7D50-4019-A098-00B3E8E35FB1}">
      <dgm:prSet/>
      <dgm:spPr/>
      <dgm:t>
        <a:bodyPr/>
        <a:lstStyle/>
        <a:p>
          <a:endParaRPr lang="en-US"/>
        </a:p>
      </dgm:t>
    </dgm:pt>
    <dgm:pt modelId="{3D9B4934-46C7-4E9A-A8AD-E31AB113E8AD}" type="sibTrans" cxnId="{0FD8D3E9-7D50-4019-A098-00B3E8E35FB1}">
      <dgm:prSet/>
      <dgm:spPr/>
      <dgm:t>
        <a:bodyPr/>
        <a:lstStyle/>
        <a:p>
          <a:endParaRPr lang="en-US"/>
        </a:p>
      </dgm:t>
    </dgm:pt>
    <dgm:pt modelId="{5F7211F6-8DD2-4D0E-82A9-21EF8D0382EA}">
      <dgm:prSet/>
      <dgm:spPr/>
      <dgm:t>
        <a:bodyPr/>
        <a:lstStyle/>
        <a:p>
          <a:r>
            <a:rPr lang="en-US" dirty="0"/>
            <a:t>Primary pediatric hospital- [Policy ]</a:t>
          </a:r>
        </a:p>
      </dgm:t>
    </dgm:pt>
    <dgm:pt modelId="{7E3D3BE6-1224-43CB-82AD-7D1E9E17FA1E}" type="parTrans" cxnId="{12DAD35B-02A3-4978-B418-DCA410DC234B}">
      <dgm:prSet/>
      <dgm:spPr/>
      <dgm:t>
        <a:bodyPr/>
        <a:lstStyle/>
        <a:p>
          <a:endParaRPr lang="en-US"/>
        </a:p>
      </dgm:t>
    </dgm:pt>
    <dgm:pt modelId="{B7736570-D9D8-4A4A-8B7A-7479FC64DA7B}" type="sibTrans" cxnId="{12DAD35B-02A3-4978-B418-DCA410DC234B}">
      <dgm:prSet/>
      <dgm:spPr/>
      <dgm:t>
        <a:bodyPr/>
        <a:lstStyle/>
        <a:p>
          <a:endParaRPr lang="en-US"/>
        </a:p>
      </dgm:t>
    </dgm:pt>
    <dgm:pt modelId="{8E9FD9C2-E04A-4CE9-81FD-6610D8F87E30}" type="pres">
      <dgm:prSet presAssocID="{5BA44DDC-56A1-4957-8361-8B2CC232F3D2}" presName="linear" presStyleCnt="0">
        <dgm:presLayoutVars>
          <dgm:animLvl val="lvl"/>
          <dgm:resizeHandles val="exact"/>
        </dgm:presLayoutVars>
      </dgm:prSet>
      <dgm:spPr/>
    </dgm:pt>
    <dgm:pt modelId="{1992C9FE-315D-4790-BA8D-0F827137E7CC}" type="pres">
      <dgm:prSet presAssocID="{4AAD5682-305A-4176-885B-F9E42F88200E}" presName="parentText" presStyleLbl="node1" presStyleIdx="0" presStyleCnt="4">
        <dgm:presLayoutVars>
          <dgm:chMax val="0"/>
          <dgm:bulletEnabled val="1"/>
        </dgm:presLayoutVars>
      </dgm:prSet>
      <dgm:spPr/>
    </dgm:pt>
    <dgm:pt modelId="{71D021CE-43A7-4611-B273-47BB6FE5D86E}" type="pres">
      <dgm:prSet presAssocID="{B00B0479-8A2E-4EFF-AB2B-24E38B5855AE}" presName="spacer" presStyleCnt="0"/>
      <dgm:spPr/>
    </dgm:pt>
    <dgm:pt modelId="{2C05D033-D0C2-4A6C-B8DF-2960D4159D00}" type="pres">
      <dgm:prSet presAssocID="{E31DB772-F974-4422-B871-1DF29E6BA238}" presName="parentText" presStyleLbl="node1" presStyleIdx="1" presStyleCnt="4">
        <dgm:presLayoutVars>
          <dgm:chMax val="0"/>
          <dgm:bulletEnabled val="1"/>
        </dgm:presLayoutVars>
      </dgm:prSet>
      <dgm:spPr/>
    </dgm:pt>
    <dgm:pt modelId="{DE5D7F10-22FD-4DFA-B020-5F14DD829D1E}" type="pres">
      <dgm:prSet presAssocID="{1BCC2AC2-CCFC-4AB1-A4D5-C7EA0782FD39}" presName="spacer" presStyleCnt="0"/>
      <dgm:spPr/>
    </dgm:pt>
    <dgm:pt modelId="{178200DC-C645-4E48-80C8-1F750CAB47CF}" type="pres">
      <dgm:prSet presAssocID="{218ABB54-6DE5-4B95-9A7C-4770B8364B03}" presName="parentText" presStyleLbl="node1" presStyleIdx="2" presStyleCnt="4">
        <dgm:presLayoutVars>
          <dgm:chMax val="0"/>
          <dgm:bulletEnabled val="1"/>
        </dgm:presLayoutVars>
      </dgm:prSet>
      <dgm:spPr/>
    </dgm:pt>
    <dgm:pt modelId="{B2ADF776-A21A-4E7F-90B7-88C7645303A6}" type="pres">
      <dgm:prSet presAssocID="{3D9B4934-46C7-4E9A-A8AD-E31AB113E8AD}" presName="spacer" presStyleCnt="0"/>
      <dgm:spPr/>
    </dgm:pt>
    <dgm:pt modelId="{4F8EA2C4-D16C-430F-BDE7-8934CC478EE4}" type="pres">
      <dgm:prSet presAssocID="{5F7211F6-8DD2-4D0E-82A9-21EF8D0382EA}" presName="parentText" presStyleLbl="node1" presStyleIdx="3" presStyleCnt="4">
        <dgm:presLayoutVars>
          <dgm:chMax val="0"/>
          <dgm:bulletEnabled val="1"/>
        </dgm:presLayoutVars>
      </dgm:prSet>
      <dgm:spPr/>
    </dgm:pt>
  </dgm:ptLst>
  <dgm:cxnLst>
    <dgm:cxn modelId="{8DD6F70F-A1DF-4919-B56D-6BDEFC749B02}" type="presOf" srcId="{218ABB54-6DE5-4B95-9A7C-4770B8364B03}" destId="{178200DC-C645-4E48-80C8-1F750CAB47CF}" srcOrd="0" destOrd="0" presId="urn:microsoft.com/office/officeart/2005/8/layout/vList2"/>
    <dgm:cxn modelId="{C0D8C532-CFD2-498B-B8F6-AC591A96E992}" type="presOf" srcId="{5F7211F6-8DD2-4D0E-82A9-21EF8D0382EA}" destId="{4F8EA2C4-D16C-430F-BDE7-8934CC478EE4}" srcOrd="0" destOrd="0" presId="urn:microsoft.com/office/officeart/2005/8/layout/vList2"/>
    <dgm:cxn modelId="{12DAD35B-02A3-4978-B418-DCA410DC234B}" srcId="{5BA44DDC-56A1-4957-8361-8B2CC232F3D2}" destId="{5F7211F6-8DD2-4D0E-82A9-21EF8D0382EA}" srcOrd="3" destOrd="0" parTransId="{7E3D3BE6-1224-43CB-82AD-7D1E9E17FA1E}" sibTransId="{B7736570-D9D8-4A4A-8B7A-7479FC64DA7B}"/>
    <dgm:cxn modelId="{7EF2C28B-05E6-4EFC-8A0A-A5CB7669FD08}" type="presOf" srcId="{4AAD5682-305A-4176-885B-F9E42F88200E}" destId="{1992C9FE-315D-4790-BA8D-0F827137E7CC}" srcOrd="0" destOrd="0" presId="urn:microsoft.com/office/officeart/2005/8/layout/vList2"/>
    <dgm:cxn modelId="{B0D97B8D-4711-4EB2-842B-03EA1C30DD0E}" srcId="{5BA44DDC-56A1-4957-8361-8B2CC232F3D2}" destId="{E31DB772-F974-4422-B871-1DF29E6BA238}" srcOrd="1" destOrd="0" parTransId="{A0A87C7E-A6FA-4F8F-AE27-25B570B9DD0A}" sibTransId="{1BCC2AC2-CCFC-4AB1-A4D5-C7EA0782FD39}"/>
    <dgm:cxn modelId="{7F2327C3-09F3-43EA-B0FD-49AA8B31888B}" srcId="{5BA44DDC-56A1-4957-8361-8B2CC232F3D2}" destId="{4AAD5682-305A-4176-885B-F9E42F88200E}" srcOrd="0" destOrd="0" parTransId="{0C93F693-B375-4B72-9D5F-0EADCA914128}" sibTransId="{B00B0479-8A2E-4EFF-AB2B-24E38B5855AE}"/>
    <dgm:cxn modelId="{156E06C7-1293-4D6A-8718-8C8BDECB6932}" type="presOf" srcId="{5BA44DDC-56A1-4957-8361-8B2CC232F3D2}" destId="{8E9FD9C2-E04A-4CE9-81FD-6610D8F87E30}" srcOrd="0" destOrd="0" presId="urn:microsoft.com/office/officeart/2005/8/layout/vList2"/>
    <dgm:cxn modelId="{0FD8D3E9-7D50-4019-A098-00B3E8E35FB1}" srcId="{5BA44DDC-56A1-4957-8361-8B2CC232F3D2}" destId="{218ABB54-6DE5-4B95-9A7C-4770B8364B03}" srcOrd="2" destOrd="0" parTransId="{48E1CE32-38C3-4FA5-A950-A375CB9B4F26}" sibTransId="{3D9B4934-46C7-4E9A-A8AD-E31AB113E8AD}"/>
    <dgm:cxn modelId="{95F7E9ED-B3EF-4680-BFF2-EB093AB22BFF}" type="presOf" srcId="{E31DB772-F974-4422-B871-1DF29E6BA238}" destId="{2C05D033-D0C2-4A6C-B8DF-2960D4159D00}" srcOrd="0" destOrd="0" presId="urn:microsoft.com/office/officeart/2005/8/layout/vList2"/>
    <dgm:cxn modelId="{7640DD02-785A-4D93-A80C-05011D89272D}" type="presParOf" srcId="{8E9FD9C2-E04A-4CE9-81FD-6610D8F87E30}" destId="{1992C9FE-315D-4790-BA8D-0F827137E7CC}" srcOrd="0" destOrd="0" presId="urn:microsoft.com/office/officeart/2005/8/layout/vList2"/>
    <dgm:cxn modelId="{709BBD4A-DB7E-4B3A-980B-752BD49C8BA0}" type="presParOf" srcId="{8E9FD9C2-E04A-4CE9-81FD-6610D8F87E30}" destId="{71D021CE-43A7-4611-B273-47BB6FE5D86E}" srcOrd="1" destOrd="0" presId="urn:microsoft.com/office/officeart/2005/8/layout/vList2"/>
    <dgm:cxn modelId="{74B2E7E9-098A-4C7C-BF84-5806FE797AC5}" type="presParOf" srcId="{8E9FD9C2-E04A-4CE9-81FD-6610D8F87E30}" destId="{2C05D033-D0C2-4A6C-B8DF-2960D4159D00}" srcOrd="2" destOrd="0" presId="urn:microsoft.com/office/officeart/2005/8/layout/vList2"/>
    <dgm:cxn modelId="{9FF72B92-BD7C-4D34-9349-81A8014797B7}" type="presParOf" srcId="{8E9FD9C2-E04A-4CE9-81FD-6610D8F87E30}" destId="{DE5D7F10-22FD-4DFA-B020-5F14DD829D1E}" srcOrd="3" destOrd="0" presId="urn:microsoft.com/office/officeart/2005/8/layout/vList2"/>
    <dgm:cxn modelId="{E56C2EB3-9D82-46AF-8292-39C22FC06C52}" type="presParOf" srcId="{8E9FD9C2-E04A-4CE9-81FD-6610D8F87E30}" destId="{178200DC-C645-4E48-80C8-1F750CAB47CF}" srcOrd="4" destOrd="0" presId="urn:microsoft.com/office/officeart/2005/8/layout/vList2"/>
    <dgm:cxn modelId="{EA9D373F-4F1E-4D19-AEC7-627818D8C779}" type="presParOf" srcId="{8E9FD9C2-E04A-4CE9-81FD-6610D8F87E30}" destId="{B2ADF776-A21A-4E7F-90B7-88C7645303A6}" srcOrd="5" destOrd="0" presId="urn:microsoft.com/office/officeart/2005/8/layout/vList2"/>
    <dgm:cxn modelId="{59AAA45F-BF8E-4D8F-BC99-E83BB8E748A9}" type="presParOf" srcId="{8E9FD9C2-E04A-4CE9-81FD-6610D8F87E30}" destId="{4F8EA2C4-D16C-430F-BDE7-8934CC478EE4}"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BA44DDC-56A1-4957-8361-8B2CC232F3D2}" type="doc">
      <dgm:prSet loTypeId="urn:microsoft.com/office/officeart/2008/layout/LinedList" loCatId="list" qsTypeId="urn:microsoft.com/office/officeart/2005/8/quickstyle/simple2" qsCatId="simple" csTypeId="urn:microsoft.com/office/officeart/2005/8/colors/colorful5" csCatId="colorful" phldr="1"/>
      <dgm:spPr/>
      <dgm:t>
        <a:bodyPr/>
        <a:lstStyle/>
        <a:p>
          <a:endParaRPr lang="en-US"/>
        </a:p>
      </dgm:t>
    </dgm:pt>
    <dgm:pt modelId="{7B9B671C-DBDB-4E3E-8BA4-9EB44367D839}">
      <dgm:prSet phldr="0"/>
      <dgm:spPr/>
      <dgm:t>
        <a:bodyPr/>
        <a:lstStyle/>
        <a:p>
          <a:pPr rtl="0"/>
          <a:r>
            <a:rPr lang="en-US">
              <a:latin typeface="Calibri Light" panose="020F0302020204030204"/>
            </a:rPr>
            <a:t>What have you seen?</a:t>
          </a:r>
          <a:endParaRPr lang="en-US"/>
        </a:p>
      </dgm:t>
    </dgm:pt>
    <dgm:pt modelId="{60171399-700D-4821-AD30-6776D74A1F98}" type="parTrans" cxnId="{BC1D2F63-7EBA-49E0-BF79-4E0EB3F0CC87}">
      <dgm:prSet/>
      <dgm:spPr/>
    </dgm:pt>
    <dgm:pt modelId="{08A57DBB-43A9-4A07-BCEE-3B408E88A4C9}" type="sibTrans" cxnId="{BC1D2F63-7EBA-49E0-BF79-4E0EB3F0CC87}">
      <dgm:prSet/>
      <dgm:spPr/>
      <dgm:t>
        <a:bodyPr/>
        <a:lstStyle/>
        <a:p>
          <a:endParaRPr lang="en-US"/>
        </a:p>
      </dgm:t>
    </dgm:pt>
    <dgm:pt modelId="{61289203-7349-47C2-8077-B69F1033236A}">
      <dgm:prSet phldr="0"/>
      <dgm:spPr/>
      <dgm:t>
        <a:bodyPr/>
        <a:lstStyle/>
        <a:p>
          <a:endParaRPr lang="en-US">
            <a:latin typeface="Calibri Light" panose="020F0302020204030204"/>
          </a:endParaRPr>
        </a:p>
      </dgm:t>
    </dgm:pt>
    <dgm:pt modelId="{56D195E9-5312-4E74-A7EC-A48AF5168085}" type="parTrans" cxnId="{2E1BDAE7-14F2-4446-AD4B-EF06F61DA320}">
      <dgm:prSet/>
      <dgm:spPr/>
    </dgm:pt>
    <dgm:pt modelId="{B8CBAD3A-50E1-4C2D-8713-B405010A0286}" type="sibTrans" cxnId="{2E1BDAE7-14F2-4446-AD4B-EF06F61DA320}">
      <dgm:prSet/>
      <dgm:spPr/>
    </dgm:pt>
    <dgm:pt modelId="{78199A00-63F9-4BDC-B434-8DBFA4B197CE}" type="pres">
      <dgm:prSet presAssocID="{5BA44DDC-56A1-4957-8361-8B2CC232F3D2}" presName="vert0" presStyleCnt="0">
        <dgm:presLayoutVars>
          <dgm:dir/>
          <dgm:animOne val="branch"/>
          <dgm:animLvl val="lvl"/>
        </dgm:presLayoutVars>
      </dgm:prSet>
      <dgm:spPr/>
    </dgm:pt>
    <dgm:pt modelId="{D8F75BC9-9096-4F94-AEB8-ED8720D769BC}" type="pres">
      <dgm:prSet presAssocID="{7B9B671C-DBDB-4E3E-8BA4-9EB44367D839}" presName="thickLine" presStyleLbl="alignNode1" presStyleIdx="0" presStyleCnt="2"/>
      <dgm:spPr/>
    </dgm:pt>
    <dgm:pt modelId="{741F1B3D-63C4-4187-9203-7BC73ED4E45A}" type="pres">
      <dgm:prSet presAssocID="{7B9B671C-DBDB-4E3E-8BA4-9EB44367D839}" presName="horz1" presStyleCnt="0"/>
      <dgm:spPr/>
    </dgm:pt>
    <dgm:pt modelId="{C919A526-4EAD-4CA5-BE7D-60D327582A36}" type="pres">
      <dgm:prSet presAssocID="{7B9B671C-DBDB-4E3E-8BA4-9EB44367D839}" presName="tx1" presStyleLbl="revTx" presStyleIdx="0" presStyleCnt="2"/>
      <dgm:spPr/>
    </dgm:pt>
    <dgm:pt modelId="{5F70A007-B45E-471A-93E0-38A30A19473D}" type="pres">
      <dgm:prSet presAssocID="{7B9B671C-DBDB-4E3E-8BA4-9EB44367D839}" presName="vert1" presStyleCnt="0"/>
      <dgm:spPr/>
    </dgm:pt>
    <dgm:pt modelId="{7668BD6D-E267-4E93-9E99-B7A02DC5214E}" type="pres">
      <dgm:prSet presAssocID="{61289203-7349-47C2-8077-B69F1033236A}" presName="thickLine" presStyleLbl="alignNode1" presStyleIdx="1" presStyleCnt="2"/>
      <dgm:spPr/>
    </dgm:pt>
    <dgm:pt modelId="{700234BB-EB54-4D71-991E-AEE47FD4AED3}" type="pres">
      <dgm:prSet presAssocID="{61289203-7349-47C2-8077-B69F1033236A}" presName="horz1" presStyleCnt="0"/>
      <dgm:spPr/>
    </dgm:pt>
    <dgm:pt modelId="{A89D1EE6-5504-4301-A1AA-4A8B42F63A98}" type="pres">
      <dgm:prSet presAssocID="{61289203-7349-47C2-8077-B69F1033236A}" presName="tx1" presStyleLbl="revTx" presStyleIdx="1" presStyleCnt="2"/>
      <dgm:spPr/>
    </dgm:pt>
    <dgm:pt modelId="{943CE464-1675-450C-8A6A-0B25D703698F}" type="pres">
      <dgm:prSet presAssocID="{61289203-7349-47C2-8077-B69F1033236A}" presName="vert1" presStyleCnt="0"/>
      <dgm:spPr/>
    </dgm:pt>
  </dgm:ptLst>
  <dgm:cxnLst>
    <dgm:cxn modelId="{95438D25-622C-44EE-9F0C-FECDFE46E3C3}" type="presOf" srcId="{5BA44DDC-56A1-4957-8361-8B2CC232F3D2}" destId="{78199A00-63F9-4BDC-B434-8DBFA4B197CE}" srcOrd="0" destOrd="0" presId="urn:microsoft.com/office/officeart/2008/layout/LinedList"/>
    <dgm:cxn modelId="{BC1D2F63-7EBA-49E0-BF79-4E0EB3F0CC87}" srcId="{5BA44DDC-56A1-4957-8361-8B2CC232F3D2}" destId="{7B9B671C-DBDB-4E3E-8BA4-9EB44367D839}" srcOrd="0" destOrd="0" parTransId="{60171399-700D-4821-AD30-6776D74A1F98}" sibTransId="{08A57DBB-43A9-4A07-BCEE-3B408E88A4C9}"/>
    <dgm:cxn modelId="{94A7CA53-BA82-4112-AD9A-1D1A95D42EBE}" type="presOf" srcId="{61289203-7349-47C2-8077-B69F1033236A}" destId="{A89D1EE6-5504-4301-A1AA-4A8B42F63A98}" srcOrd="0" destOrd="0" presId="urn:microsoft.com/office/officeart/2008/layout/LinedList"/>
    <dgm:cxn modelId="{05D2E096-ED95-485D-A911-56F6E11482FC}" type="presOf" srcId="{7B9B671C-DBDB-4E3E-8BA4-9EB44367D839}" destId="{C919A526-4EAD-4CA5-BE7D-60D327582A36}" srcOrd="0" destOrd="0" presId="urn:microsoft.com/office/officeart/2008/layout/LinedList"/>
    <dgm:cxn modelId="{2E1BDAE7-14F2-4446-AD4B-EF06F61DA320}" srcId="{5BA44DDC-56A1-4957-8361-8B2CC232F3D2}" destId="{61289203-7349-47C2-8077-B69F1033236A}" srcOrd="1" destOrd="0" parTransId="{56D195E9-5312-4E74-A7EC-A48AF5168085}" sibTransId="{B8CBAD3A-50E1-4C2D-8713-B405010A0286}"/>
    <dgm:cxn modelId="{8E6B280C-8C78-4686-B118-F026499599CA}" type="presParOf" srcId="{78199A00-63F9-4BDC-B434-8DBFA4B197CE}" destId="{D8F75BC9-9096-4F94-AEB8-ED8720D769BC}" srcOrd="0" destOrd="0" presId="urn:microsoft.com/office/officeart/2008/layout/LinedList"/>
    <dgm:cxn modelId="{2238CDB2-FE3B-49AA-8D64-3A79CF38C334}" type="presParOf" srcId="{78199A00-63F9-4BDC-B434-8DBFA4B197CE}" destId="{741F1B3D-63C4-4187-9203-7BC73ED4E45A}" srcOrd="1" destOrd="0" presId="urn:microsoft.com/office/officeart/2008/layout/LinedList"/>
    <dgm:cxn modelId="{2DB9011D-DCEC-4C09-BCB6-92A3C3079F91}" type="presParOf" srcId="{741F1B3D-63C4-4187-9203-7BC73ED4E45A}" destId="{C919A526-4EAD-4CA5-BE7D-60D327582A36}" srcOrd="0" destOrd="0" presId="urn:microsoft.com/office/officeart/2008/layout/LinedList"/>
    <dgm:cxn modelId="{CE31123A-6527-43BF-8DD9-645E4D9D7F05}" type="presParOf" srcId="{741F1B3D-63C4-4187-9203-7BC73ED4E45A}" destId="{5F70A007-B45E-471A-93E0-38A30A19473D}" srcOrd="1" destOrd="0" presId="urn:microsoft.com/office/officeart/2008/layout/LinedList"/>
    <dgm:cxn modelId="{5A615747-089E-409A-9988-FDCC6D470F2D}" type="presParOf" srcId="{78199A00-63F9-4BDC-B434-8DBFA4B197CE}" destId="{7668BD6D-E267-4E93-9E99-B7A02DC5214E}" srcOrd="2" destOrd="0" presId="urn:microsoft.com/office/officeart/2008/layout/LinedList"/>
    <dgm:cxn modelId="{3CFB3D05-5E9B-4CD9-939C-B73F179109FD}" type="presParOf" srcId="{78199A00-63F9-4BDC-B434-8DBFA4B197CE}" destId="{700234BB-EB54-4D71-991E-AEE47FD4AED3}" srcOrd="3" destOrd="0" presId="urn:microsoft.com/office/officeart/2008/layout/LinedList"/>
    <dgm:cxn modelId="{005D50B4-241E-4267-8742-CDCE97FE414D}" type="presParOf" srcId="{700234BB-EB54-4D71-991E-AEE47FD4AED3}" destId="{A89D1EE6-5504-4301-A1AA-4A8B42F63A98}" srcOrd="0" destOrd="0" presId="urn:microsoft.com/office/officeart/2008/layout/LinedList"/>
    <dgm:cxn modelId="{3FC52020-981A-4330-AE52-108773C0B5E9}" type="presParOf" srcId="{700234BB-EB54-4D71-991E-AEE47FD4AED3}" destId="{943CE464-1675-450C-8A6A-0B25D703698F}"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5BA44DDC-56A1-4957-8361-8B2CC232F3D2}" type="doc">
      <dgm:prSet loTypeId="urn:microsoft.com/office/officeart/2008/layout/LinedList" loCatId="list" qsTypeId="urn:microsoft.com/office/officeart/2005/8/quickstyle/simple1" qsCatId="simple" csTypeId="urn:microsoft.com/office/officeart/2005/8/colors/colorful5" csCatId="colorful" phldr="1"/>
      <dgm:spPr/>
      <dgm:t>
        <a:bodyPr/>
        <a:lstStyle/>
        <a:p>
          <a:endParaRPr lang="en-US"/>
        </a:p>
      </dgm:t>
    </dgm:pt>
    <dgm:pt modelId="{4AAD5682-305A-4176-885B-F9E42F88200E}">
      <dgm:prSet/>
      <dgm:spPr/>
      <dgm:t>
        <a:bodyPr/>
        <a:lstStyle/>
        <a:p>
          <a:pPr rtl="0"/>
          <a:r>
            <a:rPr lang="en-US" b="0" dirty="0">
              <a:latin typeface="Calibri"/>
              <a:ea typeface="Calibri"/>
              <a:cs typeface="Calibri"/>
            </a:rPr>
            <a:t>Sponsor GME - How to report</a:t>
          </a:r>
        </a:p>
      </dgm:t>
    </dgm:pt>
    <dgm:pt modelId="{0C93F693-B375-4B72-9D5F-0EADCA914128}" type="parTrans" cxnId="{7F2327C3-09F3-43EA-B0FD-49AA8B31888B}">
      <dgm:prSet/>
      <dgm:spPr/>
      <dgm:t>
        <a:bodyPr/>
        <a:lstStyle/>
        <a:p>
          <a:endParaRPr lang="en-US"/>
        </a:p>
      </dgm:t>
    </dgm:pt>
    <dgm:pt modelId="{B00B0479-8A2E-4EFF-AB2B-24E38B5855AE}" type="sibTrans" cxnId="{7F2327C3-09F3-43EA-B0FD-49AA8B31888B}">
      <dgm:prSet/>
      <dgm:spPr/>
      <dgm:t>
        <a:bodyPr/>
        <a:lstStyle/>
        <a:p>
          <a:endParaRPr lang="en-US"/>
        </a:p>
      </dgm:t>
    </dgm:pt>
    <dgm:pt modelId="{E31DB772-F974-4422-B871-1DF29E6BA238}">
      <dgm:prSet/>
      <dgm:spPr/>
      <dgm:t>
        <a:bodyPr/>
        <a:lstStyle/>
        <a:p>
          <a:pPr rtl="0"/>
          <a:r>
            <a:rPr lang="en-US" b="0" dirty="0">
              <a:latin typeface="Calibri"/>
              <a:ea typeface="Calibri"/>
              <a:cs typeface="Calibri"/>
            </a:rPr>
            <a:t>Primary outpatient site - </a:t>
          </a:r>
          <a:r>
            <a:rPr lang="en-US" b="0" dirty="0">
              <a:latin typeface="Calibri"/>
              <a:cs typeface="Calibri"/>
            </a:rPr>
            <a:t>How to report</a:t>
          </a:r>
        </a:p>
      </dgm:t>
    </dgm:pt>
    <dgm:pt modelId="{A0A87C7E-A6FA-4F8F-AE27-25B570B9DD0A}" type="parTrans" cxnId="{B0D97B8D-4711-4EB2-842B-03EA1C30DD0E}">
      <dgm:prSet/>
      <dgm:spPr/>
      <dgm:t>
        <a:bodyPr/>
        <a:lstStyle/>
        <a:p>
          <a:endParaRPr lang="en-US"/>
        </a:p>
      </dgm:t>
    </dgm:pt>
    <dgm:pt modelId="{1BCC2AC2-CCFC-4AB1-A4D5-C7EA0782FD39}" type="sibTrans" cxnId="{B0D97B8D-4711-4EB2-842B-03EA1C30DD0E}">
      <dgm:prSet/>
      <dgm:spPr/>
      <dgm:t>
        <a:bodyPr/>
        <a:lstStyle/>
        <a:p>
          <a:endParaRPr lang="en-US"/>
        </a:p>
      </dgm:t>
    </dgm:pt>
    <dgm:pt modelId="{218ABB54-6DE5-4B95-9A7C-4770B8364B03}">
      <dgm:prSet/>
      <dgm:spPr/>
      <dgm:t>
        <a:bodyPr/>
        <a:lstStyle/>
        <a:p>
          <a:pPr rtl="0"/>
          <a:r>
            <a:rPr lang="en-US" b="0" dirty="0">
              <a:latin typeface="Calibri"/>
              <a:ea typeface="Calibri"/>
              <a:cs typeface="Calibri"/>
            </a:rPr>
            <a:t>Primary inpatient institution– How to report</a:t>
          </a:r>
        </a:p>
      </dgm:t>
    </dgm:pt>
    <dgm:pt modelId="{48E1CE32-38C3-4FA5-A950-A375CB9B4F26}" type="parTrans" cxnId="{0FD8D3E9-7D50-4019-A098-00B3E8E35FB1}">
      <dgm:prSet/>
      <dgm:spPr/>
      <dgm:t>
        <a:bodyPr/>
        <a:lstStyle/>
        <a:p>
          <a:endParaRPr lang="en-US"/>
        </a:p>
      </dgm:t>
    </dgm:pt>
    <dgm:pt modelId="{3D9B4934-46C7-4E9A-A8AD-E31AB113E8AD}" type="sibTrans" cxnId="{0FD8D3E9-7D50-4019-A098-00B3E8E35FB1}">
      <dgm:prSet/>
      <dgm:spPr/>
      <dgm:t>
        <a:bodyPr/>
        <a:lstStyle/>
        <a:p>
          <a:endParaRPr lang="en-US"/>
        </a:p>
      </dgm:t>
    </dgm:pt>
    <dgm:pt modelId="{5F7211F6-8DD2-4D0E-82A9-21EF8D0382EA}">
      <dgm:prSet/>
      <dgm:spPr/>
      <dgm:t>
        <a:bodyPr/>
        <a:lstStyle/>
        <a:p>
          <a:pPr rtl="0"/>
          <a:r>
            <a:rPr lang="en-US" b="0" dirty="0">
              <a:latin typeface="Calibri"/>
              <a:ea typeface="Calibri"/>
              <a:cs typeface="Calibri"/>
            </a:rPr>
            <a:t>Primary</a:t>
          </a:r>
          <a:r>
            <a:rPr lang="en-US" b="0" dirty="0">
              <a:latin typeface="Calibri"/>
              <a:ea typeface="Calibri"/>
              <a:cs typeface="Calibri Light"/>
            </a:rPr>
            <a:t> pediatric institution – How to </a:t>
          </a:r>
          <a:r>
            <a:rPr lang="en-US" b="0" dirty="0">
              <a:latin typeface="Calibri"/>
              <a:cs typeface="Calibri"/>
            </a:rPr>
            <a:t>report</a:t>
          </a:r>
          <a:endParaRPr lang="en-US" b="0" dirty="0">
            <a:latin typeface="Calibri"/>
            <a:ea typeface="Calibri"/>
            <a:cs typeface="Calibri"/>
          </a:endParaRPr>
        </a:p>
      </dgm:t>
    </dgm:pt>
    <dgm:pt modelId="{7E3D3BE6-1224-43CB-82AD-7D1E9E17FA1E}" type="parTrans" cxnId="{12DAD35B-02A3-4978-B418-DCA410DC234B}">
      <dgm:prSet/>
      <dgm:spPr/>
      <dgm:t>
        <a:bodyPr/>
        <a:lstStyle/>
        <a:p>
          <a:endParaRPr lang="en-US"/>
        </a:p>
      </dgm:t>
    </dgm:pt>
    <dgm:pt modelId="{B7736570-D9D8-4A4A-8B7A-7479FC64DA7B}" type="sibTrans" cxnId="{12DAD35B-02A3-4978-B418-DCA410DC234B}">
      <dgm:prSet/>
      <dgm:spPr/>
      <dgm:t>
        <a:bodyPr/>
        <a:lstStyle/>
        <a:p>
          <a:endParaRPr lang="en-US"/>
        </a:p>
      </dgm:t>
    </dgm:pt>
    <dgm:pt modelId="{E48F3AF4-4873-4426-806A-6A2EF61B6BA5}">
      <dgm:prSet phldr="0"/>
      <dgm:spPr/>
      <dgm:t>
        <a:bodyPr/>
        <a:lstStyle/>
        <a:p>
          <a:r>
            <a:rPr lang="en-US" b="0" dirty="0">
              <a:latin typeface="Calibri"/>
              <a:ea typeface="Calibri"/>
              <a:cs typeface="Calibri"/>
            </a:rPr>
            <a:t>Incident reports can be done anonymously, are protected (do not reference in patient chart)</a:t>
          </a:r>
        </a:p>
      </dgm:t>
    </dgm:pt>
    <dgm:pt modelId="{92644222-0954-4216-B039-D2FCDAFFE1A9}" type="parTrans" cxnId="{F7A1D197-DE9A-477D-82C8-BC8023ADA7A6}">
      <dgm:prSet/>
      <dgm:spPr/>
    </dgm:pt>
    <dgm:pt modelId="{D7B3BA6C-0A71-4D03-BE5C-28E63216C73C}" type="sibTrans" cxnId="{F7A1D197-DE9A-477D-82C8-BC8023ADA7A6}">
      <dgm:prSet/>
      <dgm:spPr/>
    </dgm:pt>
    <dgm:pt modelId="{E8B38D10-2D93-4EF0-A5E8-4822D04955D8}" type="pres">
      <dgm:prSet presAssocID="{5BA44DDC-56A1-4957-8361-8B2CC232F3D2}" presName="vert0" presStyleCnt="0">
        <dgm:presLayoutVars>
          <dgm:dir/>
          <dgm:animOne val="branch"/>
          <dgm:animLvl val="lvl"/>
        </dgm:presLayoutVars>
      </dgm:prSet>
      <dgm:spPr/>
    </dgm:pt>
    <dgm:pt modelId="{842955AE-E913-4A45-A703-0CA7A0316939}" type="pres">
      <dgm:prSet presAssocID="{4AAD5682-305A-4176-885B-F9E42F88200E}" presName="thickLine" presStyleLbl="alignNode1" presStyleIdx="0" presStyleCnt="5"/>
      <dgm:spPr/>
    </dgm:pt>
    <dgm:pt modelId="{4993EF49-3C67-4503-B21D-DE5B06427FEE}" type="pres">
      <dgm:prSet presAssocID="{4AAD5682-305A-4176-885B-F9E42F88200E}" presName="horz1" presStyleCnt="0"/>
      <dgm:spPr/>
    </dgm:pt>
    <dgm:pt modelId="{7307591E-B974-4DBE-9419-D5D86BD75427}" type="pres">
      <dgm:prSet presAssocID="{4AAD5682-305A-4176-885B-F9E42F88200E}" presName="tx1" presStyleLbl="revTx" presStyleIdx="0" presStyleCnt="5"/>
      <dgm:spPr/>
    </dgm:pt>
    <dgm:pt modelId="{2FD1AD35-B597-48E5-BCA7-CDF69E67A56C}" type="pres">
      <dgm:prSet presAssocID="{4AAD5682-305A-4176-885B-F9E42F88200E}" presName="vert1" presStyleCnt="0"/>
      <dgm:spPr/>
    </dgm:pt>
    <dgm:pt modelId="{3B751C5B-3B19-41C2-936E-B2B4922BE227}" type="pres">
      <dgm:prSet presAssocID="{E31DB772-F974-4422-B871-1DF29E6BA238}" presName="thickLine" presStyleLbl="alignNode1" presStyleIdx="1" presStyleCnt="5"/>
      <dgm:spPr/>
    </dgm:pt>
    <dgm:pt modelId="{6193C4F4-873C-42F0-964A-5094395F215A}" type="pres">
      <dgm:prSet presAssocID="{E31DB772-F974-4422-B871-1DF29E6BA238}" presName="horz1" presStyleCnt="0"/>
      <dgm:spPr/>
    </dgm:pt>
    <dgm:pt modelId="{ED5D68C3-DBC5-4B69-996F-77E67BB42D54}" type="pres">
      <dgm:prSet presAssocID="{E31DB772-F974-4422-B871-1DF29E6BA238}" presName="tx1" presStyleLbl="revTx" presStyleIdx="1" presStyleCnt="5"/>
      <dgm:spPr/>
    </dgm:pt>
    <dgm:pt modelId="{CB0180B0-91A9-48B8-A223-6A3332297281}" type="pres">
      <dgm:prSet presAssocID="{E31DB772-F974-4422-B871-1DF29E6BA238}" presName="vert1" presStyleCnt="0"/>
      <dgm:spPr/>
    </dgm:pt>
    <dgm:pt modelId="{0B1175B9-A81F-4AB2-B107-AD14FE4C3724}" type="pres">
      <dgm:prSet presAssocID="{218ABB54-6DE5-4B95-9A7C-4770B8364B03}" presName="thickLine" presStyleLbl="alignNode1" presStyleIdx="2" presStyleCnt="5"/>
      <dgm:spPr/>
    </dgm:pt>
    <dgm:pt modelId="{E15316E1-1E97-4F5A-A1FD-2DAA72822417}" type="pres">
      <dgm:prSet presAssocID="{218ABB54-6DE5-4B95-9A7C-4770B8364B03}" presName="horz1" presStyleCnt="0"/>
      <dgm:spPr/>
    </dgm:pt>
    <dgm:pt modelId="{24EC08AB-1952-48C8-BE2F-F755AE2A4B33}" type="pres">
      <dgm:prSet presAssocID="{218ABB54-6DE5-4B95-9A7C-4770B8364B03}" presName="tx1" presStyleLbl="revTx" presStyleIdx="2" presStyleCnt="5"/>
      <dgm:spPr/>
    </dgm:pt>
    <dgm:pt modelId="{62D60CDF-E7ED-497B-BA45-BCE85ED4B2A5}" type="pres">
      <dgm:prSet presAssocID="{218ABB54-6DE5-4B95-9A7C-4770B8364B03}" presName="vert1" presStyleCnt="0"/>
      <dgm:spPr/>
    </dgm:pt>
    <dgm:pt modelId="{79864414-BF9E-4764-AFC7-2ABAF5E1ADC3}" type="pres">
      <dgm:prSet presAssocID="{5F7211F6-8DD2-4D0E-82A9-21EF8D0382EA}" presName="thickLine" presStyleLbl="alignNode1" presStyleIdx="3" presStyleCnt="5"/>
      <dgm:spPr/>
    </dgm:pt>
    <dgm:pt modelId="{EFBA7491-63A3-4824-9D4C-7383AFBBBFC1}" type="pres">
      <dgm:prSet presAssocID="{5F7211F6-8DD2-4D0E-82A9-21EF8D0382EA}" presName="horz1" presStyleCnt="0"/>
      <dgm:spPr/>
    </dgm:pt>
    <dgm:pt modelId="{D7E539DB-66E1-4C12-B40E-5544C5A90A39}" type="pres">
      <dgm:prSet presAssocID="{5F7211F6-8DD2-4D0E-82A9-21EF8D0382EA}" presName="tx1" presStyleLbl="revTx" presStyleIdx="3" presStyleCnt="5"/>
      <dgm:spPr/>
    </dgm:pt>
    <dgm:pt modelId="{FB2CDEF1-9937-4203-8E1E-DD366A34BC6F}" type="pres">
      <dgm:prSet presAssocID="{5F7211F6-8DD2-4D0E-82A9-21EF8D0382EA}" presName="vert1" presStyleCnt="0"/>
      <dgm:spPr/>
    </dgm:pt>
    <dgm:pt modelId="{19175116-D959-4D13-84C1-BCFC06B73E39}" type="pres">
      <dgm:prSet presAssocID="{E48F3AF4-4873-4426-806A-6A2EF61B6BA5}" presName="thickLine" presStyleLbl="alignNode1" presStyleIdx="4" presStyleCnt="5"/>
      <dgm:spPr/>
    </dgm:pt>
    <dgm:pt modelId="{484F4183-8501-4CD8-98D1-724472E32B71}" type="pres">
      <dgm:prSet presAssocID="{E48F3AF4-4873-4426-806A-6A2EF61B6BA5}" presName="horz1" presStyleCnt="0"/>
      <dgm:spPr/>
    </dgm:pt>
    <dgm:pt modelId="{643583C5-090A-4BAE-ADFF-107AADFE0294}" type="pres">
      <dgm:prSet presAssocID="{E48F3AF4-4873-4426-806A-6A2EF61B6BA5}" presName="tx1" presStyleLbl="revTx" presStyleIdx="4" presStyleCnt="5"/>
      <dgm:spPr/>
    </dgm:pt>
    <dgm:pt modelId="{9C1FB9CB-8650-46CD-B132-6B6CD2C71755}" type="pres">
      <dgm:prSet presAssocID="{E48F3AF4-4873-4426-806A-6A2EF61B6BA5}" presName="vert1" presStyleCnt="0"/>
      <dgm:spPr/>
    </dgm:pt>
  </dgm:ptLst>
  <dgm:cxnLst>
    <dgm:cxn modelId="{091DF111-997E-4E7D-8080-FF1C676BD8F7}" type="presOf" srcId="{218ABB54-6DE5-4B95-9A7C-4770B8364B03}" destId="{24EC08AB-1952-48C8-BE2F-F755AE2A4B33}" srcOrd="0" destOrd="0" presId="urn:microsoft.com/office/officeart/2008/layout/LinedList"/>
    <dgm:cxn modelId="{4F69392E-4E9E-44A0-9B24-1ED683112CA3}" type="presOf" srcId="{5F7211F6-8DD2-4D0E-82A9-21EF8D0382EA}" destId="{D7E539DB-66E1-4C12-B40E-5544C5A90A39}" srcOrd="0" destOrd="0" presId="urn:microsoft.com/office/officeart/2008/layout/LinedList"/>
    <dgm:cxn modelId="{40901935-27D6-4B82-A8E8-07A60EA4B797}" type="presOf" srcId="{5BA44DDC-56A1-4957-8361-8B2CC232F3D2}" destId="{E8B38D10-2D93-4EF0-A5E8-4822D04955D8}" srcOrd="0" destOrd="0" presId="urn:microsoft.com/office/officeart/2008/layout/LinedList"/>
    <dgm:cxn modelId="{12DAD35B-02A3-4978-B418-DCA410DC234B}" srcId="{5BA44DDC-56A1-4957-8361-8B2CC232F3D2}" destId="{5F7211F6-8DD2-4D0E-82A9-21EF8D0382EA}" srcOrd="3" destOrd="0" parTransId="{7E3D3BE6-1224-43CB-82AD-7D1E9E17FA1E}" sibTransId="{B7736570-D9D8-4A4A-8B7A-7479FC64DA7B}"/>
    <dgm:cxn modelId="{ECCB7B4B-A1DC-4259-881A-949ED983BF5C}" type="presOf" srcId="{E48F3AF4-4873-4426-806A-6A2EF61B6BA5}" destId="{643583C5-090A-4BAE-ADFF-107AADFE0294}" srcOrd="0" destOrd="0" presId="urn:microsoft.com/office/officeart/2008/layout/LinedList"/>
    <dgm:cxn modelId="{55450E6C-1493-41B5-BB4A-7B8E25D8DFD2}" type="presOf" srcId="{4AAD5682-305A-4176-885B-F9E42F88200E}" destId="{7307591E-B974-4DBE-9419-D5D86BD75427}" srcOrd="0" destOrd="0" presId="urn:microsoft.com/office/officeart/2008/layout/LinedList"/>
    <dgm:cxn modelId="{B0D97B8D-4711-4EB2-842B-03EA1C30DD0E}" srcId="{5BA44DDC-56A1-4957-8361-8B2CC232F3D2}" destId="{E31DB772-F974-4422-B871-1DF29E6BA238}" srcOrd="1" destOrd="0" parTransId="{A0A87C7E-A6FA-4F8F-AE27-25B570B9DD0A}" sibTransId="{1BCC2AC2-CCFC-4AB1-A4D5-C7EA0782FD39}"/>
    <dgm:cxn modelId="{F7A1D197-DE9A-477D-82C8-BC8023ADA7A6}" srcId="{5BA44DDC-56A1-4957-8361-8B2CC232F3D2}" destId="{E48F3AF4-4873-4426-806A-6A2EF61B6BA5}" srcOrd="4" destOrd="0" parTransId="{92644222-0954-4216-B039-D2FCDAFFE1A9}" sibTransId="{D7B3BA6C-0A71-4D03-BE5C-28E63216C73C}"/>
    <dgm:cxn modelId="{7F2327C3-09F3-43EA-B0FD-49AA8B31888B}" srcId="{5BA44DDC-56A1-4957-8361-8B2CC232F3D2}" destId="{4AAD5682-305A-4176-885B-F9E42F88200E}" srcOrd="0" destOrd="0" parTransId="{0C93F693-B375-4B72-9D5F-0EADCA914128}" sibTransId="{B00B0479-8A2E-4EFF-AB2B-24E38B5855AE}"/>
    <dgm:cxn modelId="{711B62D4-A47C-47BF-B319-BE0528B7A80C}" type="presOf" srcId="{E31DB772-F974-4422-B871-1DF29E6BA238}" destId="{ED5D68C3-DBC5-4B69-996F-77E67BB42D54}" srcOrd="0" destOrd="0" presId="urn:microsoft.com/office/officeart/2008/layout/LinedList"/>
    <dgm:cxn modelId="{0FD8D3E9-7D50-4019-A098-00B3E8E35FB1}" srcId="{5BA44DDC-56A1-4957-8361-8B2CC232F3D2}" destId="{218ABB54-6DE5-4B95-9A7C-4770B8364B03}" srcOrd="2" destOrd="0" parTransId="{48E1CE32-38C3-4FA5-A950-A375CB9B4F26}" sibTransId="{3D9B4934-46C7-4E9A-A8AD-E31AB113E8AD}"/>
    <dgm:cxn modelId="{E03B4269-0CC6-4D23-9BB5-8DF46E6A6621}" type="presParOf" srcId="{E8B38D10-2D93-4EF0-A5E8-4822D04955D8}" destId="{842955AE-E913-4A45-A703-0CA7A0316939}" srcOrd="0" destOrd="0" presId="urn:microsoft.com/office/officeart/2008/layout/LinedList"/>
    <dgm:cxn modelId="{6022E43C-E0D2-47C5-BFCC-9B961EB154D5}" type="presParOf" srcId="{E8B38D10-2D93-4EF0-A5E8-4822D04955D8}" destId="{4993EF49-3C67-4503-B21D-DE5B06427FEE}" srcOrd="1" destOrd="0" presId="urn:microsoft.com/office/officeart/2008/layout/LinedList"/>
    <dgm:cxn modelId="{32C9DA03-E6DD-49DE-95FC-28E3155662D6}" type="presParOf" srcId="{4993EF49-3C67-4503-B21D-DE5B06427FEE}" destId="{7307591E-B974-4DBE-9419-D5D86BD75427}" srcOrd="0" destOrd="0" presId="urn:microsoft.com/office/officeart/2008/layout/LinedList"/>
    <dgm:cxn modelId="{38ECFDA9-B9A3-41A4-A7F5-590B8760FA4F}" type="presParOf" srcId="{4993EF49-3C67-4503-B21D-DE5B06427FEE}" destId="{2FD1AD35-B597-48E5-BCA7-CDF69E67A56C}" srcOrd="1" destOrd="0" presId="urn:microsoft.com/office/officeart/2008/layout/LinedList"/>
    <dgm:cxn modelId="{12C52FE4-B4D7-4FA1-A31B-3EF83B84090D}" type="presParOf" srcId="{E8B38D10-2D93-4EF0-A5E8-4822D04955D8}" destId="{3B751C5B-3B19-41C2-936E-B2B4922BE227}" srcOrd="2" destOrd="0" presId="urn:microsoft.com/office/officeart/2008/layout/LinedList"/>
    <dgm:cxn modelId="{3349C5E3-ED22-4C59-B7EE-3B7207D99666}" type="presParOf" srcId="{E8B38D10-2D93-4EF0-A5E8-4822D04955D8}" destId="{6193C4F4-873C-42F0-964A-5094395F215A}" srcOrd="3" destOrd="0" presId="urn:microsoft.com/office/officeart/2008/layout/LinedList"/>
    <dgm:cxn modelId="{3E615C29-F218-44C7-9846-F7F8A6C93FF7}" type="presParOf" srcId="{6193C4F4-873C-42F0-964A-5094395F215A}" destId="{ED5D68C3-DBC5-4B69-996F-77E67BB42D54}" srcOrd="0" destOrd="0" presId="urn:microsoft.com/office/officeart/2008/layout/LinedList"/>
    <dgm:cxn modelId="{7A0A9461-E4EA-4515-B7D7-173777FE821B}" type="presParOf" srcId="{6193C4F4-873C-42F0-964A-5094395F215A}" destId="{CB0180B0-91A9-48B8-A223-6A3332297281}" srcOrd="1" destOrd="0" presId="urn:microsoft.com/office/officeart/2008/layout/LinedList"/>
    <dgm:cxn modelId="{BC2A05AE-0045-4B06-A9CF-8BD63EAA17E2}" type="presParOf" srcId="{E8B38D10-2D93-4EF0-A5E8-4822D04955D8}" destId="{0B1175B9-A81F-4AB2-B107-AD14FE4C3724}" srcOrd="4" destOrd="0" presId="urn:microsoft.com/office/officeart/2008/layout/LinedList"/>
    <dgm:cxn modelId="{B6E9E09C-9E0C-400B-A469-29F8BF2C8C83}" type="presParOf" srcId="{E8B38D10-2D93-4EF0-A5E8-4822D04955D8}" destId="{E15316E1-1E97-4F5A-A1FD-2DAA72822417}" srcOrd="5" destOrd="0" presId="urn:microsoft.com/office/officeart/2008/layout/LinedList"/>
    <dgm:cxn modelId="{AD1886B7-3B1C-4616-ACF0-4B8F15276EAA}" type="presParOf" srcId="{E15316E1-1E97-4F5A-A1FD-2DAA72822417}" destId="{24EC08AB-1952-48C8-BE2F-F755AE2A4B33}" srcOrd="0" destOrd="0" presId="urn:microsoft.com/office/officeart/2008/layout/LinedList"/>
    <dgm:cxn modelId="{FD03C187-7983-49E5-862D-79222AED5B40}" type="presParOf" srcId="{E15316E1-1E97-4F5A-A1FD-2DAA72822417}" destId="{62D60CDF-E7ED-497B-BA45-BCE85ED4B2A5}" srcOrd="1" destOrd="0" presId="urn:microsoft.com/office/officeart/2008/layout/LinedList"/>
    <dgm:cxn modelId="{06C60FA0-6FF4-45CE-9ABF-A30760695F28}" type="presParOf" srcId="{E8B38D10-2D93-4EF0-A5E8-4822D04955D8}" destId="{79864414-BF9E-4764-AFC7-2ABAF5E1ADC3}" srcOrd="6" destOrd="0" presId="urn:microsoft.com/office/officeart/2008/layout/LinedList"/>
    <dgm:cxn modelId="{AD532F41-3040-47A1-9813-A9ADDE9252C1}" type="presParOf" srcId="{E8B38D10-2D93-4EF0-A5E8-4822D04955D8}" destId="{EFBA7491-63A3-4824-9D4C-7383AFBBBFC1}" srcOrd="7" destOrd="0" presId="urn:microsoft.com/office/officeart/2008/layout/LinedList"/>
    <dgm:cxn modelId="{8B54A372-5DF8-418D-8CE8-B956C19F436E}" type="presParOf" srcId="{EFBA7491-63A3-4824-9D4C-7383AFBBBFC1}" destId="{D7E539DB-66E1-4C12-B40E-5544C5A90A39}" srcOrd="0" destOrd="0" presId="urn:microsoft.com/office/officeart/2008/layout/LinedList"/>
    <dgm:cxn modelId="{AE174ECF-EE7A-4B77-883E-95A0E996DB22}" type="presParOf" srcId="{EFBA7491-63A3-4824-9D4C-7383AFBBBFC1}" destId="{FB2CDEF1-9937-4203-8E1E-DD366A34BC6F}" srcOrd="1" destOrd="0" presId="urn:microsoft.com/office/officeart/2008/layout/LinedList"/>
    <dgm:cxn modelId="{DB65034D-DCF6-41E3-8228-E70759866CE2}" type="presParOf" srcId="{E8B38D10-2D93-4EF0-A5E8-4822D04955D8}" destId="{19175116-D959-4D13-84C1-BCFC06B73E39}" srcOrd="8" destOrd="0" presId="urn:microsoft.com/office/officeart/2008/layout/LinedList"/>
    <dgm:cxn modelId="{DD89B797-72CE-440B-A4E3-9FC5BD3BC01B}" type="presParOf" srcId="{E8B38D10-2D93-4EF0-A5E8-4822D04955D8}" destId="{484F4183-8501-4CD8-98D1-724472E32B71}" srcOrd="9" destOrd="0" presId="urn:microsoft.com/office/officeart/2008/layout/LinedList"/>
    <dgm:cxn modelId="{0E868C4A-284F-4E50-9D5B-53B2CF4AB5AB}" type="presParOf" srcId="{484F4183-8501-4CD8-98D1-724472E32B71}" destId="{643583C5-090A-4BAE-ADFF-107AADFE0294}" srcOrd="0" destOrd="0" presId="urn:microsoft.com/office/officeart/2008/layout/LinedList"/>
    <dgm:cxn modelId="{B998BBAF-B4A0-4D4F-A30B-0008EAC29260}" type="presParOf" srcId="{484F4183-8501-4CD8-98D1-724472E32B71}" destId="{9C1FB9CB-8650-46CD-B132-6B6CD2C7175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BA465BEE-4C25-4252-92D7-ECE9FF77C333}" type="doc">
      <dgm:prSet loTypeId="urn:microsoft.com/office/officeart/2005/8/layout/vList2" loCatId="list" qsTypeId="urn:microsoft.com/office/officeart/2005/8/quickstyle/simple1" qsCatId="simple" csTypeId="urn:microsoft.com/office/officeart/2005/8/colors/colorful2" csCatId="colorful"/>
      <dgm:spPr/>
      <dgm:t>
        <a:bodyPr/>
        <a:lstStyle/>
        <a:p>
          <a:endParaRPr lang="en-US"/>
        </a:p>
      </dgm:t>
    </dgm:pt>
    <dgm:pt modelId="{0A5FF1F9-EDE4-48E6-8461-1B5C398B701A}">
      <dgm:prSet/>
      <dgm:spPr/>
      <dgm:t>
        <a:bodyPr/>
        <a:lstStyle/>
        <a:p>
          <a:r>
            <a:rPr lang="en-US"/>
            <a:t>chaos and accident response</a:t>
          </a:r>
        </a:p>
      </dgm:t>
    </dgm:pt>
    <dgm:pt modelId="{890D61B0-27F4-4F7A-97CB-73562707988B}" type="parTrans" cxnId="{2C8E6FC9-0E0E-4A78-BBB2-ABE91B2B80C7}">
      <dgm:prSet/>
      <dgm:spPr/>
      <dgm:t>
        <a:bodyPr/>
        <a:lstStyle/>
        <a:p>
          <a:endParaRPr lang="en-US"/>
        </a:p>
      </dgm:t>
    </dgm:pt>
    <dgm:pt modelId="{6FACE0F7-55CC-4D2F-AFCD-D443E92ED45A}" type="sibTrans" cxnId="{2C8E6FC9-0E0E-4A78-BBB2-ABE91B2B80C7}">
      <dgm:prSet/>
      <dgm:spPr/>
      <dgm:t>
        <a:bodyPr/>
        <a:lstStyle/>
        <a:p>
          <a:endParaRPr lang="en-US"/>
        </a:p>
      </dgm:t>
    </dgm:pt>
    <dgm:pt modelId="{EC4F842A-C57E-4D5F-A2F4-D3397E83EF2B}">
      <dgm:prSet/>
      <dgm:spPr/>
      <dgm:t>
        <a:bodyPr/>
        <a:lstStyle/>
        <a:p>
          <a:r>
            <a:rPr lang="en-US"/>
            <a:t>intrusive reflections</a:t>
          </a:r>
        </a:p>
      </dgm:t>
    </dgm:pt>
    <dgm:pt modelId="{A6F7242C-4CEA-45D7-9D54-086A561A15F7}" type="parTrans" cxnId="{C1B88906-5C89-478E-BEA1-BE39508BA218}">
      <dgm:prSet/>
      <dgm:spPr/>
      <dgm:t>
        <a:bodyPr/>
        <a:lstStyle/>
        <a:p>
          <a:endParaRPr lang="en-US"/>
        </a:p>
      </dgm:t>
    </dgm:pt>
    <dgm:pt modelId="{1EDE6851-D0F4-45D1-85CB-70469FEB42A4}" type="sibTrans" cxnId="{C1B88906-5C89-478E-BEA1-BE39508BA218}">
      <dgm:prSet/>
      <dgm:spPr/>
      <dgm:t>
        <a:bodyPr/>
        <a:lstStyle/>
        <a:p>
          <a:endParaRPr lang="en-US"/>
        </a:p>
      </dgm:t>
    </dgm:pt>
    <dgm:pt modelId="{9317634D-1178-45BB-A6C7-F1C2BDAEACDE}">
      <dgm:prSet/>
      <dgm:spPr/>
      <dgm:t>
        <a:bodyPr/>
        <a:lstStyle/>
        <a:p>
          <a:r>
            <a:rPr lang="en-US"/>
            <a:t>restoring personal integrity</a:t>
          </a:r>
        </a:p>
      </dgm:t>
    </dgm:pt>
    <dgm:pt modelId="{B59CCF6C-7062-4741-A54C-6B6D23C73E94}" type="parTrans" cxnId="{DF3460D0-B186-461B-87C5-4045248C36C3}">
      <dgm:prSet/>
      <dgm:spPr/>
      <dgm:t>
        <a:bodyPr/>
        <a:lstStyle/>
        <a:p>
          <a:endParaRPr lang="en-US"/>
        </a:p>
      </dgm:t>
    </dgm:pt>
    <dgm:pt modelId="{DCB0AD1C-E1EE-4B08-8DF0-A51B3A130862}" type="sibTrans" cxnId="{DF3460D0-B186-461B-87C5-4045248C36C3}">
      <dgm:prSet/>
      <dgm:spPr/>
      <dgm:t>
        <a:bodyPr/>
        <a:lstStyle/>
        <a:p>
          <a:endParaRPr lang="en-US"/>
        </a:p>
      </dgm:t>
    </dgm:pt>
    <dgm:pt modelId="{2F154F4E-B578-4F81-8828-46F8D0BE03BB}">
      <dgm:prSet/>
      <dgm:spPr/>
      <dgm:t>
        <a:bodyPr/>
        <a:lstStyle/>
        <a:p>
          <a:r>
            <a:rPr lang="en-US"/>
            <a:t>enduring the inquisition</a:t>
          </a:r>
        </a:p>
      </dgm:t>
    </dgm:pt>
    <dgm:pt modelId="{A8BF3944-9E5C-4F72-A7E8-A009DC9D7C26}" type="parTrans" cxnId="{5AB9F2CC-713A-4BEB-91A1-0E4133E17702}">
      <dgm:prSet/>
      <dgm:spPr/>
      <dgm:t>
        <a:bodyPr/>
        <a:lstStyle/>
        <a:p>
          <a:endParaRPr lang="en-US"/>
        </a:p>
      </dgm:t>
    </dgm:pt>
    <dgm:pt modelId="{8F209CC5-A4DB-47F6-9F6F-B9BD74FDDCC0}" type="sibTrans" cxnId="{5AB9F2CC-713A-4BEB-91A1-0E4133E17702}">
      <dgm:prSet/>
      <dgm:spPr/>
      <dgm:t>
        <a:bodyPr/>
        <a:lstStyle/>
        <a:p>
          <a:endParaRPr lang="en-US"/>
        </a:p>
      </dgm:t>
    </dgm:pt>
    <dgm:pt modelId="{AA21800B-7F17-4BAD-BD61-16D001046E0F}">
      <dgm:prSet/>
      <dgm:spPr/>
      <dgm:t>
        <a:bodyPr/>
        <a:lstStyle/>
        <a:p>
          <a:r>
            <a:rPr lang="en-US"/>
            <a:t>obtaining emotional first aid</a:t>
          </a:r>
        </a:p>
      </dgm:t>
    </dgm:pt>
    <dgm:pt modelId="{9E77E344-56CD-4A00-BAB3-42A62F8823B4}" type="parTrans" cxnId="{6386D4CB-AF62-4457-ADB3-4388925EF083}">
      <dgm:prSet/>
      <dgm:spPr/>
      <dgm:t>
        <a:bodyPr/>
        <a:lstStyle/>
        <a:p>
          <a:endParaRPr lang="en-US"/>
        </a:p>
      </dgm:t>
    </dgm:pt>
    <dgm:pt modelId="{0D8FF533-0C72-4DE6-BEB2-251A85D2503C}" type="sibTrans" cxnId="{6386D4CB-AF62-4457-ADB3-4388925EF083}">
      <dgm:prSet/>
      <dgm:spPr/>
      <dgm:t>
        <a:bodyPr/>
        <a:lstStyle/>
        <a:p>
          <a:endParaRPr lang="en-US"/>
        </a:p>
      </dgm:t>
    </dgm:pt>
    <dgm:pt modelId="{0CACA63E-9A6F-4585-98FC-D3782805CD99}">
      <dgm:prSet/>
      <dgm:spPr/>
      <dgm:t>
        <a:bodyPr/>
        <a:lstStyle/>
        <a:p>
          <a:r>
            <a:rPr lang="en-US"/>
            <a:t>moving on</a:t>
          </a:r>
        </a:p>
      </dgm:t>
    </dgm:pt>
    <dgm:pt modelId="{24A629C9-360D-430F-91BA-86D38603CB35}" type="parTrans" cxnId="{200621F2-C157-4C74-A915-1E1A89C6097D}">
      <dgm:prSet/>
      <dgm:spPr/>
      <dgm:t>
        <a:bodyPr/>
        <a:lstStyle/>
        <a:p>
          <a:endParaRPr lang="en-US"/>
        </a:p>
      </dgm:t>
    </dgm:pt>
    <dgm:pt modelId="{4143E89A-4677-4BC8-BFD6-7A4F6947923B}" type="sibTrans" cxnId="{200621F2-C157-4C74-A915-1E1A89C6097D}">
      <dgm:prSet/>
      <dgm:spPr/>
      <dgm:t>
        <a:bodyPr/>
        <a:lstStyle/>
        <a:p>
          <a:endParaRPr lang="en-US"/>
        </a:p>
      </dgm:t>
    </dgm:pt>
    <dgm:pt modelId="{81687C23-C7A4-4ABB-932F-53CE8B44E2A1}">
      <dgm:prSet/>
      <dgm:spPr/>
      <dgm:t>
        <a:bodyPr/>
        <a:lstStyle/>
        <a:p>
          <a:r>
            <a:rPr lang="en-US"/>
            <a:t>drop out</a:t>
          </a:r>
        </a:p>
      </dgm:t>
    </dgm:pt>
    <dgm:pt modelId="{0FD4F285-3684-4771-91E1-FCBA6DACB773}" type="parTrans" cxnId="{3B4E3AB3-F3D6-4A45-9BC9-C8E8D8893F92}">
      <dgm:prSet/>
      <dgm:spPr/>
      <dgm:t>
        <a:bodyPr/>
        <a:lstStyle/>
        <a:p>
          <a:endParaRPr lang="en-US"/>
        </a:p>
      </dgm:t>
    </dgm:pt>
    <dgm:pt modelId="{BE6168C1-E9A0-4726-A54B-8C58CCC6F09E}" type="sibTrans" cxnId="{3B4E3AB3-F3D6-4A45-9BC9-C8E8D8893F92}">
      <dgm:prSet/>
      <dgm:spPr/>
      <dgm:t>
        <a:bodyPr/>
        <a:lstStyle/>
        <a:p>
          <a:endParaRPr lang="en-US"/>
        </a:p>
      </dgm:t>
    </dgm:pt>
    <dgm:pt modelId="{20C28E46-FE07-4EBC-9911-0458FEA810E8}">
      <dgm:prSet/>
      <dgm:spPr/>
      <dgm:t>
        <a:bodyPr/>
        <a:lstStyle/>
        <a:p>
          <a:r>
            <a:rPr lang="en-US"/>
            <a:t>Survive</a:t>
          </a:r>
        </a:p>
      </dgm:t>
    </dgm:pt>
    <dgm:pt modelId="{6A4E9978-84E2-41F5-B186-933BE3DE0E00}" type="parTrans" cxnId="{B235191F-2215-4271-A2DE-CDAE7219143D}">
      <dgm:prSet/>
      <dgm:spPr/>
      <dgm:t>
        <a:bodyPr/>
        <a:lstStyle/>
        <a:p>
          <a:endParaRPr lang="en-US"/>
        </a:p>
      </dgm:t>
    </dgm:pt>
    <dgm:pt modelId="{A4382339-4C07-4FB7-9188-4687722A74DD}" type="sibTrans" cxnId="{B235191F-2215-4271-A2DE-CDAE7219143D}">
      <dgm:prSet/>
      <dgm:spPr/>
      <dgm:t>
        <a:bodyPr/>
        <a:lstStyle/>
        <a:p>
          <a:endParaRPr lang="en-US"/>
        </a:p>
      </dgm:t>
    </dgm:pt>
    <dgm:pt modelId="{23D38689-597D-439E-9E11-88938985CC84}">
      <dgm:prSet/>
      <dgm:spPr/>
      <dgm:t>
        <a:bodyPr/>
        <a:lstStyle/>
        <a:p>
          <a:r>
            <a:rPr lang="en-US"/>
            <a:t>thrive</a:t>
          </a:r>
        </a:p>
      </dgm:t>
    </dgm:pt>
    <dgm:pt modelId="{BFA4BE1E-80FF-46C1-9740-81E77CB0D724}" type="parTrans" cxnId="{3ED0C481-4ADB-49FD-8926-D43F0916C373}">
      <dgm:prSet/>
      <dgm:spPr/>
      <dgm:t>
        <a:bodyPr/>
        <a:lstStyle/>
        <a:p>
          <a:endParaRPr lang="en-US"/>
        </a:p>
      </dgm:t>
    </dgm:pt>
    <dgm:pt modelId="{9E426130-6C7C-499D-BDC6-659CD09065E7}" type="sibTrans" cxnId="{3ED0C481-4ADB-49FD-8926-D43F0916C373}">
      <dgm:prSet/>
      <dgm:spPr/>
      <dgm:t>
        <a:bodyPr/>
        <a:lstStyle/>
        <a:p>
          <a:endParaRPr lang="en-US"/>
        </a:p>
      </dgm:t>
    </dgm:pt>
    <dgm:pt modelId="{D4D11055-6642-4D9B-8608-80FE18ACE568}" type="pres">
      <dgm:prSet presAssocID="{BA465BEE-4C25-4252-92D7-ECE9FF77C333}" presName="linear" presStyleCnt="0">
        <dgm:presLayoutVars>
          <dgm:animLvl val="lvl"/>
          <dgm:resizeHandles val="exact"/>
        </dgm:presLayoutVars>
      </dgm:prSet>
      <dgm:spPr/>
    </dgm:pt>
    <dgm:pt modelId="{57B3B20F-5B44-40FF-BC4B-E74D659C97C7}" type="pres">
      <dgm:prSet presAssocID="{0A5FF1F9-EDE4-48E6-8461-1B5C398B701A}" presName="parentText" presStyleLbl="node1" presStyleIdx="0" presStyleCnt="6">
        <dgm:presLayoutVars>
          <dgm:chMax val="0"/>
          <dgm:bulletEnabled val="1"/>
        </dgm:presLayoutVars>
      </dgm:prSet>
      <dgm:spPr/>
    </dgm:pt>
    <dgm:pt modelId="{00E42B65-88D2-4058-8AB7-0EE638E49F90}" type="pres">
      <dgm:prSet presAssocID="{6FACE0F7-55CC-4D2F-AFCD-D443E92ED45A}" presName="spacer" presStyleCnt="0"/>
      <dgm:spPr/>
    </dgm:pt>
    <dgm:pt modelId="{A18A1873-B0AC-46D9-AA61-70BA4B047E25}" type="pres">
      <dgm:prSet presAssocID="{EC4F842A-C57E-4D5F-A2F4-D3397E83EF2B}" presName="parentText" presStyleLbl="node1" presStyleIdx="1" presStyleCnt="6">
        <dgm:presLayoutVars>
          <dgm:chMax val="0"/>
          <dgm:bulletEnabled val="1"/>
        </dgm:presLayoutVars>
      </dgm:prSet>
      <dgm:spPr/>
    </dgm:pt>
    <dgm:pt modelId="{20BC8910-D867-40CC-8414-C148ADEDCEA8}" type="pres">
      <dgm:prSet presAssocID="{1EDE6851-D0F4-45D1-85CB-70469FEB42A4}" presName="spacer" presStyleCnt="0"/>
      <dgm:spPr/>
    </dgm:pt>
    <dgm:pt modelId="{874329C0-0370-4FDA-9FF7-25AD17B223C9}" type="pres">
      <dgm:prSet presAssocID="{9317634D-1178-45BB-A6C7-F1C2BDAEACDE}" presName="parentText" presStyleLbl="node1" presStyleIdx="2" presStyleCnt="6">
        <dgm:presLayoutVars>
          <dgm:chMax val="0"/>
          <dgm:bulletEnabled val="1"/>
        </dgm:presLayoutVars>
      </dgm:prSet>
      <dgm:spPr/>
    </dgm:pt>
    <dgm:pt modelId="{217608D6-C4B5-46A8-AB05-5C3FCA69A065}" type="pres">
      <dgm:prSet presAssocID="{DCB0AD1C-E1EE-4B08-8DF0-A51B3A130862}" presName="spacer" presStyleCnt="0"/>
      <dgm:spPr/>
    </dgm:pt>
    <dgm:pt modelId="{C3FA4E35-4C38-4EB3-ABA9-C42CB2184707}" type="pres">
      <dgm:prSet presAssocID="{2F154F4E-B578-4F81-8828-46F8D0BE03BB}" presName="parentText" presStyleLbl="node1" presStyleIdx="3" presStyleCnt="6">
        <dgm:presLayoutVars>
          <dgm:chMax val="0"/>
          <dgm:bulletEnabled val="1"/>
        </dgm:presLayoutVars>
      </dgm:prSet>
      <dgm:spPr/>
    </dgm:pt>
    <dgm:pt modelId="{288FD7EF-A587-4185-A988-19C6D5CE7192}" type="pres">
      <dgm:prSet presAssocID="{8F209CC5-A4DB-47F6-9F6F-B9BD74FDDCC0}" presName="spacer" presStyleCnt="0"/>
      <dgm:spPr/>
    </dgm:pt>
    <dgm:pt modelId="{F42F488E-7B6C-4CF8-84AD-60127C4926B3}" type="pres">
      <dgm:prSet presAssocID="{AA21800B-7F17-4BAD-BD61-16D001046E0F}" presName="parentText" presStyleLbl="node1" presStyleIdx="4" presStyleCnt="6">
        <dgm:presLayoutVars>
          <dgm:chMax val="0"/>
          <dgm:bulletEnabled val="1"/>
        </dgm:presLayoutVars>
      </dgm:prSet>
      <dgm:spPr/>
    </dgm:pt>
    <dgm:pt modelId="{F597817E-D47C-4721-AC54-7B1F320A7E9E}" type="pres">
      <dgm:prSet presAssocID="{0D8FF533-0C72-4DE6-BEB2-251A85D2503C}" presName="spacer" presStyleCnt="0"/>
      <dgm:spPr/>
    </dgm:pt>
    <dgm:pt modelId="{AE6839EC-AB35-4936-819C-F5562AA2AB44}" type="pres">
      <dgm:prSet presAssocID="{0CACA63E-9A6F-4585-98FC-D3782805CD99}" presName="parentText" presStyleLbl="node1" presStyleIdx="5" presStyleCnt="6">
        <dgm:presLayoutVars>
          <dgm:chMax val="0"/>
          <dgm:bulletEnabled val="1"/>
        </dgm:presLayoutVars>
      </dgm:prSet>
      <dgm:spPr/>
    </dgm:pt>
    <dgm:pt modelId="{6ADFD48B-6466-4A8D-9CAE-14E60CC08537}" type="pres">
      <dgm:prSet presAssocID="{0CACA63E-9A6F-4585-98FC-D3782805CD99}" presName="childText" presStyleLbl="revTx" presStyleIdx="0" presStyleCnt="1">
        <dgm:presLayoutVars>
          <dgm:bulletEnabled val="1"/>
        </dgm:presLayoutVars>
      </dgm:prSet>
      <dgm:spPr/>
    </dgm:pt>
  </dgm:ptLst>
  <dgm:cxnLst>
    <dgm:cxn modelId="{C1B88906-5C89-478E-BEA1-BE39508BA218}" srcId="{BA465BEE-4C25-4252-92D7-ECE9FF77C333}" destId="{EC4F842A-C57E-4D5F-A2F4-D3397E83EF2B}" srcOrd="1" destOrd="0" parTransId="{A6F7242C-4CEA-45D7-9D54-086A561A15F7}" sibTransId="{1EDE6851-D0F4-45D1-85CB-70469FEB42A4}"/>
    <dgm:cxn modelId="{B235191F-2215-4271-A2DE-CDAE7219143D}" srcId="{0CACA63E-9A6F-4585-98FC-D3782805CD99}" destId="{20C28E46-FE07-4EBC-9911-0458FEA810E8}" srcOrd="1" destOrd="0" parTransId="{6A4E9978-84E2-41F5-B186-933BE3DE0E00}" sibTransId="{A4382339-4C07-4FB7-9188-4687722A74DD}"/>
    <dgm:cxn modelId="{EC653C2A-17B9-4158-99DB-540BEBAF8C41}" type="presOf" srcId="{BA465BEE-4C25-4252-92D7-ECE9FF77C333}" destId="{D4D11055-6642-4D9B-8608-80FE18ACE568}" srcOrd="0" destOrd="0" presId="urn:microsoft.com/office/officeart/2005/8/layout/vList2"/>
    <dgm:cxn modelId="{774B6E38-14E9-4C25-A33A-7C144FDC4E5D}" type="presOf" srcId="{2F154F4E-B578-4F81-8828-46F8D0BE03BB}" destId="{C3FA4E35-4C38-4EB3-ABA9-C42CB2184707}" srcOrd="0" destOrd="0" presId="urn:microsoft.com/office/officeart/2005/8/layout/vList2"/>
    <dgm:cxn modelId="{3C126E69-01FF-4355-B762-B0D80EA128F1}" type="presOf" srcId="{0A5FF1F9-EDE4-48E6-8461-1B5C398B701A}" destId="{57B3B20F-5B44-40FF-BC4B-E74D659C97C7}" srcOrd="0" destOrd="0" presId="urn:microsoft.com/office/officeart/2005/8/layout/vList2"/>
    <dgm:cxn modelId="{6CBBC06A-7BBE-4DAA-B1C8-471E60D8A6BE}" type="presOf" srcId="{81687C23-C7A4-4ABB-932F-53CE8B44E2A1}" destId="{6ADFD48B-6466-4A8D-9CAE-14E60CC08537}" srcOrd="0" destOrd="0" presId="urn:microsoft.com/office/officeart/2005/8/layout/vList2"/>
    <dgm:cxn modelId="{6E4BA076-7B03-4261-B35E-30601241B458}" type="presOf" srcId="{20C28E46-FE07-4EBC-9911-0458FEA810E8}" destId="{6ADFD48B-6466-4A8D-9CAE-14E60CC08537}" srcOrd="0" destOrd="1" presId="urn:microsoft.com/office/officeart/2005/8/layout/vList2"/>
    <dgm:cxn modelId="{3ED0C481-4ADB-49FD-8926-D43F0916C373}" srcId="{0CACA63E-9A6F-4585-98FC-D3782805CD99}" destId="{23D38689-597D-439E-9E11-88938985CC84}" srcOrd="2" destOrd="0" parTransId="{BFA4BE1E-80FF-46C1-9740-81E77CB0D724}" sibTransId="{9E426130-6C7C-499D-BDC6-659CD09065E7}"/>
    <dgm:cxn modelId="{D05ABC98-3ECF-45BB-8B63-DC022C06EE62}" type="presOf" srcId="{AA21800B-7F17-4BAD-BD61-16D001046E0F}" destId="{F42F488E-7B6C-4CF8-84AD-60127C4926B3}" srcOrd="0" destOrd="0" presId="urn:microsoft.com/office/officeart/2005/8/layout/vList2"/>
    <dgm:cxn modelId="{3B4E3AB3-F3D6-4A45-9BC9-C8E8D8893F92}" srcId="{0CACA63E-9A6F-4585-98FC-D3782805CD99}" destId="{81687C23-C7A4-4ABB-932F-53CE8B44E2A1}" srcOrd="0" destOrd="0" parTransId="{0FD4F285-3684-4771-91E1-FCBA6DACB773}" sibTransId="{BE6168C1-E9A0-4726-A54B-8C58CCC6F09E}"/>
    <dgm:cxn modelId="{38F50DBE-0C20-4D28-9256-F124D81C9D83}" type="presOf" srcId="{9317634D-1178-45BB-A6C7-F1C2BDAEACDE}" destId="{874329C0-0370-4FDA-9FF7-25AD17B223C9}" srcOrd="0" destOrd="0" presId="urn:microsoft.com/office/officeart/2005/8/layout/vList2"/>
    <dgm:cxn modelId="{2C8E6FC9-0E0E-4A78-BBB2-ABE91B2B80C7}" srcId="{BA465BEE-4C25-4252-92D7-ECE9FF77C333}" destId="{0A5FF1F9-EDE4-48E6-8461-1B5C398B701A}" srcOrd="0" destOrd="0" parTransId="{890D61B0-27F4-4F7A-97CB-73562707988B}" sibTransId="{6FACE0F7-55CC-4D2F-AFCD-D443E92ED45A}"/>
    <dgm:cxn modelId="{6386D4CB-AF62-4457-ADB3-4388925EF083}" srcId="{BA465BEE-4C25-4252-92D7-ECE9FF77C333}" destId="{AA21800B-7F17-4BAD-BD61-16D001046E0F}" srcOrd="4" destOrd="0" parTransId="{9E77E344-56CD-4A00-BAB3-42A62F8823B4}" sibTransId="{0D8FF533-0C72-4DE6-BEB2-251A85D2503C}"/>
    <dgm:cxn modelId="{5AB9F2CC-713A-4BEB-91A1-0E4133E17702}" srcId="{BA465BEE-4C25-4252-92D7-ECE9FF77C333}" destId="{2F154F4E-B578-4F81-8828-46F8D0BE03BB}" srcOrd="3" destOrd="0" parTransId="{A8BF3944-9E5C-4F72-A7E8-A009DC9D7C26}" sibTransId="{8F209CC5-A4DB-47F6-9F6F-B9BD74FDDCC0}"/>
    <dgm:cxn modelId="{DF3460D0-B186-461B-87C5-4045248C36C3}" srcId="{BA465BEE-4C25-4252-92D7-ECE9FF77C333}" destId="{9317634D-1178-45BB-A6C7-F1C2BDAEACDE}" srcOrd="2" destOrd="0" parTransId="{B59CCF6C-7062-4741-A54C-6B6D23C73E94}" sibTransId="{DCB0AD1C-E1EE-4B08-8DF0-A51B3A130862}"/>
    <dgm:cxn modelId="{16F817D9-4522-43FC-81AB-B1E85E8B6B65}" type="presOf" srcId="{23D38689-597D-439E-9E11-88938985CC84}" destId="{6ADFD48B-6466-4A8D-9CAE-14E60CC08537}" srcOrd="0" destOrd="2" presId="urn:microsoft.com/office/officeart/2005/8/layout/vList2"/>
    <dgm:cxn modelId="{BAA8ACE5-D270-4082-8C97-9A751E631807}" type="presOf" srcId="{0CACA63E-9A6F-4585-98FC-D3782805CD99}" destId="{AE6839EC-AB35-4936-819C-F5562AA2AB44}" srcOrd="0" destOrd="0" presId="urn:microsoft.com/office/officeart/2005/8/layout/vList2"/>
    <dgm:cxn modelId="{E6EB90EA-CA94-4355-B1F4-2B308FAF0854}" type="presOf" srcId="{EC4F842A-C57E-4D5F-A2F4-D3397E83EF2B}" destId="{A18A1873-B0AC-46D9-AA61-70BA4B047E25}" srcOrd="0" destOrd="0" presId="urn:microsoft.com/office/officeart/2005/8/layout/vList2"/>
    <dgm:cxn modelId="{200621F2-C157-4C74-A915-1E1A89C6097D}" srcId="{BA465BEE-4C25-4252-92D7-ECE9FF77C333}" destId="{0CACA63E-9A6F-4585-98FC-D3782805CD99}" srcOrd="5" destOrd="0" parTransId="{24A629C9-360D-430F-91BA-86D38603CB35}" sibTransId="{4143E89A-4677-4BC8-BFD6-7A4F6947923B}"/>
    <dgm:cxn modelId="{60BEF9C4-B770-4987-8F02-2DBEA15ECEC0}" type="presParOf" srcId="{D4D11055-6642-4D9B-8608-80FE18ACE568}" destId="{57B3B20F-5B44-40FF-BC4B-E74D659C97C7}" srcOrd="0" destOrd="0" presId="urn:microsoft.com/office/officeart/2005/8/layout/vList2"/>
    <dgm:cxn modelId="{DB1E3D40-1E8D-408F-BAE9-6FC19967D685}" type="presParOf" srcId="{D4D11055-6642-4D9B-8608-80FE18ACE568}" destId="{00E42B65-88D2-4058-8AB7-0EE638E49F90}" srcOrd="1" destOrd="0" presId="urn:microsoft.com/office/officeart/2005/8/layout/vList2"/>
    <dgm:cxn modelId="{0476B3F5-D205-448A-91A8-E08216A5F1AA}" type="presParOf" srcId="{D4D11055-6642-4D9B-8608-80FE18ACE568}" destId="{A18A1873-B0AC-46D9-AA61-70BA4B047E25}" srcOrd="2" destOrd="0" presId="urn:microsoft.com/office/officeart/2005/8/layout/vList2"/>
    <dgm:cxn modelId="{8CD487DB-7986-47A5-B54F-66B6829C107C}" type="presParOf" srcId="{D4D11055-6642-4D9B-8608-80FE18ACE568}" destId="{20BC8910-D867-40CC-8414-C148ADEDCEA8}" srcOrd="3" destOrd="0" presId="urn:microsoft.com/office/officeart/2005/8/layout/vList2"/>
    <dgm:cxn modelId="{15127636-32D1-458C-8B1F-C11F50EB8E05}" type="presParOf" srcId="{D4D11055-6642-4D9B-8608-80FE18ACE568}" destId="{874329C0-0370-4FDA-9FF7-25AD17B223C9}" srcOrd="4" destOrd="0" presId="urn:microsoft.com/office/officeart/2005/8/layout/vList2"/>
    <dgm:cxn modelId="{C662C752-ED12-400B-A75F-13F082F52074}" type="presParOf" srcId="{D4D11055-6642-4D9B-8608-80FE18ACE568}" destId="{217608D6-C4B5-46A8-AB05-5C3FCA69A065}" srcOrd="5" destOrd="0" presId="urn:microsoft.com/office/officeart/2005/8/layout/vList2"/>
    <dgm:cxn modelId="{D42B5601-9ABB-4915-9D1A-DC702B100186}" type="presParOf" srcId="{D4D11055-6642-4D9B-8608-80FE18ACE568}" destId="{C3FA4E35-4C38-4EB3-ABA9-C42CB2184707}" srcOrd="6" destOrd="0" presId="urn:microsoft.com/office/officeart/2005/8/layout/vList2"/>
    <dgm:cxn modelId="{1F96EB06-9573-4D8C-8430-0B870B7F16D3}" type="presParOf" srcId="{D4D11055-6642-4D9B-8608-80FE18ACE568}" destId="{288FD7EF-A587-4185-A988-19C6D5CE7192}" srcOrd="7" destOrd="0" presId="urn:microsoft.com/office/officeart/2005/8/layout/vList2"/>
    <dgm:cxn modelId="{861C2498-35E9-41C9-8586-BEB45A4E093A}" type="presParOf" srcId="{D4D11055-6642-4D9B-8608-80FE18ACE568}" destId="{F42F488E-7B6C-4CF8-84AD-60127C4926B3}" srcOrd="8" destOrd="0" presId="urn:microsoft.com/office/officeart/2005/8/layout/vList2"/>
    <dgm:cxn modelId="{03B82D79-09FC-44F4-8633-951642639D9F}" type="presParOf" srcId="{D4D11055-6642-4D9B-8608-80FE18ACE568}" destId="{F597817E-D47C-4721-AC54-7B1F320A7E9E}" srcOrd="9" destOrd="0" presId="urn:microsoft.com/office/officeart/2005/8/layout/vList2"/>
    <dgm:cxn modelId="{A71930C9-5B62-4F6F-91DB-D1779875C606}" type="presParOf" srcId="{D4D11055-6642-4D9B-8608-80FE18ACE568}" destId="{AE6839EC-AB35-4936-819C-F5562AA2AB44}" srcOrd="10" destOrd="0" presId="urn:microsoft.com/office/officeart/2005/8/layout/vList2"/>
    <dgm:cxn modelId="{1BE7A895-7C49-48BF-8328-87F7D7573C54}" type="presParOf" srcId="{D4D11055-6642-4D9B-8608-80FE18ACE568}" destId="{6ADFD48B-6466-4A8D-9CAE-14E60CC08537}" srcOrd="1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C8AEEB1-28A9-4D51-89D5-79BAE4DAC0BD}">
      <dsp:nvSpPr>
        <dsp:cNvPr id="0" name=""/>
        <dsp:cNvSpPr/>
      </dsp:nvSpPr>
      <dsp:spPr>
        <a:xfrm>
          <a:off x="0" y="2703"/>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4D363EB-2DE4-49D1-876A-175330170708}">
      <dsp:nvSpPr>
        <dsp:cNvPr id="0" name=""/>
        <dsp:cNvSpPr/>
      </dsp:nvSpPr>
      <dsp:spPr>
        <a:xfrm>
          <a:off x="0" y="2703"/>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Human beings make errors, even smart and hard working doctors</a:t>
          </a:r>
        </a:p>
      </dsp:txBody>
      <dsp:txXfrm>
        <a:off x="0" y="2703"/>
        <a:ext cx="6900512" cy="921789"/>
      </dsp:txXfrm>
    </dsp:sp>
    <dsp:sp modelId="{5B50099E-807B-4377-93BB-92B961EF3B75}">
      <dsp:nvSpPr>
        <dsp:cNvPr id="0" name=""/>
        <dsp:cNvSpPr/>
      </dsp:nvSpPr>
      <dsp:spPr>
        <a:xfrm>
          <a:off x="0" y="924492"/>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3A8D523-1BE5-4B4E-905F-9029A944C8A2}">
      <dsp:nvSpPr>
        <dsp:cNvPr id="0" name=""/>
        <dsp:cNvSpPr/>
      </dsp:nvSpPr>
      <dsp:spPr>
        <a:xfrm>
          <a:off x="0" y="924492"/>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are aware of ourselves and our environment, anticipating when we and our colleagues are at higher risk for error</a:t>
          </a:r>
        </a:p>
      </dsp:txBody>
      <dsp:txXfrm>
        <a:off x="0" y="924492"/>
        <a:ext cx="6900512" cy="921789"/>
      </dsp:txXfrm>
    </dsp:sp>
    <dsp:sp modelId="{E8E566AD-7254-4DC9-810F-D4D017AFFB1C}">
      <dsp:nvSpPr>
        <dsp:cNvPr id="0" name=""/>
        <dsp:cNvSpPr/>
      </dsp:nvSpPr>
      <dsp:spPr>
        <a:xfrm>
          <a:off x="0" y="1846281"/>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F9F068-96EA-49E3-8A26-FE93186D4A06}">
      <dsp:nvSpPr>
        <dsp:cNvPr id="0" name=""/>
        <dsp:cNvSpPr/>
      </dsp:nvSpPr>
      <dsp:spPr>
        <a:xfrm>
          <a:off x="0" y="1846281"/>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In spite of the barriers, we will be honest and learn from our errors</a:t>
          </a:r>
        </a:p>
      </dsp:txBody>
      <dsp:txXfrm>
        <a:off x="0" y="1846281"/>
        <a:ext cx="6900512" cy="921789"/>
      </dsp:txXfrm>
    </dsp:sp>
    <dsp:sp modelId="{728EA669-9A6F-4E39-BED2-A116F0069B57}">
      <dsp:nvSpPr>
        <dsp:cNvPr id="0" name=""/>
        <dsp:cNvSpPr/>
      </dsp:nvSpPr>
      <dsp:spPr>
        <a:xfrm>
          <a:off x="0" y="2768070"/>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B9A711E-D076-44D1-A977-575038F7CA29}">
      <dsp:nvSpPr>
        <dsp:cNvPr id="0" name=""/>
        <dsp:cNvSpPr/>
      </dsp:nvSpPr>
      <dsp:spPr>
        <a:xfrm>
          <a:off x="0" y="2768070"/>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will not abandon our patients or our colleagues after error</a:t>
          </a:r>
        </a:p>
      </dsp:txBody>
      <dsp:txXfrm>
        <a:off x="0" y="2768070"/>
        <a:ext cx="6900512" cy="921789"/>
      </dsp:txXfrm>
    </dsp:sp>
    <dsp:sp modelId="{F8C3E15E-3E20-4FA7-844E-F936D7B52763}">
      <dsp:nvSpPr>
        <dsp:cNvPr id="0" name=""/>
        <dsp:cNvSpPr/>
      </dsp:nvSpPr>
      <dsp:spPr>
        <a:xfrm>
          <a:off x="0" y="3689859"/>
          <a:ext cx="6900512" cy="0"/>
        </a:xfrm>
        <a:prstGeom prst="line">
          <a:avLst/>
        </a:prstGeom>
        <a:solidFill>
          <a:schemeClr val="accent6">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C6ECA73-84B0-44BC-9382-C0DB02353EF3}">
      <dsp:nvSpPr>
        <dsp:cNvPr id="0" name=""/>
        <dsp:cNvSpPr/>
      </dsp:nvSpPr>
      <dsp:spPr>
        <a:xfrm>
          <a:off x="0" y="3689859"/>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We will practice self care after an error and get help when we need it</a:t>
          </a:r>
        </a:p>
      </dsp:txBody>
      <dsp:txXfrm>
        <a:off x="0" y="3689859"/>
        <a:ext cx="6900512" cy="921789"/>
      </dsp:txXfrm>
    </dsp:sp>
    <dsp:sp modelId="{0FF6F41B-232A-4A73-8AA3-3285316BB415}">
      <dsp:nvSpPr>
        <dsp:cNvPr id="0" name=""/>
        <dsp:cNvSpPr/>
      </dsp:nvSpPr>
      <dsp:spPr>
        <a:xfrm>
          <a:off x="0" y="4611648"/>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6AC37CA-006D-4063-8B2E-3917376F50A9}">
      <dsp:nvSpPr>
        <dsp:cNvPr id="0" name=""/>
        <dsp:cNvSpPr/>
      </dsp:nvSpPr>
      <dsp:spPr>
        <a:xfrm>
          <a:off x="0" y="4611648"/>
          <a:ext cx="6900512" cy="92178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Practice makes better </a:t>
          </a:r>
        </a:p>
      </dsp:txBody>
      <dsp:txXfrm>
        <a:off x="0" y="4611648"/>
        <a:ext cx="6900512" cy="92178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92C9FE-315D-4790-BA8D-0F827137E7CC}">
      <dsp:nvSpPr>
        <dsp:cNvPr id="0" name=""/>
        <dsp:cNvSpPr/>
      </dsp:nvSpPr>
      <dsp:spPr>
        <a:xfrm>
          <a:off x="0" y="990210"/>
          <a:ext cx="6900512" cy="81549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Sponsoring institution GME - [Policy ]</a:t>
          </a:r>
        </a:p>
      </dsp:txBody>
      <dsp:txXfrm>
        <a:off x="39809" y="1030019"/>
        <a:ext cx="6820894" cy="735872"/>
      </dsp:txXfrm>
    </dsp:sp>
    <dsp:sp modelId="{2C05D033-D0C2-4A6C-B8DF-2960D4159D00}">
      <dsp:nvSpPr>
        <dsp:cNvPr id="0" name=""/>
        <dsp:cNvSpPr/>
      </dsp:nvSpPr>
      <dsp:spPr>
        <a:xfrm>
          <a:off x="0" y="1903620"/>
          <a:ext cx="6900512" cy="815490"/>
        </a:xfrm>
        <a:prstGeom prst="roundRect">
          <a:avLst/>
        </a:prstGeom>
        <a:solidFill>
          <a:schemeClr val="accent5">
            <a:hueOff val="-2252848"/>
            <a:satOff val="-5806"/>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Primary care center- [Policy</a:t>
          </a:r>
          <a:r>
            <a:rPr lang="en-US" sz="3400" kern="1200" dirty="0">
              <a:latin typeface="Calibri Light" panose="020F0302020204030204"/>
            </a:rPr>
            <a:t>]</a:t>
          </a:r>
          <a:endParaRPr lang="en-US" sz="3400" kern="1200" dirty="0"/>
        </a:p>
      </dsp:txBody>
      <dsp:txXfrm>
        <a:off x="39809" y="1943429"/>
        <a:ext cx="6820894" cy="735872"/>
      </dsp:txXfrm>
    </dsp:sp>
    <dsp:sp modelId="{178200DC-C645-4E48-80C8-1F750CAB47CF}">
      <dsp:nvSpPr>
        <dsp:cNvPr id="0" name=""/>
        <dsp:cNvSpPr/>
      </dsp:nvSpPr>
      <dsp:spPr>
        <a:xfrm>
          <a:off x="0" y="2817030"/>
          <a:ext cx="6900512" cy="815490"/>
        </a:xfrm>
        <a:prstGeom prst="roundRect">
          <a:avLst/>
        </a:prstGeom>
        <a:solidFill>
          <a:schemeClr val="accent5">
            <a:hueOff val="-4505695"/>
            <a:satOff val="-11613"/>
            <a:lumOff val="-784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Primary adult hospital – [Policy ]</a:t>
          </a:r>
        </a:p>
      </dsp:txBody>
      <dsp:txXfrm>
        <a:off x="39809" y="2856839"/>
        <a:ext cx="6820894" cy="735872"/>
      </dsp:txXfrm>
    </dsp:sp>
    <dsp:sp modelId="{4F8EA2C4-D16C-430F-BDE7-8934CC478EE4}">
      <dsp:nvSpPr>
        <dsp:cNvPr id="0" name=""/>
        <dsp:cNvSpPr/>
      </dsp:nvSpPr>
      <dsp:spPr>
        <a:xfrm>
          <a:off x="0" y="3730440"/>
          <a:ext cx="6900512" cy="815490"/>
        </a:xfrm>
        <a:prstGeom prst="roundRec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Primary pediatric hospital- [Policy ]</a:t>
          </a:r>
        </a:p>
      </dsp:txBody>
      <dsp:txXfrm>
        <a:off x="39809" y="3770249"/>
        <a:ext cx="6820894" cy="73587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8F75BC9-9096-4F94-AEB8-ED8720D769BC}">
      <dsp:nvSpPr>
        <dsp:cNvPr id="0" name=""/>
        <dsp:cNvSpPr/>
      </dsp:nvSpPr>
      <dsp:spPr>
        <a:xfrm>
          <a:off x="0" y="0"/>
          <a:ext cx="4818888"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sp>
    <dsp:sp modelId="{C919A526-4EAD-4CA5-BE7D-60D327582A36}">
      <dsp:nvSpPr>
        <dsp:cNvPr id="0" name=""/>
        <dsp:cNvSpPr/>
      </dsp:nvSpPr>
      <dsp:spPr>
        <a:xfrm>
          <a:off x="0" y="0"/>
          <a:ext cx="4818888" cy="17739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86690" tIns="186690" rIns="186690" bIns="186690" numCol="1" spcCol="1270" anchor="t" anchorCtr="0">
          <a:noAutofit/>
        </a:bodyPr>
        <a:lstStyle/>
        <a:p>
          <a:pPr marL="0" lvl="0" indent="0" algn="l" defTabSz="2178050" rtl="0">
            <a:lnSpc>
              <a:spcPct val="90000"/>
            </a:lnSpc>
            <a:spcBef>
              <a:spcPct val="0"/>
            </a:spcBef>
            <a:spcAft>
              <a:spcPct val="35000"/>
            </a:spcAft>
            <a:buNone/>
          </a:pPr>
          <a:r>
            <a:rPr lang="en-US" sz="4900" kern="1200">
              <a:latin typeface="Calibri Light" panose="020F0302020204030204"/>
            </a:rPr>
            <a:t>What have you seen?</a:t>
          </a:r>
          <a:endParaRPr lang="en-US" sz="4900" kern="1200"/>
        </a:p>
      </dsp:txBody>
      <dsp:txXfrm>
        <a:off x="0" y="0"/>
        <a:ext cx="4818888" cy="1773936"/>
      </dsp:txXfrm>
    </dsp:sp>
    <dsp:sp modelId="{7668BD6D-E267-4E93-9E99-B7A02DC5214E}">
      <dsp:nvSpPr>
        <dsp:cNvPr id="0" name=""/>
        <dsp:cNvSpPr/>
      </dsp:nvSpPr>
      <dsp:spPr>
        <a:xfrm>
          <a:off x="0" y="1773936"/>
          <a:ext cx="4818888" cy="0"/>
        </a:xfrm>
        <a:prstGeom prst="line">
          <a:avLst/>
        </a:prstGeom>
        <a:solidFill>
          <a:schemeClr val="accent5">
            <a:hueOff val="-6758543"/>
            <a:satOff val="-17419"/>
            <a:lumOff val="-11765"/>
            <a:alphaOff val="0"/>
          </a:schemeClr>
        </a:solidFill>
        <a:ln w="12700" cap="flat" cmpd="sng" algn="ctr">
          <a:solidFill>
            <a:schemeClr val="accent5">
              <a:hueOff val="-6758543"/>
              <a:satOff val="-17419"/>
              <a:lumOff val="-11765"/>
              <a:alphaOff val="0"/>
            </a:schemeClr>
          </a:solidFill>
          <a:prstDash val="solid"/>
          <a:miter lim="800000"/>
        </a:ln>
        <a:effectLst/>
      </dsp:spPr>
      <dsp:style>
        <a:lnRef idx="2">
          <a:scrgbClr r="0" g="0" b="0"/>
        </a:lnRef>
        <a:fillRef idx="1">
          <a:scrgbClr r="0" g="0" b="0"/>
        </a:fillRef>
        <a:effectRef idx="1">
          <a:scrgbClr r="0" g="0" b="0"/>
        </a:effectRef>
        <a:fontRef idx="minor">
          <a:schemeClr val="lt1"/>
        </a:fontRef>
      </dsp:style>
    </dsp:sp>
    <dsp:sp modelId="{A89D1EE6-5504-4301-A1AA-4A8B42F63A98}">
      <dsp:nvSpPr>
        <dsp:cNvPr id="0" name=""/>
        <dsp:cNvSpPr/>
      </dsp:nvSpPr>
      <dsp:spPr>
        <a:xfrm>
          <a:off x="0" y="1773936"/>
          <a:ext cx="4818888" cy="177393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86690" tIns="186690" rIns="186690" bIns="186690" numCol="1" spcCol="1270" anchor="t" anchorCtr="0">
          <a:noAutofit/>
        </a:bodyPr>
        <a:lstStyle/>
        <a:p>
          <a:pPr marL="0" lvl="0" indent="0" algn="l" defTabSz="2178050">
            <a:lnSpc>
              <a:spcPct val="90000"/>
            </a:lnSpc>
            <a:spcBef>
              <a:spcPct val="0"/>
            </a:spcBef>
            <a:spcAft>
              <a:spcPct val="35000"/>
            </a:spcAft>
            <a:buNone/>
          </a:pPr>
          <a:endParaRPr lang="en-US" sz="4900" kern="1200">
            <a:latin typeface="Calibri Light" panose="020F0302020204030204"/>
          </a:endParaRPr>
        </a:p>
      </dsp:txBody>
      <dsp:txXfrm>
        <a:off x="0" y="1773936"/>
        <a:ext cx="4818888" cy="1773936"/>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42955AE-E913-4A45-A703-0CA7A0316939}">
      <dsp:nvSpPr>
        <dsp:cNvPr id="0" name=""/>
        <dsp:cNvSpPr/>
      </dsp:nvSpPr>
      <dsp:spPr>
        <a:xfrm>
          <a:off x="0" y="531"/>
          <a:ext cx="10515600"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307591E-B974-4DBE-9419-D5D86BD75427}">
      <dsp:nvSpPr>
        <dsp:cNvPr id="0" name=""/>
        <dsp:cNvSpPr/>
      </dsp:nvSpPr>
      <dsp:spPr>
        <a:xfrm>
          <a:off x="0" y="531"/>
          <a:ext cx="10515600" cy="87029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rtl="0">
            <a:lnSpc>
              <a:spcPct val="90000"/>
            </a:lnSpc>
            <a:spcBef>
              <a:spcPct val="0"/>
            </a:spcBef>
            <a:spcAft>
              <a:spcPct val="35000"/>
            </a:spcAft>
            <a:buNone/>
          </a:pPr>
          <a:r>
            <a:rPr lang="en-US" sz="2400" b="0" kern="1200" dirty="0">
              <a:latin typeface="Calibri"/>
              <a:ea typeface="Calibri"/>
              <a:cs typeface="Calibri"/>
            </a:rPr>
            <a:t>Sponsor GME - How to report</a:t>
          </a:r>
        </a:p>
      </dsp:txBody>
      <dsp:txXfrm>
        <a:off x="0" y="531"/>
        <a:ext cx="10515600" cy="870296"/>
      </dsp:txXfrm>
    </dsp:sp>
    <dsp:sp modelId="{3B751C5B-3B19-41C2-936E-B2B4922BE227}">
      <dsp:nvSpPr>
        <dsp:cNvPr id="0" name=""/>
        <dsp:cNvSpPr/>
      </dsp:nvSpPr>
      <dsp:spPr>
        <a:xfrm>
          <a:off x="0" y="870827"/>
          <a:ext cx="10515600" cy="0"/>
        </a:xfrm>
        <a:prstGeom prst="line">
          <a:avLst/>
        </a:prstGeom>
        <a:solidFill>
          <a:schemeClr val="accent5">
            <a:hueOff val="-1689636"/>
            <a:satOff val="-4355"/>
            <a:lumOff val="-2941"/>
            <a:alphaOff val="0"/>
          </a:schemeClr>
        </a:solidFill>
        <a:ln w="12700" cap="flat" cmpd="sng" algn="ctr">
          <a:solidFill>
            <a:schemeClr val="accent5">
              <a:hueOff val="-1689636"/>
              <a:satOff val="-4355"/>
              <a:lumOff val="-294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D5D68C3-DBC5-4B69-996F-77E67BB42D54}">
      <dsp:nvSpPr>
        <dsp:cNvPr id="0" name=""/>
        <dsp:cNvSpPr/>
      </dsp:nvSpPr>
      <dsp:spPr>
        <a:xfrm>
          <a:off x="0" y="870827"/>
          <a:ext cx="10515600" cy="87029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rtl="0">
            <a:lnSpc>
              <a:spcPct val="90000"/>
            </a:lnSpc>
            <a:spcBef>
              <a:spcPct val="0"/>
            </a:spcBef>
            <a:spcAft>
              <a:spcPct val="35000"/>
            </a:spcAft>
            <a:buNone/>
          </a:pPr>
          <a:r>
            <a:rPr lang="en-US" sz="2400" b="0" kern="1200" dirty="0">
              <a:latin typeface="Calibri"/>
              <a:ea typeface="Calibri"/>
              <a:cs typeface="Calibri"/>
            </a:rPr>
            <a:t>Primary outpatient site - </a:t>
          </a:r>
          <a:r>
            <a:rPr lang="en-US" sz="2400" b="0" kern="1200" dirty="0">
              <a:latin typeface="Calibri"/>
              <a:cs typeface="Calibri"/>
            </a:rPr>
            <a:t>How to report</a:t>
          </a:r>
        </a:p>
      </dsp:txBody>
      <dsp:txXfrm>
        <a:off x="0" y="870827"/>
        <a:ext cx="10515600" cy="870296"/>
      </dsp:txXfrm>
    </dsp:sp>
    <dsp:sp modelId="{0B1175B9-A81F-4AB2-B107-AD14FE4C3724}">
      <dsp:nvSpPr>
        <dsp:cNvPr id="0" name=""/>
        <dsp:cNvSpPr/>
      </dsp:nvSpPr>
      <dsp:spPr>
        <a:xfrm>
          <a:off x="0" y="1741123"/>
          <a:ext cx="10515600" cy="0"/>
        </a:xfrm>
        <a:prstGeom prst="line">
          <a:avLst/>
        </a:prstGeom>
        <a:solidFill>
          <a:schemeClr val="accent5">
            <a:hueOff val="-3379271"/>
            <a:satOff val="-8710"/>
            <a:lumOff val="-5883"/>
            <a:alphaOff val="0"/>
          </a:schemeClr>
        </a:solidFill>
        <a:ln w="12700" cap="flat" cmpd="sng" algn="ctr">
          <a:solidFill>
            <a:schemeClr val="accent5">
              <a:hueOff val="-3379271"/>
              <a:satOff val="-8710"/>
              <a:lumOff val="-5883"/>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4EC08AB-1952-48C8-BE2F-F755AE2A4B33}">
      <dsp:nvSpPr>
        <dsp:cNvPr id="0" name=""/>
        <dsp:cNvSpPr/>
      </dsp:nvSpPr>
      <dsp:spPr>
        <a:xfrm>
          <a:off x="0" y="1741123"/>
          <a:ext cx="10515600" cy="87029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rtl="0">
            <a:lnSpc>
              <a:spcPct val="90000"/>
            </a:lnSpc>
            <a:spcBef>
              <a:spcPct val="0"/>
            </a:spcBef>
            <a:spcAft>
              <a:spcPct val="35000"/>
            </a:spcAft>
            <a:buNone/>
          </a:pPr>
          <a:r>
            <a:rPr lang="en-US" sz="2400" b="0" kern="1200" dirty="0">
              <a:latin typeface="Calibri"/>
              <a:ea typeface="Calibri"/>
              <a:cs typeface="Calibri"/>
            </a:rPr>
            <a:t>Primary inpatient institution– How to report</a:t>
          </a:r>
        </a:p>
      </dsp:txBody>
      <dsp:txXfrm>
        <a:off x="0" y="1741123"/>
        <a:ext cx="10515600" cy="870296"/>
      </dsp:txXfrm>
    </dsp:sp>
    <dsp:sp modelId="{79864414-BF9E-4764-AFC7-2ABAF5E1ADC3}">
      <dsp:nvSpPr>
        <dsp:cNvPr id="0" name=""/>
        <dsp:cNvSpPr/>
      </dsp:nvSpPr>
      <dsp:spPr>
        <a:xfrm>
          <a:off x="0" y="2611420"/>
          <a:ext cx="10515600" cy="0"/>
        </a:xfrm>
        <a:prstGeom prst="line">
          <a:avLst/>
        </a:prstGeom>
        <a:solidFill>
          <a:schemeClr val="accent5">
            <a:hueOff val="-5068907"/>
            <a:satOff val="-13064"/>
            <a:lumOff val="-8824"/>
            <a:alphaOff val="0"/>
          </a:schemeClr>
        </a:solidFill>
        <a:ln w="12700" cap="flat" cmpd="sng" algn="ctr">
          <a:solidFill>
            <a:schemeClr val="accent5">
              <a:hueOff val="-5068907"/>
              <a:satOff val="-13064"/>
              <a:lumOff val="-8824"/>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7E539DB-66E1-4C12-B40E-5544C5A90A39}">
      <dsp:nvSpPr>
        <dsp:cNvPr id="0" name=""/>
        <dsp:cNvSpPr/>
      </dsp:nvSpPr>
      <dsp:spPr>
        <a:xfrm>
          <a:off x="0" y="2611420"/>
          <a:ext cx="10515600" cy="87029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rtl="0">
            <a:lnSpc>
              <a:spcPct val="90000"/>
            </a:lnSpc>
            <a:spcBef>
              <a:spcPct val="0"/>
            </a:spcBef>
            <a:spcAft>
              <a:spcPct val="35000"/>
            </a:spcAft>
            <a:buNone/>
          </a:pPr>
          <a:r>
            <a:rPr lang="en-US" sz="2400" b="0" kern="1200" dirty="0">
              <a:latin typeface="Calibri"/>
              <a:ea typeface="Calibri"/>
              <a:cs typeface="Calibri"/>
            </a:rPr>
            <a:t>Primary</a:t>
          </a:r>
          <a:r>
            <a:rPr lang="en-US" sz="2400" b="0" kern="1200" dirty="0">
              <a:latin typeface="Calibri"/>
              <a:ea typeface="Calibri"/>
              <a:cs typeface="Calibri Light"/>
            </a:rPr>
            <a:t> pediatric institution – How to </a:t>
          </a:r>
          <a:r>
            <a:rPr lang="en-US" sz="2400" b="0" kern="1200" dirty="0">
              <a:latin typeface="Calibri"/>
              <a:cs typeface="Calibri"/>
            </a:rPr>
            <a:t>report</a:t>
          </a:r>
          <a:endParaRPr lang="en-US" sz="2400" b="0" kern="1200" dirty="0">
            <a:latin typeface="Calibri"/>
            <a:ea typeface="Calibri"/>
            <a:cs typeface="Calibri"/>
          </a:endParaRPr>
        </a:p>
      </dsp:txBody>
      <dsp:txXfrm>
        <a:off x="0" y="2611420"/>
        <a:ext cx="10515600" cy="870296"/>
      </dsp:txXfrm>
    </dsp:sp>
    <dsp:sp modelId="{19175116-D959-4D13-84C1-BCFC06B73E39}">
      <dsp:nvSpPr>
        <dsp:cNvPr id="0" name=""/>
        <dsp:cNvSpPr/>
      </dsp:nvSpPr>
      <dsp:spPr>
        <a:xfrm>
          <a:off x="0" y="3481716"/>
          <a:ext cx="10515600" cy="0"/>
        </a:xfrm>
        <a:prstGeom prst="line">
          <a:avLst/>
        </a:prstGeom>
        <a:solidFill>
          <a:schemeClr val="accent5">
            <a:hueOff val="-6758543"/>
            <a:satOff val="-17419"/>
            <a:lumOff val="-11765"/>
            <a:alphaOff val="0"/>
          </a:schemeClr>
        </a:solidFill>
        <a:ln w="12700" cap="flat" cmpd="sng" algn="ctr">
          <a:solidFill>
            <a:schemeClr val="accent5">
              <a:hueOff val="-6758543"/>
              <a:satOff val="-17419"/>
              <a:lumOff val="-11765"/>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43583C5-090A-4BAE-ADFF-107AADFE0294}">
      <dsp:nvSpPr>
        <dsp:cNvPr id="0" name=""/>
        <dsp:cNvSpPr/>
      </dsp:nvSpPr>
      <dsp:spPr>
        <a:xfrm>
          <a:off x="0" y="3481716"/>
          <a:ext cx="10515600" cy="87029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1440" tIns="91440" rIns="91440" bIns="91440" numCol="1" spcCol="1270" anchor="t" anchorCtr="0">
          <a:noAutofit/>
        </a:bodyPr>
        <a:lstStyle/>
        <a:p>
          <a:pPr marL="0" lvl="0" indent="0" algn="l" defTabSz="1066800">
            <a:lnSpc>
              <a:spcPct val="90000"/>
            </a:lnSpc>
            <a:spcBef>
              <a:spcPct val="0"/>
            </a:spcBef>
            <a:spcAft>
              <a:spcPct val="35000"/>
            </a:spcAft>
            <a:buNone/>
          </a:pPr>
          <a:r>
            <a:rPr lang="en-US" sz="2400" b="0" kern="1200" dirty="0">
              <a:latin typeface="Calibri"/>
              <a:ea typeface="Calibri"/>
              <a:cs typeface="Calibri"/>
            </a:rPr>
            <a:t>Incident reports can be done anonymously, are protected (do not reference in patient chart)</a:t>
          </a:r>
        </a:p>
      </dsp:txBody>
      <dsp:txXfrm>
        <a:off x="0" y="3481716"/>
        <a:ext cx="10515600" cy="87029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7B3B20F-5B44-40FF-BC4B-E74D659C97C7}">
      <dsp:nvSpPr>
        <dsp:cNvPr id="0" name=""/>
        <dsp:cNvSpPr/>
      </dsp:nvSpPr>
      <dsp:spPr>
        <a:xfrm>
          <a:off x="0" y="57659"/>
          <a:ext cx="5811128" cy="67158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chaos and accident response</a:t>
          </a:r>
        </a:p>
      </dsp:txBody>
      <dsp:txXfrm>
        <a:off x="32784" y="90443"/>
        <a:ext cx="5745560" cy="606012"/>
      </dsp:txXfrm>
    </dsp:sp>
    <dsp:sp modelId="{A18A1873-B0AC-46D9-AA61-70BA4B047E25}">
      <dsp:nvSpPr>
        <dsp:cNvPr id="0" name=""/>
        <dsp:cNvSpPr/>
      </dsp:nvSpPr>
      <dsp:spPr>
        <a:xfrm>
          <a:off x="0" y="809879"/>
          <a:ext cx="5811128" cy="671580"/>
        </a:xfrm>
        <a:prstGeom prst="roundRect">
          <a:avLst/>
        </a:prstGeom>
        <a:solidFill>
          <a:schemeClr val="accent2">
            <a:hueOff val="-291073"/>
            <a:satOff val="-16786"/>
            <a:lumOff val="172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intrusive reflections</a:t>
          </a:r>
        </a:p>
      </dsp:txBody>
      <dsp:txXfrm>
        <a:off x="32784" y="842663"/>
        <a:ext cx="5745560" cy="606012"/>
      </dsp:txXfrm>
    </dsp:sp>
    <dsp:sp modelId="{874329C0-0370-4FDA-9FF7-25AD17B223C9}">
      <dsp:nvSpPr>
        <dsp:cNvPr id="0" name=""/>
        <dsp:cNvSpPr/>
      </dsp:nvSpPr>
      <dsp:spPr>
        <a:xfrm>
          <a:off x="0" y="1562099"/>
          <a:ext cx="5811128" cy="671580"/>
        </a:xfrm>
        <a:prstGeom prst="roundRect">
          <a:avLst/>
        </a:prstGeom>
        <a:solidFill>
          <a:schemeClr val="accent2">
            <a:hueOff val="-582145"/>
            <a:satOff val="-33571"/>
            <a:lumOff val="345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restoring personal integrity</a:t>
          </a:r>
        </a:p>
      </dsp:txBody>
      <dsp:txXfrm>
        <a:off x="32784" y="1594883"/>
        <a:ext cx="5745560" cy="606012"/>
      </dsp:txXfrm>
    </dsp:sp>
    <dsp:sp modelId="{C3FA4E35-4C38-4EB3-ABA9-C42CB2184707}">
      <dsp:nvSpPr>
        <dsp:cNvPr id="0" name=""/>
        <dsp:cNvSpPr/>
      </dsp:nvSpPr>
      <dsp:spPr>
        <a:xfrm>
          <a:off x="0" y="2314319"/>
          <a:ext cx="5811128" cy="671580"/>
        </a:xfrm>
        <a:prstGeom prst="roundRect">
          <a:avLst/>
        </a:prstGeom>
        <a:solidFill>
          <a:schemeClr val="accent2">
            <a:hueOff val="-873218"/>
            <a:satOff val="-50357"/>
            <a:lumOff val="517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enduring the inquisition</a:t>
          </a:r>
        </a:p>
      </dsp:txBody>
      <dsp:txXfrm>
        <a:off x="32784" y="2347103"/>
        <a:ext cx="5745560" cy="606012"/>
      </dsp:txXfrm>
    </dsp:sp>
    <dsp:sp modelId="{F42F488E-7B6C-4CF8-84AD-60127C4926B3}">
      <dsp:nvSpPr>
        <dsp:cNvPr id="0" name=""/>
        <dsp:cNvSpPr/>
      </dsp:nvSpPr>
      <dsp:spPr>
        <a:xfrm>
          <a:off x="0" y="3066539"/>
          <a:ext cx="5811128" cy="671580"/>
        </a:xfrm>
        <a:prstGeom prst="roundRect">
          <a:avLst/>
        </a:prstGeom>
        <a:solidFill>
          <a:schemeClr val="accent2">
            <a:hueOff val="-1164290"/>
            <a:satOff val="-67142"/>
            <a:lumOff val="690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obtaining emotional first aid</a:t>
          </a:r>
        </a:p>
      </dsp:txBody>
      <dsp:txXfrm>
        <a:off x="32784" y="3099323"/>
        <a:ext cx="5745560" cy="606012"/>
      </dsp:txXfrm>
    </dsp:sp>
    <dsp:sp modelId="{AE6839EC-AB35-4936-819C-F5562AA2AB44}">
      <dsp:nvSpPr>
        <dsp:cNvPr id="0" name=""/>
        <dsp:cNvSpPr/>
      </dsp:nvSpPr>
      <dsp:spPr>
        <a:xfrm>
          <a:off x="0" y="3818759"/>
          <a:ext cx="5811128" cy="671580"/>
        </a:xfrm>
        <a:prstGeom prst="roundRect">
          <a:avLst/>
        </a:prstGeom>
        <a:solidFill>
          <a:schemeClr val="accent2">
            <a:hueOff val="-1455363"/>
            <a:satOff val="-83928"/>
            <a:lumOff val="862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l" defTabSz="1244600">
            <a:lnSpc>
              <a:spcPct val="90000"/>
            </a:lnSpc>
            <a:spcBef>
              <a:spcPct val="0"/>
            </a:spcBef>
            <a:spcAft>
              <a:spcPct val="35000"/>
            </a:spcAft>
            <a:buNone/>
          </a:pPr>
          <a:r>
            <a:rPr lang="en-US" sz="2800" kern="1200"/>
            <a:t>moving on</a:t>
          </a:r>
        </a:p>
      </dsp:txBody>
      <dsp:txXfrm>
        <a:off x="32784" y="3851543"/>
        <a:ext cx="5745560" cy="606012"/>
      </dsp:txXfrm>
    </dsp:sp>
    <dsp:sp modelId="{6ADFD48B-6466-4A8D-9CAE-14E60CC08537}">
      <dsp:nvSpPr>
        <dsp:cNvPr id="0" name=""/>
        <dsp:cNvSpPr/>
      </dsp:nvSpPr>
      <dsp:spPr>
        <a:xfrm>
          <a:off x="0" y="4490339"/>
          <a:ext cx="5811128" cy="11302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84503" tIns="35560" rIns="199136" bIns="35560" numCol="1" spcCol="1270" anchor="t" anchorCtr="0">
          <a:noAutofit/>
        </a:bodyPr>
        <a:lstStyle/>
        <a:p>
          <a:pPr marL="228600" lvl="1" indent="-228600" algn="l" defTabSz="977900">
            <a:lnSpc>
              <a:spcPct val="90000"/>
            </a:lnSpc>
            <a:spcBef>
              <a:spcPct val="0"/>
            </a:spcBef>
            <a:spcAft>
              <a:spcPct val="20000"/>
            </a:spcAft>
            <a:buChar char="•"/>
          </a:pPr>
          <a:r>
            <a:rPr lang="en-US" sz="2200" kern="1200"/>
            <a:t>drop out</a:t>
          </a:r>
        </a:p>
        <a:p>
          <a:pPr marL="228600" lvl="1" indent="-228600" algn="l" defTabSz="977900">
            <a:lnSpc>
              <a:spcPct val="90000"/>
            </a:lnSpc>
            <a:spcBef>
              <a:spcPct val="0"/>
            </a:spcBef>
            <a:spcAft>
              <a:spcPct val="20000"/>
            </a:spcAft>
            <a:buChar char="•"/>
          </a:pPr>
          <a:r>
            <a:rPr lang="en-US" sz="2200" kern="1200"/>
            <a:t>Survive</a:t>
          </a:r>
        </a:p>
        <a:p>
          <a:pPr marL="228600" lvl="1" indent="-228600" algn="l" defTabSz="977900">
            <a:lnSpc>
              <a:spcPct val="90000"/>
            </a:lnSpc>
            <a:spcBef>
              <a:spcPct val="0"/>
            </a:spcBef>
            <a:spcAft>
              <a:spcPct val="20000"/>
            </a:spcAft>
            <a:buChar char="•"/>
          </a:pPr>
          <a:r>
            <a:rPr lang="en-US" sz="2200" kern="1200"/>
            <a:t>thrive</a:t>
          </a:r>
        </a:p>
      </dsp:txBody>
      <dsp:txXfrm>
        <a:off x="0" y="4490339"/>
        <a:ext cx="5811128" cy="1130220"/>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4.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5.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0A9FB52-DF47-468F-967E-8FD130C110E8}" type="datetimeFigureOut">
              <a:t>5/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5FD6209-B16A-40ED-9B0D-5FF89551DBC9}" type="slidenum">
              <a:t>‹#›</a:t>
            </a:fld>
            <a:endParaRPr lang="en-US"/>
          </a:p>
        </p:txBody>
      </p:sp>
    </p:spTree>
    <p:extLst>
      <p:ext uri="{BB962C8B-B14F-4D97-AF65-F5344CB8AC3E}">
        <p14:creationId xmlns:p14="http://schemas.microsoft.com/office/powerpoint/2010/main" val="11963432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gratulations today is the third and final session on medical error.  </a:t>
            </a:r>
            <a:endParaRPr lang="en-US"/>
          </a:p>
          <a:p>
            <a:r>
              <a:rPr lang="en-US" dirty="0"/>
              <a:t>Last time we discussed the ethics related to medical error and today we will start practicing some of our skills.  </a:t>
            </a:r>
          </a:p>
          <a:p>
            <a:r>
              <a:rPr lang="en-US" dirty="0"/>
              <a:t>Learning takes a lot of courage- you have to be willing to be honest about your skills and knowledge and be willing to fail in order to learn.  </a:t>
            </a:r>
          </a:p>
          <a:p>
            <a:r>
              <a:rPr lang="en-US" dirty="0"/>
              <a:t>Let’s take this chance to learn in a safe setting.  </a:t>
            </a:r>
          </a:p>
          <a:p>
            <a:r>
              <a:rPr lang="en-US" dirty="0"/>
              <a:t>Remember any discussion of error is protected and private today. </a:t>
            </a:r>
          </a:p>
          <a:p>
            <a:r>
              <a:rPr lang="en-US" dirty="0"/>
              <a:t>We are using this for learning and improvement</a:t>
            </a:r>
          </a:p>
        </p:txBody>
      </p:sp>
      <p:sp>
        <p:nvSpPr>
          <p:cNvPr id="4" name="Slide Number Placeholder 3"/>
          <p:cNvSpPr>
            <a:spLocks noGrp="1"/>
          </p:cNvSpPr>
          <p:nvPr>
            <p:ph type="sldNum" sz="quarter" idx="5"/>
          </p:nvPr>
        </p:nvSpPr>
        <p:spPr/>
        <p:txBody>
          <a:bodyPr/>
          <a:lstStyle/>
          <a:p>
            <a:fld id="{65FD6209-B16A-40ED-9B0D-5FF89551DBC9}" type="slidenum">
              <a:rPr lang="en-US" smtClean="0"/>
              <a:t>1</a:t>
            </a:fld>
            <a:endParaRPr lang="en-US"/>
          </a:p>
        </p:txBody>
      </p:sp>
    </p:spTree>
    <p:extLst>
      <p:ext uri="{BB962C8B-B14F-4D97-AF65-F5344CB8AC3E}">
        <p14:creationId xmlns:p14="http://schemas.microsoft.com/office/powerpoint/2010/main" val="112965599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endParaRPr lang="en-US" dirty="0">
              <a:cs typeface="Calibri"/>
            </a:endParaRPr>
          </a:p>
          <a:p>
            <a:r>
              <a:rPr lang="en-US" dirty="0">
                <a:cs typeface="Calibri"/>
              </a:rPr>
              <a:t>-Doctors/humans are emotional.  Acknowledge and park your natural Fear/defensiveness with error</a:t>
            </a:r>
            <a:endParaRPr lang="en-US" dirty="0">
              <a:ea typeface="Calibri"/>
              <a:cs typeface="Calibri"/>
            </a:endParaRPr>
          </a:p>
          <a:p>
            <a:r>
              <a:rPr lang="en-US" dirty="0">
                <a:cs typeface="Calibri"/>
              </a:rPr>
              <a:t>-We may initially worry what will happen to me?</a:t>
            </a:r>
            <a:endParaRPr lang="en-US" dirty="0">
              <a:ea typeface="Calibri"/>
              <a:cs typeface="Calibri"/>
            </a:endParaRPr>
          </a:p>
          <a:p>
            <a:r>
              <a:rPr lang="en-US" dirty="0">
                <a:ea typeface="Calibri"/>
                <a:cs typeface="Calibri"/>
              </a:rPr>
              <a:t>-Instead, refocus on patient/family</a:t>
            </a:r>
            <a:endParaRPr lang="en-US" dirty="0">
              <a:cs typeface="Calibri"/>
            </a:endParaRPr>
          </a:p>
          <a:p>
            <a:r>
              <a:rPr lang="en-US" dirty="0">
                <a:ea typeface="Calibri"/>
                <a:cs typeface="Calibri"/>
              </a:rPr>
              <a:t>-Acknowledge the incident</a:t>
            </a:r>
            <a:endParaRPr lang="en-US" dirty="0">
              <a:cs typeface="Calibri"/>
            </a:endParaRPr>
          </a:p>
          <a:p>
            <a:r>
              <a:rPr lang="en-US" dirty="0">
                <a:ea typeface="Calibri"/>
                <a:cs typeface="Calibri"/>
              </a:rPr>
              <a:t>-Express regret/apology</a:t>
            </a:r>
            <a:endParaRPr lang="en-US" dirty="0">
              <a:cs typeface="Calibri"/>
            </a:endParaRPr>
          </a:p>
          <a:p>
            <a:r>
              <a:rPr lang="en-US" dirty="0">
                <a:cs typeface="Calibri"/>
              </a:rPr>
              <a:t>-Allow pt to express/sit with their emotion...“</a:t>
            </a:r>
            <a:r>
              <a:rPr lang="en-US" dirty="0"/>
              <a:t>will I (or my loved one) be ok?</a:t>
            </a:r>
            <a:endParaRPr lang="en-US" dirty="0">
              <a:cs typeface="Calibri"/>
            </a:endParaRPr>
          </a:p>
          <a:p>
            <a:r>
              <a:rPr lang="en-US" dirty="0"/>
              <a:t>-Learning how we respond to the emotions of others helps us rehearse/prepare</a:t>
            </a:r>
            <a:endParaRPr lang="en-US" dirty="0">
              <a:cs typeface="Calibri"/>
            </a:endParaRPr>
          </a:p>
          <a:p>
            <a:r>
              <a:rPr lang="en-US" dirty="0"/>
              <a:t>-Respond to emotional concerns with empathy and reassurance.  Respond to cognitive concerns with information</a:t>
            </a:r>
            <a:endParaRPr lang="en-US" dirty="0">
              <a:ea typeface="Calibri" panose="020F0502020204030204"/>
              <a:cs typeface="Calibri" panose="020F0502020204030204"/>
            </a:endParaRPr>
          </a:p>
          <a:p>
            <a:pPr marL="171450" indent="-171450">
              <a:buFont typeface="Arial"/>
              <a:buChar char="•"/>
            </a:pPr>
            <a:r>
              <a:rPr lang="en-US" dirty="0"/>
              <a:t>End with empathy, reassurance (if possible), and assuring your availability, making sure questions have been addressed</a:t>
            </a:r>
            <a:endParaRPr lang="en-US" dirty="0">
              <a:ea typeface="Calibri" panose="020F0502020204030204"/>
              <a:cs typeface="Calibri" panose="020F0502020204030204"/>
            </a:endParaRPr>
          </a:p>
          <a:p>
            <a:r>
              <a:rPr lang="en-US" dirty="0">
                <a:ea typeface="Calibri" panose="020F0502020204030204"/>
                <a:cs typeface="Calibri" panose="020F0502020204030204"/>
              </a:rPr>
              <a:t>-Seek support</a:t>
            </a:r>
          </a:p>
          <a:p>
            <a:r>
              <a:rPr lang="en-US" dirty="0">
                <a:ea typeface="Calibri" panose="020F0502020204030204"/>
                <a:cs typeface="Calibri" panose="020F0502020204030204"/>
              </a:rPr>
              <a:t>-Help staff seek support</a:t>
            </a:r>
          </a:p>
          <a:p>
            <a:endParaRPr lang="en-US"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65FD6209-B16A-40ED-9B0D-5FF89551DBC9}" type="slidenum">
              <a:rPr lang="en-US"/>
              <a:t>10</a:t>
            </a:fld>
            <a:endParaRPr lang="en-US"/>
          </a:p>
        </p:txBody>
      </p:sp>
    </p:spTree>
    <p:extLst>
      <p:ext uri="{BB962C8B-B14F-4D97-AF65-F5344CB8AC3E}">
        <p14:creationId xmlns:p14="http://schemas.microsoft.com/office/powerpoint/2010/main" val="251572980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Materials:</a:t>
            </a:r>
          </a:p>
          <a:p>
            <a:r>
              <a:rPr lang="en-US" dirty="0">
                <a:ea typeface="Calibri"/>
                <a:cs typeface="Calibri"/>
              </a:rPr>
              <a:t>Clinical error cases for session 3 roleplay handout OR</a:t>
            </a:r>
          </a:p>
          <a:p>
            <a:r>
              <a:rPr lang="en-US" dirty="0">
                <a:ea typeface="Calibri"/>
                <a:cs typeface="Calibri"/>
              </a:rPr>
              <a:t>Faculty developed error stories to share with groups (3 different error stories) </a:t>
            </a:r>
            <a:endParaRPr lang="en-US" dirty="0"/>
          </a:p>
          <a:p>
            <a:endParaRPr lang="en-US" dirty="0">
              <a:ea typeface="Calibri"/>
              <a:cs typeface="Calibri"/>
            </a:endParaRPr>
          </a:p>
          <a:p>
            <a:r>
              <a:rPr lang="en-US" dirty="0">
                <a:ea typeface="Calibri"/>
                <a:cs typeface="Calibri"/>
              </a:rPr>
              <a:t>Small group exercise:</a:t>
            </a:r>
            <a:endParaRPr lang="en-US" dirty="0"/>
          </a:p>
          <a:p>
            <a:r>
              <a:rPr lang="en-US" dirty="0"/>
              <a:t>Residents can improve their confidence in error disclosure and management by practicing</a:t>
            </a:r>
            <a:endParaRPr lang="en-US" dirty="0">
              <a:ea typeface="Calibri"/>
              <a:cs typeface="Calibri"/>
            </a:endParaRPr>
          </a:p>
          <a:p>
            <a:r>
              <a:rPr lang="en-US" dirty="0">
                <a:ea typeface="Calibri"/>
                <a:cs typeface="Calibri"/>
              </a:rPr>
              <a:t>Now we are going to practice error disclosure</a:t>
            </a:r>
          </a:p>
          <a:p>
            <a:r>
              <a:rPr lang="en-US" dirty="0"/>
              <a:t>Learners should split into groups of 3 with a case (faculty developed or handout)</a:t>
            </a:r>
            <a:endParaRPr lang="en-US" dirty="0">
              <a:ea typeface="Calibri"/>
              <a:cs typeface="Calibri"/>
            </a:endParaRPr>
          </a:p>
          <a:p>
            <a:r>
              <a:rPr lang="en-US" dirty="0">
                <a:ea typeface="Calibri"/>
                <a:cs typeface="Calibri"/>
              </a:rPr>
              <a:t>Look at case</a:t>
            </a:r>
            <a:endParaRPr lang="en-US" dirty="0"/>
          </a:p>
          <a:p>
            <a:r>
              <a:rPr lang="en-US" dirty="0">
                <a:ea typeface="Calibri"/>
                <a:cs typeface="Calibri"/>
              </a:rPr>
              <a:t>Choose a role (physician, patient/family, observer)</a:t>
            </a:r>
          </a:p>
          <a:p>
            <a:r>
              <a:rPr lang="en-US" dirty="0">
                <a:ea typeface="Calibri"/>
                <a:cs typeface="Calibri"/>
              </a:rPr>
              <a:t>Role play a case for 2 minutes then switch</a:t>
            </a:r>
          </a:p>
          <a:p>
            <a:r>
              <a:rPr lang="en-US" dirty="0">
                <a:ea typeface="Calibri"/>
                <a:cs typeface="Calibri"/>
              </a:rPr>
              <a:t>Debrief/discuss as a large group</a:t>
            </a:r>
            <a:endParaRPr lang="en-US" dirty="0"/>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t>11</a:t>
            </a:fld>
            <a:endParaRPr lang="en-US"/>
          </a:p>
        </p:txBody>
      </p:sp>
    </p:spTree>
    <p:extLst>
      <p:ext uri="{BB962C8B-B14F-4D97-AF65-F5344CB8AC3E}">
        <p14:creationId xmlns:p14="http://schemas.microsoft.com/office/powerpoint/2010/main" val="72188078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OPTIONAL: Review video clip</a:t>
            </a:r>
          </a:p>
          <a:p>
            <a:r>
              <a:rPr lang="en-US" dirty="0"/>
              <a:t>Video is lengthy, but one option is to select a clip of a poor disclosure (3:42 to 6:49) and have residents evaluate the disclosure in large group discussion, asking ‘What went well?’ and also ‘What can we do better?’</a:t>
            </a:r>
            <a:endParaRPr lang="en-US" dirty="0">
              <a:cs typeface="Calibri"/>
            </a:endParaRPr>
          </a:p>
          <a:p>
            <a:pPr>
              <a:defRPr/>
            </a:pPr>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rPr lang="en-US" smtClean="0"/>
              <a:t>12</a:t>
            </a:fld>
            <a:endParaRPr lang="en-US"/>
          </a:p>
        </p:txBody>
      </p:sp>
    </p:spTree>
    <p:extLst>
      <p:ext uri="{BB962C8B-B14F-4D97-AF65-F5344CB8AC3E}">
        <p14:creationId xmlns:p14="http://schemas.microsoft.com/office/powerpoint/2010/main" val="12450582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endParaRPr lang="en-US" dirty="0">
              <a:cs typeface="Calibri"/>
            </a:endParaRPr>
          </a:p>
          <a:p>
            <a:r>
              <a:rPr lang="en-US" dirty="0">
                <a:cs typeface="Calibri"/>
              </a:rPr>
              <a:t>So we have taken care of our patient medically, talked to them about what happened, now we want to prevent the error if possible in future.  </a:t>
            </a:r>
            <a:endParaRPr lang="en-US" dirty="0">
              <a:ea typeface="Calibri"/>
              <a:cs typeface="Calibri"/>
            </a:endParaRPr>
          </a:p>
          <a:p>
            <a:r>
              <a:rPr lang="en-US" dirty="0">
                <a:cs typeface="Calibri"/>
              </a:rPr>
              <a:t>Root Cause Analysis is a way to do this work.  </a:t>
            </a:r>
          </a:p>
          <a:p>
            <a:r>
              <a:rPr lang="en-US">
                <a:cs typeface="Calibri"/>
              </a:rPr>
              <a:t>There are many reasons for medical error, in fact physician cognitive or procedural error is not the most common cause. </a:t>
            </a:r>
          </a:p>
          <a:p>
            <a:r>
              <a:rPr lang="en-US" dirty="0">
                <a:ea typeface="Calibri" panose="020F0502020204030204"/>
                <a:cs typeface="Calibri" panose="020F0502020204030204"/>
              </a:rPr>
              <a:t>As we discussed in session 1, many errors are the result of multiple system failures</a:t>
            </a:r>
          </a:p>
        </p:txBody>
      </p:sp>
      <p:sp>
        <p:nvSpPr>
          <p:cNvPr id="4" name="Slide Number Placeholder 3"/>
          <p:cNvSpPr>
            <a:spLocks noGrp="1"/>
          </p:cNvSpPr>
          <p:nvPr>
            <p:ph type="sldNum" sz="quarter" idx="5"/>
          </p:nvPr>
        </p:nvSpPr>
        <p:spPr/>
        <p:txBody>
          <a:bodyPr/>
          <a:lstStyle/>
          <a:p>
            <a:fld id="{65FD6209-B16A-40ED-9B0D-5FF89551DBC9}" type="slidenum">
              <a:rPr lang="en-US"/>
              <a:t>13</a:t>
            </a:fld>
            <a:endParaRPr lang="en-US"/>
          </a:p>
        </p:txBody>
      </p:sp>
    </p:spTree>
    <p:extLst>
      <p:ext uri="{BB962C8B-B14F-4D97-AF65-F5344CB8AC3E}">
        <p14:creationId xmlns:p14="http://schemas.microsoft.com/office/powerpoint/2010/main" val="376121791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Materials:</a:t>
            </a:r>
          </a:p>
          <a:p>
            <a:r>
              <a:rPr lang="en-US" dirty="0">
                <a:ea typeface="Calibri"/>
                <a:cs typeface="Calibri"/>
              </a:rPr>
              <a:t>Paper and pen</a:t>
            </a:r>
          </a:p>
          <a:p>
            <a:endParaRPr lang="en-US" dirty="0">
              <a:ea typeface="Calibri"/>
              <a:cs typeface="Calibri"/>
            </a:endParaRPr>
          </a:p>
          <a:p>
            <a:r>
              <a:rPr lang="en-US" dirty="0">
                <a:ea typeface="Calibri"/>
                <a:cs typeface="Calibri"/>
              </a:rPr>
              <a:t>Self-reflection:</a:t>
            </a:r>
          </a:p>
          <a:p>
            <a:r>
              <a:rPr lang="en-US" dirty="0"/>
              <a:t>Learners can improve their confidence in error prevention and management by practicing root cause analysis/reflection.</a:t>
            </a:r>
            <a:endParaRPr lang="en-US" dirty="0">
              <a:ea typeface="Calibri"/>
              <a:cs typeface="Calibri"/>
            </a:endParaRPr>
          </a:p>
          <a:p>
            <a:r>
              <a:rPr lang="en-US" dirty="0">
                <a:cs typeface="Calibri"/>
              </a:rPr>
              <a:t>Non medicine 'case' for reflection is fine</a:t>
            </a:r>
            <a:endParaRPr lang="en-US" dirty="0">
              <a:ea typeface="Calibri"/>
              <a:cs typeface="Calibri"/>
            </a:endParaRPr>
          </a:p>
          <a:p>
            <a:r>
              <a:rPr lang="en-US" dirty="0">
                <a:cs typeface="Calibri"/>
              </a:rPr>
              <a:t>Switch back to Root Cause Analysis reminders (slide 11) to allow learners to work through process</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t>14</a:t>
            </a:fld>
            <a:endParaRPr lang="en-US"/>
          </a:p>
        </p:txBody>
      </p:sp>
    </p:spTree>
    <p:extLst>
      <p:ext uri="{BB962C8B-B14F-4D97-AF65-F5344CB8AC3E}">
        <p14:creationId xmlns:p14="http://schemas.microsoft.com/office/powerpoint/2010/main" val="97920378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endParaRPr lang="en-US" dirty="0">
              <a:cs typeface="Calibri"/>
            </a:endParaRPr>
          </a:p>
          <a:p>
            <a:r>
              <a:rPr lang="en-US" dirty="0">
                <a:ea typeface="Calibri"/>
                <a:cs typeface="Calibri"/>
              </a:rPr>
              <a:t>Where do you get emotional support?</a:t>
            </a:r>
            <a:endParaRPr lang="en-US" dirty="0">
              <a:cs typeface="Calibri"/>
            </a:endParaRPr>
          </a:p>
          <a:p>
            <a:endParaRPr lang="en-US" dirty="0">
              <a:cs typeface="Calibri"/>
            </a:endParaRPr>
          </a:p>
          <a:p>
            <a:r>
              <a:rPr lang="en-US" dirty="0">
                <a:cs typeface="Calibri"/>
              </a:rPr>
              <a:t>OPTIONAL: Poll question to allow learners to report anonymously </a:t>
            </a:r>
            <a:endParaRPr lang="en-US" dirty="0"/>
          </a:p>
        </p:txBody>
      </p:sp>
      <p:sp>
        <p:nvSpPr>
          <p:cNvPr id="4" name="Slide Number Placeholder 3"/>
          <p:cNvSpPr>
            <a:spLocks noGrp="1"/>
          </p:cNvSpPr>
          <p:nvPr>
            <p:ph type="sldNum" sz="quarter" idx="5"/>
          </p:nvPr>
        </p:nvSpPr>
        <p:spPr/>
        <p:txBody>
          <a:bodyPr/>
          <a:lstStyle/>
          <a:p>
            <a:fld id="{65FD6209-B16A-40ED-9B0D-5FF89551DBC9}" type="slidenum">
              <a:t>15</a:t>
            </a:fld>
            <a:endParaRPr lang="en-US"/>
          </a:p>
        </p:txBody>
      </p:sp>
    </p:spTree>
    <p:extLst>
      <p:ext uri="{BB962C8B-B14F-4D97-AF65-F5344CB8AC3E}">
        <p14:creationId xmlns:p14="http://schemas.microsoft.com/office/powerpoint/2010/main" val="133999884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endParaRPr lang="en-US" dirty="0">
              <a:cs typeface="Calibri"/>
            </a:endParaRPr>
          </a:p>
          <a:p>
            <a:r>
              <a:rPr lang="en-US" dirty="0">
                <a:cs typeface="Calibri"/>
              </a:rPr>
              <a:t>You may recall a study that we have referenced through this series, relating to physician response to error.  </a:t>
            </a:r>
          </a:p>
          <a:p>
            <a:r>
              <a:rPr lang="en-US" dirty="0">
                <a:cs typeface="Calibri"/>
              </a:rPr>
              <a:t>There appears to be a common trajectory, with differing endpoints (drop out, survive, thrive)</a:t>
            </a:r>
            <a:endParaRPr lang="en-US" dirty="0">
              <a:ea typeface="Calibri" panose="020F0502020204030204"/>
              <a:cs typeface="Calibri" panose="020F0502020204030204"/>
            </a:endParaRPr>
          </a:p>
          <a:p>
            <a:r>
              <a:rPr lang="en-US" dirty="0"/>
              <a:t>Scott et al 2009. interview findings with 31 second victims. Volunteers representing different professional groups were solicited for private, hour-long semi-structured interviews. Univ Missouri Healthcare</a:t>
            </a:r>
            <a:endParaRPr lang="en-US" dirty="0">
              <a:ea typeface="Calibri" panose="020F0502020204030204"/>
              <a:cs typeface="Calibri"/>
            </a:endParaRPr>
          </a:p>
          <a:p>
            <a:r>
              <a:rPr lang="en-US" dirty="0">
                <a:cs typeface="Calibri"/>
              </a:rPr>
              <a:t>Trajectory is largely predictable</a:t>
            </a:r>
            <a:endParaRPr lang="en-US" dirty="0">
              <a:ea typeface="Calibri"/>
              <a:cs typeface="Calibri"/>
            </a:endParaRPr>
          </a:p>
          <a:p>
            <a:r>
              <a:rPr lang="en-US" dirty="0">
                <a:cs typeface="Calibri"/>
              </a:rPr>
              <a:t>How organizations handle medical error can significantly impact recovery outcome</a:t>
            </a:r>
          </a:p>
          <a:p>
            <a:r>
              <a:rPr lang="en-US" dirty="0">
                <a:cs typeface="Calibri"/>
              </a:rPr>
              <a:t>Critical Incident Stress Management techniques and formal support network known as Medically Induced Trauma Support Services are examples of education and programs that organizations can support/develop</a:t>
            </a:r>
            <a:endParaRPr lang="en-US" dirty="0"/>
          </a:p>
        </p:txBody>
      </p:sp>
      <p:sp>
        <p:nvSpPr>
          <p:cNvPr id="4" name="Slide Number Placeholder 3"/>
          <p:cNvSpPr>
            <a:spLocks noGrp="1"/>
          </p:cNvSpPr>
          <p:nvPr>
            <p:ph type="sldNum" sz="quarter" idx="5"/>
          </p:nvPr>
        </p:nvSpPr>
        <p:spPr/>
        <p:txBody>
          <a:bodyPr/>
          <a:lstStyle/>
          <a:p>
            <a:fld id="{65FD6209-B16A-40ED-9B0D-5FF89551DBC9}" type="slidenum">
              <a:rPr lang="en-US"/>
              <a:t>16</a:t>
            </a:fld>
            <a:endParaRPr lang="en-US"/>
          </a:p>
        </p:txBody>
      </p:sp>
    </p:spTree>
    <p:extLst>
      <p:ext uri="{BB962C8B-B14F-4D97-AF65-F5344CB8AC3E}">
        <p14:creationId xmlns:p14="http://schemas.microsoft.com/office/powerpoint/2010/main" val="304233155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endParaRPr lang="en-US" dirty="0"/>
          </a:p>
          <a:p>
            <a:r>
              <a:rPr lang="en-US"/>
              <a:t>Residents can improve their confidence in error management by rehearsing or planning coping skills.</a:t>
            </a:r>
          </a:p>
          <a:p>
            <a:r>
              <a:rPr lang="en-US" dirty="0">
                <a:cs typeface="Calibri"/>
              </a:rPr>
              <a:t>How do you cope with error, near miss, or even just a bad day at work?</a:t>
            </a:r>
            <a:endParaRPr lang="en-US" dirty="0">
              <a:ea typeface="Calibri"/>
              <a:cs typeface="Calibri"/>
            </a:endParaRPr>
          </a:p>
          <a:p>
            <a:r>
              <a:rPr lang="en-US" dirty="0">
                <a:ea typeface="Calibri"/>
                <a:cs typeface="Calibri"/>
              </a:rPr>
              <a:t>Which of these strategies are adaptive and which are not?</a:t>
            </a:r>
          </a:p>
        </p:txBody>
      </p:sp>
      <p:sp>
        <p:nvSpPr>
          <p:cNvPr id="4" name="Slide Number Placeholder 3"/>
          <p:cNvSpPr>
            <a:spLocks noGrp="1"/>
          </p:cNvSpPr>
          <p:nvPr>
            <p:ph type="sldNum" sz="quarter" idx="5"/>
          </p:nvPr>
        </p:nvSpPr>
        <p:spPr/>
        <p:txBody>
          <a:bodyPr/>
          <a:lstStyle/>
          <a:p>
            <a:fld id="{65FD6209-B16A-40ED-9B0D-5FF89551DBC9}" type="slidenum">
              <a:t>17</a:t>
            </a:fld>
            <a:endParaRPr lang="en-US"/>
          </a:p>
        </p:txBody>
      </p:sp>
    </p:spTree>
    <p:extLst>
      <p:ext uri="{BB962C8B-B14F-4D97-AF65-F5344CB8AC3E}">
        <p14:creationId xmlns:p14="http://schemas.microsoft.com/office/powerpoint/2010/main" val="259300401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Materials:</a:t>
            </a:r>
            <a:endParaRPr lang="en-US" dirty="0">
              <a:cs typeface="Calibri"/>
            </a:endParaRPr>
          </a:p>
          <a:p>
            <a:r>
              <a:rPr lang="en-US" dirty="0">
                <a:ea typeface="Calibri" panose="020F0502020204030204"/>
                <a:cs typeface="Calibri"/>
              </a:rPr>
              <a:t>Paper and pen</a:t>
            </a:r>
          </a:p>
          <a:p>
            <a:endParaRPr lang="en-US" dirty="0">
              <a:cs typeface="Calibri"/>
            </a:endParaRPr>
          </a:p>
          <a:p>
            <a:r>
              <a:rPr lang="en-US" dirty="0">
                <a:ea typeface="Calibri"/>
                <a:cs typeface="Calibri"/>
              </a:rPr>
              <a:t>Lecture:</a:t>
            </a:r>
            <a:endParaRPr lang="en-US" dirty="0">
              <a:cs typeface="Calibri"/>
            </a:endParaRPr>
          </a:p>
          <a:p>
            <a:r>
              <a:rPr lang="en-US" dirty="0">
                <a:cs typeface="Calibri"/>
              </a:rPr>
              <a:t>Review the study of wisdom exemplars from session 1 (those who have thrived after error)</a:t>
            </a:r>
            <a:endParaRPr lang="en-US" dirty="0"/>
          </a:p>
          <a:p>
            <a:r>
              <a:rPr lang="en-US" sz="1200" b="0" i="0" u="none" strike="noStrike" kern="1200" dirty="0">
                <a:solidFill>
                  <a:schemeClr val="tx1"/>
                </a:solidFill>
                <a:effectLst/>
                <a:latin typeface="+mn-lt"/>
                <a:ea typeface="+mn-ea"/>
                <a:cs typeface="+mn-cs"/>
              </a:rPr>
              <a:t>Investigators identified themes reflecting </a:t>
            </a:r>
            <a:r>
              <a:rPr lang="en-US" dirty="0"/>
              <a:t>what</a:t>
            </a:r>
            <a:r>
              <a:rPr lang="en-US" sz="1200" b="0" i="0" u="none" strike="noStrike" kern="1200" dirty="0">
                <a:solidFill>
                  <a:schemeClr val="tx1"/>
                </a:solidFill>
                <a:effectLst/>
                <a:latin typeface="+mn-lt"/>
                <a:ea typeface="+mn-ea"/>
                <a:cs typeface="+mn-cs"/>
              </a:rPr>
              <a:t> helped physician wisdom exemplars cope </a:t>
            </a:r>
            <a:r>
              <a:rPr lang="en-US" dirty="0"/>
              <a:t>positively and provided recommendations</a:t>
            </a:r>
            <a:r>
              <a:rPr lang="en-US" sz="1200" b="0" i="0" u="none" strike="noStrike" kern="1200" dirty="0">
                <a:solidFill>
                  <a:schemeClr val="tx1"/>
                </a:solidFill>
                <a:effectLst/>
                <a:latin typeface="+mn-lt"/>
                <a:ea typeface="+mn-ea"/>
                <a:cs typeface="+mn-cs"/>
              </a:rPr>
              <a:t> for institutions</a:t>
            </a:r>
            <a:endParaRPr lang="en-US" dirty="0">
              <a:ea typeface="Calibri"/>
              <a:cs typeface="Calibri"/>
            </a:endParaRPr>
          </a:p>
          <a:p>
            <a:r>
              <a:rPr lang="en-US" dirty="0"/>
              <a:t>Residents can improve their confidence in error management by rehearsing or planning coping skills.</a:t>
            </a:r>
          </a:p>
          <a:p>
            <a:endParaRPr lang="en-US" dirty="0">
              <a:ea typeface="Calibri" panose="020F0502020204030204"/>
              <a:cs typeface="Calibri"/>
            </a:endParaRPr>
          </a:p>
          <a:p>
            <a:r>
              <a:rPr lang="en-US" dirty="0">
                <a:ea typeface="Calibri" panose="020F0502020204030204"/>
                <a:cs typeface="Calibri"/>
              </a:rPr>
              <a:t>Self reflection:</a:t>
            </a:r>
          </a:p>
          <a:p>
            <a:r>
              <a:rPr lang="en-US" dirty="0">
                <a:ea typeface="Calibri" panose="020F0502020204030204"/>
                <a:cs typeface="Calibri"/>
              </a:rPr>
              <a:t>Take a few minutes to write a letter to a colleague to read in the wake of a self perceived failure</a:t>
            </a:r>
          </a:p>
          <a:p>
            <a:r>
              <a:rPr lang="en-US" dirty="0">
                <a:ea typeface="Calibri" panose="020F0502020204030204"/>
                <a:cs typeface="Calibri"/>
              </a:rPr>
              <a:t>What do you want to remind them of?</a:t>
            </a:r>
          </a:p>
          <a:p>
            <a:r>
              <a:rPr lang="en-US" dirty="0">
                <a:ea typeface="Calibri" panose="020F0502020204030204"/>
                <a:cs typeface="Calibri"/>
              </a:rPr>
              <a:t>What do you hope they will feel and do?</a:t>
            </a:r>
          </a:p>
          <a:p>
            <a:r>
              <a:rPr lang="en-US" dirty="0">
                <a:ea typeface="Calibri" panose="020F0502020204030204"/>
                <a:cs typeface="Calibri"/>
              </a:rPr>
              <a:t>Where can they find strength and support?</a:t>
            </a:r>
          </a:p>
        </p:txBody>
      </p:sp>
      <p:sp>
        <p:nvSpPr>
          <p:cNvPr id="4" name="Slide Number Placeholder 3"/>
          <p:cNvSpPr>
            <a:spLocks noGrp="1"/>
          </p:cNvSpPr>
          <p:nvPr>
            <p:ph type="sldNum" sz="quarter" idx="5"/>
          </p:nvPr>
        </p:nvSpPr>
        <p:spPr/>
        <p:txBody>
          <a:bodyPr/>
          <a:lstStyle/>
          <a:p>
            <a:fld id="{65FD6209-B16A-40ED-9B0D-5FF89551DBC9}" type="slidenum">
              <a:t>18</a:t>
            </a:fld>
            <a:endParaRPr lang="en-US"/>
          </a:p>
        </p:txBody>
      </p:sp>
    </p:spTree>
    <p:extLst>
      <p:ext uri="{BB962C8B-B14F-4D97-AF65-F5344CB8AC3E}">
        <p14:creationId xmlns:p14="http://schemas.microsoft.com/office/powerpoint/2010/main" val="167680347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Lecture:</a:t>
            </a:r>
          </a:p>
          <a:p>
            <a:r>
              <a:rPr lang="en-US" dirty="0">
                <a:cs typeface="Calibri"/>
              </a:rPr>
              <a:t>I know you may already have some ideas for personal coping, from your wellness curriculum/plan or from other experiences.  </a:t>
            </a:r>
          </a:p>
          <a:p>
            <a:r>
              <a:rPr lang="en-US" dirty="0">
                <a:cs typeface="Calibri"/>
              </a:rPr>
              <a:t>There are many resources for coping, including things you can do on your own if you are not ready to reach out to someone else yet (consider the University of Wisconsin's integrative health section on relaxing and healing)</a:t>
            </a:r>
          </a:p>
          <a:p>
            <a:r>
              <a:rPr lang="en-US" dirty="0">
                <a:ea typeface="Calibri"/>
                <a:cs typeface="Calibri"/>
              </a:rPr>
              <a:t>If you would like to reach our to someone, your Employee Assistance Program can be a good place to start</a:t>
            </a:r>
          </a:p>
          <a:p>
            <a:r>
              <a:rPr lang="en-US" dirty="0">
                <a:ea typeface="Calibri"/>
                <a:cs typeface="Calibri"/>
              </a:rPr>
              <a:t>OPTIONAL: feel free to personalize to include local support services/programs</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rPr lang="en-US"/>
              <a:t>19</a:t>
            </a:fld>
            <a:endParaRPr lang="en-US"/>
          </a:p>
        </p:txBody>
      </p:sp>
    </p:spTree>
    <p:extLst>
      <p:ext uri="{BB962C8B-B14F-4D97-AF65-F5344CB8AC3E}">
        <p14:creationId xmlns:p14="http://schemas.microsoft.com/office/powerpoint/2010/main" val="41385193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p>
          <a:p>
            <a:r>
              <a:rPr lang="en-US" dirty="0"/>
              <a:t>Practicing self-awareness can improve our confidence in reducing risk for error.</a:t>
            </a:r>
          </a:p>
          <a:p>
            <a:r>
              <a:rPr lang="en-US" dirty="0">
                <a:ea typeface="Calibri"/>
                <a:cs typeface="Calibri"/>
              </a:rPr>
              <a:t>Have learners self reflect on how they are feeling.</a:t>
            </a:r>
          </a:p>
          <a:p>
            <a:endParaRPr lang="en-US" dirty="0">
              <a:ea typeface="Calibri"/>
              <a:cs typeface="Calibri"/>
            </a:endParaRPr>
          </a:p>
          <a:p>
            <a:r>
              <a:rPr lang="en-US" dirty="0">
                <a:ea typeface="Calibri"/>
                <a:cs typeface="Calibri"/>
              </a:rPr>
              <a:t>OPTIONAL: Use polling software to have learners participate and answer questions</a:t>
            </a:r>
          </a:p>
        </p:txBody>
      </p:sp>
      <p:sp>
        <p:nvSpPr>
          <p:cNvPr id="4" name="Slide Number Placeholder 3"/>
          <p:cNvSpPr>
            <a:spLocks noGrp="1"/>
          </p:cNvSpPr>
          <p:nvPr>
            <p:ph type="sldNum" sz="quarter" idx="5"/>
          </p:nvPr>
        </p:nvSpPr>
        <p:spPr/>
        <p:txBody>
          <a:bodyPr/>
          <a:lstStyle/>
          <a:p>
            <a:fld id="{65FD6209-B16A-40ED-9B0D-5FF89551DBC9}" type="slidenum">
              <a:t>2</a:t>
            </a:fld>
            <a:endParaRPr lang="en-US"/>
          </a:p>
        </p:txBody>
      </p:sp>
    </p:spTree>
    <p:extLst>
      <p:ext uri="{BB962C8B-B14F-4D97-AF65-F5344CB8AC3E}">
        <p14:creationId xmlns:p14="http://schemas.microsoft.com/office/powerpoint/2010/main" val="4279120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p>
          <a:p>
            <a:r>
              <a:rPr lang="en-US" dirty="0">
                <a:ea typeface="Calibri"/>
                <a:cs typeface="Calibri"/>
              </a:rPr>
              <a:t>Summarize for learners that they are humans who are fallible</a:t>
            </a:r>
          </a:p>
          <a:p>
            <a:r>
              <a:rPr lang="en-US" dirty="0">
                <a:ea typeface="Calibri"/>
                <a:cs typeface="Calibri"/>
              </a:rPr>
              <a:t>They are capable of surviving and growing from mistakes</a:t>
            </a:r>
          </a:p>
          <a:p>
            <a:r>
              <a:rPr lang="en-US" dirty="0">
                <a:ea typeface="Calibri"/>
                <a:cs typeface="Calibri"/>
              </a:rPr>
              <a:t>Supportive environment is key</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rPr lang="en-US"/>
              <a:t>20</a:t>
            </a:fld>
            <a:endParaRPr lang="en-US"/>
          </a:p>
        </p:txBody>
      </p:sp>
    </p:spTree>
    <p:extLst>
      <p:ext uri="{BB962C8B-B14F-4D97-AF65-F5344CB8AC3E}">
        <p14:creationId xmlns:p14="http://schemas.microsoft.com/office/powerpoint/2010/main" val="101399865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p>
          <a:p>
            <a:r>
              <a:rPr lang="en-US" dirty="0">
                <a:cs typeface="Calibri"/>
              </a:rPr>
              <a:t>I want to remind you that we are all responsible for the state of our profession.  </a:t>
            </a:r>
            <a:endParaRPr lang="en-US" dirty="0">
              <a:ea typeface="Calibri"/>
              <a:cs typeface="Calibri"/>
            </a:endParaRPr>
          </a:p>
          <a:p>
            <a:r>
              <a:rPr lang="en-US" dirty="0">
                <a:cs typeface="Calibri"/>
              </a:rPr>
              <a:t>One of my heroes is David Hilfiker- a family physician (rural MN) who wrote a seminal article in 1984 in NEJM relating the story of a medical error.  This is an excerpt of that writing.</a:t>
            </a:r>
            <a:endParaRPr lang="en-US" dirty="0"/>
          </a:p>
          <a:p>
            <a:r>
              <a:rPr lang="en-US" dirty="0">
                <a:cs typeface="Calibri"/>
              </a:rPr>
              <a:t>CONSIDER INSERTING A PHOTO OF DR HILFIKER</a:t>
            </a:r>
          </a:p>
        </p:txBody>
      </p:sp>
      <p:sp>
        <p:nvSpPr>
          <p:cNvPr id="4" name="Slide Number Placeholder 3"/>
          <p:cNvSpPr>
            <a:spLocks noGrp="1"/>
          </p:cNvSpPr>
          <p:nvPr>
            <p:ph type="sldNum" sz="quarter" idx="5"/>
          </p:nvPr>
        </p:nvSpPr>
        <p:spPr/>
        <p:txBody>
          <a:bodyPr/>
          <a:lstStyle/>
          <a:p>
            <a:fld id="{65FD6209-B16A-40ED-9B0D-5FF89551DBC9}" type="slidenum">
              <a:rPr lang="en-US"/>
              <a:t>21</a:t>
            </a:fld>
            <a:endParaRPr lang="en-US"/>
          </a:p>
        </p:txBody>
      </p:sp>
    </p:spTree>
    <p:extLst>
      <p:ext uri="{BB962C8B-B14F-4D97-AF65-F5344CB8AC3E}">
        <p14:creationId xmlns:p14="http://schemas.microsoft.com/office/powerpoint/2010/main" val="74105050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ank you for going on this exploration with me.</a:t>
            </a:r>
            <a:r>
              <a:rPr lang="en-US">
                <a:cs typeface="Calibri"/>
              </a:rPr>
              <a:t> </a:t>
            </a:r>
            <a:endParaRPr lang="en-US" dirty="0"/>
          </a:p>
        </p:txBody>
      </p:sp>
      <p:sp>
        <p:nvSpPr>
          <p:cNvPr id="4" name="Slide Number Placeholder 3"/>
          <p:cNvSpPr>
            <a:spLocks noGrp="1"/>
          </p:cNvSpPr>
          <p:nvPr>
            <p:ph type="sldNum" sz="quarter" idx="5"/>
          </p:nvPr>
        </p:nvSpPr>
        <p:spPr/>
        <p:txBody>
          <a:bodyPr/>
          <a:lstStyle/>
          <a:p>
            <a:fld id="{65FD6209-B16A-40ED-9B0D-5FF89551DBC9}" type="slidenum">
              <a:rPr lang="en-US"/>
              <a:t>22</a:t>
            </a:fld>
            <a:endParaRPr lang="en-US"/>
          </a:p>
        </p:txBody>
      </p:sp>
    </p:spTree>
    <p:extLst>
      <p:ext uri="{BB962C8B-B14F-4D97-AF65-F5344CB8AC3E}">
        <p14:creationId xmlns:p14="http://schemas.microsoft.com/office/powerpoint/2010/main" val="26562520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p>
          <a:p>
            <a:r>
              <a:rPr lang="en-US" dirty="0">
                <a:ea typeface="Calibri"/>
                <a:cs typeface="Calibri"/>
              </a:rPr>
              <a:t>Review information from this slide.  </a:t>
            </a:r>
            <a:endParaRPr lang="en-US" dirty="0">
              <a:cs typeface="Calibri"/>
            </a:endParaRPr>
          </a:p>
          <a:p>
            <a:r>
              <a:rPr lang="en-US" dirty="0">
                <a:ea typeface="Calibri"/>
                <a:cs typeface="Calibri"/>
              </a:rPr>
              <a:t>Do residents believe these things?  </a:t>
            </a:r>
          </a:p>
          <a:p>
            <a:r>
              <a:rPr lang="en-US" dirty="0">
                <a:ea typeface="Calibri"/>
                <a:cs typeface="Calibri"/>
              </a:rPr>
              <a:t>Our curriculum attempts to build this case.</a:t>
            </a:r>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65FD6209-B16A-40ED-9B0D-5FF89551DBC9}" type="slidenum">
              <a:rPr lang="en-US"/>
              <a:t>3</a:t>
            </a:fld>
            <a:endParaRPr lang="en-US"/>
          </a:p>
        </p:txBody>
      </p:sp>
    </p:spTree>
    <p:extLst>
      <p:ext uri="{BB962C8B-B14F-4D97-AF65-F5344CB8AC3E}">
        <p14:creationId xmlns:p14="http://schemas.microsoft.com/office/powerpoint/2010/main" val="40168456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ecture:</a:t>
            </a:r>
            <a:endParaRPr lang="en-US" dirty="0">
              <a:cs typeface="Calibri"/>
            </a:endParaRPr>
          </a:p>
          <a:p>
            <a:r>
              <a:rPr lang="en-US" dirty="0">
                <a:ea typeface="Calibri"/>
                <a:cs typeface="Calibri"/>
              </a:rPr>
              <a:t>There are policies within each organization that you interact with</a:t>
            </a:r>
          </a:p>
          <a:p>
            <a:r>
              <a:rPr lang="en-US" dirty="0">
                <a:ea typeface="Calibri"/>
                <a:cs typeface="Calibri"/>
              </a:rPr>
              <a:t>It is important to know what the policies are at each organization you interact with and how they are similar and different </a:t>
            </a:r>
          </a:p>
          <a:p>
            <a:endParaRPr lang="en-US" dirty="0">
              <a:cs typeface="Calibri"/>
            </a:endParaRPr>
          </a:p>
          <a:p>
            <a:r>
              <a:rPr lang="en-US" dirty="0">
                <a:ea typeface="Calibri"/>
                <a:cs typeface="Calibri"/>
              </a:rPr>
              <a:t>Preparation:</a:t>
            </a:r>
          </a:p>
          <a:p>
            <a:r>
              <a:rPr lang="en-US" dirty="0"/>
              <a:t>Facilitator should update information for your specific program</a:t>
            </a:r>
            <a:r>
              <a:rPr lang="en-US" dirty="0">
                <a:ea typeface="Calibri"/>
                <a:cs typeface="Calibri"/>
              </a:rPr>
              <a:t> </a:t>
            </a:r>
            <a:endParaRPr lang="en-US" dirty="0"/>
          </a:p>
          <a:p>
            <a:r>
              <a:rPr lang="en-US" dirty="0">
                <a:ea typeface="Calibri"/>
                <a:cs typeface="Calibri"/>
              </a:rPr>
              <a:t>Faculty are encouraged to look at the policies within and between organizations that learners may interact with (e.g., sponsoring GME, clinic, adult and/or pediatric hospital)</a:t>
            </a:r>
          </a:p>
          <a:p>
            <a:r>
              <a:rPr lang="en-US" dirty="0">
                <a:ea typeface="Calibri"/>
                <a:cs typeface="Calibri"/>
              </a:rPr>
              <a:t>Knowing these policies in advance can help guide the discussion </a:t>
            </a:r>
            <a:endParaRPr lang="en-US" dirty="0">
              <a:cs typeface="Calibri"/>
            </a:endParaRPr>
          </a:p>
          <a:p>
            <a:endParaRPr lang="en-US"/>
          </a:p>
        </p:txBody>
      </p:sp>
      <p:sp>
        <p:nvSpPr>
          <p:cNvPr id="4" name="Slide Number Placeholder 3"/>
          <p:cNvSpPr>
            <a:spLocks noGrp="1"/>
          </p:cNvSpPr>
          <p:nvPr>
            <p:ph type="sldNum" sz="quarter" idx="5"/>
          </p:nvPr>
        </p:nvSpPr>
        <p:spPr/>
        <p:txBody>
          <a:bodyPr/>
          <a:lstStyle/>
          <a:p>
            <a:fld id="{65FD6209-B16A-40ED-9B0D-5FF89551DBC9}" type="slidenum">
              <a:rPr lang="en-US"/>
              <a:t>4</a:t>
            </a:fld>
            <a:endParaRPr lang="en-US"/>
          </a:p>
        </p:txBody>
      </p:sp>
    </p:spTree>
    <p:extLst>
      <p:ext uri="{BB962C8B-B14F-4D97-AF65-F5344CB8AC3E}">
        <p14:creationId xmlns:p14="http://schemas.microsoft.com/office/powerpoint/2010/main" val="66479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p>
          <a:p>
            <a:r>
              <a:rPr lang="en-US" dirty="0"/>
              <a:t>Do these policies address physician support or simply focus on risk management focused on the organization?</a:t>
            </a:r>
            <a:endParaRPr lang="en-US" dirty="0">
              <a:cs typeface="Calibri"/>
            </a:endParaRPr>
          </a:p>
          <a:p>
            <a:r>
              <a:rPr lang="en-US" dirty="0">
                <a:cs typeface="Calibri"/>
              </a:rPr>
              <a:t>If there are policies to support physicians, what are they?</a:t>
            </a:r>
          </a:p>
          <a:p>
            <a:endParaRPr lang="en-US" dirty="0"/>
          </a:p>
          <a:p>
            <a:r>
              <a:rPr lang="en-US" dirty="0"/>
              <a:t>How good are these policies?  </a:t>
            </a:r>
          </a:p>
          <a:p>
            <a:endParaRPr lang="en-US" dirty="0"/>
          </a:p>
          <a:p>
            <a:r>
              <a:rPr lang="en-US" dirty="0"/>
              <a:t>OPTIONAL: consider using polling software to allow learners to anonymously rate </a:t>
            </a:r>
            <a:endParaRPr lang="en-US" dirty="0">
              <a:ea typeface="Calibri"/>
              <a:cs typeface="Calibri"/>
            </a:endParaRPr>
          </a:p>
          <a:p>
            <a:endParaRPr lang="en-US" dirty="0"/>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65FD6209-B16A-40ED-9B0D-5FF89551DBC9}" type="slidenum">
              <a:rPr lang="en-US"/>
              <a:t>5</a:t>
            </a:fld>
            <a:endParaRPr lang="en-US"/>
          </a:p>
        </p:txBody>
      </p:sp>
    </p:spTree>
    <p:extLst>
      <p:ext uri="{BB962C8B-B14F-4D97-AF65-F5344CB8AC3E}">
        <p14:creationId xmlns:p14="http://schemas.microsoft.com/office/powerpoint/2010/main" val="291527751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group discussion:</a:t>
            </a:r>
          </a:p>
          <a:p>
            <a:r>
              <a:rPr lang="en-US" dirty="0"/>
              <a:t>Policy does not always translate into practice</a:t>
            </a:r>
            <a:endParaRPr lang="en-US" dirty="0">
              <a:cs typeface="Calibri"/>
            </a:endParaRPr>
          </a:p>
          <a:p>
            <a:r>
              <a:rPr lang="en-US" dirty="0"/>
              <a:t>What practices do you see when an error has been made?</a:t>
            </a:r>
            <a:endParaRPr lang="en-US" dirty="0">
              <a:cs typeface="Calibri"/>
            </a:endParaRPr>
          </a:p>
          <a:p>
            <a:r>
              <a:rPr lang="en-US" dirty="0">
                <a:ea typeface="Calibri"/>
                <a:cs typeface="Calibri"/>
              </a:rPr>
              <a:t>Are policies being followed?</a:t>
            </a:r>
          </a:p>
        </p:txBody>
      </p:sp>
      <p:sp>
        <p:nvSpPr>
          <p:cNvPr id="4" name="Slide Number Placeholder 3"/>
          <p:cNvSpPr>
            <a:spLocks noGrp="1"/>
          </p:cNvSpPr>
          <p:nvPr>
            <p:ph type="sldNum" sz="quarter" idx="5"/>
          </p:nvPr>
        </p:nvSpPr>
        <p:spPr/>
        <p:txBody>
          <a:bodyPr/>
          <a:lstStyle/>
          <a:p>
            <a:fld id="{65FD6209-B16A-40ED-9B0D-5FF89551DBC9}" type="slidenum">
              <a:rPr lang="en-US" smtClean="0"/>
              <a:t>6</a:t>
            </a:fld>
            <a:endParaRPr lang="en-US"/>
          </a:p>
        </p:txBody>
      </p:sp>
    </p:spTree>
    <p:extLst>
      <p:ext uri="{BB962C8B-B14F-4D97-AF65-F5344CB8AC3E}">
        <p14:creationId xmlns:p14="http://schemas.microsoft.com/office/powerpoint/2010/main" val="16121698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paration:</a:t>
            </a:r>
          </a:p>
          <a:p>
            <a:r>
              <a:rPr lang="en-US" dirty="0">
                <a:cs typeface="Calibri"/>
              </a:rPr>
              <a:t>Presenter should be aware of processes at pertinent sites</a:t>
            </a:r>
          </a:p>
          <a:p>
            <a:endParaRPr lang="en-US" dirty="0">
              <a:cs typeface="Calibri"/>
            </a:endParaRPr>
          </a:p>
          <a:p>
            <a:r>
              <a:rPr lang="en-US" dirty="0">
                <a:cs typeface="Calibri"/>
              </a:rPr>
              <a:t>Large</a:t>
            </a:r>
            <a:r>
              <a:rPr lang="en-US" dirty="0">
                <a:ea typeface="Calibri"/>
                <a:cs typeface="Calibri"/>
              </a:rPr>
              <a:t> group discussion:</a:t>
            </a:r>
            <a:endParaRPr lang="en-US" dirty="0">
              <a:cs typeface="Calibri"/>
            </a:endParaRPr>
          </a:p>
          <a:p>
            <a:r>
              <a:rPr lang="en-US" dirty="0">
                <a:cs typeface="Calibri"/>
              </a:rPr>
              <a:t>Discuss the actual process locally</a:t>
            </a:r>
            <a:endParaRPr lang="en-US" dirty="0"/>
          </a:p>
          <a:p>
            <a:r>
              <a:rPr lang="en-US" dirty="0"/>
              <a:t>(e.g.) AFTER we care for patient, notify supervisor, WE WANT TO report...disclose/document</a:t>
            </a:r>
            <a:endParaRPr lang="en-US" dirty="0">
              <a:cs typeface="Calibri"/>
            </a:endParaRPr>
          </a:p>
          <a:p>
            <a:r>
              <a:rPr lang="en-US" dirty="0">
                <a:cs typeface="Calibri"/>
              </a:rPr>
              <a:t>Are learners aware of incident reporting software/processes?  'How would you report an error at your location?'</a:t>
            </a:r>
            <a:endParaRPr lang="en-US" dirty="0">
              <a:ea typeface="Calibri"/>
              <a:cs typeface="Calibri"/>
            </a:endParaRPr>
          </a:p>
          <a:p>
            <a:r>
              <a:rPr lang="en-US" dirty="0"/>
              <a:t>How are we doing practice-wise at clinical sites?  Are we reporting?</a:t>
            </a:r>
            <a:endParaRPr lang="en-US" dirty="0">
              <a:cs typeface="Calibri"/>
            </a:endParaRPr>
          </a:p>
        </p:txBody>
      </p:sp>
      <p:sp>
        <p:nvSpPr>
          <p:cNvPr id="4" name="Slide Number Placeholder 3"/>
          <p:cNvSpPr>
            <a:spLocks noGrp="1"/>
          </p:cNvSpPr>
          <p:nvPr>
            <p:ph type="sldNum" sz="quarter" idx="5"/>
          </p:nvPr>
        </p:nvSpPr>
        <p:spPr/>
        <p:txBody>
          <a:bodyPr/>
          <a:lstStyle/>
          <a:p>
            <a:fld id="{65FD6209-B16A-40ED-9B0D-5FF89551DBC9}" type="slidenum">
              <a:rPr lang="en-US"/>
              <a:t>7</a:t>
            </a:fld>
            <a:endParaRPr lang="en-US"/>
          </a:p>
        </p:txBody>
      </p:sp>
    </p:spTree>
    <p:extLst>
      <p:ext uri="{BB962C8B-B14F-4D97-AF65-F5344CB8AC3E}">
        <p14:creationId xmlns:p14="http://schemas.microsoft.com/office/powerpoint/2010/main" val="305941383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paration:</a:t>
            </a:r>
          </a:p>
          <a:p>
            <a:r>
              <a:rPr lang="en-US" dirty="0"/>
              <a:t>Facilitator should update information for your specific program</a:t>
            </a:r>
          </a:p>
          <a:p>
            <a:r>
              <a:rPr lang="en-US" dirty="0">
                <a:ea typeface="Calibri" panose="020F0502020204030204"/>
                <a:cs typeface="Calibri" panose="020F0502020204030204"/>
              </a:rPr>
              <a:t>Include contacts as each rotation</a:t>
            </a:r>
          </a:p>
        </p:txBody>
      </p:sp>
      <p:sp>
        <p:nvSpPr>
          <p:cNvPr id="4" name="Slide Number Placeholder 3"/>
          <p:cNvSpPr>
            <a:spLocks noGrp="1"/>
          </p:cNvSpPr>
          <p:nvPr>
            <p:ph type="sldNum" sz="quarter" idx="5"/>
          </p:nvPr>
        </p:nvSpPr>
        <p:spPr/>
        <p:txBody>
          <a:bodyPr/>
          <a:lstStyle/>
          <a:p>
            <a:fld id="{65FD6209-B16A-40ED-9B0D-5FF89551DBC9}" type="slidenum">
              <a:rPr lang="en-US" smtClean="0"/>
              <a:t>8</a:t>
            </a:fld>
            <a:endParaRPr lang="en-US"/>
          </a:p>
        </p:txBody>
      </p:sp>
    </p:spTree>
    <p:extLst>
      <p:ext uri="{BB962C8B-B14F-4D97-AF65-F5344CB8AC3E}">
        <p14:creationId xmlns:p14="http://schemas.microsoft.com/office/powerpoint/2010/main" val="252346192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Large group discussion:</a:t>
            </a:r>
            <a:endParaRPr lang="en-US" dirty="0"/>
          </a:p>
          <a:p>
            <a:r>
              <a:rPr lang="en-US" dirty="0">
                <a:ea typeface="Calibri"/>
                <a:cs typeface="Calibri"/>
              </a:rPr>
              <a:t>If you were a patient impacted by error, what would you want?</a:t>
            </a:r>
          </a:p>
        </p:txBody>
      </p:sp>
      <p:sp>
        <p:nvSpPr>
          <p:cNvPr id="4" name="Slide Number Placeholder 3"/>
          <p:cNvSpPr>
            <a:spLocks noGrp="1"/>
          </p:cNvSpPr>
          <p:nvPr>
            <p:ph type="sldNum" sz="quarter" idx="5"/>
          </p:nvPr>
        </p:nvSpPr>
        <p:spPr/>
        <p:txBody>
          <a:bodyPr/>
          <a:lstStyle/>
          <a:p>
            <a:fld id="{65FD6209-B16A-40ED-9B0D-5FF89551DBC9}" type="slidenum">
              <a:rPr lang="en-US" smtClean="0"/>
              <a:t>9</a:t>
            </a:fld>
            <a:endParaRPr lang="en-US"/>
          </a:p>
        </p:txBody>
      </p:sp>
    </p:spTree>
    <p:extLst>
      <p:ext uri="{BB962C8B-B14F-4D97-AF65-F5344CB8AC3E}">
        <p14:creationId xmlns:p14="http://schemas.microsoft.com/office/powerpoint/2010/main" val="9742699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C02E08-EE54-4AFB-AD97-DE59682A916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AA74FBA-1632-4E87-8F15-159DBA2431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2013584-7313-48D2-9E2A-B12B304589B6}"/>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83104D3B-A59E-4265-9A23-88112AE932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4C20A4-5068-486B-8BEF-13AD974B82CF}"/>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4886391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C3195C-1369-45A1-B3AF-29769A4289F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F60974F-D37D-48DA-8D24-C26FDF6A6C82}"/>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E88D9A-3992-4106-86DD-37FA4428DCCB}"/>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2F7C546B-DC09-433A-B490-AD4E969EAE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1DD2717-9CA8-475C-A09D-672786325836}"/>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28617841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7FB9E8F-FBA5-4FCC-AC40-1E017B565AF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79E1735-B910-42F5-A2A8-CECAF49DF0E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AD21A3-2DF5-4AFD-B163-3F8EF39EB820}"/>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6F212545-15B8-4255-B843-128E4DCEF07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5B550A-81FD-42D1-80B5-C118FB13E650}"/>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24946281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554711-451B-4BAB-A95D-68F5F9A48EF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9E6940E-7FAD-4474-A4A4-87E122A6054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7123335-4673-4E22-83B5-CB8BC1FA1DC9}"/>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DD41596C-87C9-45AD-9521-A5165EFDB4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55513C-5960-4784-B57D-BC1E7F82C97B}"/>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30144402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AC2417-6B7D-488F-AC75-17A3ED884D7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1F5FD8A-E5C2-43E0-AF0E-C1D53B4FC73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64A22FF-A5DB-427D-A54D-AD690B6C40BE}"/>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790660F4-6608-42BB-B6B7-01F8D87F6E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24CC53-BC78-4275-B2A6-F61524E0598A}"/>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17173024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7D8ED8-D793-499E-A8BA-D689551DC88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E4ACD1-538A-4086-9160-340004F766F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8E0AD23-FA48-4B99-A160-40783154BD7B}"/>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59DAE46-35A7-4E3E-8C21-4B8351AC2C63}"/>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6" name="Footer Placeholder 5">
            <a:extLst>
              <a:ext uri="{FF2B5EF4-FFF2-40B4-BE49-F238E27FC236}">
                <a16:creationId xmlns:a16="http://schemas.microsoft.com/office/drawing/2014/main" id="{97DC94F1-4CCE-426B-A54F-EB96A310A29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E68BE59-0242-44E6-872A-7E807F381183}"/>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4346112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F3C260-D0FF-4918-878A-EABAC2EA0A0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3FC8B2E-807D-4697-8CD9-413F09EE00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5C33A54A-40DE-4537-84D8-30296F9927E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B49C552-00CE-411A-8475-214DD0428D1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88B4CEA-BADD-4024-BB5F-F19AE2FD89B4}"/>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5C238DB-466F-41D6-9D0A-27F9574B3697}"/>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8" name="Footer Placeholder 7">
            <a:extLst>
              <a:ext uri="{FF2B5EF4-FFF2-40B4-BE49-F238E27FC236}">
                <a16:creationId xmlns:a16="http://schemas.microsoft.com/office/drawing/2014/main" id="{E69746C9-1FD4-4663-BA50-7C044B2DD2C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1FAC504-EE26-4E69-9F0A-9D339113D179}"/>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10016903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F70589-4E75-40D1-ADDD-562233C3200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C403582-EB52-4514-922F-F0D8FC128FB1}"/>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4" name="Footer Placeholder 3">
            <a:extLst>
              <a:ext uri="{FF2B5EF4-FFF2-40B4-BE49-F238E27FC236}">
                <a16:creationId xmlns:a16="http://schemas.microsoft.com/office/drawing/2014/main" id="{D733C5FD-81D1-4333-9737-546850FD882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DD0910D-0BB4-4565-83A1-DF12604F3C27}"/>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38002863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D36F101-7754-4749-B6BE-D66259F315CE}"/>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3" name="Footer Placeholder 2">
            <a:extLst>
              <a:ext uri="{FF2B5EF4-FFF2-40B4-BE49-F238E27FC236}">
                <a16:creationId xmlns:a16="http://schemas.microsoft.com/office/drawing/2014/main" id="{AAB26116-7EF1-4DCB-B027-3842967CF9A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DED42FA-9A32-4BF0-803A-90B52FCF3CAC}"/>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33058741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C9378A-8222-42B9-A021-2480BEC348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03080F9-471C-47FC-8E5E-B181FFBDE6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44979D7-56B2-4212-AEC5-128D92D0F61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ACD997A-E374-4B99-9055-C66E8E6AACEB}"/>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6" name="Footer Placeholder 5">
            <a:extLst>
              <a:ext uri="{FF2B5EF4-FFF2-40B4-BE49-F238E27FC236}">
                <a16:creationId xmlns:a16="http://schemas.microsoft.com/office/drawing/2014/main" id="{E4665DEF-2051-4C42-B91F-447C38B333D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363D4F7-3592-4D5A-8570-FF73F2BCCDD3}"/>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7826381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C6D34E-C4C6-4478-9F59-71EBB25FF7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8BBC919-783C-414C-88A8-FC4A354EA29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9D4AFA9-F379-483D-A86A-610D889B05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2F1FD05-2AD7-42F6-967F-81A21D7DAF05}"/>
              </a:ext>
            </a:extLst>
          </p:cNvPr>
          <p:cNvSpPr>
            <a:spLocks noGrp="1"/>
          </p:cNvSpPr>
          <p:nvPr>
            <p:ph type="dt" sz="half" idx="10"/>
          </p:nvPr>
        </p:nvSpPr>
        <p:spPr/>
        <p:txBody>
          <a:bodyPr/>
          <a:lstStyle/>
          <a:p>
            <a:fld id="{0B70AF06-6D5D-4A90-882B-D6F59B555824}" type="datetimeFigureOut">
              <a:rPr lang="en-US" smtClean="0"/>
              <a:t>5/3/2024</a:t>
            </a:fld>
            <a:endParaRPr lang="en-US"/>
          </a:p>
        </p:txBody>
      </p:sp>
      <p:sp>
        <p:nvSpPr>
          <p:cNvPr id="6" name="Footer Placeholder 5">
            <a:extLst>
              <a:ext uri="{FF2B5EF4-FFF2-40B4-BE49-F238E27FC236}">
                <a16:creationId xmlns:a16="http://schemas.microsoft.com/office/drawing/2014/main" id="{F25EE5EB-C23B-4C07-8CFD-0CE7E3806D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CF5D38-9429-4A43-AF0C-21A2848ACD83}"/>
              </a:ext>
            </a:extLst>
          </p:cNvPr>
          <p:cNvSpPr>
            <a:spLocks noGrp="1"/>
          </p:cNvSpPr>
          <p:nvPr>
            <p:ph type="sldNum" sz="quarter" idx="12"/>
          </p:nvPr>
        </p:nvSpPr>
        <p:spPr/>
        <p:txBody>
          <a:bodyPr/>
          <a:lstStyle/>
          <a:p>
            <a:fld id="{DF2DA0ED-33BE-4F47-8027-F4403B4B1D03}" type="slidenum">
              <a:rPr lang="en-US" smtClean="0"/>
              <a:t>‹#›</a:t>
            </a:fld>
            <a:endParaRPr lang="en-US"/>
          </a:p>
        </p:txBody>
      </p:sp>
    </p:spTree>
    <p:extLst>
      <p:ext uri="{BB962C8B-B14F-4D97-AF65-F5344CB8AC3E}">
        <p14:creationId xmlns:p14="http://schemas.microsoft.com/office/powerpoint/2010/main" val="26015995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70A05D-78C1-4C9D-B183-8BBB3AF4DB7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49DEB4A-A68B-4BF6-B758-CAF6784CAEF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460B12-B3DB-46CE-BA33-FA1BADD1596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70AF06-6D5D-4A90-882B-D6F59B555824}" type="datetimeFigureOut">
              <a:rPr lang="en-US" smtClean="0"/>
              <a:t>5/3/2024</a:t>
            </a:fld>
            <a:endParaRPr lang="en-US"/>
          </a:p>
        </p:txBody>
      </p:sp>
      <p:sp>
        <p:nvSpPr>
          <p:cNvPr id="5" name="Footer Placeholder 4">
            <a:extLst>
              <a:ext uri="{FF2B5EF4-FFF2-40B4-BE49-F238E27FC236}">
                <a16:creationId xmlns:a16="http://schemas.microsoft.com/office/drawing/2014/main" id="{6D0F4EEF-6B5B-4CB7-B810-0D1D8C1E97E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BA753B2-06C8-47B5-BAC3-C1861BA82F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2DA0ED-33BE-4F47-8027-F4403B4B1D03}" type="slidenum">
              <a:rPr lang="en-US" smtClean="0"/>
              <a:t>‹#›</a:t>
            </a:fld>
            <a:endParaRPr lang="en-US"/>
          </a:p>
        </p:txBody>
      </p:sp>
    </p:spTree>
    <p:extLst>
      <p:ext uri="{BB962C8B-B14F-4D97-AF65-F5344CB8AC3E}">
        <p14:creationId xmlns:p14="http://schemas.microsoft.com/office/powerpoint/2010/main" val="6174058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3.JPG"/><Relationship Id="rId5" Type="http://schemas.microsoft.com/office/2007/relationships/hdphoto" Target="../media/hdphoto1.wdp"/><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video" Target="https://www.youtube.com/embed/3OsA0z7j4WM?feature=oembed" TargetMode="External"/><Relationship Id="rId4" Type="http://schemas.openxmlformats.org/officeDocument/2006/relationships/image" Target="../media/image4.jpe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psnet.ahrq.gov/" TargetMode="Externa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hyperlink" Target="https://www.patientsafety.va.gov/professionals/onthejob/rca.asp" TargetMode="External"/><Relationship Id="rId5" Type="http://schemas.openxmlformats.org/officeDocument/2006/relationships/hyperlink" Target="https://www.acponline.org/cme-moc/online-learning-center/getting-it-right-cases-to-improve-diagnosis" TargetMode="External"/><Relationship Id="rId4" Type="http://schemas.openxmlformats.org/officeDocument/2006/relationships/hyperlink" Target="https://www.ihi.org/education/Conferences/National-Forum/Pages/default.aspx?utm_campaign=us-6292022-all-forum2022-all-dmt-b--kt-text(sem)&amp;utm_content=link----inperson1&amp;utm_source=bing&amp;utm_medium=cpc&amp;utm_term=awareness--registernowv&amp;msclkid=73305f378ab11f90d4143dd25e468807" TargetMode="Externa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DBF01F-FF58-4643-8BAB-169EB6D28C11}"/>
              </a:ext>
            </a:extLst>
          </p:cNvPr>
          <p:cNvSpPr>
            <a:spLocks noGrp="1"/>
          </p:cNvSpPr>
          <p:nvPr>
            <p:ph type="ctrTitle"/>
          </p:nvPr>
        </p:nvSpPr>
        <p:spPr>
          <a:xfrm>
            <a:off x="642996" y="4571216"/>
            <a:ext cx="10906008" cy="1115415"/>
          </a:xfrm>
        </p:spPr>
        <p:txBody>
          <a:bodyPr>
            <a:normAutofit fontScale="90000"/>
          </a:bodyPr>
          <a:lstStyle/>
          <a:p>
            <a:r>
              <a:rPr lang="en-US"/>
              <a:t>Medical error 3: Practice makes better</a:t>
            </a:r>
          </a:p>
        </p:txBody>
      </p:sp>
      <p:pic>
        <p:nvPicPr>
          <p:cNvPr id="4" name="Picture 4">
            <a:extLst>
              <a:ext uri="{FF2B5EF4-FFF2-40B4-BE49-F238E27FC236}">
                <a16:creationId xmlns:a16="http://schemas.microsoft.com/office/drawing/2014/main" id="{EFAC2477-438B-ECB3-5137-307B8600418A}"/>
              </a:ext>
            </a:extLst>
          </p:cNvPr>
          <p:cNvPicPr>
            <a:picLocks noChangeAspect="1"/>
          </p:cNvPicPr>
          <p:nvPr/>
        </p:nvPicPr>
        <p:blipFill rotWithShape="1">
          <a:blip r:embed="rId3"/>
          <a:srcRect r="6845" b="1"/>
          <a:stretch/>
        </p:blipFill>
        <p:spPr>
          <a:xfrm>
            <a:off x="8075142" y="320511"/>
            <a:ext cx="3794760" cy="3930978"/>
          </a:xfrm>
          <a:prstGeom prst="rect">
            <a:avLst/>
          </a:prstGeom>
        </p:spPr>
      </p:pic>
      <p:cxnSp>
        <p:nvCxnSpPr>
          <p:cNvPr id="17" name="Straight Connector 16">
            <a:extLst>
              <a:ext uri="{FF2B5EF4-FFF2-40B4-BE49-F238E27FC236}">
                <a16:creationId xmlns:a16="http://schemas.microsoft.com/office/drawing/2014/main" id="{60188E89-AF78-40F6-B787-E9BD9C625686}"/>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524000" y="5778706"/>
            <a:ext cx="9144000"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08E25000-D397-0B06-2A3C-FA343B6A63BC}"/>
              </a:ext>
            </a:extLst>
          </p:cNvPr>
          <p:cNvSpPr txBox="1"/>
          <p:nvPr/>
        </p:nvSpPr>
        <p:spPr>
          <a:xfrm>
            <a:off x="9635612" y="4043515"/>
            <a:ext cx="4289322"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dirty="0">
                <a:solidFill>
                  <a:srgbClr val="E7E6E6"/>
                </a:solidFill>
                <a:ea typeface="Calibri"/>
                <a:cs typeface="Calibri"/>
              </a:rPr>
              <a:t>Images by Sherry Adkins, Author owned</a:t>
            </a:r>
            <a:endParaRPr lang="en-US" sz="1000" dirty="0">
              <a:solidFill>
                <a:srgbClr val="E7E6E6"/>
              </a:solidFill>
            </a:endParaRPr>
          </a:p>
        </p:txBody>
      </p:sp>
      <p:pic>
        <p:nvPicPr>
          <p:cNvPr id="5" name="Picture 4">
            <a:extLst>
              <a:ext uri="{FF2B5EF4-FFF2-40B4-BE49-F238E27FC236}">
                <a16:creationId xmlns:a16="http://schemas.microsoft.com/office/drawing/2014/main" id="{53DC89D7-0ADE-41D8-A148-70F90F73E305}"/>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2000" contrast="5000"/>
                    </a14:imgEffect>
                  </a14:imgLayer>
                </a14:imgProps>
              </a:ext>
              <a:ext uri="{28A0092B-C50C-407E-A947-70E740481C1C}">
                <a14:useLocalDpi xmlns:a14="http://schemas.microsoft.com/office/drawing/2010/main" val="0"/>
              </a:ext>
            </a:extLst>
          </a:blip>
          <a:srcRect t="18290" b="14587"/>
          <a:stretch/>
        </p:blipFill>
        <p:spPr>
          <a:xfrm>
            <a:off x="4369565" y="320511"/>
            <a:ext cx="3452399" cy="3930978"/>
          </a:xfrm>
          <a:prstGeom prst="rect">
            <a:avLst/>
          </a:prstGeom>
        </p:spPr>
      </p:pic>
      <p:pic>
        <p:nvPicPr>
          <p:cNvPr id="10" name="Picture 9">
            <a:extLst>
              <a:ext uri="{FF2B5EF4-FFF2-40B4-BE49-F238E27FC236}">
                <a16:creationId xmlns:a16="http://schemas.microsoft.com/office/drawing/2014/main" id="{BFAA9DEF-DEBA-443A-9DE6-5F281A935E55}"/>
              </a:ext>
            </a:extLst>
          </p:cNvPr>
          <p:cNvPicPr>
            <a:picLocks noChangeAspect="1"/>
          </p:cNvPicPr>
          <p:nvPr/>
        </p:nvPicPr>
        <p:blipFill rotWithShape="1">
          <a:blip r:embed="rId6">
            <a:extLst>
              <a:ext uri="{28A0092B-C50C-407E-A947-70E740481C1C}">
                <a14:useLocalDpi xmlns:a14="http://schemas.microsoft.com/office/drawing/2010/main" val="0"/>
              </a:ext>
            </a:extLst>
          </a:blip>
          <a:srcRect l="28891" t="21025" r="9074" b="21655"/>
          <a:stretch/>
        </p:blipFill>
        <p:spPr>
          <a:xfrm>
            <a:off x="949570" y="320511"/>
            <a:ext cx="3166818" cy="3970716"/>
          </a:xfrm>
          <a:prstGeom prst="rect">
            <a:avLst/>
          </a:prstGeom>
        </p:spPr>
      </p:pic>
    </p:spTree>
    <p:extLst>
      <p:ext uri="{BB962C8B-B14F-4D97-AF65-F5344CB8AC3E}">
        <p14:creationId xmlns:p14="http://schemas.microsoft.com/office/powerpoint/2010/main" val="16395286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9582FF1-983E-4D4D-98E0-148E1CCB8262}"/>
              </a:ext>
            </a:extLst>
          </p:cNvPr>
          <p:cNvSpPr>
            <a:spLocks noGrp="1"/>
          </p:cNvSpPr>
          <p:nvPr>
            <p:ph type="title"/>
          </p:nvPr>
        </p:nvSpPr>
        <p:spPr>
          <a:xfrm>
            <a:off x="838200" y="365125"/>
            <a:ext cx="10515600" cy="1325563"/>
          </a:xfrm>
        </p:spPr>
        <p:txBody>
          <a:bodyPr>
            <a:normAutofit/>
          </a:bodyPr>
          <a:lstStyle/>
          <a:p>
            <a:r>
              <a:rPr lang="en-US" sz="5400">
                <a:cs typeface="Calibri Light"/>
              </a:rPr>
              <a:t>Key principles of open disclosure</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FB2EB9C-1382-4DD3-8425-6057DCA19775}"/>
              </a:ext>
            </a:extLst>
          </p:cNvPr>
          <p:cNvSpPr>
            <a:spLocks noGrp="1"/>
          </p:cNvSpPr>
          <p:nvPr>
            <p:ph idx="1"/>
          </p:nvPr>
        </p:nvSpPr>
        <p:spPr>
          <a:xfrm>
            <a:off x="838200" y="1929384"/>
            <a:ext cx="10515600" cy="4251960"/>
          </a:xfrm>
        </p:spPr>
        <p:txBody>
          <a:bodyPr vert="horz" lIns="91440" tIns="45720" rIns="91440" bIns="45720" rtlCol="0" anchor="t">
            <a:normAutofit/>
          </a:bodyPr>
          <a:lstStyle/>
          <a:p>
            <a:r>
              <a:rPr lang="en-US" sz="2200" dirty="0">
                <a:ea typeface="+mn-lt"/>
                <a:cs typeface="+mn-lt"/>
              </a:rPr>
              <a:t>Open and timely communication (tip – park your fear)</a:t>
            </a:r>
          </a:p>
          <a:p>
            <a:r>
              <a:rPr lang="en-US" sz="2200" dirty="0">
                <a:ea typeface="+mn-lt"/>
                <a:cs typeface="+mn-lt"/>
              </a:rPr>
              <a:t>Acknowledge the incident </a:t>
            </a:r>
          </a:p>
          <a:p>
            <a:r>
              <a:rPr lang="en-US" sz="2200" dirty="0">
                <a:ea typeface="+mn-lt"/>
                <a:cs typeface="+mn-lt"/>
              </a:rPr>
              <a:t>Express regret/apology (end with empathy, assuring your availability)</a:t>
            </a:r>
          </a:p>
          <a:p>
            <a:r>
              <a:rPr lang="en-US" sz="2200" dirty="0">
                <a:ea typeface="+mn-lt"/>
                <a:cs typeface="+mn-lt"/>
              </a:rPr>
              <a:t>Recognize reasonable expectations of patient/family </a:t>
            </a:r>
          </a:p>
          <a:p>
            <a:r>
              <a:rPr lang="en-US" sz="2200" dirty="0">
                <a:ea typeface="+mn-lt"/>
                <a:cs typeface="+mn-lt"/>
              </a:rPr>
              <a:t>Support for staff </a:t>
            </a:r>
          </a:p>
          <a:p>
            <a:r>
              <a:rPr lang="en-US" sz="2200" dirty="0">
                <a:ea typeface="+mn-lt"/>
                <a:cs typeface="+mn-lt"/>
              </a:rPr>
              <a:t>Confidentiality</a:t>
            </a:r>
            <a:endParaRPr lang="en-US" sz="2200" dirty="0"/>
          </a:p>
          <a:p>
            <a:endParaRPr lang="en-US" sz="2200" dirty="0">
              <a:cs typeface="Calibri"/>
            </a:endParaRPr>
          </a:p>
        </p:txBody>
      </p:sp>
    </p:spTree>
    <p:extLst>
      <p:ext uri="{BB962C8B-B14F-4D97-AF65-F5344CB8AC3E}">
        <p14:creationId xmlns:p14="http://schemas.microsoft.com/office/powerpoint/2010/main" val="24635466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9582FF1-983E-4D4D-98E0-148E1CCB8262}"/>
              </a:ext>
            </a:extLst>
          </p:cNvPr>
          <p:cNvSpPr>
            <a:spLocks noGrp="1"/>
          </p:cNvSpPr>
          <p:nvPr>
            <p:ph type="title"/>
          </p:nvPr>
        </p:nvSpPr>
        <p:spPr>
          <a:xfrm>
            <a:off x="841248" y="548640"/>
            <a:ext cx="3600860" cy="5431536"/>
          </a:xfrm>
        </p:spPr>
        <p:txBody>
          <a:bodyPr>
            <a:normAutofit/>
          </a:bodyPr>
          <a:lstStyle/>
          <a:p>
            <a:r>
              <a:rPr lang="en-US" sz="3000">
                <a:cs typeface="Calibri Light"/>
              </a:rPr>
              <a:t>Practice!  Disclosure</a:t>
            </a: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FB2EB9C-1382-4DD3-8425-6057DCA19775}"/>
              </a:ext>
            </a:extLst>
          </p:cNvPr>
          <p:cNvSpPr>
            <a:spLocks noGrp="1"/>
          </p:cNvSpPr>
          <p:nvPr>
            <p:ph idx="1"/>
          </p:nvPr>
        </p:nvSpPr>
        <p:spPr>
          <a:xfrm>
            <a:off x="5126418" y="552091"/>
            <a:ext cx="6224335" cy="5431536"/>
          </a:xfrm>
        </p:spPr>
        <p:txBody>
          <a:bodyPr vert="horz" lIns="91440" tIns="45720" rIns="91440" bIns="45720" rtlCol="0" anchor="ctr">
            <a:normAutofit/>
          </a:bodyPr>
          <a:lstStyle/>
          <a:p>
            <a:endParaRPr lang="en-US" sz="2200">
              <a:ea typeface="+mn-lt"/>
              <a:cs typeface="+mn-lt"/>
            </a:endParaRPr>
          </a:p>
          <a:p>
            <a:r>
              <a:rPr lang="en-US" sz="2200" dirty="0">
                <a:cs typeface="Calibri"/>
              </a:rPr>
              <a:t>Take a look at your case in a group of 3.</a:t>
            </a:r>
          </a:p>
          <a:p>
            <a:r>
              <a:rPr lang="en-US" sz="2200" dirty="0">
                <a:cs typeface="Calibri"/>
              </a:rPr>
              <a:t>Choose a role (doctor, patient/family, observer).</a:t>
            </a:r>
          </a:p>
          <a:p>
            <a:r>
              <a:rPr lang="en-US" sz="2200" dirty="0">
                <a:cs typeface="Calibri"/>
              </a:rPr>
              <a:t>Role play for 2 minutes then switch.</a:t>
            </a:r>
          </a:p>
          <a:p>
            <a:r>
              <a:rPr lang="en-US" sz="2200" dirty="0">
                <a:cs typeface="Calibri"/>
              </a:rPr>
              <a:t>Debrief/discuss as a large group</a:t>
            </a:r>
          </a:p>
        </p:txBody>
      </p:sp>
    </p:spTree>
    <p:extLst>
      <p:ext uri="{BB962C8B-B14F-4D97-AF65-F5344CB8AC3E}">
        <p14:creationId xmlns:p14="http://schemas.microsoft.com/office/powerpoint/2010/main" val="264695491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CAB1F8-7DA0-A658-152E-C4C2077EE81F}"/>
              </a:ext>
            </a:extLst>
          </p:cNvPr>
          <p:cNvSpPr>
            <a:spLocks noGrp="1"/>
          </p:cNvSpPr>
          <p:nvPr>
            <p:ph type="title"/>
          </p:nvPr>
        </p:nvSpPr>
        <p:spPr>
          <a:xfrm>
            <a:off x="263106" y="379502"/>
            <a:ext cx="11651411" cy="1440581"/>
          </a:xfrm>
        </p:spPr>
        <p:txBody>
          <a:bodyPr>
            <a:normAutofit fontScale="90000"/>
          </a:bodyPr>
          <a:lstStyle/>
          <a:p>
            <a:r>
              <a:rPr lang="en-US" sz="3400" dirty="0"/>
              <a:t>Medical Error: A Case Based Approach to Apology and Disclosure –</a:t>
            </a:r>
            <a:r>
              <a:rPr lang="en-US" sz="3600" dirty="0"/>
              <a:t> </a:t>
            </a:r>
            <a:r>
              <a:rPr lang="en-US" sz="3200" dirty="0"/>
              <a:t>Brigham and Woman's Hospital 2014 </a:t>
            </a:r>
            <a:r>
              <a:rPr lang="en-US" sz="3100" dirty="0"/>
              <a:t>(Optional)</a:t>
            </a:r>
            <a:br>
              <a:rPr lang="en-US" b="1" dirty="0">
                <a:cs typeface="Calibri"/>
              </a:rPr>
            </a:br>
            <a:endParaRPr lang="en-US" dirty="0"/>
          </a:p>
        </p:txBody>
      </p:sp>
      <p:pic>
        <p:nvPicPr>
          <p:cNvPr id="5" name="Online Media 4" title="Medical Error: A Case Based Approach to Apology and Disclosure Video - Brigham and Women's Hospital">
            <a:hlinkClick r:id="" action="ppaction://media"/>
            <a:extLst>
              <a:ext uri="{FF2B5EF4-FFF2-40B4-BE49-F238E27FC236}">
                <a16:creationId xmlns:a16="http://schemas.microsoft.com/office/drawing/2014/main" id="{2206E6E4-C516-A8C8-9BA3-E02AFFB1F34E}"/>
              </a:ext>
            </a:extLst>
          </p:cNvPr>
          <p:cNvPicPr>
            <a:picLocks noGrp="1" noRot="1" noChangeAspect="1"/>
          </p:cNvPicPr>
          <p:nvPr>
            <p:ph idx="1"/>
            <a:videoFile r:link="rId1"/>
          </p:nvPr>
        </p:nvPicPr>
        <p:blipFill>
          <a:blip r:embed="rId4"/>
          <a:stretch>
            <a:fillRect/>
          </a:stretch>
        </p:blipFill>
        <p:spPr>
          <a:xfrm>
            <a:off x="2244725" y="1825625"/>
            <a:ext cx="7700963" cy="4351338"/>
          </a:xfrm>
        </p:spPr>
      </p:pic>
    </p:spTree>
    <p:extLst>
      <p:ext uri="{BB962C8B-B14F-4D97-AF65-F5344CB8AC3E}">
        <p14:creationId xmlns:p14="http://schemas.microsoft.com/office/powerpoint/2010/main" val="1650181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6F56A5-53EC-4856-A456-6E1DE98E31E7}"/>
              </a:ext>
            </a:extLst>
          </p:cNvPr>
          <p:cNvSpPr>
            <a:spLocks noGrp="1"/>
          </p:cNvSpPr>
          <p:nvPr>
            <p:ph type="title"/>
          </p:nvPr>
        </p:nvSpPr>
        <p:spPr>
          <a:xfrm>
            <a:off x="838200" y="365125"/>
            <a:ext cx="10515600" cy="1325563"/>
          </a:xfrm>
        </p:spPr>
        <p:txBody>
          <a:bodyPr>
            <a:normAutofit/>
          </a:bodyPr>
          <a:lstStyle/>
          <a:p>
            <a:r>
              <a:rPr lang="en-US" sz="5400"/>
              <a:t>Root cause analysis, reminders </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B26DCF6B-B3FB-42D6-96C8-995C85FCBB54}"/>
              </a:ext>
            </a:extLst>
          </p:cNvPr>
          <p:cNvSpPr>
            <a:spLocks noGrp="1"/>
          </p:cNvSpPr>
          <p:nvPr>
            <p:ph idx="1"/>
          </p:nvPr>
        </p:nvSpPr>
        <p:spPr>
          <a:xfrm>
            <a:off x="838200" y="1929384"/>
            <a:ext cx="10515600" cy="4251960"/>
          </a:xfrm>
        </p:spPr>
        <p:txBody>
          <a:bodyPr vert="horz" lIns="91440" tIns="45720" rIns="91440" bIns="45720" rtlCol="0" anchor="t">
            <a:normAutofit/>
          </a:bodyPr>
          <a:lstStyle/>
          <a:p>
            <a:r>
              <a:rPr lang="en-US" sz="2200">
                <a:ea typeface="+mn-lt"/>
                <a:cs typeface="+mn-lt"/>
              </a:rPr>
              <a:t>Rigorous confidential approach to answering</a:t>
            </a:r>
          </a:p>
          <a:p>
            <a:pPr lvl="1"/>
            <a:r>
              <a:rPr lang="en-US" sz="2200">
                <a:cs typeface="Calibri" panose="020F0502020204030204"/>
              </a:rPr>
              <a:t>What happened?</a:t>
            </a:r>
          </a:p>
          <a:p>
            <a:pPr lvl="1"/>
            <a:r>
              <a:rPr lang="en-US" sz="2200">
                <a:cs typeface="Calibri" panose="020F0502020204030204"/>
              </a:rPr>
              <a:t>Who?  When?  Where?</a:t>
            </a:r>
          </a:p>
          <a:p>
            <a:pPr lvl="1"/>
            <a:r>
              <a:rPr lang="en-US" sz="2200">
                <a:cs typeface="Calibri" panose="020F0502020204030204"/>
              </a:rPr>
              <a:t>How severe was the harm?</a:t>
            </a:r>
          </a:p>
          <a:p>
            <a:pPr lvl="1"/>
            <a:r>
              <a:rPr lang="en-US" sz="2200">
                <a:cs typeface="Calibri" panose="020F0502020204030204"/>
              </a:rPr>
              <a:t>What's the likelihood of recurrence?</a:t>
            </a:r>
          </a:p>
          <a:p>
            <a:pPr lvl="1"/>
            <a:r>
              <a:rPr lang="en-US" sz="2200">
                <a:cs typeface="Calibri" panose="020F0502020204030204"/>
              </a:rPr>
              <a:t>What were the consequences?</a:t>
            </a:r>
          </a:p>
          <a:p>
            <a:r>
              <a:rPr lang="en-US" sz="2200">
                <a:cs typeface="Calibri" panose="020F0502020204030204"/>
              </a:rPr>
              <a:t>Focus on prevention, system vulnerabilities</a:t>
            </a:r>
          </a:p>
          <a:p>
            <a:pPr lvl="1"/>
            <a:r>
              <a:rPr lang="en-US" sz="1800">
                <a:cs typeface="Calibri" panose="020F0502020204030204"/>
              </a:rPr>
              <a:t>Examine communication, training, fatigue, environment, policies, barriers</a:t>
            </a:r>
          </a:p>
          <a:p>
            <a:r>
              <a:rPr lang="en-US" sz="2200">
                <a:cs typeface="Calibri" panose="020F0502020204030204"/>
              </a:rPr>
              <a:t>Sentinel event - </a:t>
            </a:r>
            <a:r>
              <a:rPr lang="en-US" sz="2200" b="1">
                <a:ea typeface="+mn-lt"/>
                <a:cs typeface="+mn-lt"/>
              </a:rPr>
              <a:t>a patient safety event that results in death, permanent harm, or severe temporary harm.</a:t>
            </a:r>
            <a:endParaRPr lang="en-US" sz="2200">
              <a:ea typeface="+mn-lt"/>
              <a:cs typeface="+mn-lt"/>
            </a:endParaRPr>
          </a:p>
        </p:txBody>
      </p:sp>
    </p:spTree>
    <p:extLst>
      <p:ext uri="{BB962C8B-B14F-4D97-AF65-F5344CB8AC3E}">
        <p14:creationId xmlns:p14="http://schemas.microsoft.com/office/powerpoint/2010/main" val="5487834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6F56A5-53EC-4856-A456-6E1DE98E31E7}"/>
              </a:ext>
            </a:extLst>
          </p:cNvPr>
          <p:cNvSpPr>
            <a:spLocks noGrp="1"/>
          </p:cNvSpPr>
          <p:nvPr>
            <p:ph type="title"/>
          </p:nvPr>
        </p:nvSpPr>
        <p:spPr>
          <a:xfrm>
            <a:off x="841248" y="548640"/>
            <a:ext cx="3600860" cy="5431536"/>
          </a:xfrm>
        </p:spPr>
        <p:txBody>
          <a:bodyPr>
            <a:normAutofit/>
          </a:bodyPr>
          <a:lstStyle/>
          <a:p>
            <a:r>
              <a:rPr lang="en-US" sz="4200"/>
              <a:t>Practice!   Root cause analysis </a:t>
            </a: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B26DCF6B-B3FB-42D6-96C8-995C85FCBB54}"/>
              </a:ext>
            </a:extLst>
          </p:cNvPr>
          <p:cNvSpPr>
            <a:spLocks noGrp="1"/>
          </p:cNvSpPr>
          <p:nvPr>
            <p:ph idx="1"/>
          </p:nvPr>
        </p:nvSpPr>
        <p:spPr>
          <a:xfrm>
            <a:off x="5126418" y="552091"/>
            <a:ext cx="6224335" cy="5431536"/>
          </a:xfrm>
        </p:spPr>
        <p:txBody>
          <a:bodyPr vert="horz" lIns="91440" tIns="45720" rIns="91440" bIns="45720" rtlCol="0" anchor="ctr">
            <a:normAutofit/>
          </a:bodyPr>
          <a:lstStyle/>
          <a:p>
            <a:r>
              <a:rPr lang="en-US" sz="2200" dirty="0">
                <a:cs typeface="Calibri" panose="020F0502020204030204"/>
              </a:rPr>
              <a:t>Choose the last mistake you made (outside of medicine is fine), or a near miss...reflect on root causes for this over the next 2 minutes. </a:t>
            </a:r>
          </a:p>
        </p:txBody>
      </p:sp>
    </p:spTree>
    <p:extLst>
      <p:ext uri="{BB962C8B-B14F-4D97-AF65-F5344CB8AC3E}">
        <p14:creationId xmlns:p14="http://schemas.microsoft.com/office/powerpoint/2010/main" val="351047497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05CBC3C-2E5A-4839-8B9B-2E5A6ADF0F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827FF362-FC97-4BF5-949B-D4ADFA26E4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8888549">
            <a:off x="-1059473" y="-1108988"/>
            <a:ext cx="7179830" cy="5226565"/>
          </a:xfrm>
          <a:custGeom>
            <a:avLst/>
            <a:gdLst>
              <a:gd name="connsiteX0" fmla="*/ 5217841 w 7179830"/>
              <a:gd name="connsiteY0" fmla="*/ 464824 h 5226565"/>
              <a:gd name="connsiteX1" fmla="*/ 5222490 w 7179830"/>
              <a:gd name="connsiteY1" fmla="*/ 464289 h 5226565"/>
              <a:gd name="connsiteX2" fmla="*/ 5216768 w 7179830"/>
              <a:gd name="connsiteY2" fmla="*/ 463394 h 5226565"/>
              <a:gd name="connsiteX3" fmla="*/ 5217841 w 7179830"/>
              <a:gd name="connsiteY3" fmla="*/ 464824 h 5226565"/>
              <a:gd name="connsiteX4" fmla="*/ 4945201 w 7179830"/>
              <a:gd name="connsiteY4" fmla="*/ 5226565 h 5226565"/>
              <a:gd name="connsiteX5" fmla="*/ 140449 w 7179830"/>
              <a:gd name="connsiteY5" fmla="*/ 2240811 h 5226565"/>
              <a:gd name="connsiteX6" fmla="*/ 232913 w 7179830"/>
              <a:gd name="connsiteY6" fmla="*/ 2052782 h 5226565"/>
              <a:gd name="connsiteX7" fmla="*/ 375714 w 7179830"/>
              <a:gd name="connsiteY7" fmla="*/ 1803205 h 5226565"/>
              <a:gd name="connsiteX8" fmla="*/ 1512756 w 7179830"/>
              <a:gd name="connsiteY8" fmla="*/ 638448 h 5226565"/>
              <a:gd name="connsiteX9" fmla="*/ 2902095 w 7179830"/>
              <a:gd name="connsiteY9" fmla="*/ 120440 h 5226565"/>
              <a:gd name="connsiteX10" fmla="*/ 2848453 w 7179830"/>
              <a:gd name="connsiteY10" fmla="*/ 125626 h 5226565"/>
              <a:gd name="connsiteX11" fmla="*/ 1837830 w 7179830"/>
              <a:gd name="connsiteY11" fmla="*/ 426203 h 5226565"/>
              <a:gd name="connsiteX12" fmla="*/ 214608 w 7179830"/>
              <a:gd name="connsiteY12" fmla="*/ 1882239 h 5226565"/>
              <a:gd name="connsiteX13" fmla="*/ 91317 w 7179830"/>
              <a:gd name="connsiteY13" fmla="*/ 2123701 h 5226565"/>
              <a:gd name="connsiteX14" fmla="*/ 64092 w 7179830"/>
              <a:gd name="connsiteY14" fmla="*/ 2193361 h 5226565"/>
              <a:gd name="connsiteX15" fmla="*/ 0 w 7179830"/>
              <a:gd name="connsiteY15" fmla="*/ 2153533 h 5226565"/>
              <a:gd name="connsiteX16" fmla="*/ 42834 w 7179830"/>
              <a:gd name="connsiteY16" fmla="*/ 2047277 h 5226565"/>
              <a:gd name="connsiteX17" fmla="*/ 923582 w 7179830"/>
              <a:gd name="connsiteY17" fmla="*/ 915600 h 5226565"/>
              <a:gd name="connsiteX18" fmla="*/ 2686989 w 7179830"/>
              <a:gd name="connsiteY18" fmla="*/ 73950 h 5226565"/>
              <a:gd name="connsiteX19" fmla="*/ 3059983 w 7179830"/>
              <a:gd name="connsiteY19" fmla="*/ 20308 h 5226565"/>
              <a:gd name="connsiteX20" fmla="*/ 3454435 w 7179830"/>
              <a:gd name="connsiteY20" fmla="*/ 1176 h 5226565"/>
              <a:gd name="connsiteX21" fmla="*/ 3923806 w 7179830"/>
              <a:gd name="connsiteY21" fmla="*/ 49990 h 5226565"/>
              <a:gd name="connsiteX22" fmla="*/ 5350874 w 7179830"/>
              <a:gd name="connsiteY22" fmla="*/ 426917 h 5226565"/>
              <a:gd name="connsiteX23" fmla="*/ 6607360 w 7179830"/>
              <a:gd name="connsiteY23" fmla="*/ 1075097 h 5226565"/>
              <a:gd name="connsiteX24" fmla="*/ 7110534 w 7179830"/>
              <a:gd name="connsiteY24" fmla="*/ 1541421 h 5226565"/>
              <a:gd name="connsiteX25" fmla="*/ 7179830 w 7179830"/>
              <a:gd name="connsiteY25" fmla="*/ 1630542 h 5226565"/>
              <a:gd name="connsiteX26" fmla="*/ 7136295 w 7179830"/>
              <a:gd name="connsiteY26" fmla="*/ 1700600 h 5226565"/>
              <a:gd name="connsiteX27" fmla="*/ 7131140 w 7179830"/>
              <a:gd name="connsiteY27" fmla="*/ 1693045 h 5226565"/>
              <a:gd name="connsiteX28" fmla="*/ 6577499 w 7179830"/>
              <a:gd name="connsiteY28" fmla="*/ 1148230 h 5226565"/>
              <a:gd name="connsiteX29" fmla="*/ 5494816 w 7179830"/>
              <a:gd name="connsiteY29" fmla="*/ 563527 h 5226565"/>
              <a:gd name="connsiteX30" fmla="*/ 5366967 w 7179830"/>
              <a:gd name="connsiteY30" fmla="*/ 514176 h 5226565"/>
              <a:gd name="connsiteX31" fmla="*/ 5244661 w 7179830"/>
              <a:gd name="connsiteY31" fmla="*/ 470725 h 5226565"/>
              <a:gd name="connsiteX32" fmla="*/ 5904822 w 7179830"/>
              <a:gd name="connsiteY32" fmla="*/ 815468 h 5226565"/>
              <a:gd name="connsiteX33" fmla="*/ 7015222 w 7179830"/>
              <a:gd name="connsiteY33" fmla="*/ 1815185 h 5226565"/>
              <a:gd name="connsiteX34" fmla="*/ 7040454 w 7179830"/>
              <a:gd name="connsiteY34" fmla="*/ 1854830 h 522656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7179830" h="5226565">
                <a:moveTo>
                  <a:pt x="5217841" y="464824"/>
                </a:moveTo>
                <a:lnTo>
                  <a:pt x="5222490" y="464289"/>
                </a:lnTo>
                <a:lnTo>
                  <a:pt x="5216768" y="463394"/>
                </a:lnTo>
                <a:cubicBezTo>
                  <a:pt x="5216768" y="463394"/>
                  <a:pt x="5216768" y="464646"/>
                  <a:pt x="5217841" y="464824"/>
                </a:cubicBezTo>
                <a:close/>
                <a:moveTo>
                  <a:pt x="4945201" y="5226565"/>
                </a:moveTo>
                <a:lnTo>
                  <a:pt x="140449" y="2240811"/>
                </a:lnTo>
                <a:lnTo>
                  <a:pt x="232913" y="2052782"/>
                </a:lnTo>
                <a:cubicBezTo>
                  <a:pt x="277693" y="1968290"/>
                  <a:pt x="325201" y="1885054"/>
                  <a:pt x="375714" y="1803205"/>
                </a:cubicBezTo>
                <a:cubicBezTo>
                  <a:pt x="667528" y="1329721"/>
                  <a:pt x="1039629" y="935091"/>
                  <a:pt x="1512756" y="638448"/>
                </a:cubicBezTo>
                <a:cubicBezTo>
                  <a:pt x="1939392" y="370950"/>
                  <a:pt x="2405724" y="210560"/>
                  <a:pt x="2902095" y="120440"/>
                </a:cubicBezTo>
                <a:cubicBezTo>
                  <a:pt x="2884054" y="118134"/>
                  <a:pt x="2865727" y="119904"/>
                  <a:pt x="2848453" y="125626"/>
                </a:cubicBezTo>
                <a:cubicBezTo>
                  <a:pt x="2498704" y="175943"/>
                  <a:pt x="2158217" y="277201"/>
                  <a:pt x="1837830" y="426203"/>
                </a:cubicBezTo>
                <a:cubicBezTo>
                  <a:pt x="1147094" y="744660"/>
                  <a:pt x="593502" y="1217071"/>
                  <a:pt x="214608" y="1882239"/>
                </a:cubicBezTo>
                <a:cubicBezTo>
                  <a:pt x="169441" y="1960776"/>
                  <a:pt x="128308" y="2041369"/>
                  <a:pt x="91317" y="2123701"/>
                </a:cubicBezTo>
                <a:lnTo>
                  <a:pt x="64092" y="2193361"/>
                </a:lnTo>
                <a:lnTo>
                  <a:pt x="0" y="2153533"/>
                </a:lnTo>
                <a:lnTo>
                  <a:pt x="42834" y="2047277"/>
                </a:lnTo>
                <a:cubicBezTo>
                  <a:pt x="241792" y="1615775"/>
                  <a:pt x="541268" y="1241591"/>
                  <a:pt x="923582" y="915600"/>
                </a:cubicBezTo>
                <a:cubicBezTo>
                  <a:pt x="1435331" y="478415"/>
                  <a:pt x="2028081" y="205375"/>
                  <a:pt x="2686989" y="73950"/>
                </a:cubicBezTo>
                <a:cubicBezTo>
                  <a:pt x="2810367" y="49274"/>
                  <a:pt x="2934818" y="32466"/>
                  <a:pt x="3059983" y="20308"/>
                </a:cubicBezTo>
                <a:cubicBezTo>
                  <a:pt x="3185149" y="8148"/>
                  <a:pt x="3308706" y="2963"/>
                  <a:pt x="3454435" y="1176"/>
                </a:cubicBezTo>
                <a:cubicBezTo>
                  <a:pt x="3599805" y="-5977"/>
                  <a:pt x="3761985" y="20665"/>
                  <a:pt x="3923806" y="49990"/>
                </a:cubicBezTo>
                <a:cubicBezTo>
                  <a:pt x="4409449" y="137964"/>
                  <a:pt x="4886867" y="257228"/>
                  <a:pt x="5350874" y="426917"/>
                </a:cubicBezTo>
                <a:cubicBezTo>
                  <a:pt x="5797001" y="589991"/>
                  <a:pt x="6223101" y="792223"/>
                  <a:pt x="6607360" y="1075097"/>
                </a:cubicBezTo>
                <a:cubicBezTo>
                  <a:pt x="6794438" y="1212779"/>
                  <a:pt x="6965102" y="1365689"/>
                  <a:pt x="7110534" y="1541421"/>
                </a:cubicBezTo>
                <a:lnTo>
                  <a:pt x="7179830" y="1630542"/>
                </a:lnTo>
                <a:lnTo>
                  <a:pt x="7136295" y="1700600"/>
                </a:lnTo>
                <a:lnTo>
                  <a:pt x="7131140" y="1693045"/>
                </a:lnTo>
                <a:cubicBezTo>
                  <a:pt x="6977874" y="1483026"/>
                  <a:pt x="6788448" y="1305671"/>
                  <a:pt x="6577499" y="1148230"/>
                </a:cubicBezTo>
                <a:cubicBezTo>
                  <a:pt x="6245452" y="900401"/>
                  <a:pt x="5878538" y="716408"/>
                  <a:pt x="5494816" y="563527"/>
                </a:cubicBezTo>
                <a:cubicBezTo>
                  <a:pt x="5452491" y="546487"/>
                  <a:pt x="5409881" y="530036"/>
                  <a:pt x="5366967" y="514176"/>
                </a:cubicBezTo>
                <a:cubicBezTo>
                  <a:pt x="5326377" y="499156"/>
                  <a:pt x="5285430" y="485210"/>
                  <a:pt x="5244661" y="470725"/>
                </a:cubicBezTo>
                <a:cubicBezTo>
                  <a:pt x="5471517" y="572127"/>
                  <a:pt x="5691970" y="687263"/>
                  <a:pt x="5904822" y="815468"/>
                </a:cubicBezTo>
                <a:cubicBezTo>
                  <a:pt x="6336645" y="1080104"/>
                  <a:pt x="6718758" y="1400351"/>
                  <a:pt x="7015222" y="1815185"/>
                </a:cubicBezTo>
                <a:lnTo>
                  <a:pt x="7040454" y="1854830"/>
                </a:lnTo>
                <a:close/>
              </a:path>
            </a:pathLst>
          </a:custGeom>
          <a:solidFill>
            <a:schemeClr val="accent2"/>
          </a:solidFill>
          <a:ln w="12700" cap="flat">
            <a:noFill/>
            <a:prstDash val="solid"/>
            <a:miter/>
          </a:ln>
        </p:spPr>
        <p:txBody>
          <a:bodyPr wrap="square" rtlCol="0" anchor="ctr">
            <a:noAutofit/>
          </a:bodyPr>
          <a:lstStyle/>
          <a:p>
            <a:endParaRPr lang="en-US"/>
          </a:p>
        </p:txBody>
      </p:sp>
      <p:sp>
        <p:nvSpPr>
          <p:cNvPr id="2" name="Title 1">
            <a:extLst>
              <a:ext uri="{FF2B5EF4-FFF2-40B4-BE49-F238E27FC236}">
                <a16:creationId xmlns:a16="http://schemas.microsoft.com/office/drawing/2014/main" id="{A10CC770-8F9B-4430-87B0-C97350B02DAE}"/>
              </a:ext>
            </a:extLst>
          </p:cNvPr>
          <p:cNvSpPr>
            <a:spLocks noGrp="1"/>
          </p:cNvSpPr>
          <p:nvPr>
            <p:ph type="title"/>
          </p:nvPr>
        </p:nvSpPr>
        <p:spPr>
          <a:xfrm>
            <a:off x="841246" y="673770"/>
            <a:ext cx="3644489" cy="2414488"/>
          </a:xfrm>
        </p:spPr>
        <p:txBody>
          <a:bodyPr anchor="t">
            <a:normAutofit/>
          </a:bodyPr>
          <a:lstStyle/>
          <a:p>
            <a:r>
              <a:rPr lang="en-US" sz="5000">
                <a:solidFill>
                  <a:srgbClr val="FFFFFF"/>
                </a:solidFill>
              </a:rPr>
              <a:t>Where to get emotional support</a:t>
            </a:r>
          </a:p>
        </p:txBody>
      </p:sp>
      <p:sp>
        <p:nvSpPr>
          <p:cNvPr id="3" name="Content Placeholder 2">
            <a:extLst>
              <a:ext uri="{FF2B5EF4-FFF2-40B4-BE49-F238E27FC236}">
                <a16:creationId xmlns:a16="http://schemas.microsoft.com/office/drawing/2014/main" id="{A743669D-2CCD-45CC-A053-2AAD0E7546D3}"/>
              </a:ext>
            </a:extLst>
          </p:cNvPr>
          <p:cNvSpPr>
            <a:spLocks noGrp="1"/>
          </p:cNvSpPr>
          <p:nvPr>
            <p:ph idx="1"/>
          </p:nvPr>
        </p:nvSpPr>
        <p:spPr>
          <a:xfrm>
            <a:off x="6095999" y="882315"/>
            <a:ext cx="5254754" cy="5294647"/>
          </a:xfrm>
        </p:spPr>
        <p:txBody>
          <a:bodyPr vert="horz" lIns="91440" tIns="45720" rIns="91440" bIns="45720" rtlCol="0" anchor="t">
            <a:normAutofit/>
          </a:bodyPr>
          <a:lstStyle/>
          <a:p>
            <a:r>
              <a:rPr lang="en-US" sz="2200" dirty="0">
                <a:cs typeface="Calibri"/>
              </a:rPr>
              <a:t>Where do you get emotional support? </a:t>
            </a:r>
            <a:endParaRPr lang="en-US" sz="2200" dirty="0"/>
          </a:p>
        </p:txBody>
      </p:sp>
    </p:spTree>
    <p:extLst>
      <p:ext uri="{BB962C8B-B14F-4D97-AF65-F5344CB8AC3E}">
        <p14:creationId xmlns:p14="http://schemas.microsoft.com/office/powerpoint/2010/main" val="357456003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C05CBC3C-2E5A-4839-8B9B-2E5A6ADF0F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DB5B423A-57CC-4C58-AA26-8E2E862B03A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1"/>
            <a:ext cx="5217023" cy="3994777"/>
          </a:xfrm>
          <a:custGeom>
            <a:avLst/>
            <a:gdLst>
              <a:gd name="connsiteX0" fmla="*/ 1945461 w 5217023"/>
              <a:gd name="connsiteY0" fmla="*/ 3787398 h 3994777"/>
              <a:gd name="connsiteX1" fmla="*/ 1942113 w 5217023"/>
              <a:gd name="connsiteY1" fmla="*/ 3790053 h 3994777"/>
              <a:gd name="connsiteX2" fmla="*/ 1946982 w 5217023"/>
              <a:gd name="connsiteY2" fmla="*/ 3787990 h 3994777"/>
              <a:gd name="connsiteX3" fmla="*/ 1945461 w 5217023"/>
              <a:gd name="connsiteY3" fmla="*/ 3787398 h 3994777"/>
              <a:gd name="connsiteX4" fmla="*/ 0 w 5217023"/>
              <a:gd name="connsiteY4" fmla="*/ 0 h 3994777"/>
              <a:gd name="connsiteX5" fmla="*/ 5030958 w 5217023"/>
              <a:gd name="connsiteY5" fmla="*/ 0 h 3994777"/>
              <a:gd name="connsiteX6" fmla="*/ 5046198 w 5217023"/>
              <a:gd name="connsiteY6" fmla="*/ 153449 h 3994777"/>
              <a:gd name="connsiteX7" fmla="*/ 5055729 w 5217023"/>
              <a:gd name="connsiteY7" fmla="*/ 415828 h 3994777"/>
              <a:gd name="connsiteX8" fmla="*/ 4735242 w 5217023"/>
              <a:gd name="connsiteY8" fmla="*/ 1867130 h 3994777"/>
              <a:gd name="connsiteX9" fmla="*/ 3907395 w 5217023"/>
              <a:gd name="connsiteY9" fmla="*/ 2938441 h 3994777"/>
              <a:gd name="connsiteX10" fmla="*/ 3946497 w 5217023"/>
              <a:gd name="connsiteY10" fmla="*/ 2908567 h 3994777"/>
              <a:gd name="connsiteX11" fmla="*/ 4585421 w 5217023"/>
              <a:gd name="connsiteY11" fmla="*/ 2188401 h 3994777"/>
              <a:gd name="connsiteX12" fmla="*/ 5142585 w 5217023"/>
              <a:gd name="connsiteY12" fmla="*/ 276891 h 3994777"/>
              <a:gd name="connsiteX13" fmla="*/ 5121833 w 5217023"/>
              <a:gd name="connsiteY13" fmla="*/ 30208 h 3994777"/>
              <a:gd name="connsiteX14" fmla="*/ 5116229 w 5217023"/>
              <a:gd name="connsiteY14" fmla="*/ 0 h 3994777"/>
              <a:gd name="connsiteX15" fmla="*/ 5184724 w 5217023"/>
              <a:gd name="connsiteY15" fmla="*/ 0 h 3994777"/>
              <a:gd name="connsiteX16" fmla="*/ 5196265 w 5217023"/>
              <a:gd name="connsiteY16" fmla="*/ 66113 h 3994777"/>
              <a:gd name="connsiteX17" fmla="*/ 5058603 w 5217023"/>
              <a:gd name="connsiteY17" fmla="*/ 1368242 h 3994777"/>
              <a:gd name="connsiteX18" fmla="*/ 4096624 w 5217023"/>
              <a:gd name="connsiteY18" fmla="*/ 2870829 h 3994777"/>
              <a:gd name="connsiteX19" fmla="*/ 3833203 w 5217023"/>
              <a:gd name="connsiteY19" fmla="*/ 3092190 h 3994777"/>
              <a:gd name="connsiteX20" fmla="*/ 3536509 w 5217023"/>
              <a:gd name="connsiteY20" fmla="*/ 3297128 h 3994777"/>
              <a:gd name="connsiteX21" fmla="*/ 3148966 w 5217023"/>
              <a:gd name="connsiteY21" fmla="*/ 3485478 h 3994777"/>
              <a:gd name="connsiteX22" fmla="*/ 1860557 w 5217023"/>
              <a:gd name="connsiteY22" fmla="*/ 3880910 h 3994777"/>
              <a:gd name="connsiteX23" fmla="*/ 573715 w 5217023"/>
              <a:gd name="connsiteY23" fmla="*/ 3983764 h 3994777"/>
              <a:gd name="connsiteX24" fmla="*/ 108410 w 5217023"/>
              <a:gd name="connsiteY24" fmla="*/ 3908816 h 3994777"/>
              <a:gd name="connsiteX25" fmla="*/ 0 w 5217023"/>
              <a:gd name="connsiteY25" fmla="*/ 3876793 h 3994777"/>
              <a:gd name="connsiteX26" fmla="*/ 0 w 5217023"/>
              <a:gd name="connsiteY26" fmla="*/ 3802912 h 3994777"/>
              <a:gd name="connsiteX27" fmla="*/ 36975 w 5217023"/>
              <a:gd name="connsiteY27" fmla="*/ 3815954 h 3994777"/>
              <a:gd name="connsiteX28" fmla="*/ 561628 w 5217023"/>
              <a:gd name="connsiteY28" fmla="*/ 3912655 h 3994777"/>
              <a:gd name="connsiteX29" fmla="*/ 1683086 w 5217023"/>
              <a:gd name="connsiteY29" fmla="*/ 3844334 h 3994777"/>
              <a:gd name="connsiteX30" fmla="*/ 1806023 w 5217023"/>
              <a:gd name="connsiteY30" fmla="*/ 3820992 h 3994777"/>
              <a:gd name="connsiteX31" fmla="*/ 1921817 w 5217023"/>
              <a:gd name="connsiteY31" fmla="*/ 3795747 h 3994777"/>
              <a:gd name="connsiteX32" fmla="*/ 1243689 w 5217023"/>
              <a:gd name="connsiteY32" fmla="*/ 3846539 h 3994777"/>
              <a:gd name="connsiteX33" fmla="*/ 62875 w 5217023"/>
              <a:gd name="connsiteY33" fmla="*/ 3668143 h 3994777"/>
              <a:gd name="connsiteX34" fmla="*/ 0 w 5217023"/>
              <a:gd name="connsiteY34" fmla="*/ 3644185 h 39947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Lst>
            <a:rect l="l" t="t" r="r" b="b"/>
            <a:pathLst>
              <a:path w="5217023" h="3994777">
                <a:moveTo>
                  <a:pt x="1945461" y="3787398"/>
                </a:moveTo>
                <a:lnTo>
                  <a:pt x="1942113" y="3790053"/>
                </a:lnTo>
                <a:lnTo>
                  <a:pt x="1946982" y="3787990"/>
                </a:lnTo>
                <a:cubicBezTo>
                  <a:pt x="1946982" y="3787990"/>
                  <a:pt x="1946379" y="3787019"/>
                  <a:pt x="1945461" y="3787398"/>
                </a:cubicBezTo>
                <a:close/>
                <a:moveTo>
                  <a:pt x="0" y="0"/>
                </a:moveTo>
                <a:lnTo>
                  <a:pt x="5030958" y="0"/>
                </a:lnTo>
                <a:lnTo>
                  <a:pt x="5046198" y="153449"/>
                </a:lnTo>
                <a:cubicBezTo>
                  <a:pt x="5052189" y="240558"/>
                  <a:pt x="5055458" y="328007"/>
                  <a:pt x="5055729" y="415828"/>
                </a:cubicBezTo>
                <a:cubicBezTo>
                  <a:pt x="5057604" y="923672"/>
                  <a:pt x="4959210" y="1409054"/>
                  <a:pt x="4735242" y="1867130"/>
                </a:cubicBezTo>
                <a:cubicBezTo>
                  <a:pt x="4533284" y="2280198"/>
                  <a:pt x="4248921" y="2629330"/>
                  <a:pt x="3907395" y="2938441"/>
                </a:cubicBezTo>
                <a:cubicBezTo>
                  <a:pt x="3922498" y="2931535"/>
                  <a:pt x="3935859" y="2921330"/>
                  <a:pt x="3946497" y="2908567"/>
                </a:cubicBezTo>
                <a:cubicBezTo>
                  <a:pt x="4193494" y="2700987"/>
                  <a:pt x="4408756" y="2458364"/>
                  <a:pt x="4585421" y="2188401"/>
                </a:cubicBezTo>
                <a:cubicBezTo>
                  <a:pt x="4967641" y="1608533"/>
                  <a:pt x="5169304" y="975361"/>
                  <a:pt x="5142585" y="276891"/>
                </a:cubicBezTo>
                <a:cubicBezTo>
                  <a:pt x="5139764" y="194215"/>
                  <a:pt x="5132824" y="111888"/>
                  <a:pt x="5121833" y="30208"/>
                </a:cubicBezTo>
                <a:lnTo>
                  <a:pt x="5116229" y="0"/>
                </a:lnTo>
                <a:lnTo>
                  <a:pt x="5184724" y="0"/>
                </a:lnTo>
                <a:lnTo>
                  <a:pt x="5196265" y="66113"/>
                </a:lnTo>
                <a:cubicBezTo>
                  <a:pt x="5249921" y="496647"/>
                  <a:pt x="5197997" y="931171"/>
                  <a:pt x="5058603" y="1368242"/>
                </a:cubicBezTo>
                <a:cubicBezTo>
                  <a:pt x="4872414" y="1953929"/>
                  <a:pt x="4544298" y="2451351"/>
                  <a:pt x="4096624" y="2870829"/>
                </a:cubicBezTo>
                <a:cubicBezTo>
                  <a:pt x="4012832" y="2949426"/>
                  <a:pt x="3924415" y="3022439"/>
                  <a:pt x="3833203" y="3092190"/>
                </a:cubicBezTo>
                <a:cubicBezTo>
                  <a:pt x="3741992" y="3161943"/>
                  <a:pt x="3648667" y="3225510"/>
                  <a:pt x="3536509" y="3297128"/>
                </a:cubicBezTo>
                <a:cubicBezTo>
                  <a:pt x="3427215" y="3372735"/>
                  <a:pt x="3288598" y="3430233"/>
                  <a:pt x="3148966" y="3485478"/>
                </a:cubicBezTo>
                <a:cubicBezTo>
                  <a:pt x="2729930" y="3651299"/>
                  <a:pt x="2302194" y="3788890"/>
                  <a:pt x="1860557" y="3880910"/>
                </a:cubicBezTo>
                <a:cubicBezTo>
                  <a:pt x="1435974" y="3969444"/>
                  <a:pt x="1008052" y="4017957"/>
                  <a:pt x="573715" y="3983764"/>
                </a:cubicBezTo>
                <a:cubicBezTo>
                  <a:pt x="415134" y="3971300"/>
                  <a:pt x="259585" y="3947743"/>
                  <a:pt x="108410" y="3908816"/>
                </a:cubicBezTo>
                <a:lnTo>
                  <a:pt x="0" y="3876793"/>
                </a:lnTo>
                <a:lnTo>
                  <a:pt x="0" y="3802912"/>
                </a:lnTo>
                <a:lnTo>
                  <a:pt x="36975" y="3815954"/>
                </a:lnTo>
                <a:cubicBezTo>
                  <a:pt x="206404" y="3867475"/>
                  <a:pt x="382020" y="3897326"/>
                  <a:pt x="561628" y="3912655"/>
                </a:cubicBezTo>
                <a:cubicBezTo>
                  <a:pt x="938583" y="3944832"/>
                  <a:pt x="1311814" y="3910697"/>
                  <a:pt x="1683086" y="3844334"/>
                </a:cubicBezTo>
                <a:cubicBezTo>
                  <a:pt x="1724123" y="3837151"/>
                  <a:pt x="1765097" y="3829374"/>
                  <a:pt x="1806023" y="3820992"/>
                </a:cubicBezTo>
                <a:cubicBezTo>
                  <a:pt x="1844740" y="3813079"/>
                  <a:pt x="1883218" y="3804161"/>
                  <a:pt x="1921817" y="3795747"/>
                </a:cubicBezTo>
                <a:cubicBezTo>
                  <a:pt x="1697011" y="3826435"/>
                  <a:pt x="1470551" y="3843387"/>
                  <a:pt x="1243689" y="3846539"/>
                </a:cubicBezTo>
                <a:cubicBezTo>
                  <a:pt x="839058" y="3849054"/>
                  <a:pt x="443424" y="3800206"/>
                  <a:pt x="62875" y="3668143"/>
                </a:cubicBezTo>
                <a:lnTo>
                  <a:pt x="0" y="3644185"/>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85CBFADE-6B8B-3892-A042-BC45CCBA9CD6}"/>
              </a:ext>
            </a:extLst>
          </p:cNvPr>
          <p:cNvSpPr>
            <a:spLocks noGrp="1"/>
          </p:cNvSpPr>
          <p:nvPr>
            <p:ph type="title"/>
          </p:nvPr>
        </p:nvSpPr>
        <p:spPr>
          <a:xfrm>
            <a:off x="838200" y="673770"/>
            <a:ext cx="3220329" cy="2027227"/>
          </a:xfrm>
        </p:spPr>
        <p:txBody>
          <a:bodyPr anchor="t">
            <a:normAutofit/>
          </a:bodyPr>
          <a:lstStyle/>
          <a:p>
            <a:r>
              <a:rPr lang="en-US" sz="4200">
                <a:solidFill>
                  <a:srgbClr val="FFFFFF"/>
                </a:solidFill>
                <a:cs typeface="Calibri Light"/>
              </a:rPr>
              <a:t>Second victim trajectory of recovery</a:t>
            </a:r>
          </a:p>
        </p:txBody>
      </p:sp>
      <p:graphicFrame>
        <p:nvGraphicFramePr>
          <p:cNvPr id="5" name="Content Placeholder 2">
            <a:extLst>
              <a:ext uri="{FF2B5EF4-FFF2-40B4-BE49-F238E27FC236}">
                <a16:creationId xmlns:a16="http://schemas.microsoft.com/office/drawing/2014/main" id="{0EE4B533-6D67-218D-FBAA-66C8461AFD04}"/>
              </a:ext>
            </a:extLst>
          </p:cNvPr>
          <p:cNvGraphicFramePr>
            <a:graphicFrameLocks noGrp="1"/>
          </p:cNvGraphicFramePr>
          <p:nvPr>
            <p:ph idx="1"/>
            <p:extLst>
              <p:ext uri="{D42A27DB-BD31-4B8C-83A1-F6EECF244321}">
                <p14:modId xmlns:p14="http://schemas.microsoft.com/office/powerpoint/2010/main" val="2579055117"/>
              </p:ext>
            </p:extLst>
          </p:nvPr>
        </p:nvGraphicFramePr>
        <p:xfrm>
          <a:off x="5542672" y="541606"/>
          <a:ext cx="5811128" cy="56782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9427AD46-15AD-4E74-9494-6FD94AB71D75}"/>
              </a:ext>
            </a:extLst>
          </p:cNvPr>
          <p:cNvSpPr txBox="1"/>
          <p:nvPr/>
        </p:nvSpPr>
        <p:spPr>
          <a:xfrm>
            <a:off x="213360" y="6400800"/>
            <a:ext cx="11399520" cy="646331"/>
          </a:xfrm>
          <a:prstGeom prst="rect">
            <a:avLst/>
          </a:prstGeom>
          <a:noFill/>
        </p:spPr>
        <p:txBody>
          <a:bodyPr wrap="square" rtlCol="0">
            <a:spAutoFit/>
          </a:bodyPr>
          <a:lstStyle/>
          <a:p>
            <a:r>
              <a:rPr lang="en-US" sz="1200" dirty="0">
                <a:ea typeface="+mn-lt"/>
                <a:cs typeface="+mn-lt"/>
              </a:rPr>
              <a:t>Scott SD, </a:t>
            </a:r>
            <a:r>
              <a:rPr lang="en-US" sz="1200" dirty="0" err="1">
                <a:ea typeface="+mn-lt"/>
                <a:cs typeface="+mn-lt"/>
              </a:rPr>
              <a:t>Hirschinger</a:t>
            </a:r>
            <a:r>
              <a:rPr lang="en-US" sz="1200" dirty="0">
                <a:ea typeface="+mn-lt"/>
                <a:cs typeface="+mn-lt"/>
              </a:rPr>
              <a:t> LE, Cox KR, </a:t>
            </a:r>
            <a:r>
              <a:rPr lang="en-US" sz="1200" dirty="0" err="1">
                <a:ea typeface="+mn-lt"/>
                <a:cs typeface="+mn-lt"/>
              </a:rPr>
              <a:t>McCoig</a:t>
            </a:r>
            <a:r>
              <a:rPr lang="en-US" sz="1200" dirty="0">
                <a:ea typeface="+mn-lt"/>
                <a:cs typeface="+mn-lt"/>
              </a:rPr>
              <a:t> M, Brandt J, Hall LW. The natural history of recovery for the healthcare provider "second victim" after adverse patient events. Qual </a:t>
            </a:r>
            <a:r>
              <a:rPr lang="en-US" sz="1200" dirty="0" err="1">
                <a:ea typeface="+mn-lt"/>
                <a:cs typeface="+mn-lt"/>
              </a:rPr>
              <a:t>Saf</a:t>
            </a:r>
            <a:r>
              <a:rPr lang="en-US" sz="1200" dirty="0">
                <a:ea typeface="+mn-lt"/>
                <a:cs typeface="+mn-lt"/>
              </a:rPr>
              <a:t> Health Care. 2009 Oct;18(5):325-30. </a:t>
            </a:r>
          </a:p>
          <a:p>
            <a:endParaRPr lang="en-US" sz="1200" dirty="0"/>
          </a:p>
        </p:txBody>
      </p:sp>
    </p:spTree>
    <p:extLst>
      <p:ext uri="{BB962C8B-B14F-4D97-AF65-F5344CB8AC3E}">
        <p14:creationId xmlns:p14="http://schemas.microsoft.com/office/powerpoint/2010/main" val="36202476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A346F5D-79D2-4B03-9A8E-6BC24F8290D0}"/>
              </a:ext>
            </a:extLst>
          </p:cNvPr>
          <p:cNvSpPr>
            <a:spLocks noGrp="1"/>
          </p:cNvSpPr>
          <p:nvPr>
            <p:ph type="title"/>
          </p:nvPr>
        </p:nvSpPr>
        <p:spPr>
          <a:xfrm>
            <a:off x="841248" y="548640"/>
            <a:ext cx="3600860" cy="5431536"/>
          </a:xfrm>
        </p:spPr>
        <p:txBody>
          <a:bodyPr>
            <a:normAutofit/>
          </a:bodyPr>
          <a:lstStyle/>
          <a:p>
            <a:r>
              <a:rPr lang="en-US" sz="3400"/>
              <a:t>Practice!   Coping </a:t>
            </a: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C56349CC-610D-4B5D-910F-AEBE137B1783}"/>
              </a:ext>
            </a:extLst>
          </p:cNvPr>
          <p:cNvSpPr>
            <a:spLocks noGrp="1"/>
          </p:cNvSpPr>
          <p:nvPr>
            <p:ph idx="1"/>
          </p:nvPr>
        </p:nvSpPr>
        <p:spPr>
          <a:xfrm>
            <a:off x="5126418" y="552091"/>
            <a:ext cx="6224335" cy="5431536"/>
          </a:xfrm>
        </p:spPr>
        <p:txBody>
          <a:bodyPr vert="horz" lIns="91440" tIns="45720" rIns="91440" bIns="45720" rtlCol="0" anchor="ctr">
            <a:normAutofit/>
          </a:bodyPr>
          <a:lstStyle/>
          <a:p>
            <a:endParaRPr lang="en-US" sz="2200">
              <a:cs typeface="Calibri"/>
            </a:endParaRPr>
          </a:p>
          <a:p>
            <a:r>
              <a:rPr lang="en-US" sz="2200" dirty="0">
                <a:ea typeface="+mn-lt"/>
                <a:cs typeface="+mn-lt"/>
              </a:rPr>
              <a:t>How do you cope with a mistake, near miss, or even just a bad day at work? </a:t>
            </a:r>
            <a:endParaRPr lang="en-US" sz="2200" dirty="0">
              <a:cs typeface="Calibri"/>
            </a:endParaRPr>
          </a:p>
        </p:txBody>
      </p:sp>
    </p:spTree>
    <p:extLst>
      <p:ext uri="{BB962C8B-B14F-4D97-AF65-F5344CB8AC3E}">
        <p14:creationId xmlns:p14="http://schemas.microsoft.com/office/powerpoint/2010/main" val="406510484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A346F5D-79D2-4B03-9A8E-6BC24F8290D0}"/>
              </a:ext>
            </a:extLst>
          </p:cNvPr>
          <p:cNvSpPr>
            <a:spLocks noGrp="1"/>
          </p:cNvSpPr>
          <p:nvPr>
            <p:ph type="title"/>
          </p:nvPr>
        </p:nvSpPr>
        <p:spPr>
          <a:xfrm>
            <a:off x="841248" y="548640"/>
            <a:ext cx="3600860" cy="5431536"/>
          </a:xfrm>
        </p:spPr>
        <p:txBody>
          <a:bodyPr>
            <a:normAutofit/>
          </a:bodyPr>
          <a:lstStyle/>
          <a:p>
            <a:pPr>
              <a:spcBef>
                <a:spcPts val="1000"/>
              </a:spcBef>
            </a:pPr>
            <a:r>
              <a:rPr lang="en-US" sz="3400"/>
              <a:t>Practice!   Coping  </a:t>
            </a:r>
            <a:br>
              <a:rPr lang="en-US" sz="3400">
                <a:cs typeface="Calibri Light"/>
              </a:rPr>
            </a:br>
            <a:br>
              <a:rPr lang="en-US" sz="3400">
                <a:cs typeface="Calibri Light"/>
              </a:rPr>
            </a:br>
            <a:r>
              <a:rPr lang="en-US" sz="2800">
                <a:cs typeface="Calibri Light"/>
              </a:rPr>
              <a:t>Exemplar reminders:</a:t>
            </a:r>
            <a:br>
              <a:rPr lang="en-US" sz="3400">
                <a:latin typeface="Calibri Light"/>
                <a:cs typeface="Calibri Light"/>
              </a:rPr>
            </a:br>
            <a:endParaRPr lang="en-US" sz="1800">
              <a:latin typeface="Calibri"/>
              <a:ea typeface="+mj-lt"/>
              <a:cs typeface="Calibri"/>
            </a:endParaRPr>
          </a:p>
          <a:p>
            <a:pPr marL="285750" indent="-285750">
              <a:spcBef>
                <a:spcPts val="1000"/>
              </a:spcBef>
              <a:buFont typeface="Arial"/>
              <a:buChar char="•"/>
            </a:pPr>
            <a:r>
              <a:rPr lang="en-US" sz="1800">
                <a:latin typeface="Calibri"/>
                <a:cs typeface="Calibri"/>
              </a:rPr>
              <a:t>Talk, disclose and apologize</a:t>
            </a:r>
            <a:endParaRPr lang="en-US" sz="1800">
              <a:ea typeface="+mj-lt"/>
              <a:cs typeface="+mj-lt"/>
            </a:endParaRPr>
          </a:p>
          <a:p>
            <a:pPr marL="285750" indent="-285750">
              <a:spcBef>
                <a:spcPts val="1000"/>
              </a:spcBef>
              <a:buFont typeface="Arial"/>
              <a:buChar char="•"/>
            </a:pPr>
            <a:r>
              <a:rPr lang="en-US" sz="1800">
                <a:latin typeface="Calibri"/>
                <a:cs typeface="Calibri"/>
              </a:rPr>
              <a:t>Forgiveness</a:t>
            </a:r>
            <a:endParaRPr lang="en-US" sz="1800">
              <a:ea typeface="+mj-lt"/>
              <a:cs typeface="+mj-lt"/>
            </a:endParaRPr>
          </a:p>
          <a:p>
            <a:pPr marL="285750" indent="-285750">
              <a:spcBef>
                <a:spcPts val="1000"/>
              </a:spcBef>
              <a:buFont typeface="Arial"/>
              <a:buChar char="•"/>
            </a:pPr>
            <a:r>
              <a:rPr lang="en-US" sz="1800">
                <a:latin typeface="Calibri"/>
                <a:cs typeface="Calibri"/>
              </a:rPr>
              <a:t>Moral context</a:t>
            </a:r>
            <a:endParaRPr lang="en-US" sz="1800">
              <a:ea typeface="+mj-lt"/>
              <a:cs typeface="+mj-lt"/>
            </a:endParaRPr>
          </a:p>
          <a:p>
            <a:pPr marL="285750" indent="-285750">
              <a:spcBef>
                <a:spcPts val="1000"/>
              </a:spcBef>
              <a:buFont typeface="Arial"/>
              <a:buChar char="•"/>
            </a:pPr>
            <a:r>
              <a:rPr lang="en-US" sz="1800">
                <a:latin typeface="Calibri"/>
                <a:cs typeface="Calibri"/>
              </a:rPr>
              <a:t>Deal with imperfection</a:t>
            </a:r>
            <a:endParaRPr lang="en-US" sz="1800">
              <a:ea typeface="+mj-lt"/>
              <a:cs typeface="+mj-lt"/>
            </a:endParaRPr>
          </a:p>
          <a:p>
            <a:pPr marL="285750" indent="-285750">
              <a:spcBef>
                <a:spcPts val="1000"/>
              </a:spcBef>
              <a:buFont typeface="Arial"/>
              <a:buChar char="•"/>
            </a:pPr>
            <a:r>
              <a:rPr lang="en-US" sz="1800">
                <a:latin typeface="Calibri"/>
                <a:cs typeface="Calibri"/>
              </a:rPr>
              <a:t>Become an expert</a:t>
            </a:r>
            <a:endParaRPr lang="en-US" sz="1800">
              <a:ea typeface="+mj-lt"/>
              <a:cs typeface="+mj-lt"/>
            </a:endParaRPr>
          </a:p>
          <a:p>
            <a:pPr marL="285750" indent="-285750">
              <a:spcBef>
                <a:spcPts val="1000"/>
              </a:spcBef>
              <a:buFont typeface="Arial"/>
              <a:buChar char="•"/>
            </a:pPr>
            <a:r>
              <a:rPr lang="en-US" sz="1800">
                <a:latin typeface="Calibri"/>
                <a:cs typeface="Calibri"/>
              </a:rPr>
              <a:t>Prevent recurrence/teamwork</a:t>
            </a:r>
            <a:endParaRPr lang="en-US" sz="1800">
              <a:ea typeface="+mj-lt"/>
              <a:cs typeface="+mj-lt"/>
            </a:endParaRPr>
          </a:p>
          <a:p>
            <a:pPr marL="285750" indent="-285750">
              <a:spcBef>
                <a:spcPts val="1000"/>
              </a:spcBef>
              <a:buFont typeface="Arial"/>
              <a:buChar char="•"/>
            </a:pPr>
            <a:r>
              <a:rPr lang="en-US" sz="1800">
                <a:latin typeface="Calibri"/>
                <a:cs typeface="Calibri"/>
              </a:rPr>
              <a:t>Teach others</a:t>
            </a:r>
            <a:endParaRPr lang="en-US" sz="1800">
              <a:cs typeface="Calibri Light"/>
            </a:endParaRP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C56349CC-610D-4B5D-910F-AEBE137B1783}"/>
              </a:ext>
            </a:extLst>
          </p:cNvPr>
          <p:cNvSpPr>
            <a:spLocks noGrp="1"/>
          </p:cNvSpPr>
          <p:nvPr>
            <p:ph idx="1"/>
          </p:nvPr>
        </p:nvSpPr>
        <p:spPr>
          <a:xfrm>
            <a:off x="5126418" y="552091"/>
            <a:ext cx="6224335" cy="5431536"/>
          </a:xfrm>
        </p:spPr>
        <p:txBody>
          <a:bodyPr vert="horz" lIns="91440" tIns="45720" rIns="91440" bIns="45720" rtlCol="0" anchor="ctr">
            <a:normAutofit/>
          </a:bodyPr>
          <a:lstStyle/>
          <a:p>
            <a:pPr marL="0" indent="0">
              <a:buNone/>
            </a:pPr>
            <a:r>
              <a:rPr lang="en-US" sz="2200" dirty="0">
                <a:cs typeface="Calibri"/>
              </a:rPr>
              <a:t>Write a letter to a colleague to read in the wake of a self-perceived failure.  5 min</a:t>
            </a:r>
          </a:p>
          <a:p>
            <a:r>
              <a:rPr lang="en-US" sz="2200" dirty="0">
                <a:cs typeface="Calibri"/>
              </a:rPr>
              <a:t>What do you want to remind them of?</a:t>
            </a:r>
          </a:p>
          <a:p>
            <a:r>
              <a:rPr lang="en-US" sz="2200" dirty="0">
                <a:cs typeface="Calibri"/>
              </a:rPr>
              <a:t>What do you hope they will feel and do?</a:t>
            </a:r>
          </a:p>
          <a:p>
            <a:r>
              <a:rPr lang="en-US" sz="2200" dirty="0">
                <a:cs typeface="Calibri"/>
              </a:rPr>
              <a:t>Where can they find strength and support?</a:t>
            </a:r>
          </a:p>
        </p:txBody>
      </p:sp>
    </p:spTree>
    <p:extLst>
      <p:ext uri="{BB962C8B-B14F-4D97-AF65-F5344CB8AC3E}">
        <p14:creationId xmlns:p14="http://schemas.microsoft.com/office/powerpoint/2010/main" val="268498382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591A292-4F23-E563-FD70-5EBDC024EADF}"/>
              </a:ext>
            </a:extLst>
          </p:cNvPr>
          <p:cNvSpPr>
            <a:spLocks noGrp="1"/>
          </p:cNvSpPr>
          <p:nvPr>
            <p:ph type="title"/>
          </p:nvPr>
        </p:nvSpPr>
        <p:spPr>
          <a:xfrm>
            <a:off x="838200" y="365125"/>
            <a:ext cx="10515600" cy="1325563"/>
          </a:xfrm>
        </p:spPr>
        <p:txBody>
          <a:bodyPr>
            <a:normAutofit/>
          </a:bodyPr>
          <a:lstStyle/>
          <a:p>
            <a:r>
              <a:rPr lang="en-US" sz="4200" dirty="0">
                <a:cs typeface="Calibri Light"/>
              </a:rPr>
              <a:t>OPTIONAL –COPING RESOURCES</a:t>
            </a:r>
            <a:endParaRPr lang="en-US" sz="4200" dirty="0"/>
          </a:p>
        </p:txBody>
      </p:sp>
      <p:sp>
        <p:nvSpPr>
          <p:cNvPr id="12"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Content Placeholder 4">
            <a:extLst>
              <a:ext uri="{FF2B5EF4-FFF2-40B4-BE49-F238E27FC236}">
                <a16:creationId xmlns:a16="http://schemas.microsoft.com/office/drawing/2014/main" id="{5D84C0CA-17AF-B099-83E1-C6317BC86683}"/>
              </a:ext>
            </a:extLst>
          </p:cNvPr>
          <p:cNvSpPr>
            <a:spLocks noGrp="1"/>
          </p:cNvSpPr>
          <p:nvPr>
            <p:ph idx="1"/>
          </p:nvPr>
        </p:nvSpPr>
        <p:spPr>
          <a:xfrm>
            <a:off x="838200" y="1929384"/>
            <a:ext cx="10515600" cy="4251960"/>
          </a:xfrm>
        </p:spPr>
        <p:txBody>
          <a:bodyPr vert="horz" lIns="91440" tIns="45720" rIns="91440" bIns="45720" rtlCol="0">
            <a:normAutofit/>
          </a:bodyPr>
          <a:lstStyle/>
          <a:p>
            <a:r>
              <a:rPr lang="en-US" sz="2200">
                <a:cs typeface="Calibri"/>
              </a:rPr>
              <a:t>University of Wisconsin's integrative health website</a:t>
            </a:r>
          </a:p>
          <a:p>
            <a:pPr lvl="1">
              <a:buFont typeface="Courier New" panose="020B0604020202020204" pitchFamily="34" charset="0"/>
              <a:buChar char="o"/>
            </a:pPr>
            <a:r>
              <a:rPr lang="en-US" sz="2200">
                <a:cs typeface="Calibri"/>
              </a:rPr>
              <a:t>Section on relaxing and healing</a:t>
            </a:r>
          </a:p>
        </p:txBody>
      </p:sp>
    </p:spTree>
    <p:extLst>
      <p:ext uri="{BB962C8B-B14F-4D97-AF65-F5344CB8AC3E}">
        <p14:creationId xmlns:p14="http://schemas.microsoft.com/office/powerpoint/2010/main" val="25952510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F474AF9-C42D-4BA6-8D35-CC05307B4360}"/>
              </a:ext>
            </a:extLst>
          </p:cNvPr>
          <p:cNvSpPr>
            <a:spLocks noGrp="1"/>
          </p:cNvSpPr>
          <p:nvPr>
            <p:ph type="title"/>
          </p:nvPr>
        </p:nvSpPr>
        <p:spPr>
          <a:xfrm>
            <a:off x="414067" y="548640"/>
            <a:ext cx="4028041" cy="5431536"/>
          </a:xfrm>
        </p:spPr>
        <p:txBody>
          <a:bodyPr>
            <a:normAutofit/>
          </a:bodyPr>
          <a:lstStyle/>
          <a:p>
            <a:r>
              <a:rPr lang="en-US" sz="4600" dirty="0"/>
              <a:t>Practice!  </a:t>
            </a:r>
            <a:br>
              <a:rPr lang="en-US" sz="4600" dirty="0"/>
            </a:br>
            <a:r>
              <a:rPr lang="en-US" sz="4600" dirty="0"/>
              <a:t>Self awareness</a:t>
            </a:r>
            <a:endParaRPr lang="en-US" sz="4600" dirty="0">
              <a:cs typeface="Calibri Light"/>
            </a:endParaRP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369AE72C-8C05-4B2F-8AE7-5D5038B1A83F}"/>
              </a:ext>
            </a:extLst>
          </p:cNvPr>
          <p:cNvSpPr>
            <a:spLocks noGrp="1"/>
          </p:cNvSpPr>
          <p:nvPr>
            <p:ph idx="1"/>
          </p:nvPr>
        </p:nvSpPr>
        <p:spPr>
          <a:xfrm>
            <a:off x="5126418" y="552091"/>
            <a:ext cx="6224335" cy="5431536"/>
          </a:xfrm>
        </p:spPr>
        <p:txBody>
          <a:bodyPr vert="horz" lIns="91440" tIns="45720" rIns="91440" bIns="45720" rtlCol="0" anchor="ctr">
            <a:normAutofit/>
          </a:bodyPr>
          <a:lstStyle/>
          <a:p>
            <a:r>
              <a:rPr lang="en-US" sz="2200" dirty="0">
                <a:cs typeface="Calibri"/>
              </a:rPr>
              <a:t>How are you feeling today? </a:t>
            </a:r>
            <a:endParaRPr lang="en-US" dirty="0">
              <a:cs typeface="Calibri"/>
            </a:endParaRPr>
          </a:p>
          <a:p>
            <a:r>
              <a:rPr lang="en-US" sz="2200" dirty="0">
                <a:cs typeface="Calibri"/>
              </a:rPr>
              <a:t>Can you be more specific?  </a:t>
            </a:r>
            <a:endParaRPr lang="en-US" dirty="0">
              <a:cs typeface="Calibri"/>
            </a:endParaRPr>
          </a:p>
          <a:p>
            <a:r>
              <a:rPr lang="en-US" sz="2200" dirty="0">
                <a:cs typeface="Calibri"/>
              </a:rPr>
              <a:t>Do you feel ready to learn? </a:t>
            </a:r>
            <a:endParaRPr lang="en-US">
              <a:cs typeface="Calibri"/>
            </a:endParaRPr>
          </a:p>
          <a:p>
            <a:r>
              <a:rPr lang="en-US" sz="2200" dirty="0">
                <a:cs typeface="Calibri"/>
              </a:rPr>
              <a:t>Take care of patients?</a:t>
            </a:r>
            <a:endParaRPr lang="en-US" dirty="0">
              <a:ea typeface="Calibri" panose="020F0502020204030204"/>
              <a:cs typeface="Calibri"/>
            </a:endParaRPr>
          </a:p>
          <a:p>
            <a:endParaRPr lang="en-US" sz="2200">
              <a:cs typeface="Calibri"/>
            </a:endParaRPr>
          </a:p>
        </p:txBody>
      </p:sp>
    </p:spTree>
    <p:extLst>
      <p:ext uri="{BB962C8B-B14F-4D97-AF65-F5344CB8AC3E}">
        <p14:creationId xmlns:p14="http://schemas.microsoft.com/office/powerpoint/2010/main" val="185053020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 name="Rectangle 14">
            <a:extLst>
              <a:ext uri="{FF2B5EF4-FFF2-40B4-BE49-F238E27FC236}">
                <a16:creationId xmlns:a16="http://schemas.microsoft.com/office/drawing/2014/main" id="{7FF47CB7-972F-479F-A36D-9E72D26EC8D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Freeform: Shape 16">
            <a:extLst>
              <a:ext uri="{FF2B5EF4-FFF2-40B4-BE49-F238E27FC236}">
                <a16:creationId xmlns:a16="http://schemas.microsoft.com/office/drawing/2014/main" id="{0D153B68-5844-490D-8E67-F616D6D721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1766176" cy="2061837"/>
          </a:xfrm>
          <a:custGeom>
            <a:avLst/>
            <a:gdLst>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9437 w 10768629"/>
              <a:gd name="connsiteY140" fmla="*/ 1636968 h 1978172"/>
              <a:gd name="connsiteX141" fmla="*/ 5440853 w 10768629"/>
              <a:gd name="connsiteY141" fmla="*/ 1657958 h 1978172"/>
              <a:gd name="connsiteX142" fmla="*/ 4945936 w 10768629"/>
              <a:gd name="connsiteY142" fmla="*/ 1713743 h 1978172"/>
              <a:gd name="connsiteX143" fmla="*/ 4818446 w 10768629"/>
              <a:gd name="connsiteY143" fmla="*/ 1726895 h 1978172"/>
              <a:gd name="connsiteX144" fmla="*/ 4813657 w 10768629"/>
              <a:gd name="connsiteY144" fmla="*/ 1730706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9437 w 10768629"/>
              <a:gd name="connsiteY140" fmla="*/ 1636968 h 1978172"/>
              <a:gd name="connsiteX141" fmla="*/ 5440853 w 10768629"/>
              <a:gd name="connsiteY141" fmla="*/ 1657958 h 1978172"/>
              <a:gd name="connsiteX142" fmla="*/ 4945936 w 10768629"/>
              <a:gd name="connsiteY142" fmla="*/ 1713743 h 1978172"/>
              <a:gd name="connsiteX143" fmla="*/ 4818446 w 10768629"/>
              <a:gd name="connsiteY143" fmla="*/ 1726895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9437 w 10768629"/>
              <a:gd name="connsiteY140" fmla="*/ 1636968 h 1978172"/>
              <a:gd name="connsiteX141" fmla="*/ 5440853 w 10768629"/>
              <a:gd name="connsiteY141" fmla="*/ 1657958 h 1978172"/>
              <a:gd name="connsiteX142" fmla="*/ 4945936 w 10768629"/>
              <a:gd name="connsiteY142" fmla="*/ 1713743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9437 w 10768629"/>
              <a:gd name="connsiteY140" fmla="*/ 1636968 h 1978172"/>
              <a:gd name="connsiteX141" fmla="*/ 5440853 w 10768629"/>
              <a:gd name="connsiteY141" fmla="*/ 1657958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40853 w 10768629"/>
              <a:gd name="connsiteY141" fmla="*/ 1657958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38835 w 10768629"/>
              <a:gd name="connsiteY164" fmla="*/ 1920210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32568 w 10768629"/>
              <a:gd name="connsiteY178" fmla="*/ 1793149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57365 w 10768629"/>
              <a:gd name="connsiteY178" fmla="*/ 1832140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57365 w 10768629"/>
              <a:gd name="connsiteY178" fmla="*/ 1832140 h 1978172"/>
              <a:gd name="connsiteX179" fmla="*/ 1186881 w 10768629"/>
              <a:gd name="connsiteY179" fmla="*/ 1768613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57365 w 10768629"/>
              <a:gd name="connsiteY178" fmla="*/ 1832140 h 1978172"/>
              <a:gd name="connsiteX179" fmla="*/ 1232341 w 10768629"/>
              <a:gd name="connsiteY179" fmla="*/ 1785942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1967996 w 10768629"/>
              <a:gd name="connsiteY173" fmla="*/ 1953187 h 1978172"/>
              <a:gd name="connsiteX174" fmla="*/ 1855805 w 10768629"/>
              <a:gd name="connsiteY174" fmla="*/ 1926082 h 1978172"/>
              <a:gd name="connsiteX175" fmla="*/ 1790957 w 10768629"/>
              <a:gd name="connsiteY175" fmla="*/ 1919460 h 1978172"/>
              <a:gd name="connsiteX176" fmla="*/ 1613978 w 10768629"/>
              <a:gd name="connsiteY176" fmla="*/ 1891581 h 1978172"/>
              <a:gd name="connsiteX177" fmla="*/ 1436831 w 10768629"/>
              <a:gd name="connsiteY177" fmla="*/ 1856201 h 1978172"/>
              <a:gd name="connsiteX178" fmla="*/ 1357365 w 10768629"/>
              <a:gd name="connsiteY178" fmla="*/ 1832140 h 1978172"/>
              <a:gd name="connsiteX179" fmla="*/ 1232341 w 10768629"/>
              <a:gd name="connsiteY179" fmla="*/ 1785942 h 1978172"/>
              <a:gd name="connsiteX180" fmla="*/ 1162595 w 10768629"/>
              <a:gd name="connsiteY180" fmla="*/ 1758337 h 1978172"/>
              <a:gd name="connsiteX181" fmla="*/ 1128523 w 10768629"/>
              <a:gd name="connsiteY181" fmla="*/ 1763621 h 1978172"/>
              <a:gd name="connsiteX182" fmla="*/ 991903 w 10768629"/>
              <a:gd name="connsiteY182" fmla="*/ 1786741 h 1978172"/>
              <a:gd name="connsiteX183" fmla="*/ 883960 w 10768629"/>
              <a:gd name="connsiteY183" fmla="*/ 1822386 h 1978172"/>
              <a:gd name="connsiteX184" fmla="*/ 766531 w 10768629"/>
              <a:gd name="connsiteY184" fmla="*/ 1805053 h 1978172"/>
              <a:gd name="connsiteX185" fmla="*/ 669779 w 10768629"/>
              <a:gd name="connsiteY185" fmla="*/ 1800537 h 1978172"/>
              <a:gd name="connsiteX186" fmla="*/ 523898 w 10768629"/>
              <a:gd name="connsiteY186" fmla="*/ 1811085 h 1978172"/>
              <a:gd name="connsiteX187" fmla="*/ 360251 w 10768629"/>
              <a:gd name="connsiteY187" fmla="*/ 1830735 h 1978172"/>
              <a:gd name="connsiteX188" fmla="*/ 255207 w 10768629"/>
              <a:gd name="connsiteY188" fmla="*/ 1818275 h 1978172"/>
              <a:gd name="connsiteX189" fmla="*/ 101803 w 10768629"/>
              <a:gd name="connsiteY189" fmla="*/ 1870647 h 1978172"/>
              <a:gd name="connsiteX190" fmla="*/ 25397 w 10768629"/>
              <a:gd name="connsiteY190" fmla="*/ 1888443 h 1978172"/>
              <a:gd name="connsiteX191" fmla="*/ 2370 w 10768629"/>
              <a:gd name="connsiteY191" fmla="*/ 1878311 h 1978172"/>
              <a:gd name="connsiteX192" fmla="*/ 0 w 10768629"/>
              <a:gd name="connsiteY192" fmla="*/ 1878785 h 1978172"/>
              <a:gd name="connsiteX193" fmla="*/ 0 w 10768629"/>
              <a:gd name="connsiteY193"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115176 w 10768629"/>
              <a:gd name="connsiteY163" fmla="*/ 1943459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57504 w 10768629"/>
              <a:gd name="connsiteY162" fmla="*/ 1957276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90336 w 10768629"/>
              <a:gd name="connsiteY159" fmla="*/ 1925039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76289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407128 w 10768629"/>
              <a:gd name="connsiteY46" fmla="*/ 961344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9462 w 10768629"/>
              <a:gd name="connsiteY48" fmla="*/ 987106 h 1978172"/>
              <a:gd name="connsiteX49" fmla="*/ 8369725 w 10768629"/>
              <a:gd name="connsiteY49" fmla="*/ 989186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9462 w 10768629"/>
              <a:gd name="connsiteY48" fmla="*/ 987106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79948 w 10768629"/>
              <a:gd name="connsiteY35" fmla="*/ 576062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316893 w 10768629"/>
              <a:gd name="connsiteY28" fmla="*/ 491390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69666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43525 w 10768629"/>
              <a:gd name="connsiteY78" fmla="*/ 1179064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85942 w 10768629"/>
              <a:gd name="connsiteY79" fmla="*/ 1233723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07190 w 10768629"/>
              <a:gd name="connsiteY82" fmla="*/ 1314737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5361 w 10768629"/>
              <a:gd name="connsiteY152" fmla="*/ 1894711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20200 w 10768629"/>
              <a:gd name="connsiteY151" fmla="*/ 1873173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22386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09389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09389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8523 w 10768629"/>
              <a:gd name="connsiteY182" fmla="*/ 1763621 h 1978172"/>
              <a:gd name="connsiteX183" fmla="*/ 991903 w 10768629"/>
              <a:gd name="connsiteY183" fmla="*/ 1786741 h 1978172"/>
              <a:gd name="connsiteX184" fmla="*/ 883960 w 10768629"/>
              <a:gd name="connsiteY184" fmla="*/ 1809389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58337 h 1978172"/>
              <a:gd name="connsiteX182" fmla="*/ 1120257 w 10768629"/>
              <a:gd name="connsiteY182" fmla="*/ 1789615 h 1978172"/>
              <a:gd name="connsiteX183" fmla="*/ 991903 w 10768629"/>
              <a:gd name="connsiteY183" fmla="*/ 1786741 h 1978172"/>
              <a:gd name="connsiteX184" fmla="*/ 883960 w 10768629"/>
              <a:gd name="connsiteY184" fmla="*/ 1809389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 name="connsiteX0" fmla="*/ 0 w 10768629"/>
              <a:gd name="connsiteY0" fmla="*/ 0 h 1978172"/>
              <a:gd name="connsiteX1" fmla="*/ 10768629 w 10768629"/>
              <a:gd name="connsiteY1" fmla="*/ 0 h 1978172"/>
              <a:gd name="connsiteX2" fmla="*/ 10733254 w 10768629"/>
              <a:gd name="connsiteY2" fmla="*/ 31439 h 1978172"/>
              <a:gd name="connsiteX3" fmla="*/ 10727085 w 10768629"/>
              <a:gd name="connsiteY3" fmla="*/ 37910 h 1978172"/>
              <a:gd name="connsiteX4" fmla="*/ 10675953 w 10768629"/>
              <a:gd name="connsiteY4" fmla="*/ 68623 h 1978172"/>
              <a:gd name="connsiteX5" fmla="*/ 10637091 w 10768629"/>
              <a:gd name="connsiteY5" fmla="*/ 90361 h 1978172"/>
              <a:gd name="connsiteX6" fmla="*/ 10610971 w 10768629"/>
              <a:gd name="connsiteY6" fmla="*/ 110764 h 1978172"/>
              <a:gd name="connsiteX7" fmla="*/ 10532872 w 10768629"/>
              <a:gd name="connsiteY7" fmla="*/ 138028 h 1978172"/>
              <a:gd name="connsiteX8" fmla="*/ 10398558 w 10768629"/>
              <a:gd name="connsiteY8" fmla="*/ 172911 h 1978172"/>
              <a:gd name="connsiteX9" fmla="*/ 10371128 w 10768629"/>
              <a:gd name="connsiteY9" fmla="*/ 182609 h 1978172"/>
              <a:gd name="connsiteX10" fmla="*/ 10352178 w 10768629"/>
              <a:gd name="connsiteY10" fmla="*/ 199976 h 1978172"/>
              <a:gd name="connsiteX11" fmla="*/ 10351815 w 10768629"/>
              <a:gd name="connsiteY11" fmla="*/ 211879 h 1978172"/>
              <a:gd name="connsiteX12" fmla="*/ 10337471 w 10768629"/>
              <a:gd name="connsiteY12" fmla="*/ 218661 h 1978172"/>
              <a:gd name="connsiteX13" fmla="*/ 10334625 w 10768629"/>
              <a:gd name="connsiteY13" fmla="*/ 222351 h 1978172"/>
              <a:gd name="connsiteX14" fmla="*/ 10256365 w 10768629"/>
              <a:gd name="connsiteY14" fmla="*/ 235917 h 1978172"/>
              <a:gd name="connsiteX15" fmla="*/ 10201127 w 10768629"/>
              <a:gd name="connsiteY15" fmla="*/ 267448 h 1978172"/>
              <a:gd name="connsiteX16" fmla="*/ 9961218 w 10768629"/>
              <a:gd name="connsiteY16" fmla="*/ 326720 h 1978172"/>
              <a:gd name="connsiteX17" fmla="*/ 9859715 w 10768629"/>
              <a:gd name="connsiteY17" fmla="*/ 355698 h 1978172"/>
              <a:gd name="connsiteX18" fmla="*/ 9679867 w 10768629"/>
              <a:gd name="connsiteY18" fmla="*/ 399081 h 1978172"/>
              <a:gd name="connsiteX19" fmla="*/ 9490654 w 10768629"/>
              <a:gd name="connsiteY19" fmla="*/ 455225 h 1978172"/>
              <a:gd name="connsiteX20" fmla="*/ 9470837 w 10768629"/>
              <a:gd name="connsiteY20" fmla="*/ 452539 h 1978172"/>
              <a:gd name="connsiteX21" fmla="*/ 9469082 w 10768629"/>
              <a:gd name="connsiteY21" fmla="*/ 454891 h 1978172"/>
              <a:gd name="connsiteX22" fmla="*/ 9448038 w 10768629"/>
              <a:gd name="connsiteY22" fmla="*/ 459733 h 1978172"/>
              <a:gd name="connsiteX23" fmla="*/ 9396821 w 10768629"/>
              <a:gd name="connsiteY23" fmla="*/ 455795 h 1978172"/>
              <a:gd name="connsiteX24" fmla="*/ 9392197 w 10768629"/>
              <a:gd name="connsiteY24" fmla="*/ 459796 h 1978172"/>
              <a:gd name="connsiteX25" fmla="*/ 9347994 w 10768629"/>
              <a:gd name="connsiteY25" fmla="*/ 464462 h 1978172"/>
              <a:gd name="connsiteX26" fmla="*/ 9347889 w 10768629"/>
              <a:gd name="connsiteY26" fmla="*/ 466539 h 1978172"/>
              <a:gd name="connsiteX27" fmla="*/ 9337639 w 10768629"/>
              <a:gd name="connsiteY27" fmla="*/ 476654 h 1978172"/>
              <a:gd name="connsiteX28" fmla="*/ 9287964 w 10768629"/>
              <a:gd name="connsiteY28" fmla="*/ 513052 h 1978172"/>
              <a:gd name="connsiteX29" fmla="*/ 9229283 w 10768629"/>
              <a:gd name="connsiteY29" fmla="*/ 555377 h 1978172"/>
              <a:gd name="connsiteX30" fmla="*/ 9220274 w 10768629"/>
              <a:gd name="connsiteY30" fmla="*/ 557502 h 1978172"/>
              <a:gd name="connsiteX31" fmla="*/ 9220202 w 10768629"/>
              <a:gd name="connsiteY31" fmla="*/ 558001 h 1978172"/>
              <a:gd name="connsiteX32" fmla="*/ 9210908 w 10768629"/>
              <a:gd name="connsiteY32" fmla="*/ 561147 h 1978172"/>
              <a:gd name="connsiteX33" fmla="*/ 9186374 w 10768629"/>
              <a:gd name="connsiteY33" fmla="*/ 565502 h 1978172"/>
              <a:gd name="connsiteX34" fmla="*/ 9181058 w 10768629"/>
              <a:gd name="connsiteY34" fmla="*/ 569943 h 1978172"/>
              <a:gd name="connsiteX35" fmla="*/ 9167549 w 10768629"/>
              <a:gd name="connsiteY35" fmla="*/ 584727 h 1978172"/>
              <a:gd name="connsiteX36" fmla="*/ 9149110 w 10768629"/>
              <a:gd name="connsiteY36" fmla="*/ 598906 h 1978172"/>
              <a:gd name="connsiteX37" fmla="*/ 9078556 w 10768629"/>
              <a:gd name="connsiteY37" fmla="*/ 644039 h 1978172"/>
              <a:gd name="connsiteX38" fmla="*/ 8996399 w 10768629"/>
              <a:gd name="connsiteY38" fmla="*/ 690055 h 1978172"/>
              <a:gd name="connsiteX39" fmla="*/ 8803791 w 10768629"/>
              <a:gd name="connsiteY39" fmla="*/ 813860 h 1978172"/>
              <a:gd name="connsiteX40" fmla="*/ 8636202 w 10768629"/>
              <a:gd name="connsiteY40" fmla="*/ 848463 h 1978172"/>
              <a:gd name="connsiteX41" fmla="*/ 8555372 w 10768629"/>
              <a:gd name="connsiteY41" fmla="*/ 883171 h 1978172"/>
              <a:gd name="connsiteX42" fmla="*/ 8507229 w 10768629"/>
              <a:gd name="connsiteY42" fmla="*/ 901665 h 1978172"/>
              <a:gd name="connsiteX43" fmla="*/ 8428473 w 10768629"/>
              <a:gd name="connsiteY43" fmla="*/ 927985 h 1978172"/>
              <a:gd name="connsiteX44" fmla="*/ 8427914 w 10768629"/>
              <a:gd name="connsiteY44" fmla="*/ 933480 h 1978172"/>
              <a:gd name="connsiteX45" fmla="*/ 8420327 w 10768629"/>
              <a:gd name="connsiteY45" fmla="*/ 941984 h 1978172"/>
              <a:gd name="connsiteX46" fmla="*/ 8394729 w 10768629"/>
              <a:gd name="connsiteY46" fmla="*/ 948347 h 1978172"/>
              <a:gd name="connsiteX47" fmla="*/ 8380548 w 10768629"/>
              <a:gd name="connsiteY47" fmla="*/ 987916 h 1978172"/>
              <a:gd name="connsiteX48" fmla="*/ 8375330 w 10768629"/>
              <a:gd name="connsiteY48" fmla="*/ 965444 h 1978172"/>
              <a:gd name="connsiteX49" fmla="*/ 8340796 w 10768629"/>
              <a:gd name="connsiteY49" fmla="*/ 980522 h 1978172"/>
              <a:gd name="connsiteX50" fmla="*/ 8304438 w 10768629"/>
              <a:gd name="connsiteY50" fmla="*/ 996739 h 1978172"/>
              <a:gd name="connsiteX51" fmla="*/ 8280929 w 10768629"/>
              <a:gd name="connsiteY51" fmla="*/ 1023089 h 1978172"/>
              <a:gd name="connsiteX52" fmla="*/ 8275760 w 10768629"/>
              <a:gd name="connsiteY52" fmla="*/ 1027772 h 1978172"/>
              <a:gd name="connsiteX53" fmla="*/ 8275478 w 10768629"/>
              <a:gd name="connsiteY53" fmla="*/ 1027605 h 1978172"/>
              <a:gd name="connsiteX54" fmla="*/ 8249003 w 10768629"/>
              <a:gd name="connsiteY54" fmla="*/ 1032033 h 1978172"/>
              <a:gd name="connsiteX55" fmla="*/ 8203836 w 10768629"/>
              <a:gd name="connsiteY55" fmla="*/ 1037347 h 1978172"/>
              <a:gd name="connsiteX56" fmla="*/ 8122936 w 10768629"/>
              <a:gd name="connsiteY56" fmla="*/ 1063113 h 1978172"/>
              <a:gd name="connsiteX57" fmla="*/ 8043658 w 10768629"/>
              <a:gd name="connsiteY57" fmla="*/ 1092746 h 1978172"/>
              <a:gd name="connsiteX58" fmla="*/ 8015351 w 10768629"/>
              <a:gd name="connsiteY58" fmla="*/ 1105478 h 1978172"/>
              <a:gd name="connsiteX59" fmla="*/ 7963145 w 10768629"/>
              <a:gd name="connsiteY59" fmla="*/ 1119346 h 1978172"/>
              <a:gd name="connsiteX60" fmla="*/ 7938145 w 10768629"/>
              <a:gd name="connsiteY60" fmla="*/ 1120225 h 1978172"/>
              <a:gd name="connsiteX61" fmla="*/ 7937238 w 10768629"/>
              <a:gd name="connsiteY61" fmla="*/ 1121204 h 1978172"/>
              <a:gd name="connsiteX62" fmla="*/ 7934398 w 10768629"/>
              <a:gd name="connsiteY62" fmla="*/ 1118240 h 1978172"/>
              <a:gd name="connsiteX63" fmla="*/ 7918248 w 10768629"/>
              <a:gd name="connsiteY63" fmla="*/ 1124371 h 1978172"/>
              <a:gd name="connsiteX64" fmla="*/ 7914119 w 10768629"/>
              <a:gd name="connsiteY64" fmla="*/ 1127653 h 1978172"/>
              <a:gd name="connsiteX65" fmla="*/ 7907658 w 10768629"/>
              <a:gd name="connsiteY65" fmla="*/ 1130350 h 1978172"/>
              <a:gd name="connsiteX66" fmla="*/ 7907434 w 10768629"/>
              <a:gd name="connsiteY66" fmla="*/ 1130103 h 1978172"/>
              <a:gd name="connsiteX67" fmla="*/ 7901508 w 10768629"/>
              <a:gd name="connsiteY67" fmla="*/ 1133245 h 1978172"/>
              <a:gd name="connsiteX68" fmla="*/ 7873287 w 10768629"/>
              <a:gd name="connsiteY68" fmla="*/ 1152609 h 1978172"/>
              <a:gd name="connsiteX69" fmla="*/ 7834833 w 10768629"/>
              <a:gd name="connsiteY69" fmla="*/ 1153868 h 1978172"/>
              <a:gd name="connsiteX70" fmla="*/ 7828661 w 10768629"/>
              <a:gd name="connsiteY70" fmla="*/ 1139994 h 1978172"/>
              <a:gd name="connsiteX71" fmla="*/ 7823966 w 10768629"/>
              <a:gd name="connsiteY71" fmla="*/ 1143178 h 1978172"/>
              <a:gd name="connsiteX72" fmla="*/ 7815078 w 10768629"/>
              <a:gd name="connsiteY72" fmla="*/ 1151776 h 1978172"/>
              <a:gd name="connsiteX73" fmla="*/ 7812026 w 10768629"/>
              <a:gd name="connsiteY73" fmla="*/ 1151522 h 1978172"/>
              <a:gd name="connsiteX74" fmla="*/ 7782249 w 10768629"/>
              <a:gd name="connsiteY74" fmla="*/ 1160970 h 1978172"/>
              <a:gd name="connsiteX75" fmla="*/ 7773476 w 10768629"/>
              <a:gd name="connsiteY75" fmla="*/ 1157414 h 1978172"/>
              <a:gd name="connsiteX76" fmla="*/ 7769600 w 10768629"/>
              <a:gd name="connsiteY76" fmla="*/ 1157365 h 1978172"/>
              <a:gd name="connsiteX77" fmla="*/ 7752631 w 10768629"/>
              <a:gd name="connsiteY77" fmla="*/ 1172815 h 1978172"/>
              <a:gd name="connsiteX78" fmla="*/ 7739392 w 10768629"/>
              <a:gd name="connsiteY78" fmla="*/ 1192062 h 1978172"/>
              <a:gd name="connsiteX79" fmla="*/ 7677677 w 10768629"/>
              <a:gd name="connsiteY79" fmla="*/ 1216394 h 1978172"/>
              <a:gd name="connsiteX80" fmla="*/ 7586920 w 10768629"/>
              <a:gd name="connsiteY80" fmla="*/ 1261888 h 1978172"/>
              <a:gd name="connsiteX81" fmla="*/ 7486100 w 10768629"/>
              <a:gd name="connsiteY81" fmla="*/ 1292563 h 1978172"/>
              <a:gd name="connsiteX82" fmla="*/ 7411323 w 10768629"/>
              <a:gd name="connsiteY82" fmla="*/ 1340732 h 1978172"/>
              <a:gd name="connsiteX83" fmla="*/ 7240698 w 10768629"/>
              <a:gd name="connsiteY83" fmla="*/ 1438832 h 1978172"/>
              <a:gd name="connsiteX84" fmla="*/ 7197675 w 10768629"/>
              <a:gd name="connsiteY84" fmla="*/ 1447530 h 1978172"/>
              <a:gd name="connsiteX85" fmla="*/ 7164788 w 10768629"/>
              <a:gd name="connsiteY85" fmla="*/ 1480293 h 1978172"/>
              <a:gd name="connsiteX86" fmla="*/ 7147929 w 10768629"/>
              <a:gd name="connsiteY86" fmla="*/ 1477641 h 1978172"/>
              <a:gd name="connsiteX87" fmla="*/ 7144965 w 10768629"/>
              <a:gd name="connsiteY87" fmla="*/ 1476908 h 1978172"/>
              <a:gd name="connsiteX88" fmla="*/ 7134299 w 10768629"/>
              <a:gd name="connsiteY88" fmla="*/ 1479969 h 1978172"/>
              <a:gd name="connsiteX89" fmla="*/ 7129809 w 10768629"/>
              <a:gd name="connsiteY89" fmla="*/ 1473339 h 1978172"/>
              <a:gd name="connsiteX90" fmla="*/ 7112688 w 10768629"/>
              <a:gd name="connsiteY90" fmla="*/ 1472575 h 1978172"/>
              <a:gd name="connsiteX91" fmla="*/ 7093470 w 10768629"/>
              <a:gd name="connsiteY91" fmla="*/ 1480300 h 1978172"/>
              <a:gd name="connsiteX92" fmla="*/ 7025034 w 10768629"/>
              <a:gd name="connsiteY92" fmla="*/ 1506934 h 1978172"/>
              <a:gd name="connsiteX93" fmla="*/ 7014783 w 10768629"/>
              <a:gd name="connsiteY93" fmla="*/ 1515868 h 1978172"/>
              <a:gd name="connsiteX94" fmla="*/ 6979706 w 10768629"/>
              <a:gd name="connsiteY94" fmla="*/ 1523511 h 1978172"/>
              <a:gd name="connsiteX95" fmla="*/ 6977890 w 10768629"/>
              <a:gd name="connsiteY95" fmla="*/ 1525793 h 1978172"/>
              <a:gd name="connsiteX96" fmla="*/ 6944339 w 10768629"/>
              <a:gd name="connsiteY96" fmla="*/ 1536237 h 1978172"/>
              <a:gd name="connsiteX97" fmla="*/ 6886996 w 10768629"/>
              <a:gd name="connsiteY97" fmla="*/ 1563569 h 1978172"/>
              <a:gd name="connsiteX98" fmla="*/ 6874510 w 10768629"/>
              <a:gd name="connsiteY98" fmla="*/ 1558469 h 1978172"/>
              <a:gd name="connsiteX99" fmla="*/ 6871943 w 10768629"/>
              <a:gd name="connsiteY99" fmla="*/ 1554651 h 1978172"/>
              <a:gd name="connsiteX100" fmla="*/ 6856174 w 10768629"/>
              <a:gd name="connsiteY100" fmla="*/ 1562024 h 1978172"/>
              <a:gd name="connsiteX101" fmla="*/ 6842321 w 10768629"/>
              <a:gd name="connsiteY101" fmla="*/ 1560554 h 1978172"/>
              <a:gd name="connsiteX102" fmla="*/ 6832713 w 10768629"/>
              <a:gd name="connsiteY102" fmla="*/ 1569357 h 1978172"/>
              <a:gd name="connsiteX103" fmla="*/ 6816351 w 10768629"/>
              <a:gd name="connsiteY103" fmla="*/ 1571495 h 1978172"/>
              <a:gd name="connsiteX104" fmla="*/ 6795800 w 10768629"/>
              <a:gd name="connsiteY104" fmla="*/ 1572010 h 1978172"/>
              <a:gd name="connsiteX105" fmla="*/ 6777546 w 10768629"/>
              <a:gd name="connsiteY105" fmla="*/ 1568661 h 1978172"/>
              <a:gd name="connsiteX106" fmla="*/ 6751528 w 10768629"/>
              <a:gd name="connsiteY106" fmla="*/ 1574143 h 1978172"/>
              <a:gd name="connsiteX107" fmla="*/ 6691966 w 10768629"/>
              <a:gd name="connsiteY107" fmla="*/ 1582255 h 1978172"/>
              <a:gd name="connsiteX108" fmla="*/ 6646941 w 10768629"/>
              <a:gd name="connsiteY108" fmla="*/ 1588471 h 1978172"/>
              <a:gd name="connsiteX109" fmla="*/ 6568576 w 10768629"/>
              <a:gd name="connsiteY109" fmla="*/ 1606488 h 1978172"/>
              <a:gd name="connsiteX110" fmla="*/ 6554358 w 10768629"/>
              <a:gd name="connsiteY110" fmla="*/ 1621701 h 1978172"/>
              <a:gd name="connsiteX111" fmla="*/ 6516968 w 10768629"/>
              <a:gd name="connsiteY111" fmla="*/ 1617195 h 1978172"/>
              <a:gd name="connsiteX112" fmla="*/ 6506479 w 10768629"/>
              <a:gd name="connsiteY112" fmla="*/ 1602227 h 1978172"/>
              <a:gd name="connsiteX113" fmla="*/ 6458436 w 10768629"/>
              <a:gd name="connsiteY113" fmla="*/ 1607332 h 1978172"/>
              <a:gd name="connsiteX114" fmla="*/ 6414786 w 10768629"/>
              <a:gd name="connsiteY114" fmla="*/ 1628815 h 1978172"/>
              <a:gd name="connsiteX115" fmla="*/ 6357085 w 10768629"/>
              <a:gd name="connsiteY115" fmla="*/ 1640846 h 1978172"/>
              <a:gd name="connsiteX116" fmla="*/ 6322636 w 10768629"/>
              <a:gd name="connsiteY116" fmla="*/ 1648213 h 1978172"/>
              <a:gd name="connsiteX117" fmla="*/ 6226172 w 10768629"/>
              <a:gd name="connsiteY117" fmla="*/ 1654676 h 1978172"/>
              <a:gd name="connsiteX118" fmla="*/ 6221217 w 10768629"/>
              <a:gd name="connsiteY118" fmla="*/ 1654506 h 1978172"/>
              <a:gd name="connsiteX119" fmla="*/ 6204956 w 10768629"/>
              <a:gd name="connsiteY119" fmla="*/ 1664280 h 1978172"/>
              <a:gd name="connsiteX120" fmla="*/ 6204270 w 10768629"/>
              <a:gd name="connsiteY120" fmla="*/ 1666782 h 1978172"/>
              <a:gd name="connsiteX121" fmla="*/ 6143810 w 10768629"/>
              <a:gd name="connsiteY121" fmla="*/ 1661963 h 1978172"/>
              <a:gd name="connsiteX122" fmla="*/ 6136560 w 10768629"/>
              <a:gd name="connsiteY122" fmla="*/ 1665728 h 1978172"/>
              <a:gd name="connsiteX123" fmla="*/ 6096155 w 10768629"/>
              <a:gd name="connsiteY123" fmla="*/ 1656951 h 1978172"/>
              <a:gd name="connsiteX124" fmla="*/ 6075812 w 10768629"/>
              <a:gd name="connsiteY124" fmla="*/ 1655422 h 1978172"/>
              <a:gd name="connsiteX125" fmla="*/ 6039495 w 10768629"/>
              <a:gd name="connsiteY125" fmla="*/ 1649680 h 1978172"/>
              <a:gd name="connsiteX126" fmla="*/ 6036523 w 10768629"/>
              <a:gd name="connsiteY126" fmla="*/ 1652121 h 1978172"/>
              <a:gd name="connsiteX127" fmla="*/ 6029328 w 10768629"/>
              <a:gd name="connsiteY127" fmla="*/ 1649904 h 1978172"/>
              <a:gd name="connsiteX128" fmla="*/ 6024075 w 10768629"/>
              <a:gd name="connsiteY128" fmla="*/ 1652779 h 1978172"/>
              <a:gd name="connsiteX129" fmla="*/ 6018085 w 10768629"/>
              <a:gd name="connsiteY129" fmla="*/ 1652030 h 1978172"/>
              <a:gd name="connsiteX130" fmla="*/ 5955513 w 10768629"/>
              <a:gd name="connsiteY130" fmla="*/ 1663584 h 1978172"/>
              <a:gd name="connsiteX131" fmla="*/ 5941996 w 10768629"/>
              <a:gd name="connsiteY131" fmla="*/ 1661326 h 1978172"/>
              <a:gd name="connsiteX132" fmla="*/ 5931789 w 10768629"/>
              <a:gd name="connsiteY132" fmla="*/ 1669915 h 1978172"/>
              <a:gd name="connsiteX133" fmla="*/ 5888686 w 10768629"/>
              <a:gd name="connsiteY133" fmla="*/ 1672175 h 1978172"/>
              <a:gd name="connsiteX134" fmla="*/ 5873794 w 10768629"/>
              <a:gd name="connsiteY134" fmla="*/ 1665454 h 1978172"/>
              <a:gd name="connsiteX135" fmla="*/ 5860022 w 10768629"/>
              <a:gd name="connsiteY135" fmla="*/ 1660635 h 1978172"/>
              <a:gd name="connsiteX136" fmla="*/ 5858237 w 10768629"/>
              <a:gd name="connsiteY136" fmla="*/ 1660649 h 1978172"/>
              <a:gd name="connsiteX137" fmla="*/ 5840319 w 10768629"/>
              <a:gd name="connsiteY137" fmla="*/ 1660798 h 1978172"/>
              <a:gd name="connsiteX138" fmla="*/ 5806984 w 10768629"/>
              <a:gd name="connsiteY138" fmla="*/ 1661075 h 1978172"/>
              <a:gd name="connsiteX139" fmla="*/ 5742351 w 10768629"/>
              <a:gd name="connsiteY139" fmla="*/ 1667489 h 1978172"/>
              <a:gd name="connsiteX140" fmla="*/ 5521171 w 10768629"/>
              <a:gd name="connsiteY140" fmla="*/ 1671626 h 1978172"/>
              <a:gd name="connsiteX141" fmla="*/ 5457384 w 10768629"/>
              <a:gd name="connsiteY141" fmla="*/ 1683952 h 1978172"/>
              <a:gd name="connsiteX142" fmla="*/ 4950070 w 10768629"/>
              <a:gd name="connsiteY142" fmla="*/ 1748401 h 1978172"/>
              <a:gd name="connsiteX143" fmla="*/ 4872172 w 10768629"/>
              <a:gd name="connsiteY143" fmla="*/ 1757222 h 1978172"/>
              <a:gd name="connsiteX144" fmla="*/ 4809524 w 10768629"/>
              <a:gd name="connsiteY144" fmla="*/ 1761033 h 1978172"/>
              <a:gd name="connsiteX145" fmla="*/ 4759058 w 10768629"/>
              <a:gd name="connsiteY145" fmla="*/ 1766533 h 1978172"/>
              <a:gd name="connsiteX146" fmla="*/ 4719749 w 10768629"/>
              <a:gd name="connsiteY146" fmla="*/ 1771811 h 1978172"/>
              <a:gd name="connsiteX147" fmla="*/ 4568686 w 10768629"/>
              <a:gd name="connsiteY147" fmla="*/ 1786141 h 1978172"/>
              <a:gd name="connsiteX148" fmla="*/ 4418751 w 10768629"/>
              <a:gd name="connsiteY148" fmla="*/ 1796932 h 1978172"/>
              <a:gd name="connsiteX149" fmla="*/ 4378377 w 10768629"/>
              <a:gd name="connsiteY149" fmla="*/ 1815528 h 1978172"/>
              <a:gd name="connsiteX150" fmla="*/ 4320575 w 10768629"/>
              <a:gd name="connsiteY150" fmla="*/ 1832722 h 1978172"/>
              <a:gd name="connsiteX151" fmla="*/ 4211935 w 10768629"/>
              <a:gd name="connsiteY151" fmla="*/ 1860177 h 1978172"/>
              <a:gd name="connsiteX152" fmla="*/ 4101228 w 10768629"/>
              <a:gd name="connsiteY152" fmla="*/ 1868717 h 1978172"/>
              <a:gd name="connsiteX153" fmla="*/ 3973223 w 10768629"/>
              <a:gd name="connsiteY153" fmla="*/ 1881015 h 1978172"/>
              <a:gd name="connsiteX154" fmla="*/ 3900992 w 10768629"/>
              <a:gd name="connsiteY154" fmla="*/ 1880603 h 1978172"/>
              <a:gd name="connsiteX155" fmla="*/ 3662119 w 10768629"/>
              <a:gd name="connsiteY155" fmla="*/ 1889285 h 1978172"/>
              <a:gd name="connsiteX156" fmla="*/ 3496919 w 10768629"/>
              <a:gd name="connsiteY156" fmla="*/ 1873180 h 1978172"/>
              <a:gd name="connsiteX157" fmla="*/ 3449433 w 10768629"/>
              <a:gd name="connsiteY157" fmla="*/ 1889681 h 1978172"/>
              <a:gd name="connsiteX158" fmla="*/ 3369766 w 10768629"/>
              <a:gd name="connsiteY158" fmla="*/ 1916653 h 1978172"/>
              <a:gd name="connsiteX159" fmla="*/ 3269672 w 10768629"/>
              <a:gd name="connsiteY159" fmla="*/ 1938036 h 1978172"/>
              <a:gd name="connsiteX160" fmla="*/ 3224897 w 10768629"/>
              <a:gd name="connsiteY160" fmla="*/ 1943733 h 1978172"/>
              <a:gd name="connsiteX161" fmla="*/ 3161463 w 10768629"/>
              <a:gd name="connsiteY161" fmla="*/ 1946591 h 1978172"/>
              <a:gd name="connsiteX162" fmla="*/ 3112044 w 10768629"/>
              <a:gd name="connsiteY162" fmla="*/ 1935614 h 1978172"/>
              <a:gd name="connsiteX163" fmla="*/ 3069716 w 10768629"/>
              <a:gd name="connsiteY163" fmla="*/ 1930463 h 1978172"/>
              <a:gd name="connsiteX164" fmla="*/ 3005773 w 10768629"/>
              <a:gd name="connsiteY164" fmla="*/ 1915878 h 1978172"/>
              <a:gd name="connsiteX165" fmla="*/ 2897201 w 10768629"/>
              <a:gd name="connsiteY165" fmla="*/ 1926772 h 1978172"/>
              <a:gd name="connsiteX166" fmla="*/ 2783891 w 10768629"/>
              <a:gd name="connsiteY166" fmla="*/ 1931749 h 1978172"/>
              <a:gd name="connsiteX167" fmla="*/ 2712447 w 10768629"/>
              <a:gd name="connsiteY167" fmla="*/ 1933044 h 1978172"/>
              <a:gd name="connsiteX168" fmla="*/ 2560151 w 10768629"/>
              <a:gd name="connsiteY168" fmla="*/ 1963609 h 1978172"/>
              <a:gd name="connsiteX169" fmla="*/ 2367221 w 10768629"/>
              <a:gd name="connsiteY169" fmla="*/ 1971884 h 1978172"/>
              <a:gd name="connsiteX170" fmla="*/ 2272130 w 10768629"/>
              <a:gd name="connsiteY170" fmla="*/ 1961162 h 1978172"/>
              <a:gd name="connsiteX171" fmla="*/ 2189404 w 10768629"/>
              <a:gd name="connsiteY171" fmla="*/ 1978172 h 1978172"/>
              <a:gd name="connsiteX172" fmla="*/ 2077704 w 10768629"/>
              <a:gd name="connsiteY172" fmla="*/ 1965002 h 1978172"/>
              <a:gd name="connsiteX173" fmla="*/ 2033299 w 10768629"/>
              <a:gd name="connsiteY173" fmla="*/ 1969042 h 1978172"/>
              <a:gd name="connsiteX174" fmla="*/ 1967996 w 10768629"/>
              <a:gd name="connsiteY174" fmla="*/ 1953187 h 1978172"/>
              <a:gd name="connsiteX175" fmla="*/ 1855805 w 10768629"/>
              <a:gd name="connsiteY175" fmla="*/ 1926082 h 1978172"/>
              <a:gd name="connsiteX176" fmla="*/ 1790957 w 10768629"/>
              <a:gd name="connsiteY176" fmla="*/ 1919460 h 1978172"/>
              <a:gd name="connsiteX177" fmla="*/ 1613978 w 10768629"/>
              <a:gd name="connsiteY177" fmla="*/ 1891581 h 1978172"/>
              <a:gd name="connsiteX178" fmla="*/ 1436831 w 10768629"/>
              <a:gd name="connsiteY178" fmla="*/ 1856201 h 1978172"/>
              <a:gd name="connsiteX179" fmla="*/ 1357365 w 10768629"/>
              <a:gd name="connsiteY179" fmla="*/ 1832140 h 1978172"/>
              <a:gd name="connsiteX180" fmla="*/ 1232341 w 10768629"/>
              <a:gd name="connsiteY180" fmla="*/ 1785942 h 1978172"/>
              <a:gd name="connsiteX181" fmla="*/ 1162595 w 10768629"/>
              <a:gd name="connsiteY181" fmla="*/ 1784330 h 1978172"/>
              <a:gd name="connsiteX182" fmla="*/ 1120257 w 10768629"/>
              <a:gd name="connsiteY182" fmla="*/ 1789615 h 1978172"/>
              <a:gd name="connsiteX183" fmla="*/ 991903 w 10768629"/>
              <a:gd name="connsiteY183" fmla="*/ 1786741 h 1978172"/>
              <a:gd name="connsiteX184" fmla="*/ 883960 w 10768629"/>
              <a:gd name="connsiteY184" fmla="*/ 1809389 h 1978172"/>
              <a:gd name="connsiteX185" fmla="*/ 766531 w 10768629"/>
              <a:gd name="connsiteY185" fmla="*/ 1805053 h 1978172"/>
              <a:gd name="connsiteX186" fmla="*/ 669779 w 10768629"/>
              <a:gd name="connsiteY186" fmla="*/ 1800537 h 1978172"/>
              <a:gd name="connsiteX187" fmla="*/ 523898 w 10768629"/>
              <a:gd name="connsiteY187" fmla="*/ 1811085 h 1978172"/>
              <a:gd name="connsiteX188" fmla="*/ 360251 w 10768629"/>
              <a:gd name="connsiteY188" fmla="*/ 1830735 h 1978172"/>
              <a:gd name="connsiteX189" fmla="*/ 255207 w 10768629"/>
              <a:gd name="connsiteY189" fmla="*/ 1818275 h 1978172"/>
              <a:gd name="connsiteX190" fmla="*/ 101803 w 10768629"/>
              <a:gd name="connsiteY190" fmla="*/ 1870647 h 1978172"/>
              <a:gd name="connsiteX191" fmla="*/ 25397 w 10768629"/>
              <a:gd name="connsiteY191" fmla="*/ 1888443 h 1978172"/>
              <a:gd name="connsiteX192" fmla="*/ 2370 w 10768629"/>
              <a:gd name="connsiteY192" fmla="*/ 1878311 h 1978172"/>
              <a:gd name="connsiteX193" fmla="*/ 0 w 10768629"/>
              <a:gd name="connsiteY193" fmla="*/ 1878785 h 1978172"/>
              <a:gd name="connsiteX194" fmla="*/ 0 w 10768629"/>
              <a:gd name="connsiteY194" fmla="*/ 0 h 19781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 ang="0">
                <a:pos x="connsiteX194" y="connsiteY194"/>
              </a:cxn>
            </a:cxnLst>
            <a:rect l="l" t="t" r="r" b="b"/>
            <a:pathLst>
              <a:path w="10768629" h="1978172">
                <a:moveTo>
                  <a:pt x="0" y="0"/>
                </a:moveTo>
                <a:lnTo>
                  <a:pt x="10768629" y="0"/>
                </a:lnTo>
                <a:lnTo>
                  <a:pt x="10733254" y="31439"/>
                </a:lnTo>
                <a:lnTo>
                  <a:pt x="10727085" y="37910"/>
                </a:lnTo>
                <a:cubicBezTo>
                  <a:pt x="10712973" y="56080"/>
                  <a:pt x="10699457" y="78430"/>
                  <a:pt x="10675953" y="68623"/>
                </a:cubicBezTo>
                <a:cubicBezTo>
                  <a:pt x="10685972" y="89202"/>
                  <a:pt x="10641629" y="69781"/>
                  <a:pt x="10637091" y="90361"/>
                </a:cubicBezTo>
                <a:cubicBezTo>
                  <a:pt x="10635214" y="107005"/>
                  <a:pt x="10621323" y="104993"/>
                  <a:pt x="10610971" y="110764"/>
                </a:cubicBezTo>
                <a:cubicBezTo>
                  <a:pt x="10603980" y="127568"/>
                  <a:pt x="10551417" y="141180"/>
                  <a:pt x="10532872" y="138028"/>
                </a:cubicBezTo>
                <a:cubicBezTo>
                  <a:pt x="10480300" y="119072"/>
                  <a:pt x="10440532" y="186296"/>
                  <a:pt x="10398558" y="172911"/>
                </a:cubicBezTo>
                <a:cubicBezTo>
                  <a:pt x="10387708" y="174114"/>
                  <a:pt x="10378792" y="177646"/>
                  <a:pt x="10371128" y="182609"/>
                </a:cubicBezTo>
                <a:lnTo>
                  <a:pt x="10352178" y="199976"/>
                </a:lnTo>
                <a:lnTo>
                  <a:pt x="10351815" y="211879"/>
                </a:lnTo>
                <a:lnTo>
                  <a:pt x="10337471" y="218661"/>
                </a:lnTo>
                <a:lnTo>
                  <a:pt x="10334625" y="222351"/>
                </a:lnTo>
                <a:cubicBezTo>
                  <a:pt x="10321108" y="225227"/>
                  <a:pt x="10278615" y="228401"/>
                  <a:pt x="10256365" y="235917"/>
                </a:cubicBezTo>
                <a:cubicBezTo>
                  <a:pt x="10218136" y="258033"/>
                  <a:pt x="10224552" y="209685"/>
                  <a:pt x="10201127" y="267448"/>
                </a:cubicBezTo>
                <a:cubicBezTo>
                  <a:pt x="10121320" y="273476"/>
                  <a:pt x="10040763" y="345580"/>
                  <a:pt x="9961218" y="326720"/>
                </a:cubicBezTo>
                <a:cubicBezTo>
                  <a:pt x="9980173" y="341621"/>
                  <a:pt x="9883038" y="318484"/>
                  <a:pt x="9859715" y="355698"/>
                </a:cubicBezTo>
                <a:cubicBezTo>
                  <a:pt x="9812822" y="367758"/>
                  <a:pt x="9752089" y="383830"/>
                  <a:pt x="9679867" y="399081"/>
                </a:cubicBezTo>
                <a:cubicBezTo>
                  <a:pt x="9618357" y="415668"/>
                  <a:pt x="9525492" y="446315"/>
                  <a:pt x="9490654" y="455225"/>
                </a:cubicBezTo>
                <a:lnTo>
                  <a:pt x="9470837" y="452539"/>
                </a:lnTo>
                <a:lnTo>
                  <a:pt x="9469082" y="454891"/>
                </a:lnTo>
                <a:cubicBezTo>
                  <a:pt x="9460057" y="461184"/>
                  <a:pt x="9453495" y="461729"/>
                  <a:pt x="9448038" y="459733"/>
                </a:cubicBezTo>
                <a:lnTo>
                  <a:pt x="9396821" y="455795"/>
                </a:lnTo>
                <a:lnTo>
                  <a:pt x="9392197" y="459796"/>
                </a:lnTo>
                <a:lnTo>
                  <a:pt x="9347994" y="464462"/>
                </a:lnTo>
                <a:cubicBezTo>
                  <a:pt x="9347959" y="465155"/>
                  <a:pt x="9347925" y="465846"/>
                  <a:pt x="9347889" y="466539"/>
                </a:cubicBezTo>
                <a:cubicBezTo>
                  <a:pt x="9346648" y="471307"/>
                  <a:pt x="9343831" y="475025"/>
                  <a:pt x="9337639" y="476654"/>
                </a:cubicBezTo>
                <a:cubicBezTo>
                  <a:pt x="9354547" y="503661"/>
                  <a:pt x="9307720" y="510631"/>
                  <a:pt x="9287964" y="513052"/>
                </a:cubicBezTo>
                <a:cubicBezTo>
                  <a:pt x="9269905" y="526173"/>
                  <a:pt x="9245386" y="544358"/>
                  <a:pt x="9229283" y="555377"/>
                </a:cubicBezTo>
                <a:lnTo>
                  <a:pt x="9220274" y="557502"/>
                </a:lnTo>
                <a:cubicBezTo>
                  <a:pt x="9220250" y="557668"/>
                  <a:pt x="9220226" y="557835"/>
                  <a:pt x="9220202" y="558001"/>
                </a:cubicBezTo>
                <a:cubicBezTo>
                  <a:pt x="9218468" y="559434"/>
                  <a:pt x="9215591" y="560497"/>
                  <a:pt x="9210908" y="561147"/>
                </a:cubicBezTo>
                <a:lnTo>
                  <a:pt x="9186374" y="565502"/>
                </a:lnTo>
                <a:lnTo>
                  <a:pt x="9181058" y="569943"/>
                </a:lnTo>
                <a:lnTo>
                  <a:pt x="9167549" y="584727"/>
                </a:lnTo>
                <a:lnTo>
                  <a:pt x="9149110" y="598906"/>
                </a:lnTo>
                <a:cubicBezTo>
                  <a:pt x="9133575" y="594395"/>
                  <a:pt x="9087390" y="636567"/>
                  <a:pt x="9078556" y="644039"/>
                </a:cubicBezTo>
                <a:lnTo>
                  <a:pt x="8996399" y="690055"/>
                </a:lnTo>
                <a:cubicBezTo>
                  <a:pt x="8913147" y="777045"/>
                  <a:pt x="8867993" y="772591"/>
                  <a:pt x="8803791" y="813860"/>
                </a:cubicBezTo>
                <a:cubicBezTo>
                  <a:pt x="8745270" y="819906"/>
                  <a:pt x="8690049" y="823612"/>
                  <a:pt x="8636202" y="848463"/>
                </a:cubicBezTo>
                <a:cubicBezTo>
                  <a:pt x="8594799" y="860014"/>
                  <a:pt x="8568613" y="864779"/>
                  <a:pt x="8555372" y="883171"/>
                </a:cubicBezTo>
                <a:lnTo>
                  <a:pt x="8507229" y="901665"/>
                </a:lnTo>
                <a:lnTo>
                  <a:pt x="8428473" y="927985"/>
                </a:lnTo>
                <a:cubicBezTo>
                  <a:pt x="8428287" y="929817"/>
                  <a:pt x="8428100" y="931648"/>
                  <a:pt x="8427914" y="933480"/>
                </a:cubicBezTo>
                <a:lnTo>
                  <a:pt x="8420327" y="941984"/>
                </a:lnTo>
                <a:lnTo>
                  <a:pt x="8394729" y="948347"/>
                </a:lnTo>
                <a:lnTo>
                  <a:pt x="8380548" y="987916"/>
                </a:lnTo>
                <a:lnTo>
                  <a:pt x="8375330" y="965444"/>
                </a:lnTo>
                <a:cubicBezTo>
                  <a:pt x="8372375" y="964202"/>
                  <a:pt x="8344433" y="977378"/>
                  <a:pt x="8340796" y="980522"/>
                </a:cubicBezTo>
                <a:cubicBezTo>
                  <a:pt x="8328292" y="982128"/>
                  <a:pt x="8319237" y="991089"/>
                  <a:pt x="8304438" y="996739"/>
                </a:cubicBezTo>
                <a:cubicBezTo>
                  <a:pt x="8297193" y="1005683"/>
                  <a:pt x="8289328" y="1014568"/>
                  <a:pt x="8280929" y="1023089"/>
                </a:cubicBezTo>
                <a:lnTo>
                  <a:pt x="8275760" y="1027772"/>
                </a:lnTo>
                <a:lnTo>
                  <a:pt x="8275478" y="1027605"/>
                </a:lnTo>
                <a:cubicBezTo>
                  <a:pt x="8273970" y="1028076"/>
                  <a:pt x="8251461" y="1029408"/>
                  <a:pt x="8249003" y="1032033"/>
                </a:cubicBezTo>
                <a:lnTo>
                  <a:pt x="8203836" y="1037347"/>
                </a:lnTo>
                <a:cubicBezTo>
                  <a:pt x="8172789" y="1049890"/>
                  <a:pt x="8148166" y="1034625"/>
                  <a:pt x="8122936" y="1063113"/>
                </a:cubicBezTo>
                <a:cubicBezTo>
                  <a:pt x="8093850" y="1074757"/>
                  <a:pt x="8066781" y="1075350"/>
                  <a:pt x="8043658" y="1092746"/>
                </a:cubicBezTo>
                <a:cubicBezTo>
                  <a:pt x="8032157" y="1089174"/>
                  <a:pt x="8022145" y="1089998"/>
                  <a:pt x="8015351" y="1105478"/>
                </a:cubicBezTo>
                <a:cubicBezTo>
                  <a:pt x="7987544" y="1113006"/>
                  <a:pt x="7977708" y="1099152"/>
                  <a:pt x="7963145" y="1119346"/>
                </a:cubicBezTo>
                <a:cubicBezTo>
                  <a:pt x="7942622" y="1098880"/>
                  <a:pt x="7943760" y="1109516"/>
                  <a:pt x="7938145" y="1120225"/>
                </a:cubicBezTo>
                <a:lnTo>
                  <a:pt x="7937238" y="1121204"/>
                </a:lnTo>
                <a:lnTo>
                  <a:pt x="7934398" y="1118240"/>
                </a:lnTo>
                <a:lnTo>
                  <a:pt x="7918248" y="1124371"/>
                </a:lnTo>
                <a:lnTo>
                  <a:pt x="7914119" y="1127653"/>
                </a:lnTo>
                <a:cubicBezTo>
                  <a:pt x="7911201" y="1129547"/>
                  <a:pt x="7909169" y="1130331"/>
                  <a:pt x="7907658" y="1130350"/>
                </a:cubicBezTo>
                <a:lnTo>
                  <a:pt x="7907434" y="1130103"/>
                </a:lnTo>
                <a:lnTo>
                  <a:pt x="7901508" y="1133245"/>
                </a:lnTo>
                <a:cubicBezTo>
                  <a:pt x="7891644" y="1139271"/>
                  <a:pt x="7882185" y="1145815"/>
                  <a:pt x="7873287" y="1152609"/>
                </a:cubicBezTo>
                <a:cubicBezTo>
                  <a:pt x="7864672" y="1141906"/>
                  <a:pt x="7845199" y="1159242"/>
                  <a:pt x="7834833" y="1153868"/>
                </a:cubicBezTo>
                <a:lnTo>
                  <a:pt x="7828661" y="1139994"/>
                </a:lnTo>
                <a:lnTo>
                  <a:pt x="7823966" y="1143178"/>
                </a:lnTo>
                <a:lnTo>
                  <a:pt x="7815078" y="1151776"/>
                </a:lnTo>
                <a:cubicBezTo>
                  <a:pt x="7813692" y="1152943"/>
                  <a:pt x="7812687" y="1153116"/>
                  <a:pt x="7812026" y="1151522"/>
                </a:cubicBezTo>
                <a:cubicBezTo>
                  <a:pt x="7806555" y="1153054"/>
                  <a:pt x="7788673" y="1159989"/>
                  <a:pt x="7782249" y="1160970"/>
                </a:cubicBezTo>
                <a:lnTo>
                  <a:pt x="7773476" y="1157414"/>
                </a:lnTo>
                <a:lnTo>
                  <a:pt x="7769600" y="1157365"/>
                </a:lnTo>
                <a:lnTo>
                  <a:pt x="7752631" y="1172815"/>
                </a:lnTo>
                <a:lnTo>
                  <a:pt x="7739392" y="1192062"/>
                </a:lnTo>
                <a:lnTo>
                  <a:pt x="7677677" y="1216394"/>
                </a:lnTo>
                <a:lnTo>
                  <a:pt x="7586920" y="1261888"/>
                </a:lnTo>
                <a:cubicBezTo>
                  <a:pt x="7556723" y="1298911"/>
                  <a:pt x="7489187" y="1284518"/>
                  <a:pt x="7486100" y="1292563"/>
                </a:cubicBezTo>
                <a:cubicBezTo>
                  <a:pt x="7454875" y="1308356"/>
                  <a:pt x="7453335" y="1326361"/>
                  <a:pt x="7411323" y="1340732"/>
                </a:cubicBezTo>
                <a:cubicBezTo>
                  <a:pt x="7372519" y="1390006"/>
                  <a:pt x="7288617" y="1403664"/>
                  <a:pt x="7240698" y="1438832"/>
                </a:cubicBezTo>
                <a:cubicBezTo>
                  <a:pt x="7206467" y="1417136"/>
                  <a:pt x="7227555" y="1441678"/>
                  <a:pt x="7197675" y="1447530"/>
                </a:cubicBezTo>
                <a:cubicBezTo>
                  <a:pt x="7211601" y="1474927"/>
                  <a:pt x="7159483" y="1444981"/>
                  <a:pt x="7164788" y="1480293"/>
                </a:cubicBezTo>
                <a:cubicBezTo>
                  <a:pt x="7159184" y="1480240"/>
                  <a:pt x="7153584" y="1479075"/>
                  <a:pt x="7147929" y="1477641"/>
                </a:cubicBezTo>
                <a:lnTo>
                  <a:pt x="7144965" y="1476908"/>
                </a:lnTo>
                <a:lnTo>
                  <a:pt x="7134299" y="1479969"/>
                </a:lnTo>
                <a:lnTo>
                  <a:pt x="7129809" y="1473339"/>
                </a:lnTo>
                <a:lnTo>
                  <a:pt x="7112688" y="1472575"/>
                </a:lnTo>
                <a:cubicBezTo>
                  <a:pt x="7106506" y="1473449"/>
                  <a:pt x="7100123" y="1475741"/>
                  <a:pt x="7093470" y="1480300"/>
                </a:cubicBezTo>
                <a:cubicBezTo>
                  <a:pt x="7079039" y="1501274"/>
                  <a:pt x="7048991" y="1495718"/>
                  <a:pt x="7025034" y="1506934"/>
                </a:cubicBezTo>
                <a:lnTo>
                  <a:pt x="7014783" y="1515868"/>
                </a:lnTo>
                <a:lnTo>
                  <a:pt x="6979706" y="1523511"/>
                </a:lnTo>
                <a:lnTo>
                  <a:pt x="6977890" y="1525793"/>
                </a:lnTo>
                <a:cubicBezTo>
                  <a:pt x="6971996" y="1527914"/>
                  <a:pt x="6959488" y="1529941"/>
                  <a:pt x="6944339" y="1536237"/>
                </a:cubicBezTo>
                <a:lnTo>
                  <a:pt x="6886996" y="1563569"/>
                </a:lnTo>
                <a:lnTo>
                  <a:pt x="6874510" y="1558469"/>
                </a:lnTo>
                <a:lnTo>
                  <a:pt x="6871943" y="1554651"/>
                </a:lnTo>
                <a:lnTo>
                  <a:pt x="6856174" y="1562024"/>
                </a:lnTo>
                <a:lnTo>
                  <a:pt x="6842321" y="1560554"/>
                </a:lnTo>
                <a:lnTo>
                  <a:pt x="6832713" y="1569357"/>
                </a:lnTo>
                <a:lnTo>
                  <a:pt x="6816351" y="1571495"/>
                </a:lnTo>
                <a:cubicBezTo>
                  <a:pt x="6810216" y="1571510"/>
                  <a:pt x="6803310" y="1571324"/>
                  <a:pt x="6795800" y="1572010"/>
                </a:cubicBezTo>
                <a:lnTo>
                  <a:pt x="6777546" y="1568661"/>
                </a:lnTo>
                <a:lnTo>
                  <a:pt x="6751528" y="1574143"/>
                </a:lnTo>
                <a:cubicBezTo>
                  <a:pt x="6731455" y="1578562"/>
                  <a:pt x="6712054" y="1582098"/>
                  <a:pt x="6691966" y="1582255"/>
                </a:cubicBezTo>
                <a:cubicBezTo>
                  <a:pt x="6677921" y="1590738"/>
                  <a:pt x="6663787" y="1595441"/>
                  <a:pt x="6646941" y="1588471"/>
                </a:cubicBezTo>
                <a:cubicBezTo>
                  <a:pt x="6605135" y="1597971"/>
                  <a:pt x="6598373" y="1612583"/>
                  <a:pt x="6568576" y="1606488"/>
                </a:cubicBezTo>
                <a:cubicBezTo>
                  <a:pt x="6562510" y="1614734"/>
                  <a:pt x="6558067" y="1619360"/>
                  <a:pt x="6554358" y="1621701"/>
                </a:cubicBezTo>
                <a:cubicBezTo>
                  <a:pt x="6543227" y="1628727"/>
                  <a:pt x="6538724" y="1615196"/>
                  <a:pt x="6516968" y="1617195"/>
                </a:cubicBezTo>
                <a:cubicBezTo>
                  <a:pt x="6493173" y="1617368"/>
                  <a:pt x="6528193" y="1598652"/>
                  <a:pt x="6506479" y="1602227"/>
                </a:cubicBezTo>
                <a:cubicBezTo>
                  <a:pt x="6486674" y="1613929"/>
                  <a:pt x="6478484" y="1593997"/>
                  <a:pt x="6458436" y="1607332"/>
                </a:cubicBezTo>
                <a:cubicBezTo>
                  <a:pt x="6471168" y="1620800"/>
                  <a:pt x="6410323" y="1615478"/>
                  <a:pt x="6414786" y="1628815"/>
                </a:cubicBezTo>
                <a:cubicBezTo>
                  <a:pt x="6385942" y="1615041"/>
                  <a:pt x="6386569" y="1640238"/>
                  <a:pt x="6357085" y="1640846"/>
                </a:cubicBezTo>
                <a:cubicBezTo>
                  <a:pt x="6341163" y="1636809"/>
                  <a:pt x="6331497" y="1637754"/>
                  <a:pt x="6322636" y="1648213"/>
                </a:cubicBezTo>
                <a:cubicBezTo>
                  <a:pt x="6248448" y="1627802"/>
                  <a:pt x="6286748" y="1654976"/>
                  <a:pt x="6226172" y="1654676"/>
                </a:cubicBezTo>
                <a:lnTo>
                  <a:pt x="6221217" y="1654506"/>
                </a:lnTo>
                <a:lnTo>
                  <a:pt x="6204956" y="1664280"/>
                </a:lnTo>
                <a:cubicBezTo>
                  <a:pt x="6204728" y="1665114"/>
                  <a:pt x="6204498" y="1665947"/>
                  <a:pt x="6204270" y="1666782"/>
                </a:cubicBezTo>
                <a:lnTo>
                  <a:pt x="6143810" y="1661963"/>
                </a:lnTo>
                <a:lnTo>
                  <a:pt x="6136560" y="1665728"/>
                </a:lnTo>
                <a:lnTo>
                  <a:pt x="6096155" y="1656951"/>
                </a:lnTo>
                <a:lnTo>
                  <a:pt x="6075812" y="1655422"/>
                </a:lnTo>
                <a:lnTo>
                  <a:pt x="6039495" y="1649680"/>
                </a:lnTo>
                <a:lnTo>
                  <a:pt x="6036523" y="1652121"/>
                </a:lnTo>
                <a:lnTo>
                  <a:pt x="6029328" y="1649904"/>
                </a:lnTo>
                <a:lnTo>
                  <a:pt x="6024075" y="1652779"/>
                </a:lnTo>
                <a:lnTo>
                  <a:pt x="6018085" y="1652030"/>
                </a:lnTo>
                <a:cubicBezTo>
                  <a:pt x="6006658" y="1653831"/>
                  <a:pt x="5968194" y="1662035"/>
                  <a:pt x="5955513" y="1663584"/>
                </a:cubicBezTo>
                <a:lnTo>
                  <a:pt x="5941996" y="1661326"/>
                </a:lnTo>
                <a:lnTo>
                  <a:pt x="5931789" y="1669915"/>
                </a:lnTo>
                <a:lnTo>
                  <a:pt x="5888686" y="1672175"/>
                </a:lnTo>
                <a:lnTo>
                  <a:pt x="5873794" y="1665454"/>
                </a:lnTo>
                <a:lnTo>
                  <a:pt x="5860022" y="1660635"/>
                </a:lnTo>
                <a:lnTo>
                  <a:pt x="5858237" y="1660649"/>
                </a:lnTo>
                <a:lnTo>
                  <a:pt x="5840319" y="1660798"/>
                </a:lnTo>
                <a:lnTo>
                  <a:pt x="5806984" y="1661075"/>
                </a:lnTo>
                <a:cubicBezTo>
                  <a:pt x="5785708" y="1661533"/>
                  <a:pt x="5764126" y="1662974"/>
                  <a:pt x="5742351" y="1667489"/>
                </a:cubicBezTo>
                <a:cubicBezTo>
                  <a:pt x="5659069" y="1645168"/>
                  <a:pt x="5615134" y="1706361"/>
                  <a:pt x="5521171" y="1671626"/>
                </a:cubicBezTo>
                <a:cubicBezTo>
                  <a:pt x="5491803" y="1671296"/>
                  <a:pt x="5498089" y="1662666"/>
                  <a:pt x="5457384" y="1683952"/>
                </a:cubicBezTo>
                <a:cubicBezTo>
                  <a:pt x="5356959" y="1699287"/>
                  <a:pt x="5078905" y="1774579"/>
                  <a:pt x="4950070" y="1748401"/>
                </a:cubicBezTo>
                <a:cubicBezTo>
                  <a:pt x="4918276" y="1752255"/>
                  <a:pt x="4891043" y="1756936"/>
                  <a:pt x="4872172" y="1757222"/>
                </a:cubicBezTo>
                <a:lnTo>
                  <a:pt x="4809524" y="1761033"/>
                </a:lnTo>
                <a:cubicBezTo>
                  <a:pt x="4791324" y="1772975"/>
                  <a:pt x="4777258" y="1754591"/>
                  <a:pt x="4759058" y="1766533"/>
                </a:cubicBezTo>
                <a:cubicBezTo>
                  <a:pt x="4747481" y="1770744"/>
                  <a:pt x="4734604" y="1772921"/>
                  <a:pt x="4719749" y="1771811"/>
                </a:cubicBezTo>
                <a:cubicBezTo>
                  <a:pt x="4671168" y="1780243"/>
                  <a:pt x="4634134" y="1775931"/>
                  <a:pt x="4568686" y="1786141"/>
                </a:cubicBezTo>
                <a:cubicBezTo>
                  <a:pt x="4544667" y="1777910"/>
                  <a:pt x="4432547" y="1778168"/>
                  <a:pt x="4418751" y="1796932"/>
                </a:cubicBezTo>
                <a:cubicBezTo>
                  <a:pt x="4403360" y="1801488"/>
                  <a:pt x="4385278" y="1795746"/>
                  <a:pt x="4378377" y="1815528"/>
                </a:cubicBezTo>
                <a:cubicBezTo>
                  <a:pt x="4366870" y="1839461"/>
                  <a:pt x="4337372" y="1814003"/>
                  <a:pt x="4320575" y="1832722"/>
                </a:cubicBezTo>
                <a:cubicBezTo>
                  <a:pt x="4277898" y="1857053"/>
                  <a:pt x="4243945" y="1846759"/>
                  <a:pt x="4211935" y="1860177"/>
                </a:cubicBezTo>
                <a:cubicBezTo>
                  <a:pt x="4181519" y="1859584"/>
                  <a:pt x="4171342" y="1859762"/>
                  <a:pt x="4101228" y="1868717"/>
                </a:cubicBezTo>
                <a:cubicBezTo>
                  <a:pt x="4080159" y="1876188"/>
                  <a:pt x="4039427" y="1877381"/>
                  <a:pt x="3973223" y="1881015"/>
                </a:cubicBezTo>
                <a:cubicBezTo>
                  <a:pt x="3971330" y="1884974"/>
                  <a:pt x="3952843" y="1879225"/>
                  <a:pt x="3900992" y="1880603"/>
                </a:cubicBezTo>
                <a:cubicBezTo>
                  <a:pt x="3849141" y="1881981"/>
                  <a:pt x="3740060" y="1895686"/>
                  <a:pt x="3662119" y="1889285"/>
                </a:cubicBezTo>
                <a:cubicBezTo>
                  <a:pt x="3565155" y="1881322"/>
                  <a:pt x="3613412" y="1915150"/>
                  <a:pt x="3496919" y="1873180"/>
                </a:cubicBezTo>
                <a:cubicBezTo>
                  <a:pt x="3488062" y="1895719"/>
                  <a:pt x="3474293" y="1876288"/>
                  <a:pt x="3449433" y="1889681"/>
                </a:cubicBezTo>
                <a:cubicBezTo>
                  <a:pt x="3406553" y="1891629"/>
                  <a:pt x="3413217" y="1897797"/>
                  <a:pt x="3369766" y="1916653"/>
                </a:cubicBezTo>
                <a:cubicBezTo>
                  <a:pt x="3338805" y="1929531"/>
                  <a:pt x="3289487" y="1928617"/>
                  <a:pt x="3269672" y="1938036"/>
                </a:cubicBezTo>
                <a:lnTo>
                  <a:pt x="3224897" y="1943733"/>
                </a:lnTo>
                <a:cubicBezTo>
                  <a:pt x="3188693" y="1949271"/>
                  <a:pt x="3178540" y="1909145"/>
                  <a:pt x="3161463" y="1946591"/>
                </a:cubicBezTo>
                <a:lnTo>
                  <a:pt x="3112044" y="1935614"/>
                </a:lnTo>
                <a:lnTo>
                  <a:pt x="3069716" y="1930463"/>
                </a:lnTo>
                <a:cubicBezTo>
                  <a:pt x="3049937" y="1924285"/>
                  <a:pt x="3047816" y="1925644"/>
                  <a:pt x="3005773" y="1915878"/>
                </a:cubicBezTo>
                <a:cubicBezTo>
                  <a:pt x="2978838" y="1921092"/>
                  <a:pt x="2967972" y="1927319"/>
                  <a:pt x="2897201" y="1926772"/>
                </a:cubicBezTo>
                <a:lnTo>
                  <a:pt x="2783891" y="1931749"/>
                </a:lnTo>
                <a:cubicBezTo>
                  <a:pt x="2753098" y="1932794"/>
                  <a:pt x="2731621" y="1915151"/>
                  <a:pt x="2712447" y="1933044"/>
                </a:cubicBezTo>
                <a:cubicBezTo>
                  <a:pt x="2621923" y="1990472"/>
                  <a:pt x="2637976" y="1949546"/>
                  <a:pt x="2560151" y="1963609"/>
                </a:cubicBezTo>
                <a:cubicBezTo>
                  <a:pt x="2472084" y="1973456"/>
                  <a:pt x="2423631" y="1962133"/>
                  <a:pt x="2367221" y="1971884"/>
                </a:cubicBezTo>
                <a:cubicBezTo>
                  <a:pt x="2355331" y="1950582"/>
                  <a:pt x="2295649" y="1950006"/>
                  <a:pt x="2272130" y="1961162"/>
                </a:cubicBezTo>
                <a:cubicBezTo>
                  <a:pt x="2229336" y="1964326"/>
                  <a:pt x="2232627" y="1943953"/>
                  <a:pt x="2189404" y="1978172"/>
                </a:cubicBezTo>
                <a:cubicBezTo>
                  <a:pt x="2153824" y="1968017"/>
                  <a:pt x="2114605" y="1969166"/>
                  <a:pt x="2077704" y="1965002"/>
                </a:cubicBezTo>
                <a:cubicBezTo>
                  <a:pt x="2053064" y="1962036"/>
                  <a:pt x="2051584" y="1971011"/>
                  <a:pt x="2033299" y="1969042"/>
                </a:cubicBezTo>
                <a:cubicBezTo>
                  <a:pt x="2015014" y="1967073"/>
                  <a:pt x="1998956" y="1958903"/>
                  <a:pt x="1967996" y="1953187"/>
                </a:cubicBezTo>
                <a:cubicBezTo>
                  <a:pt x="1924117" y="1970917"/>
                  <a:pt x="1915668" y="1940297"/>
                  <a:pt x="1855805" y="1926082"/>
                </a:cubicBezTo>
                <a:cubicBezTo>
                  <a:pt x="1830663" y="1943732"/>
                  <a:pt x="1810564" y="1935694"/>
                  <a:pt x="1790957" y="1919460"/>
                </a:cubicBezTo>
                <a:cubicBezTo>
                  <a:pt x="1732588" y="1924884"/>
                  <a:pt x="1679506" y="1900619"/>
                  <a:pt x="1613978" y="1891581"/>
                </a:cubicBezTo>
                <a:cubicBezTo>
                  <a:pt x="1542961" y="1912227"/>
                  <a:pt x="1506863" y="1865666"/>
                  <a:pt x="1436831" y="1856201"/>
                </a:cubicBezTo>
                <a:cubicBezTo>
                  <a:pt x="1409149" y="1862955"/>
                  <a:pt x="1416370" y="1829853"/>
                  <a:pt x="1357365" y="1832140"/>
                </a:cubicBezTo>
                <a:cubicBezTo>
                  <a:pt x="1285880" y="1811785"/>
                  <a:pt x="1273193" y="1786872"/>
                  <a:pt x="1232341" y="1785942"/>
                </a:cubicBezTo>
                <a:cubicBezTo>
                  <a:pt x="1223903" y="1792798"/>
                  <a:pt x="1160576" y="1793911"/>
                  <a:pt x="1162595" y="1784330"/>
                </a:cubicBezTo>
                <a:cubicBezTo>
                  <a:pt x="1153167" y="1787110"/>
                  <a:pt x="1122206" y="1805077"/>
                  <a:pt x="1120257" y="1789615"/>
                </a:cubicBezTo>
                <a:cubicBezTo>
                  <a:pt x="1073149" y="1786750"/>
                  <a:pt x="1034361" y="1768718"/>
                  <a:pt x="991903" y="1786741"/>
                </a:cubicBezTo>
                <a:cubicBezTo>
                  <a:pt x="966383" y="1781126"/>
                  <a:pt x="949501" y="1800915"/>
                  <a:pt x="883960" y="1809389"/>
                </a:cubicBezTo>
                <a:cubicBezTo>
                  <a:pt x="836064" y="1808194"/>
                  <a:pt x="826980" y="1826610"/>
                  <a:pt x="766531" y="1805053"/>
                </a:cubicBezTo>
                <a:cubicBezTo>
                  <a:pt x="732778" y="1801141"/>
                  <a:pt x="694055" y="1787044"/>
                  <a:pt x="669779" y="1800537"/>
                </a:cubicBezTo>
                <a:cubicBezTo>
                  <a:pt x="645252" y="1794709"/>
                  <a:pt x="563495" y="1813232"/>
                  <a:pt x="523898" y="1811085"/>
                </a:cubicBezTo>
                <a:cubicBezTo>
                  <a:pt x="457555" y="1798530"/>
                  <a:pt x="395227" y="1824052"/>
                  <a:pt x="360251" y="1830735"/>
                </a:cubicBezTo>
                <a:cubicBezTo>
                  <a:pt x="313564" y="1825583"/>
                  <a:pt x="298281" y="1811622"/>
                  <a:pt x="255207" y="1818275"/>
                </a:cubicBezTo>
                <a:cubicBezTo>
                  <a:pt x="206572" y="1839769"/>
                  <a:pt x="160277" y="1836800"/>
                  <a:pt x="101803" y="1870647"/>
                </a:cubicBezTo>
                <a:cubicBezTo>
                  <a:pt x="85849" y="1910002"/>
                  <a:pt x="27997" y="1845258"/>
                  <a:pt x="25397" y="1888443"/>
                </a:cubicBezTo>
                <a:cubicBezTo>
                  <a:pt x="19096" y="1881154"/>
                  <a:pt x="11260" y="1878398"/>
                  <a:pt x="2370" y="1878311"/>
                </a:cubicBezTo>
                <a:lnTo>
                  <a:pt x="0" y="1878785"/>
                </a:lnTo>
                <a:lnTo>
                  <a:pt x="0" y="0"/>
                </a:lnTo>
                <a:close/>
              </a:path>
            </a:pathLst>
          </a:custGeom>
          <a:solidFill>
            <a:srgbClr val="82766A">
              <a:alpha val="15000"/>
            </a:srgbClr>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86BDC443-F8B9-2DF6-83AE-DD061F72BE1E}"/>
              </a:ext>
            </a:extLst>
          </p:cNvPr>
          <p:cNvSpPr>
            <a:spLocks noGrp="1"/>
          </p:cNvSpPr>
          <p:nvPr>
            <p:ph type="title"/>
          </p:nvPr>
        </p:nvSpPr>
        <p:spPr>
          <a:xfrm>
            <a:off x="1137034" y="609597"/>
            <a:ext cx="9392421" cy="1330841"/>
          </a:xfrm>
        </p:spPr>
        <p:txBody>
          <a:bodyPr>
            <a:normAutofit/>
          </a:bodyPr>
          <a:lstStyle/>
          <a:p>
            <a:r>
              <a:rPr lang="en-US">
                <a:cs typeface="Calibri Light"/>
              </a:rPr>
              <a:t>Medical Error</a:t>
            </a:r>
            <a:endParaRPr lang="en-US"/>
          </a:p>
        </p:txBody>
      </p:sp>
      <p:sp>
        <p:nvSpPr>
          <p:cNvPr id="3" name="Content Placeholder 2">
            <a:extLst>
              <a:ext uri="{FF2B5EF4-FFF2-40B4-BE49-F238E27FC236}">
                <a16:creationId xmlns:a16="http://schemas.microsoft.com/office/drawing/2014/main" id="{9EEEE432-4960-4B52-3BC4-D316DA1AD78C}"/>
              </a:ext>
            </a:extLst>
          </p:cNvPr>
          <p:cNvSpPr>
            <a:spLocks noGrp="1"/>
          </p:cNvSpPr>
          <p:nvPr>
            <p:ph idx="1"/>
          </p:nvPr>
        </p:nvSpPr>
        <p:spPr>
          <a:xfrm>
            <a:off x="1137034" y="2211730"/>
            <a:ext cx="5199597" cy="3904405"/>
          </a:xfrm>
        </p:spPr>
        <p:txBody>
          <a:bodyPr vert="horz" lIns="91440" tIns="45720" rIns="91440" bIns="45720" rtlCol="0" anchor="t">
            <a:normAutofit/>
          </a:bodyPr>
          <a:lstStyle/>
          <a:p>
            <a:r>
              <a:rPr lang="en-US" sz="2000">
                <a:cs typeface="Calibri"/>
              </a:rPr>
              <a:t>You are a human</a:t>
            </a:r>
          </a:p>
          <a:p>
            <a:r>
              <a:rPr lang="en-US" sz="2000">
                <a:cs typeface="Calibri"/>
              </a:rPr>
              <a:t>Humans make mistakes</a:t>
            </a:r>
          </a:p>
          <a:p>
            <a:r>
              <a:rPr lang="en-US" sz="2000">
                <a:cs typeface="Calibri"/>
              </a:rPr>
              <a:t>Humans can survive and grow from mistakes</a:t>
            </a:r>
          </a:p>
          <a:p>
            <a:r>
              <a:rPr lang="en-US" sz="2000">
                <a:cs typeface="Calibri"/>
              </a:rPr>
              <a:t>We learn best in a supportive environment</a:t>
            </a:r>
          </a:p>
          <a:p>
            <a:pPr lvl="1"/>
            <a:r>
              <a:rPr lang="en-US" sz="2000">
                <a:cs typeface="Calibri"/>
              </a:rPr>
              <a:t>Where we can process and grow as an individual, as a team, as an organization, as a profession so we can </a:t>
            </a:r>
          </a:p>
          <a:p>
            <a:pPr lvl="1"/>
            <a:endParaRPr lang="en-US" sz="2000">
              <a:cs typeface="Calibri"/>
            </a:endParaRPr>
          </a:p>
          <a:p>
            <a:pPr marL="457200" lvl="1" indent="0">
              <a:buNone/>
            </a:pPr>
            <a:r>
              <a:rPr lang="en-US" sz="2000">
                <a:cs typeface="Calibri"/>
              </a:rPr>
              <a:t>…....................keep helping patients</a:t>
            </a:r>
            <a:endParaRPr lang="en-US">
              <a:cs typeface="Calibri"/>
            </a:endParaRPr>
          </a:p>
        </p:txBody>
      </p:sp>
      <p:sp>
        <p:nvSpPr>
          <p:cNvPr id="19" name="Freeform: Shape 18">
            <a:extLst>
              <a:ext uri="{FF2B5EF4-FFF2-40B4-BE49-F238E27FC236}">
                <a16:creationId xmlns:a16="http://schemas.microsoft.com/office/drawing/2014/main" id="{9A0D773F-7A7D-4DBB-9DEA-86BB8B8F4B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5381624" y="6209414"/>
            <a:ext cx="6810375" cy="648586"/>
          </a:xfrm>
          <a:custGeom>
            <a:avLst/>
            <a:gdLst>
              <a:gd name="connsiteX0" fmla="*/ 0 w 10753706"/>
              <a:gd name="connsiteY0" fmla="*/ 0 h 1027260"/>
              <a:gd name="connsiteX1" fmla="*/ 10753706 w 10753706"/>
              <a:gd name="connsiteY1" fmla="*/ 0 h 1027260"/>
              <a:gd name="connsiteX2" fmla="*/ 10748809 w 10753706"/>
              <a:gd name="connsiteY2" fmla="*/ 2522 h 1027260"/>
              <a:gd name="connsiteX3" fmla="*/ 10725330 w 10753706"/>
              <a:gd name="connsiteY3" fmla="*/ 11977 h 1027260"/>
              <a:gd name="connsiteX4" fmla="*/ 10615423 w 10753706"/>
              <a:gd name="connsiteY4" fmla="*/ 52967 h 1027260"/>
              <a:gd name="connsiteX5" fmla="*/ 10533936 w 10753706"/>
              <a:gd name="connsiteY5" fmla="*/ 53095 h 1027260"/>
              <a:gd name="connsiteX6" fmla="*/ 10466876 w 10753706"/>
              <a:gd name="connsiteY6" fmla="*/ 45180 h 1027260"/>
              <a:gd name="connsiteX7" fmla="*/ 10355090 w 10753706"/>
              <a:gd name="connsiteY7" fmla="*/ 89741 h 1027260"/>
              <a:gd name="connsiteX8" fmla="*/ 10087145 w 10753706"/>
              <a:gd name="connsiteY8" fmla="*/ 66115 h 1027260"/>
              <a:gd name="connsiteX9" fmla="*/ 10015902 w 10753706"/>
              <a:gd name="connsiteY9" fmla="*/ 76178 h 1027260"/>
              <a:gd name="connsiteX10" fmla="*/ 9806005 w 10753706"/>
              <a:gd name="connsiteY10" fmla="*/ 102435 h 1027260"/>
              <a:gd name="connsiteX11" fmla="*/ 9602583 w 10753706"/>
              <a:gd name="connsiteY11" fmla="*/ 179170 h 1027260"/>
              <a:gd name="connsiteX12" fmla="*/ 9469719 w 10753706"/>
              <a:gd name="connsiteY12" fmla="*/ 174721 h 1027260"/>
              <a:gd name="connsiteX13" fmla="*/ 9408692 w 10753706"/>
              <a:gd name="connsiteY13" fmla="*/ 189513 h 1027260"/>
              <a:gd name="connsiteX14" fmla="*/ 9364151 w 10753706"/>
              <a:gd name="connsiteY14" fmla="*/ 194072 h 1027260"/>
              <a:gd name="connsiteX15" fmla="*/ 9337751 w 10753706"/>
              <a:gd name="connsiteY15" fmla="*/ 197579 h 1027260"/>
              <a:gd name="connsiteX16" fmla="*/ 9297166 w 10753706"/>
              <a:gd name="connsiteY16" fmla="*/ 216558 h 1027260"/>
              <a:gd name="connsiteX17" fmla="*/ 9123859 w 10753706"/>
              <a:gd name="connsiteY17" fmla="*/ 237356 h 1027260"/>
              <a:gd name="connsiteX18" fmla="*/ 8950741 w 10753706"/>
              <a:gd name="connsiteY18" fmla="*/ 238020 h 1027260"/>
              <a:gd name="connsiteX19" fmla="*/ 8718236 w 10753706"/>
              <a:gd name="connsiteY19" fmla="*/ 303148 h 1027260"/>
              <a:gd name="connsiteX20" fmla="*/ 8694011 w 10753706"/>
              <a:gd name="connsiteY20" fmla="*/ 308812 h 1027260"/>
              <a:gd name="connsiteX21" fmla="*/ 8611976 w 10753706"/>
              <a:gd name="connsiteY21" fmla="*/ 324819 h 1027260"/>
              <a:gd name="connsiteX22" fmla="*/ 8562074 w 10753706"/>
              <a:gd name="connsiteY22" fmla="*/ 337971 h 1027260"/>
              <a:gd name="connsiteX23" fmla="*/ 8501724 w 10753706"/>
              <a:gd name="connsiteY23" fmla="*/ 360865 h 1027260"/>
              <a:gd name="connsiteX24" fmla="*/ 8504489 w 10753706"/>
              <a:gd name="connsiteY24" fmla="*/ 364790 h 1027260"/>
              <a:gd name="connsiteX25" fmla="*/ 8492774 w 10753706"/>
              <a:gd name="connsiteY25" fmla="*/ 366181 h 1027260"/>
              <a:gd name="connsiteX26" fmla="*/ 8466405 w 10753706"/>
              <a:gd name="connsiteY26" fmla="*/ 368724 h 1027260"/>
              <a:gd name="connsiteX27" fmla="*/ 8427069 w 10753706"/>
              <a:gd name="connsiteY27" fmla="*/ 387211 h 1027260"/>
              <a:gd name="connsiteX28" fmla="*/ 8387766 w 10753706"/>
              <a:gd name="connsiteY28" fmla="*/ 377161 h 1027260"/>
              <a:gd name="connsiteX29" fmla="*/ 8315874 w 10753706"/>
              <a:gd name="connsiteY29" fmla="*/ 395527 h 1027260"/>
              <a:gd name="connsiteX30" fmla="*/ 8274474 w 10753706"/>
              <a:gd name="connsiteY30" fmla="*/ 405112 h 1027260"/>
              <a:gd name="connsiteX31" fmla="*/ 8234664 w 10753706"/>
              <a:gd name="connsiteY31" fmla="*/ 410219 h 1027260"/>
              <a:gd name="connsiteX32" fmla="*/ 8211268 w 10753706"/>
              <a:gd name="connsiteY32" fmla="*/ 416791 h 1027260"/>
              <a:gd name="connsiteX33" fmla="*/ 8188615 w 10753706"/>
              <a:gd name="connsiteY33" fmla="*/ 421755 h 1027260"/>
              <a:gd name="connsiteX34" fmla="*/ 8179981 w 10753706"/>
              <a:gd name="connsiteY34" fmla="*/ 420402 h 1027260"/>
              <a:gd name="connsiteX35" fmla="*/ 8179307 w 10753706"/>
              <a:gd name="connsiteY35" fmla="*/ 422516 h 1027260"/>
              <a:gd name="connsiteX36" fmla="*/ 8147929 w 10753706"/>
              <a:gd name="connsiteY36" fmla="*/ 450302 h 1027260"/>
              <a:gd name="connsiteX37" fmla="*/ 8089136 w 10753706"/>
              <a:gd name="connsiteY37" fmla="*/ 465283 h 1027260"/>
              <a:gd name="connsiteX38" fmla="*/ 8049973 w 10753706"/>
              <a:gd name="connsiteY38" fmla="*/ 454121 h 1027260"/>
              <a:gd name="connsiteX39" fmla="*/ 7965913 w 10753706"/>
              <a:gd name="connsiteY39" fmla="*/ 464415 h 1027260"/>
              <a:gd name="connsiteX40" fmla="*/ 7945093 w 10753706"/>
              <a:gd name="connsiteY40" fmla="*/ 464798 h 1027260"/>
              <a:gd name="connsiteX41" fmla="*/ 7935335 w 10753706"/>
              <a:gd name="connsiteY41" fmla="*/ 462442 h 1027260"/>
              <a:gd name="connsiteX42" fmla="*/ 7904779 w 10753706"/>
              <a:gd name="connsiteY42" fmla="*/ 471429 h 1027260"/>
              <a:gd name="connsiteX43" fmla="*/ 7855604 w 10753706"/>
              <a:gd name="connsiteY43" fmla="*/ 480199 h 1027260"/>
              <a:gd name="connsiteX44" fmla="*/ 7832630 w 10753706"/>
              <a:gd name="connsiteY44" fmla="*/ 485371 h 1027260"/>
              <a:gd name="connsiteX45" fmla="*/ 7812438 w 10753706"/>
              <a:gd name="connsiteY45" fmla="*/ 485391 h 1027260"/>
              <a:gd name="connsiteX46" fmla="*/ 7701399 w 10753706"/>
              <a:gd name="connsiteY46" fmla="*/ 495197 h 1027260"/>
              <a:gd name="connsiteX47" fmla="*/ 7674778 w 10753706"/>
              <a:gd name="connsiteY47" fmla="*/ 494723 h 1027260"/>
              <a:gd name="connsiteX48" fmla="*/ 7660445 w 10753706"/>
              <a:gd name="connsiteY48" fmla="*/ 490194 h 1027260"/>
              <a:gd name="connsiteX49" fmla="*/ 7651781 w 10753706"/>
              <a:gd name="connsiteY49" fmla="*/ 493084 h 1027260"/>
              <a:gd name="connsiteX50" fmla="*/ 7584807 w 10753706"/>
              <a:gd name="connsiteY50" fmla="*/ 499490 h 1027260"/>
              <a:gd name="connsiteX51" fmla="*/ 7541324 w 10753706"/>
              <a:gd name="connsiteY51" fmla="*/ 504184 h 1027260"/>
              <a:gd name="connsiteX52" fmla="*/ 7541756 w 10753706"/>
              <a:gd name="connsiteY52" fmla="*/ 512184 h 1027260"/>
              <a:gd name="connsiteX53" fmla="*/ 7503906 w 10753706"/>
              <a:gd name="connsiteY53" fmla="*/ 518551 h 1027260"/>
              <a:gd name="connsiteX54" fmla="*/ 7460411 w 10753706"/>
              <a:gd name="connsiteY54" fmla="*/ 517415 h 1027260"/>
              <a:gd name="connsiteX55" fmla="*/ 7460116 w 10753706"/>
              <a:gd name="connsiteY55" fmla="*/ 517548 h 1027260"/>
              <a:gd name="connsiteX56" fmla="*/ 7297810 w 10753706"/>
              <a:gd name="connsiteY56" fmla="*/ 563947 h 1027260"/>
              <a:gd name="connsiteX57" fmla="*/ 6946388 w 10753706"/>
              <a:gd name="connsiteY57" fmla="*/ 665244 h 1027260"/>
              <a:gd name="connsiteX58" fmla="*/ 6741704 w 10753706"/>
              <a:gd name="connsiteY58" fmla="*/ 679365 h 1027260"/>
              <a:gd name="connsiteX59" fmla="*/ 6624680 w 10753706"/>
              <a:gd name="connsiteY59" fmla="*/ 677674 h 1027260"/>
              <a:gd name="connsiteX60" fmla="*/ 6605700 w 10753706"/>
              <a:gd name="connsiteY60" fmla="*/ 683566 h 1027260"/>
              <a:gd name="connsiteX61" fmla="*/ 6576922 w 10753706"/>
              <a:gd name="connsiteY61" fmla="*/ 683030 h 1027260"/>
              <a:gd name="connsiteX62" fmla="*/ 6405123 w 10753706"/>
              <a:gd name="connsiteY62" fmla="*/ 721946 h 1027260"/>
              <a:gd name="connsiteX63" fmla="*/ 6368938 w 10753706"/>
              <a:gd name="connsiteY63" fmla="*/ 717341 h 1027260"/>
              <a:gd name="connsiteX64" fmla="*/ 6295102 w 10753706"/>
              <a:gd name="connsiteY64" fmla="*/ 729508 h 1027260"/>
              <a:gd name="connsiteX65" fmla="*/ 6202084 w 10753706"/>
              <a:gd name="connsiteY65" fmla="*/ 767091 h 1027260"/>
              <a:gd name="connsiteX66" fmla="*/ 6067157 w 10753706"/>
              <a:gd name="connsiteY66" fmla="*/ 790339 h 1027260"/>
              <a:gd name="connsiteX67" fmla="*/ 6061443 w 10753706"/>
              <a:gd name="connsiteY67" fmla="*/ 796151 h 1027260"/>
              <a:gd name="connsiteX68" fmla="*/ 6051406 w 10753706"/>
              <a:gd name="connsiteY68" fmla="*/ 800684 h 1027260"/>
              <a:gd name="connsiteX69" fmla="*/ 6049097 w 10753706"/>
              <a:gd name="connsiteY69" fmla="*/ 800636 h 1027260"/>
              <a:gd name="connsiteX70" fmla="*/ 6034222 w 10753706"/>
              <a:gd name="connsiteY70" fmla="*/ 804110 h 1027260"/>
              <a:gd name="connsiteX71" fmla="*/ 6033121 w 10753706"/>
              <a:gd name="connsiteY71" fmla="*/ 806078 h 1027260"/>
              <a:gd name="connsiteX72" fmla="*/ 6023593 w 10753706"/>
              <a:gd name="connsiteY72" fmla="*/ 808842 h 1027260"/>
              <a:gd name="connsiteX73" fmla="*/ 6006639 w 10753706"/>
              <a:gd name="connsiteY73" fmla="*/ 815304 h 1027260"/>
              <a:gd name="connsiteX74" fmla="*/ 6001762 w 10753706"/>
              <a:gd name="connsiteY74" fmla="*/ 815557 h 1027260"/>
              <a:gd name="connsiteX75" fmla="*/ 5973534 w 10753706"/>
              <a:gd name="connsiteY75" fmla="*/ 823815 h 1027260"/>
              <a:gd name="connsiteX76" fmla="*/ 5972336 w 10753706"/>
              <a:gd name="connsiteY76" fmla="*/ 823476 h 1027260"/>
              <a:gd name="connsiteX77" fmla="*/ 5960841 w 10753706"/>
              <a:gd name="connsiteY77" fmla="*/ 823819 h 1027260"/>
              <a:gd name="connsiteX78" fmla="*/ 5940719 w 10753706"/>
              <a:gd name="connsiteY78" fmla="*/ 825514 h 1027260"/>
              <a:gd name="connsiteX79" fmla="*/ 5884298 w 10753706"/>
              <a:gd name="connsiteY79" fmla="*/ 823806 h 1027260"/>
              <a:gd name="connsiteX80" fmla="*/ 5854779 w 10753706"/>
              <a:gd name="connsiteY80" fmla="*/ 832365 h 1027260"/>
              <a:gd name="connsiteX81" fmla="*/ 5848382 w 10753706"/>
              <a:gd name="connsiteY81" fmla="*/ 833844 h 1027260"/>
              <a:gd name="connsiteX82" fmla="*/ 5848066 w 10753706"/>
              <a:gd name="connsiteY82" fmla="*/ 833772 h 1027260"/>
              <a:gd name="connsiteX83" fmla="*/ 5840944 w 10753706"/>
              <a:gd name="connsiteY83" fmla="*/ 835132 h 1027260"/>
              <a:gd name="connsiteX84" fmla="*/ 5836719 w 10753706"/>
              <a:gd name="connsiteY84" fmla="*/ 836539 h 1027260"/>
              <a:gd name="connsiteX85" fmla="*/ 5824311 w 10753706"/>
              <a:gd name="connsiteY85" fmla="*/ 839408 h 1027260"/>
              <a:gd name="connsiteX86" fmla="*/ 5818788 w 10753706"/>
              <a:gd name="connsiteY86" fmla="*/ 839727 h 1027260"/>
              <a:gd name="connsiteX87" fmla="*/ 5763953 w 10753706"/>
              <a:gd name="connsiteY87" fmla="*/ 834282 h 1027260"/>
              <a:gd name="connsiteX88" fmla="*/ 5667748 w 10753706"/>
              <a:gd name="connsiteY88" fmla="*/ 840211 h 1027260"/>
              <a:gd name="connsiteX89" fmla="*/ 5573108 w 10753706"/>
              <a:gd name="connsiteY89" fmla="*/ 847611 h 1027260"/>
              <a:gd name="connsiteX90" fmla="*/ 5539137 w 10753706"/>
              <a:gd name="connsiteY90" fmla="*/ 851033 h 1027260"/>
              <a:gd name="connsiteX91" fmla="*/ 5510651 w 10753706"/>
              <a:gd name="connsiteY91" fmla="*/ 844215 h 1027260"/>
              <a:gd name="connsiteX92" fmla="*/ 5457331 w 10753706"/>
              <a:gd name="connsiteY92" fmla="*/ 839159 h 1027260"/>
              <a:gd name="connsiteX93" fmla="*/ 5410613 w 10753706"/>
              <a:gd name="connsiteY93" fmla="*/ 834358 h 1027260"/>
              <a:gd name="connsiteX94" fmla="*/ 5370040 w 10753706"/>
              <a:gd name="connsiteY94" fmla="*/ 862127 h 1027260"/>
              <a:gd name="connsiteX95" fmla="*/ 5318778 w 10753706"/>
              <a:gd name="connsiteY95" fmla="*/ 855310 h 1027260"/>
              <a:gd name="connsiteX96" fmla="*/ 5298645 w 10753706"/>
              <a:gd name="connsiteY96" fmla="*/ 855171 h 1027260"/>
              <a:gd name="connsiteX97" fmla="*/ 5253828 w 10753706"/>
              <a:gd name="connsiteY97" fmla="*/ 859670 h 1027260"/>
              <a:gd name="connsiteX98" fmla="*/ 5216955 w 10753706"/>
              <a:gd name="connsiteY98" fmla="*/ 866245 h 1027260"/>
              <a:gd name="connsiteX99" fmla="*/ 5214344 w 10753706"/>
              <a:gd name="connsiteY99" fmla="*/ 868102 h 1027260"/>
              <a:gd name="connsiteX100" fmla="*/ 5195561 w 10753706"/>
              <a:gd name="connsiteY100" fmla="*/ 869949 h 1027260"/>
              <a:gd name="connsiteX101" fmla="*/ 5182555 w 10753706"/>
              <a:gd name="connsiteY101" fmla="*/ 873542 h 1027260"/>
              <a:gd name="connsiteX102" fmla="*/ 5172552 w 10753706"/>
              <a:gd name="connsiteY102" fmla="*/ 878801 h 1027260"/>
              <a:gd name="connsiteX103" fmla="*/ 5027993 w 10753706"/>
              <a:gd name="connsiteY103" fmla="*/ 889666 h 1027260"/>
              <a:gd name="connsiteX104" fmla="*/ 4939844 w 10753706"/>
              <a:gd name="connsiteY104" fmla="*/ 934802 h 1027260"/>
              <a:gd name="connsiteX105" fmla="*/ 4792576 w 10753706"/>
              <a:gd name="connsiteY105" fmla="*/ 934820 h 1027260"/>
              <a:gd name="connsiteX106" fmla="*/ 4602423 w 10753706"/>
              <a:gd name="connsiteY106" fmla="*/ 958063 h 1027260"/>
              <a:gd name="connsiteX107" fmla="*/ 4290656 w 10753706"/>
              <a:gd name="connsiteY107" fmla="*/ 969152 h 1027260"/>
              <a:gd name="connsiteX108" fmla="*/ 3952334 w 10753706"/>
              <a:gd name="connsiteY108" fmla="*/ 954043 h 1027260"/>
              <a:gd name="connsiteX109" fmla="*/ 3858560 w 10753706"/>
              <a:gd name="connsiteY109" fmla="*/ 948781 h 1027260"/>
              <a:gd name="connsiteX110" fmla="*/ 3846597 w 10753706"/>
              <a:gd name="connsiteY110" fmla="*/ 948382 h 1027260"/>
              <a:gd name="connsiteX111" fmla="*/ 3736044 w 10753706"/>
              <a:gd name="connsiteY111" fmla="*/ 947759 h 1027260"/>
              <a:gd name="connsiteX112" fmla="*/ 3713136 w 10753706"/>
              <a:gd name="connsiteY112" fmla="*/ 946963 h 1027260"/>
              <a:gd name="connsiteX113" fmla="*/ 3695939 w 10753706"/>
              <a:gd name="connsiteY113" fmla="*/ 943639 h 1027260"/>
              <a:gd name="connsiteX114" fmla="*/ 3694125 w 10753706"/>
              <a:gd name="connsiteY114" fmla="*/ 940567 h 1027260"/>
              <a:gd name="connsiteX115" fmla="*/ 3681925 w 10753706"/>
              <a:gd name="connsiteY115" fmla="*/ 939706 h 1027260"/>
              <a:gd name="connsiteX116" fmla="*/ 3679204 w 10753706"/>
              <a:gd name="connsiteY116" fmla="*/ 938926 h 1027260"/>
              <a:gd name="connsiteX117" fmla="*/ 3615656 w 10753706"/>
              <a:gd name="connsiteY117" fmla="*/ 940320 h 1027260"/>
              <a:gd name="connsiteX118" fmla="*/ 3567983 w 10753706"/>
              <a:gd name="connsiteY118" fmla="*/ 935596 h 1027260"/>
              <a:gd name="connsiteX119" fmla="*/ 3422423 w 10753706"/>
              <a:gd name="connsiteY119" fmla="*/ 932129 h 1027260"/>
              <a:gd name="connsiteX120" fmla="*/ 3310925 w 10753706"/>
              <a:gd name="connsiteY120" fmla="*/ 911072 h 1027260"/>
              <a:gd name="connsiteX121" fmla="*/ 3139421 w 10753706"/>
              <a:gd name="connsiteY121" fmla="*/ 934151 h 1027260"/>
              <a:gd name="connsiteX122" fmla="*/ 2996922 w 10753706"/>
              <a:gd name="connsiteY122" fmla="*/ 927537 h 1027260"/>
              <a:gd name="connsiteX123" fmla="*/ 2982785 w 10753706"/>
              <a:gd name="connsiteY123" fmla="*/ 931453 h 1027260"/>
              <a:gd name="connsiteX124" fmla="*/ 2967478 w 10753706"/>
              <a:gd name="connsiteY124" fmla="*/ 933397 h 1027260"/>
              <a:gd name="connsiteX125" fmla="*/ 2948552 w 10753706"/>
              <a:gd name="connsiteY125" fmla="*/ 932961 h 1027260"/>
              <a:gd name="connsiteX126" fmla="*/ 2944404 w 10753706"/>
              <a:gd name="connsiteY126" fmla="*/ 934452 h 1027260"/>
              <a:gd name="connsiteX127" fmla="*/ 2908608 w 10753706"/>
              <a:gd name="connsiteY127" fmla="*/ 937205 h 1027260"/>
              <a:gd name="connsiteX128" fmla="*/ 2904443 w 10753706"/>
              <a:gd name="connsiteY128" fmla="*/ 936455 h 1027260"/>
              <a:gd name="connsiteX129" fmla="*/ 2868935 w 10753706"/>
              <a:gd name="connsiteY129" fmla="*/ 938022 h 1027260"/>
              <a:gd name="connsiteX130" fmla="*/ 2868586 w 10753706"/>
              <a:gd name="connsiteY130" fmla="*/ 937487 h 1027260"/>
              <a:gd name="connsiteX131" fmla="*/ 2859191 w 10753706"/>
              <a:gd name="connsiteY131" fmla="*/ 935503 h 1027260"/>
              <a:gd name="connsiteX132" fmla="*/ 2840915 w 10753706"/>
              <a:gd name="connsiteY132" fmla="*/ 932977 h 1027260"/>
              <a:gd name="connsiteX133" fmla="*/ 2763509 w 10753706"/>
              <a:gd name="connsiteY133" fmla="*/ 921850 h 1027260"/>
              <a:gd name="connsiteX134" fmla="*/ 2756121 w 10753706"/>
              <a:gd name="connsiteY134" fmla="*/ 921864 h 1027260"/>
              <a:gd name="connsiteX135" fmla="*/ 2755998 w 10753706"/>
              <a:gd name="connsiteY135" fmla="*/ 921739 h 1027260"/>
              <a:gd name="connsiteX136" fmla="*/ 2748255 w 10753706"/>
              <a:gd name="connsiteY136" fmla="*/ 921505 h 1027260"/>
              <a:gd name="connsiteX137" fmla="*/ 2694601 w 10753706"/>
              <a:gd name="connsiteY137" fmla="*/ 915575 h 1027260"/>
              <a:gd name="connsiteX138" fmla="*/ 2635357 w 10753706"/>
              <a:gd name="connsiteY138" fmla="*/ 910976 h 1027260"/>
              <a:gd name="connsiteX139" fmla="*/ 2601047 w 10753706"/>
              <a:gd name="connsiteY139" fmla="*/ 910263 h 1027260"/>
              <a:gd name="connsiteX140" fmla="*/ 2507482 w 10753706"/>
              <a:gd name="connsiteY140" fmla="*/ 906211 h 1027260"/>
              <a:gd name="connsiteX141" fmla="*/ 2413884 w 10753706"/>
              <a:gd name="connsiteY141" fmla="*/ 900545 h 1027260"/>
              <a:gd name="connsiteX142" fmla="*/ 2368912 w 10753706"/>
              <a:gd name="connsiteY142" fmla="*/ 888755 h 1027260"/>
              <a:gd name="connsiteX143" fmla="*/ 2349490 w 10753706"/>
              <a:gd name="connsiteY143" fmla="*/ 889719 h 1027260"/>
              <a:gd name="connsiteX144" fmla="*/ 2344290 w 10753706"/>
              <a:gd name="connsiteY144" fmla="*/ 890584 h 1027260"/>
              <a:gd name="connsiteX145" fmla="*/ 2336488 w 10753706"/>
              <a:gd name="connsiteY145" fmla="*/ 891058 h 1027260"/>
              <a:gd name="connsiteX146" fmla="*/ 2329015 w 10753706"/>
              <a:gd name="connsiteY146" fmla="*/ 891627 h 1027260"/>
              <a:gd name="connsiteX147" fmla="*/ 2293898 w 10753706"/>
              <a:gd name="connsiteY147" fmla="*/ 896431 h 1027260"/>
              <a:gd name="connsiteX148" fmla="*/ 2243927 w 10753706"/>
              <a:gd name="connsiteY148" fmla="*/ 888076 h 1027260"/>
              <a:gd name="connsiteX149" fmla="*/ 2223920 w 10753706"/>
              <a:gd name="connsiteY149" fmla="*/ 887331 h 1027260"/>
              <a:gd name="connsiteX150" fmla="*/ 2213081 w 10753706"/>
              <a:gd name="connsiteY150" fmla="*/ 886302 h 1027260"/>
              <a:gd name="connsiteX151" fmla="*/ 2212307 w 10753706"/>
              <a:gd name="connsiteY151" fmla="*/ 885829 h 1027260"/>
              <a:gd name="connsiteX152" fmla="*/ 2152321 w 10753706"/>
              <a:gd name="connsiteY152" fmla="*/ 894418 h 1027260"/>
              <a:gd name="connsiteX153" fmla="*/ 2140985 w 10753706"/>
              <a:gd name="connsiteY153" fmla="*/ 895968 h 1027260"/>
              <a:gd name="connsiteX154" fmla="*/ 2121210 w 10753706"/>
              <a:gd name="connsiteY154" fmla="*/ 899354 h 1027260"/>
              <a:gd name="connsiteX155" fmla="*/ 2119146 w 10753706"/>
              <a:gd name="connsiteY155" fmla="*/ 899033 h 1027260"/>
              <a:gd name="connsiteX156" fmla="*/ 2105666 w 10753706"/>
              <a:gd name="connsiteY156" fmla="*/ 902240 h 1027260"/>
              <a:gd name="connsiteX157" fmla="*/ 2094924 w 10753706"/>
              <a:gd name="connsiteY157" fmla="*/ 907203 h 1027260"/>
              <a:gd name="connsiteX158" fmla="*/ 1949478 w 10753706"/>
              <a:gd name="connsiteY158" fmla="*/ 913748 h 1027260"/>
              <a:gd name="connsiteX159" fmla="*/ 1749684 w 10753706"/>
              <a:gd name="connsiteY159" fmla="*/ 942223 h 1027260"/>
              <a:gd name="connsiteX160" fmla="*/ 1585576 w 10753706"/>
              <a:gd name="connsiteY160" fmla="*/ 954170 h 1027260"/>
              <a:gd name="connsiteX161" fmla="*/ 1476250 w 10753706"/>
              <a:gd name="connsiteY161" fmla="*/ 950653 h 1027260"/>
              <a:gd name="connsiteX162" fmla="*/ 1433927 w 10753706"/>
              <a:gd name="connsiteY162" fmla="*/ 959926 h 1027260"/>
              <a:gd name="connsiteX163" fmla="*/ 1414893 w 10753706"/>
              <a:gd name="connsiteY163" fmla="*/ 957671 h 1027260"/>
              <a:gd name="connsiteX164" fmla="*/ 1411585 w 10753706"/>
              <a:gd name="connsiteY164" fmla="*/ 957179 h 1027260"/>
              <a:gd name="connsiteX165" fmla="*/ 1398896 w 10753706"/>
              <a:gd name="connsiteY165" fmla="*/ 957460 h 1027260"/>
              <a:gd name="connsiteX166" fmla="*/ 1394632 w 10753706"/>
              <a:gd name="connsiteY166" fmla="*/ 954725 h 1027260"/>
              <a:gd name="connsiteX167" fmla="*/ 1375043 w 10753706"/>
              <a:gd name="connsiteY167" fmla="*/ 953132 h 1027260"/>
              <a:gd name="connsiteX168" fmla="*/ 1351876 w 10753706"/>
              <a:gd name="connsiteY168" fmla="*/ 954436 h 1027260"/>
              <a:gd name="connsiteX169" fmla="*/ 1242676 w 10753706"/>
              <a:gd name="connsiteY169" fmla="*/ 963767 h 1027260"/>
              <a:gd name="connsiteX170" fmla="*/ 1205993 w 10753706"/>
              <a:gd name="connsiteY170" fmla="*/ 974080 h 1027260"/>
              <a:gd name="connsiteX171" fmla="*/ 1052221 w 10753706"/>
              <a:gd name="connsiteY171" fmla="*/ 963954 h 1027260"/>
              <a:gd name="connsiteX172" fmla="*/ 968270 w 10753706"/>
              <a:gd name="connsiteY172" fmla="*/ 964761 h 1027260"/>
              <a:gd name="connsiteX173" fmla="*/ 874493 w 10753706"/>
              <a:gd name="connsiteY173" fmla="*/ 998122 h 1027260"/>
              <a:gd name="connsiteX174" fmla="*/ 814411 w 10753706"/>
              <a:gd name="connsiteY174" fmla="*/ 1007391 h 1027260"/>
              <a:gd name="connsiteX175" fmla="*/ 688604 w 10753706"/>
              <a:gd name="connsiteY175" fmla="*/ 1015631 h 1027260"/>
              <a:gd name="connsiteX176" fmla="*/ 618171 w 10753706"/>
              <a:gd name="connsiteY176" fmla="*/ 1027260 h 1027260"/>
              <a:gd name="connsiteX177" fmla="*/ 570379 w 10753706"/>
              <a:gd name="connsiteY177" fmla="*/ 1023487 h 1027260"/>
              <a:gd name="connsiteX178" fmla="*/ 482519 w 10753706"/>
              <a:gd name="connsiteY178" fmla="*/ 1002108 h 1027260"/>
              <a:gd name="connsiteX179" fmla="*/ 475319 w 10753706"/>
              <a:gd name="connsiteY179" fmla="*/ 1009922 h 1027260"/>
              <a:gd name="connsiteX180" fmla="*/ 431104 w 10753706"/>
              <a:gd name="connsiteY180" fmla="*/ 1009317 h 1027260"/>
              <a:gd name="connsiteX181" fmla="*/ 363782 w 10753706"/>
              <a:gd name="connsiteY181" fmla="*/ 1007585 h 1027260"/>
              <a:gd name="connsiteX182" fmla="*/ 325533 w 10753706"/>
              <a:gd name="connsiteY182" fmla="*/ 1008502 h 1027260"/>
              <a:gd name="connsiteX183" fmla="*/ 220429 w 10753706"/>
              <a:gd name="connsiteY183" fmla="*/ 1008927 h 1027260"/>
              <a:gd name="connsiteX184" fmla="*/ 114676 w 10753706"/>
              <a:gd name="connsiteY184" fmla="*/ 1007765 h 1027260"/>
              <a:gd name="connsiteX185" fmla="*/ 13470 w 10753706"/>
              <a:gd name="connsiteY185" fmla="*/ 998544 h 1027260"/>
              <a:gd name="connsiteX186" fmla="*/ 0 w 10753706"/>
              <a:gd name="connsiteY186" fmla="*/ 997355 h 10272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Lst>
            <a:rect l="l" t="t" r="r" b="b"/>
            <a:pathLst>
              <a:path w="10753706" h="1027260">
                <a:moveTo>
                  <a:pt x="0" y="0"/>
                </a:moveTo>
                <a:lnTo>
                  <a:pt x="10753706" y="0"/>
                </a:lnTo>
                <a:lnTo>
                  <a:pt x="10748809" y="2522"/>
                </a:lnTo>
                <a:cubicBezTo>
                  <a:pt x="10744031" y="4644"/>
                  <a:pt x="10737551" y="7204"/>
                  <a:pt x="10725330" y="11977"/>
                </a:cubicBezTo>
                <a:cubicBezTo>
                  <a:pt x="10700888" y="21523"/>
                  <a:pt x="10652058" y="39304"/>
                  <a:pt x="10615423" y="52967"/>
                </a:cubicBezTo>
                <a:cubicBezTo>
                  <a:pt x="10598524" y="49017"/>
                  <a:pt x="10550674" y="61360"/>
                  <a:pt x="10533936" y="53095"/>
                </a:cubicBezTo>
                <a:cubicBezTo>
                  <a:pt x="10519435" y="55674"/>
                  <a:pt x="10480156" y="49393"/>
                  <a:pt x="10466876" y="45180"/>
                </a:cubicBezTo>
                <a:cubicBezTo>
                  <a:pt x="10443145" y="68059"/>
                  <a:pt x="10382269" y="71294"/>
                  <a:pt x="10355090" y="89741"/>
                </a:cubicBezTo>
                <a:cubicBezTo>
                  <a:pt x="10286222" y="95376"/>
                  <a:pt x="10146285" y="63529"/>
                  <a:pt x="10087145" y="66115"/>
                </a:cubicBezTo>
                <a:cubicBezTo>
                  <a:pt x="10067575" y="79584"/>
                  <a:pt x="10043111" y="68921"/>
                  <a:pt x="10015902" y="76178"/>
                </a:cubicBezTo>
                <a:cubicBezTo>
                  <a:pt x="9952302" y="84628"/>
                  <a:pt x="9893286" y="103337"/>
                  <a:pt x="9806005" y="102435"/>
                </a:cubicBezTo>
                <a:cubicBezTo>
                  <a:pt x="9782247" y="141133"/>
                  <a:pt x="9674787" y="151643"/>
                  <a:pt x="9602583" y="179170"/>
                </a:cubicBezTo>
                <a:cubicBezTo>
                  <a:pt x="9557658" y="187584"/>
                  <a:pt x="9478290" y="154235"/>
                  <a:pt x="9469719" y="174721"/>
                </a:cubicBezTo>
                <a:cubicBezTo>
                  <a:pt x="9443779" y="165070"/>
                  <a:pt x="9431317" y="185692"/>
                  <a:pt x="9408692" y="189513"/>
                </a:cubicBezTo>
                <a:cubicBezTo>
                  <a:pt x="9387154" y="183843"/>
                  <a:pt x="9380475" y="191089"/>
                  <a:pt x="9364151" y="194072"/>
                </a:cubicBezTo>
                <a:cubicBezTo>
                  <a:pt x="9354686" y="190222"/>
                  <a:pt x="9340485" y="191782"/>
                  <a:pt x="9337751" y="197579"/>
                </a:cubicBezTo>
                <a:cubicBezTo>
                  <a:pt x="9349566" y="209270"/>
                  <a:pt x="9297468" y="207714"/>
                  <a:pt x="9297166" y="216558"/>
                </a:cubicBezTo>
                <a:cubicBezTo>
                  <a:pt x="9269057" y="220999"/>
                  <a:pt x="9139630" y="221783"/>
                  <a:pt x="9123859" y="237356"/>
                </a:cubicBezTo>
                <a:cubicBezTo>
                  <a:pt x="9068176" y="249209"/>
                  <a:pt x="8975349" y="235349"/>
                  <a:pt x="8950741" y="238020"/>
                </a:cubicBezTo>
                <a:cubicBezTo>
                  <a:pt x="8916265" y="215428"/>
                  <a:pt x="8822808" y="292026"/>
                  <a:pt x="8718236" y="303148"/>
                </a:cubicBezTo>
                <a:cubicBezTo>
                  <a:pt x="8703111" y="302060"/>
                  <a:pt x="8695551" y="302792"/>
                  <a:pt x="8694011" y="308812"/>
                </a:cubicBezTo>
                <a:cubicBezTo>
                  <a:pt x="8661810" y="312764"/>
                  <a:pt x="8637956" y="329628"/>
                  <a:pt x="8611976" y="324819"/>
                </a:cubicBezTo>
                <a:cubicBezTo>
                  <a:pt x="8621849" y="336388"/>
                  <a:pt x="8562809" y="325917"/>
                  <a:pt x="8562074" y="337971"/>
                </a:cubicBezTo>
                <a:cubicBezTo>
                  <a:pt x="8543699" y="343978"/>
                  <a:pt x="8511321" y="356396"/>
                  <a:pt x="8501724" y="360865"/>
                </a:cubicBezTo>
                <a:lnTo>
                  <a:pt x="8504489" y="364790"/>
                </a:lnTo>
                <a:lnTo>
                  <a:pt x="8492774" y="366181"/>
                </a:lnTo>
                <a:lnTo>
                  <a:pt x="8466405" y="368724"/>
                </a:lnTo>
                <a:cubicBezTo>
                  <a:pt x="8455454" y="372229"/>
                  <a:pt x="8440175" y="385805"/>
                  <a:pt x="8427069" y="387211"/>
                </a:cubicBezTo>
                <a:cubicBezTo>
                  <a:pt x="8400442" y="392215"/>
                  <a:pt x="8397079" y="382989"/>
                  <a:pt x="8387766" y="377161"/>
                </a:cubicBezTo>
                <a:cubicBezTo>
                  <a:pt x="8369233" y="378548"/>
                  <a:pt x="8334756" y="390869"/>
                  <a:pt x="8315874" y="395527"/>
                </a:cubicBezTo>
                <a:cubicBezTo>
                  <a:pt x="8306664" y="400500"/>
                  <a:pt x="8272845" y="393679"/>
                  <a:pt x="8274474" y="405112"/>
                </a:cubicBezTo>
                <a:cubicBezTo>
                  <a:pt x="8255483" y="406194"/>
                  <a:pt x="8244963" y="408376"/>
                  <a:pt x="8234664" y="410219"/>
                </a:cubicBezTo>
                <a:lnTo>
                  <a:pt x="8211268" y="416791"/>
                </a:lnTo>
                <a:cubicBezTo>
                  <a:pt x="8204720" y="419941"/>
                  <a:pt x="8197411" y="422004"/>
                  <a:pt x="8188615" y="421755"/>
                </a:cubicBezTo>
                <a:lnTo>
                  <a:pt x="8179981" y="420402"/>
                </a:lnTo>
                <a:lnTo>
                  <a:pt x="8179307" y="422516"/>
                </a:lnTo>
                <a:cubicBezTo>
                  <a:pt x="8179027" y="425797"/>
                  <a:pt x="8175790" y="448341"/>
                  <a:pt x="8147929" y="450302"/>
                </a:cubicBezTo>
                <a:cubicBezTo>
                  <a:pt x="8130300" y="457967"/>
                  <a:pt x="8114933" y="461015"/>
                  <a:pt x="8089136" y="465283"/>
                </a:cubicBezTo>
                <a:cubicBezTo>
                  <a:pt x="8072810" y="465920"/>
                  <a:pt x="8069376" y="451569"/>
                  <a:pt x="8049973" y="454121"/>
                </a:cubicBezTo>
                <a:cubicBezTo>
                  <a:pt x="7974508" y="471465"/>
                  <a:pt x="8006050" y="447139"/>
                  <a:pt x="7965913" y="464415"/>
                </a:cubicBezTo>
                <a:cubicBezTo>
                  <a:pt x="7958234" y="466025"/>
                  <a:pt x="7951405" y="465800"/>
                  <a:pt x="7945093" y="464798"/>
                </a:cubicBezTo>
                <a:lnTo>
                  <a:pt x="7935335" y="462442"/>
                </a:lnTo>
                <a:lnTo>
                  <a:pt x="7904779" y="471429"/>
                </a:lnTo>
                <a:cubicBezTo>
                  <a:pt x="7889387" y="474999"/>
                  <a:pt x="7872867" y="477951"/>
                  <a:pt x="7855604" y="480199"/>
                </a:cubicBezTo>
                <a:cubicBezTo>
                  <a:pt x="7850005" y="476378"/>
                  <a:pt x="7838628" y="483595"/>
                  <a:pt x="7832630" y="485371"/>
                </a:cubicBezTo>
                <a:cubicBezTo>
                  <a:pt x="7831473" y="482645"/>
                  <a:pt x="7816623" y="482661"/>
                  <a:pt x="7812438" y="485391"/>
                </a:cubicBezTo>
                <a:cubicBezTo>
                  <a:pt x="7709470" y="505049"/>
                  <a:pt x="7759426" y="473956"/>
                  <a:pt x="7701399" y="495197"/>
                </a:cubicBezTo>
                <a:cubicBezTo>
                  <a:pt x="7690986" y="496989"/>
                  <a:pt x="7682397" y="496365"/>
                  <a:pt x="7674778" y="494723"/>
                </a:cubicBezTo>
                <a:lnTo>
                  <a:pt x="7660445" y="490194"/>
                </a:lnTo>
                <a:lnTo>
                  <a:pt x="7651781" y="493084"/>
                </a:lnTo>
                <a:cubicBezTo>
                  <a:pt x="7616113" y="496548"/>
                  <a:pt x="7603273" y="491735"/>
                  <a:pt x="7584807" y="499490"/>
                </a:cubicBezTo>
                <a:cubicBezTo>
                  <a:pt x="7549256" y="490212"/>
                  <a:pt x="7563949" y="500167"/>
                  <a:pt x="7541324" y="504184"/>
                </a:cubicBezTo>
                <a:cubicBezTo>
                  <a:pt x="7523851" y="508307"/>
                  <a:pt x="7559546" y="509825"/>
                  <a:pt x="7541756" y="512184"/>
                </a:cubicBezTo>
                <a:cubicBezTo>
                  <a:pt x="7520963" y="510864"/>
                  <a:pt x="7525755" y="520497"/>
                  <a:pt x="7503906" y="518551"/>
                </a:cubicBezTo>
                <a:cubicBezTo>
                  <a:pt x="7505924" y="510774"/>
                  <a:pt x="7464361" y="523683"/>
                  <a:pt x="7460411" y="517415"/>
                </a:cubicBezTo>
                <a:lnTo>
                  <a:pt x="7460116" y="517548"/>
                </a:lnTo>
                <a:cubicBezTo>
                  <a:pt x="7447785" y="530928"/>
                  <a:pt x="7310141" y="550568"/>
                  <a:pt x="7297810" y="563947"/>
                </a:cubicBezTo>
                <a:cubicBezTo>
                  <a:pt x="7221791" y="605698"/>
                  <a:pt x="7039072" y="646008"/>
                  <a:pt x="6946388" y="665244"/>
                </a:cubicBezTo>
                <a:cubicBezTo>
                  <a:pt x="6853704" y="684480"/>
                  <a:pt x="6804875" y="677485"/>
                  <a:pt x="6741704" y="679365"/>
                </a:cubicBezTo>
                <a:lnTo>
                  <a:pt x="6624680" y="677674"/>
                </a:lnTo>
                <a:lnTo>
                  <a:pt x="6605700" y="683566"/>
                </a:lnTo>
                <a:cubicBezTo>
                  <a:pt x="6603309" y="685184"/>
                  <a:pt x="6599550" y="685647"/>
                  <a:pt x="6576922" y="683030"/>
                </a:cubicBezTo>
                <a:cubicBezTo>
                  <a:pt x="6527275" y="698355"/>
                  <a:pt x="6440981" y="702347"/>
                  <a:pt x="6405123" y="721946"/>
                </a:cubicBezTo>
                <a:cubicBezTo>
                  <a:pt x="6407963" y="715467"/>
                  <a:pt x="6383450" y="712913"/>
                  <a:pt x="6368938" y="717341"/>
                </a:cubicBezTo>
                <a:cubicBezTo>
                  <a:pt x="6377914" y="692119"/>
                  <a:pt x="6315316" y="744281"/>
                  <a:pt x="6295102" y="729508"/>
                </a:cubicBezTo>
                <a:cubicBezTo>
                  <a:pt x="6300358" y="744473"/>
                  <a:pt x="6240070" y="776254"/>
                  <a:pt x="6202084" y="767091"/>
                </a:cubicBezTo>
                <a:cubicBezTo>
                  <a:pt x="6152826" y="774744"/>
                  <a:pt x="6122010" y="790367"/>
                  <a:pt x="6067157" y="790339"/>
                </a:cubicBezTo>
                <a:cubicBezTo>
                  <a:pt x="6066310" y="792484"/>
                  <a:pt x="6064283" y="794403"/>
                  <a:pt x="6061443" y="796151"/>
                </a:cubicBezTo>
                <a:lnTo>
                  <a:pt x="6051406" y="800684"/>
                </a:lnTo>
                <a:lnTo>
                  <a:pt x="6049097" y="800636"/>
                </a:lnTo>
                <a:cubicBezTo>
                  <a:pt x="6040408" y="801393"/>
                  <a:pt x="6036299" y="802645"/>
                  <a:pt x="6034222" y="804110"/>
                </a:cubicBezTo>
                <a:lnTo>
                  <a:pt x="6033121" y="806078"/>
                </a:lnTo>
                <a:lnTo>
                  <a:pt x="6023593" y="808842"/>
                </a:lnTo>
                <a:lnTo>
                  <a:pt x="6006639" y="815304"/>
                </a:lnTo>
                <a:lnTo>
                  <a:pt x="6001762" y="815557"/>
                </a:lnTo>
                <a:lnTo>
                  <a:pt x="5973534" y="823815"/>
                </a:lnTo>
                <a:lnTo>
                  <a:pt x="5972336" y="823476"/>
                </a:lnTo>
                <a:cubicBezTo>
                  <a:pt x="5969004" y="822901"/>
                  <a:pt x="5965329" y="822833"/>
                  <a:pt x="5960841" y="823819"/>
                </a:cubicBezTo>
                <a:cubicBezTo>
                  <a:pt x="5955860" y="815655"/>
                  <a:pt x="5953515" y="821882"/>
                  <a:pt x="5940719" y="825514"/>
                </a:cubicBezTo>
                <a:cubicBezTo>
                  <a:pt x="5930130" y="813644"/>
                  <a:pt x="5900943" y="827979"/>
                  <a:pt x="5884298" y="823806"/>
                </a:cubicBezTo>
                <a:cubicBezTo>
                  <a:pt x="5875133" y="826741"/>
                  <a:pt x="5865250" y="829630"/>
                  <a:pt x="5854779" y="832365"/>
                </a:cubicBezTo>
                <a:lnTo>
                  <a:pt x="5848382" y="833844"/>
                </a:lnTo>
                <a:lnTo>
                  <a:pt x="5848066" y="833772"/>
                </a:lnTo>
                <a:cubicBezTo>
                  <a:pt x="5846273" y="833879"/>
                  <a:pt x="5844018" y="834284"/>
                  <a:pt x="5840944" y="835132"/>
                </a:cubicBezTo>
                <a:lnTo>
                  <a:pt x="5836719" y="836539"/>
                </a:lnTo>
                <a:lnTo>
                  <a:pt x="5824311" y="839408"/>
                </a:lnTo>
                <a:lnTo>
                  <a:pt x="5818788" y="839727"/>
                </a:lnTo>
                <a:cubicBezTo>
                  <a:pt x="5797008" y="838594"/>
                  <a:pt x="5786883" y="822081"/>
                  <a:pt x="5763953" y="834282"/>
                </a:cubicBezTo>
                <a:cubicBezTo>
                  <a:pt x="5726813" y="837521"/>
                  <a:pt x="5699446" y="830949"/>
                  <a:pt x="5667748" y="840211"/>
                </a:cubicBezTo>
                <a:cubicBezTo>
                  <a:pt x="5632959" y="843205"/>
                  <a:pt x="5601436" y="842280"/>
                  <a:pt x="5573108" y="847611"/>
                </a:cubicBezTo>
                <a:cubicBezTo>
                  <a:pt x="5560030" y="845832"/>
                  <a:pt x="5549547" y="851598"/>
                  <a:pt x="5539137" y="851033"/>
                </a:cubicBezTo>
                <a:cubicBezTo>
                  <a:pt x="5528728" y="850467"/>
                  <a:pt x="5529256" y="837509"/>
                  <a:pt x="5510651" y="844215"/>
                </a:cubicBezTo>
                <a:cubicBezTo>
                  <a:pt x="5494241" y="833607"/>
                  <a:pt x="5466101" y="839171"/>
                  <a:pt x="5457331" y="839159"/>
                </a:cubicBezTo>
                <a:lnTo>
                  <a:pt x="5410613" y="834358"/>
                </a:lnTo>
                <a:lnTo>
                  <a:pt x="5370040" y="862127"/>
                </a:lnTo>
                <a:cubicBezTo>
                  <a:pt x="5357863" y="856469"/>
                  <a:pt x="5319115" y="868069"/>
                  <a:pt x="5318778" y="855310"/>
                </a:cubicBezTo>
                <a:cubicBezTo>
                  <a:pt x="5303920" y="857760"/>
                  <a:pt x="5296727" y="863736"/>
                  <a:pt x="5298645" y="855171"/>
                </a:cubicBezTo>
                <a:cubicBezTo>
                  <a:pt x="5287819" y="855897"/>
                  <a:pt x="5267444" y="857825"/>
                  <a:pt x="5253828" y="859670"/>
                </a:cubicBezTo>
                <a:lnTo>
                  <a:pt x="5216955" y="866245"/>
                </a:lnTo>
                <a:lnTo>
                  <a:pt x="5214344" y="868102"/>
                </a:lnTo>
                <a:cubicBezTo>
                  <a:pt x="5210778" y="868719"/>
                  <a:pt x="5200859" y="869042"/>
                  <a:pt x="5195561" y="869949"/>
                </a:cubicBezTo>
                <a:lnTo>
                  <a:pt x="5182555" y="873542"/>
                </a:lnTo>
                <a:cubicBezTo>
                  <a:pt x="5178496" y="875023"/>
                  <a:pt x="5175066" y="876746"/>
                  <a:pt x="5172552" y="878801"/>
                </a:cubicBezTo>
                <a:cubicBezTo>
                  <a:pt x="5121406" y="873797"/>
                  <a:pt x="5080096" y="886529"/>
                  <a:pt x="5027993" y="889666"/>
                </a:cubicBezTo>
                <a:cubicBezTo>
                  <a:pt x="4999924" y="877115"/>
                  <a:pt x="4946973" y="919452"/>
                  <a:pt x="4939844" y="934802"/>
                </a:cubicBezTo>
                <a:cubicBezTo>
                  <a:pt x="4895154" y="940701"/>
                  <a:pt x="4844006" y="928240"/>
                  <a:pt x="4792576" y="934820"/>
                </a:cubicBezTo>
                <a:lnTo>
                  <a:pt x="4602423" y="958063"/>
                </a:lnTo>
                <a:cubicBezTo>
                  <a:pt x="4488530" y="967131"/>
                  <a:pt x="4399004" y="969822"/>
                  <a:pt x="4290656" y="969152"/>
                </a:cubicBezTo>
                <a:cubicBezTo>
                  <a:pt x="4182308" y="968482"/>
                  <a:pt x="4046938" y="971167"/>
                  <a:pt x="3952334" y="954043"/>
                </a:cubicBezTo>
                <a:lnTo>
                  <a:pt x="3858560" y="948781"/>
                </a:lnTo>
                <a:lnTo>
                  <a:pt x="3846597" y="948382"/>
                </a:lnTo>
                <a:cubicBezTo>
                  <a:pt x="3807516" y="956616"/>
                  <a:pt x="3767475" y="941640"/>
                  <a:pt x="3736044" y="947759"/>
                </a:cubicBezTo>
                <a:cubicBezTo>
                  <a:pt x="3727323" y="948128"/>
                  <a:pt x="3719828" y="947771"/>
                  <a:pt x="3713136" y="946963"/>
                </a:cubicBezTo>
                <a:lnTo>
                  <a:pt x="3695939" y="943639"/>
                </a:lnTo>
                <a:lnTo>
                  <a:pt x="3694125" y="940567"/>
                </a:lnTo>
                <a:lnTo>
                  <a:pt x="3681925" y="939706"/>
                </a:lnTo>
                <a:lnTo>
                  <a:pt x="3679204" y="938926"/>
                </a:lnTo>
                <a:cubicBezTo>
                  <a:pt x="3668160" y="939028"/>
                  <a:pt x="3634193" y="940875"/>
                  <a:pt x="3615656" y="940320"/>
                </a:cubicBezTo>
                <a:cubicBezTo>
                  <a:pt x="3582626" y="936974"/>
                  <a:pt x="3593904" y="949140"/>
                  <a:pt x="3567983" y="935596"/>
                </a:cubicBezTo>
                <a:cubicBezTo>
                  <a:pt x="3504185" y="939048"/>
                  <a:pt x="3482818" y="922224"/>
                  <a:pt x="3422423" y="932129"/>
                </a:cubicBezTo>
                <a:cubicBezTo>
                  <a:pt x="3369166" y="933413"/>
                  <a:pt x="3329486" y="910108"/>
                  <a:pt x="3310925" y="911072"/>
                </a:cubicBezTo>
                <a:cubicBezTo>
                  <a:pt x="3261363" y="909787"/>
                  <a:pt x="3198415" y="933574"/>
                  <a:pt x="3139421" y="934151"/>
                </a:cubicBezTo>
                <a:cubicBezTo>
                  <a:pt x="3088799" y="931012"/>
                  <a:pt x="3038941" y="938464"/>
                  <a:pt x="2996922" y="927537"/>
                </a:cubicBezTo>
                <a:cubicBezTo>
                  <a:pt x="2992673" y="929234"/>
                  <a:pt x="2987900" y="930498"/>
                  <a:pt x="2982785" y="931453"/>
                </a:cubicBezTo>
                <a:lnTo>
                  <a:pt x="2967478" y="933397"/>
                </a:lnTo>
                <a:lnTo>
                  <a:pt x="2948552" y="932961"/>
                </a:lnTo>
                <a:lnTo>
                  <a:pt x="2944404" y="934452"/>
                </a:lnTo>
                <a:lnTo>
                  <a:pt x="2908608" y="937205"/>
                </a:lnTo>
                <a:lnTo>
                  <a:pt x="2904443" y="936455"/>
                </a:lnTo>
                <a:lnTo>
                  <a:pt x="2868935" y="938022"/>
                </a:lnTo>
                <a:lnTo>
                  <a:pt x="2868586" y="937487"/>
                </a:lnTo>
                <a:cubicBezTo>
                  <a:pt x="2866994" y="936327"/>
                  <a:pt x="2864292" y="935538"/>
                  <a:pt x="2859191" y="935503"/>
                </a:cubicBezTo>
                <a:cubicBezTo>
                  <a:pt x="2869075" y="927418"/>
                  <a:pt x="2856828" y="932364"/>
                  <a:pt x="2840915" y="932977"/>
                </a:cubicBezTo>
                <a:lnTo>
                  <a:pt x="2763509" y="921850"/>
                </a:lnTo>
                <a:lnTo>
                  <a:pt x="2756121" y="921864"/>
                </a:lnTo>
                <a:cubicBezTo>
                  <a:pt x="2756081" y="921822"/>
                  <a:pt x="2756039" y="921781"/>
                  <a:pt x="2755998" y="921739"/>
                </a:cubicBezTo>
                <a:cubicBezTo>
                  <a:pt x="2754445" y="921476"/>
                  <a:pt x="2752036" y="921380"/>
                  <a:pt x="2748255" y="921505"/>
                </a:cubicBezTo>
                <a:lnTo>
                  <a:pt x="2694601" y="915575"/>
                </a:lnTo>
                <a:cubicBezTo>
                  <a:pt x="2671223" y="919874"/>
                  <a:pt x="2666972" y="913376"/>
                  <a:pt x="2635357" y="910976"/>
                </a:cubicBezTo>
                <a:cubicBezTo>
                  <a:pt x="2621906" y="915051"/>
                  <a:pt x="2611315" y="913542"/>
                  <a:pt x="2601047" y="910263"/>
                </a:cubicBezTo>
                <a:cubicBezTo>
                  <a:pt x="2570084" y="912074"/>
                  <a:pt x="2542135" y="907435"/>
                  <a:pt x="2507482" y="906211"/>
                </a:cubicBezTo>
                <a:cubicBezTo>
                  <a:pt x="2469706" y="911437"/>
                  <a:pt x="2450920" y="901812"/>
                  <a:pt x="2413884" y="900545"/>
                </a:cubicBezTo>
                <a:cubicBezTo>
                  <a:pt x="2381338" y="909664"/>
                  <a:pt x="2387753" y="892438"/>
                  <a:pt x="2368912" y="888755"/>
                </a:cubicBezTo>
                <a:lnTo>
                  <a:pt x="2349490" y="889719"/>
                </a:lnTo>
                <a:lnTo>
                  <a:pt x="2344290" y="890584"/>
                </a:lnTo>
                <a:cubicBezTo>
                  <a:pt x="2340673" y="891041"/>
                  <a:pt x="2338228" y="891167"/>
                  <a:pt x="2336488" y="891058"/>
                </a:cubicBezTo>
                <a:lnTo>
                  <a:pt x="2329015" y="891627"/>
                </a:lnTo>
                <a:cubicBezTo>
                  <a:pt x="2316843" y="893039"/>
                  <a:pt x="2305064" y="894669"/>
                  <a:pt x="2293898" y="896431"/>
                </a:cubicBezTo>
                <a:cubicBezTo>
                  <a:pt x="2282637" y="890404"/>
                  <a:pt x="2242346" y="900851"/>
                  <a:pt x="2243927" y="888076"/>
                </a:cubicBezTo>
                <a:cubicBezTo>
                  <a:pt x="2228778" y="890081"/>
                  <a:pt x="2220725" y="895845"/>
                  <a:pt x="2223920" y="887331"/>
                </a:cubicBezTo>
                <a:cubicBezTo>
                  <a:pt x="2218877" y="887756"/>
                  <a:pt x="2215583" y="887254"/>
                  <a:pt x="2213081" y="886302"/>
                </a:cubicBezTo>
                <a:lnTo>
                  <a:pt x="2212307" y="885829"/>
                </a:lnTo>
                <a:lnTo>
                  <a:pt x="2152321" y="894418"/>
                </a:lnTo>
                <a:lnTo>
                  <a:pt x="2140985" y="895968"/>
                </a:lnTo>
                <a:lnTo>
                  <a:pt x="2121210" y="899354"/>
                </a:lnTo>
                <a:lnTo>
                  <a:pt x="2119146" y="899033"/>
                </a:lnTo>
                <a:lnTo>
                  <a:pt x="2105666" y="902240"/>
                </a:lnTo>
                <a:cubicBezTo>
                  <a:pt x="2101407" y="903601"/>
                  <a:pt x="2097735" y="905221"/>
                  <a:pt x="2094924" y="907203"/>
                </a:cubicBezTo>
                <a:cubicBezTo>
                  <a:pt x="2044793" y="900664"/>
                  <a:pt x="2001785" y="912168"/>
                  <a:pt x="1949478" y="913748"/>
                </a:cubicBezTo>
                <a:cubicBezTo>
                  <a:pt x="1891937" y="919585"/>
                  <a:pt x="1810334" y="935486"/>
                  <a:pt x="1749684" y="942223"/>
                </a:cubicBezTo>
                <a:lnTo>
                  <a:pt x="1585576" y="954170"/>
                </a:lnTo>
                <a:cubicBezTo>
                  <a:pt x="1549165" y="943719"/>
                  <a:pt x="1511425" y="950847"/>
                  <a:pt x="1476250" y="950653"/>
                </a:cubicBezTo>
                <a:cubicBezTo>
                  <a:pt x="1488515" y="961596"/>
                  <a:pt x="1432660" y="946795"/>
                  <a:pt x="1433927" y="959926"/>
                </a:cubicBezTo>
                <a:cubicBezTo>
                  <a:pt x="1427485" y="959475"/>
                  <a:pt x="1421205" y="958623"/>
                  <a:pt x="1414893" y="957671"/>
                </a:cubicBezTo>
                <a:lnTo>
                  <a:pt x="1411585" y="957179"/>
                </a:lnTo>
                <a:lnTo>
                  <a:pt x="1398896" y="957460"/>
                </a:lnTo>
                <a:lnTo>
                  <a:pt x="1394632" y="954725"/>
                </a:lnTo>
                <a:lnTo>
                  <a:pt x="1375043" y="953132"/>
                </a:lnTo>
                <a:cubicBezTo>
                  <a:pt x="1367813" y="952970"/>
                  <a:pt x="1360155" y="953305"/>
                  <a:pt x="1351876" y="954436"/>
                </a:cubicBezTo>
                <a:cubicBezTo>
                  <a:pt x="1325912" y="963028"/>
                  <a:pt x="1274459" y="952492"/>
                  <a:pt x="1242676" y="963767"/>
                </a:cubicBezTo>
                <a:cubicBezTo>
                  <a:pt x="1230276" y="966918"/>
                  <a:pt x="1216715" y="977098"/>
                  <a:pt x="1205993" y="974080"/>
                </a:cubicBezTo>
                <a:cubicBezTo>
                  <a:pt x="1174251" y="974112"/>
                  <a:pt x="1086982" y="964420"/>
                  <a:pt x="1052221" y="963954"/>
                </a:cubicBezTo>
                <a:cubicBezTo>
                  <a:pt x="1038515" y="970622"/>
                  <a:pt x="1009522" y="962342"/>
                  <a:pt x="968270" y="964761"/>
                </a:cubicBezTo>
                <a:cubicBezTo>
                  <a:pt x="943437" y="973698"/>
                  <a:pt x="900136" y="991017"/>
                  <a:pt x="874493" y="998122"/>
                </a:cubicBezTo>
                <a:cubicBezTo>
                  <a:pt x="848849" y="1005226"/>
                  <a:pt x="853424" y="1009427"/>
                  <a:pt x="814411" y="1007391"/>
                </a:cubicBezTo>
                <a:cubicBezTo>
                  <a:pt x="765926" y="1022821"/>
                  <a:pt x="732885" y="1009859"/>
                  <a:pt x="688604" y="1015631"/>
                </a:cubicBezTo>
                <a:cubicBezTo>
                  <a:pt x="638045" y="1020877"/>
                  <a:pt x="677999" y="1011556"/>
                  <a:pt x="618171" y="1027260"/>
                </a:cubicBezTo>
                <a:cubicBezTo>
                  <a:pt x="609680" y="1023165"/>
                  <a:pt x="583253" y="1020277"/>
                  <a:pt x="570379" y="1023487"/>
                </a:cubicBezTo>
                <a:cubicBezTo>
                  <a:pt x="543992" y="1022523"/>
                  <a:pt x="505183" y="1001686"/>
                  <a:pt x="482519" y="1002108"/>
                </a:cubicBezTo>
                <a:cubicBezTo>
                  <a:pt x="464011" y="1002285"/>
                  <a:pt x="495211" y="1007995"/>
                  <a:pt x="475319" y="1009922"/>
                </a:cubicBezTo>
                <a:cubicBezTo>
                  <a:pt x="450818" y="1011135"/>
                  <a:pt x="454804" y="1022539"/>
                  <a:pt x="431104" y="1009317"/>
                </a:cubicBezTo>
                <a:cubicBezTo>
                  <a:pt x="406857" y="1014651"/>
                  <a:pt x="399686" y="1008456"/>
                  <a:pt x="363782" y="1007585"/>
                </a:cubicBezTo>
                <a:cubicBezTo>
                  <a:pt x="350440" y="1012231"/>
                  <a:pt x="338145" y="1011245"/>
                  <a:pt x="325533" y="1008502"/>
                </a:cubicBezTo>
                <a:cubicBezTo>
                  <a:pt x="291944" y="1011745"/>
                  <a:pt x="259251" y="1008497"/>
                  <a:pt x="220429" y="1008927"/>
                </a:cubicBezTo>
                <a:cubicBezTo>
                  <a:pt x="180594" y="1015852"/>
                  <a:pt x="156150" y="1007265"/>
                  <a:pt x="114676" y="1007765"/>
                </a:cubicBezTo>
                <a:cubicBezTo>
                  <a:pt x="85718" y="1006195"/>
                  <a:pt x="43316" y="1001491"/>
                  <a:pt x="13470" y="998544"/>
                </a:cubicBezTo>
                <a:lnTo>
                  <a:pt x="0" y="997355"/>
                </a:lnTo>
                <a:close/>
              </a:path>
            </a:pathLst>
          </a:custGeom>
          <a:solidFill>
            <a:srgbClr val="82766A">
              <a:alpha val="15000"/>
            </a:srgbClr>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pic>
        <p:nvPicPr>
          <p:cNvPr id="6" name="Picture 5" descr="A picture containing plant, flower&#10;&#10;Description automatically generated">
            <a:extLst>
              <a:ext uri="{FF2B5EF4-FFF2-40B4-BE49-F238E27FC236}">
                <a16:creationId xmlns:a16="http://schemas.microsoft.com/office/drawing/2014/main" id="{D26D43E2-91F7-E4A9-E2C1-FFB13EF30BB1}"/>
              </a:ext>
            </a:extLst>
          </p:cNvPr>
          <p:cNvPicPr>
            <a:picLocks noChangeAspect="1"/>
          </p:cNvPicPr>
          <p:nvPr/>
        </p:nvPicPr>
        <p:blipFill>
          <a:blip r:embed="rId3"/>
          <a:stretch>
            <a:fillRect/>
          </a:stretch>
        </p:blipFill>
        <p:spPr>
          <a:xfrm>
            <a:off x="6557244" y="1676400"/>
            <a:ext cx="4943475" cy="3505200"/>
          </a:xfrm>
          <a:prstGeom prst="rect">
            <a:avLst/>
          </a:prstGeom>
        </p:spPr>
      </p:pic>
      <p:sp>
        <p:nvSpPr>
          <p:cNvPr id="7" name="TextBox 3">
            <a:extLst>
              <a:ext uri="{FF2B5EF4-FFF2-40B4-BE49-F238E27FC236}">
                <a16:creationId xmlns:a16="http://schemas.microsoft.com/office/drawing/2014/main" id="{372CEA2E-CF8D-0BCE-4269-B4F0D5CCD608}"/>
              </a:ext>
            </a:extLst>
          </p:cNvPr>
          <p:cNvSpPr txBox="1"/>
          <p:nvPr/>
        </p:nvSpPr>
        <p:spPr>
          <a:xfrm>
            <a:off x="6641767" y="4904606"/>
            <a:ext cx="4289322"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a:solidFill>
                  <a:srgbClr val="E7E6E6"/>
                </a:solidFill>
                <a:ea typeface="Calibri"/>
                <a:cs typeface="Calibri"/>
              </a:rPr>
              <a:t>Image by Sherry Adkins, Author owned</a:t>
            </a:r>
            <a:endParaRPr lang="en-US">
              <a:solidFill>
                <a:srgbClr val="E7E6E6"/>
              </a:solidFill>
            </a:endParaRPr>
          </a:p>
        </p:txBody>
      </p:sp>
    </p:spTree>
    <p:extLst>
      <p:ext uri="{BB962C8B-B14F-4D97-AF65-F5344CB8AC3E}">
        <p14:creationId xmlns:p14="http://schemas.microsoft.com/office/powerpoint/2010/main" val="283092480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E591470-78E3-CA5B-5EBD-7179C4BD691C}"/>
              </a:ext>
            </a:extLst>
          </p:cNvPr>
          <p:cNvSpPr>
            <a:spLocks noGrp="1"/>
          </p:cNvSpPr>
          <p:nvPr>
            <p:ph idx="1"/>
          </p:nvPr>
        </p:nvSpPr>
        <p:spPr>
          <a:xfrm>
            <a:off x="5126418" y="552091"/>
            <a:ext cx="6224335" cy="5431536"/>
          </a:xfrm>
        </p:spPr>
        <p:txBody>
          <a:bodyPr vert="horz" lIns="91440" tIns="45720" rIns="91440" bIns="45720" rtlCol="0" anchor="ctr">
            <a:normAutofit/>
          </a:bodyPr>
          <a:lstStyle/>
          <a:p>
            <a:pPr marL="0" indent="0">
              <a:buNone/>
            </a:pPr>
            <a:r>
              <a:rPr lang="en-US" sz="2200" dirty="0">
                <a:ea typeface="+mn-lt"/>
                <a:cs typeface="+mn-lt"/>
              </a:rPr>
              <a:t>I am a healer, yet sometimes I do more harm than good...</a:t>
            </a:r>
          </a:p>
          <a:p>
            <a:pPr marL="0" indent="0">
              <a:buNone/>
            </a:pPr>
            <a:endParaRPr lang="en-US" sz="2200" dirty="0">
              <a:ea typeface="+mn-lt"/>
              <a:cs typeface="+mn-lt"/>
            </a:endParaRPr>
          </a:p>
          <a:p>
            <a:pPr marL="0" indent="0">
              <a:buNone/>
            </a:pPr>
            <a:r>
              <a:rPr lang="en-US" sz="2200" dirty="0">
                <a:ea typeface="+mn-lt"/>
                <a:cs typeface="+mn-lt"/>
              </a:rPr>
              <a:t>At some point we must all bring medical mistakes out of the closet. This will be difficult as long as both the profession and society continue to project their desires for perfection onto the doctor. </a:t>
            </a:r>
            <a:r>
              <a:rPr lang="en-US" sz="2200" i="1" dirty="0">
                <a:ea typeface="+mn-lt"/>
                <a:cs typeface="+mn-lt"/>
              </a:rPr>
              <a:t>Physicians need permission to admit errors. They need permission to share them with their patients. The practice of medicine is difficult enough without having to bear the yoke of perfection.</a:t>
            </a:r>
          </a:p>
          <a:p>
            <a:pPr marL="0" indent="0">
              <a:buNone/>
            </a:pPr>
            <a:endParaRPr lang="en-US" sz="2200" dirty="0">
              <a:cs typeface="Calibri"/>
            </a:endParaRPr>
          </a:p>
          <a:p>
            <a:pPr marL="0" indent="0">
              <a:buNone/>
            </a:pPr>
            <a:r>
              <a:rPr lang="en-US" sz="2200" dirty="0">
                <a:cs typeface="Calibri"/>
              </a:rPr>
              <a:t>David </a:t>
            </a:r>
            <a:r>
              <a:rPr lang="en-US" sz="2200" dirty="0" err="1">
                <a:cs typeface="Calibri"/>
              </a:rPr>
              <a:t>Hilfiker</a:t>
            </a:r>
            <a:endParaRPr lang="en-US" sz="2200" dirty="0">
              <a:cs typeface="Calibri"/>
            </a:endParaRPr>
          </a:p>
        </p:txBody>
      </p:sp>
      <p:sp>
        <p:nvSpPr>
          <p:cNvPr id="6" name="TextBox 5">
            <a:extLst>
              <a:ext uri="{FF2B5EF4-FFF2-40B4-BE49-F238E27FC236}">
                <a16:creationId xmlns:a16="http://schemas.microsoft.com/office/drawing/2014/main" id="{842ED925-2370-4EB3-818C-2C72069E540D}"/>
              </a:ext>
            </a:extLst>
          </p:cNvPr>
          <p:cNvSpPr txBox="1"/>
          <p:nvPr/>
        </p:nvSpPr>
        <p:spPr>
          <a:xfrm>
            <a:off x="5126418" y="6361471"/>
            <a:ext cx="6417374" cy="276999"/>
          </a:xfrm>
          <a:prstGeom prst="rect">
            <a:avLst/>
          </a:prstGeom>
          <a:noFill/>
        </p:spPr>
        <p:txBody>
          <a:bodyPr wrap="square" rtlCol="0">
            <a:spAutoFit/>
          </a:bodyPr>
          <a:lstStyle/>
          <a:p>
            <a:r>
              <a:rPr lang="en-US" sz="1200" dirty="0" err="1"/>
              <a:t>Hilfiker</a:t>
            </a:r>
            <a:r>
              <a:rPr lang="en-US" sz="1200" dirty="0"/>
              <a:t> D. Facing our mistakes. NEJM 1984; 310: 118-122. </a:t>
            </a:r>
          </a:p>
        </p:txBody>
      </p:sp>
    </p:spTree>
    <p:extLst>
      <p:ext uri="{BB962C8B-B14F-4D97-AF65-F5344CB8AC3E}">
        <p14:creationId xmlns:p14="http://schemas.microsoft.com/office/powerpoint/2010/main" val="79511055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95A37F6-B4A0-06EC-1CE3-FFA09F337BA6}"/>
              </a:ext>
            </a:extLst>
          </p:cNvPr>
          <p:cNvSpPr>
            <a:spLocks noGrp="1"/>
          </p:cNvSpPr>
          <p:nvPr>
            <p:ph type="title"/>
          </p:nvPr>
        </p:nvSpPr>
        <p:spPr>
          <a:xfrm>
            <a:off x="838200" y="365125"/>
            <a:ext cx="10515600" cy="1325563"/>
          </a:xfrm>
        </p:spPr>
        <p:txBody>
          <a:bodyPr>
            <a:normAutofit/>
          </a:bodyPr>
          <a:lstStyle/>
          <a:p>
            <a:r>
              <a:rPr lang="en-US" sz="5400" dirty="0">
                <a:cs typeface="Calibri Light"/>
              </a:rPr>
              <a:t>Resources</a:t>
            </a:r>
            <a:endParaRPr lang="en-US" sz="5400" dirty="0"/>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89E9CA7-6514-1DF9-5585-7A97DA025800}"/>
              </a:ext>
            </a:extLst>
          </p:cNvPr>
          <p:cNvSpPr>
            <a:spLocks noGrp="1"/>
          </p:cNvSpPr>
          <p:nvPr>
            <p:ph idx="1"/>
          </p:nvPr>
        </p:nvSpPr>
        <p:spPr>
          <a:xfrm>
            <a:off x="838200" y="1929384"/>
            <a:ext cx="10515600" cy="4251960"/>
          </a:xfrm>
        </p:spPr>
        <p:txBody>
          <a:bodyPr vert="horz" lIns="91440" tIns="45720" rIns="91440" bIns="45720" rtlCol="0" anchor="t">
            <a:normAutofit fontScale="85000" lnSpcReduction="20000"/>
          </a:bodyPr>
          <a:lstStyle/>
          <a:p>
            <a:r>
              <a:rPr lang="en-US" sz="1400" dirty="0">
                <a:cs typeface="Calibri"/>
              </a:rPr>
              <a:t>Stacy Flowers, PsyD (doctor of psychology), Kelly Rabah, </a:t>
            </a:r>
            <a:r>
              <a:rPr lang="en-US" sz="1400" dirty="0"/>
              <a:t>MSW CPHQ CPHRM SSGB (Director</a:t>
            </a:r>
            <a:r>
              <a:rPr lang="en-US" sz="1400" dirty="0">
                <a:ea typeface="+mn-lt"/>
                <a:cs typeface="+mn-lt"/>
              </a:rPr>
              <a:t> of Patient Safety &amp; Quality Improvement)</a:t>
            </a:r>
            <a:endParaRPr lang="en-US" sz="1400" dirty="0">
              <a:cs typeface="Calibri" panose="020F0502020204030204"/>
            </a:endParaRPr>
          </a:p>
          <a:p>
            <a:r>
              <a:rPr lang="en-US" sz="1400" dirty="0">
                <a:cs typeface="Calibri" panose="020F0502020204030204"/>
              </a:rPr>
              <a:t>Local algorithm/policies, mentors and peers</a:t>
            </a:r>
          </a:p>
          <a:p>
            <a:r>
              <a:rPr lang="en-US" sz="1400" dirty="0">
                <a:ea typeface="+mn-lt"/>
                <a:cs typeface="+mn-lt"/>
              </a:rPr>
              <a:t>Patient Safety Network Home | PSNet (ahrq.gov). https://psnet.ahrq.gov/</a:t>
            </a:r>
            <a:endParaRPr lang="en-US" sz="1400" dirty="0">
              <a:ea typeface="+mn-lt"/>
              <a:cs typeface="+mn-lt"/>
              <a:hlinkClick r:id="rId3"/>
            </a:endParaRPr>
          </a:p>
          <a:p>
            <a:r>
              <a:rPr lang="en-US" sz="1400" dirty="0">
                <a:ea typeface="+mn-lt"/>
                <a:cs typeface="+mn-lt"/>
              </a:rPr>
              <a:t>IHI Forum | IHI - Institute for Healthcare Improvement. https://www.ihi.org/education/Conferences/National-Forum/Pages/default.aspx?utm_campaign=us-6292022-all-forum2022-all-dmt-b--kt-text(sem)&amp;utm_content=link----inperson1&amp;utm_source=bing&amp;utm_medium=cpc&amp;utm_term=awareness--registernowv&amp;msclkid=73305f378ab11f90d4143dd25e468807</a:t>
            </a:r>
            <a:endParaRPr lang="en-US" sz="1400" dirty="0">
              <a:ea typeface="+mn-lt"/>
              <a:cs typeface="+mn-lt"/>
              <a:hlinkClick r:id="rId4"/>
            </a:endParaRPr>
          </a:p>
          <a:p>
            <a:r>
              <a:rPr lang="en-US" sz="1400" dirty="0">
                <a:ea typeface="+mn-lt"/>
                <a:cs typeface="+mn-lt"/>
              </a:rPr>
              <a:t>Getting it Right: Cases to Improve Diagnosis | Earn CME/MOC | ACP (acponline.org). https://www.acponline.org/cme-moc/online-learning-center/getting-it-right-cases-to-improve-diagnosis</a:t>
            </a:r>
            <a:endParaRPr lang="en-US" sz="1400" dirty="0">
              <a:ea typeface="+mn-lt"/>
              <a:cs typeface="+mn-lt"/>
              <a:hlinkClick r:id="rId5"/>
            </a:endParaRPr>
          </a:p>
          <a:p>
            <a:r>
              <a:rPr lang="en-US" sz="1400" dirty="0">
                <a:ea typeface="+mn-lt"/>
                <a:cs typeface="+mn-lt"/>
              </a:rPr>
              <a:t>Medical Error: A Case Based Approach to Apology and Disclosure Video - Brigham and Women's Hospital 2014. https://www.youtube.com/watch?v=3OsA0z7j4WM</a:t>
            </a:r>
          </a:p>
          <a:p>
            <a:r>
              <a:rPr lang="en-US" sz="1400" dirty="0">
                <a:ea typeface="+mn-lt"/>
                <a:cs typeface="+mn-lt"/>
              </a:rPr>
              <a:t>Root Cause Analysis - VHA National Center for Patient Safety (va.gov). https://www.patientsafety.va.gov/professionals/onthejob/rca.asp</a:t>
            </a:r>
            <a:endParaRPr lang="en-US" sz="1400" dirty="0">
              <a:ea typeface="+mn-lt"/>
              <a:cs typeface="+mn-lt"/>
              <a:hlinkClick r:id="rId6"/>
            </a:endParaRPr>
          </a:p>
          <a:p>
            <a:r>
              <a:rPr lang="en-US" sz="1400" dirty="0">
                <a:ea typeface="+mn-lt"/>
                <a:cs typeface="+mn-lt"/>
              </a:rPr>
              <a:t>Patient Safety Fellowship - The University of Toledo (utoledo.edu). https://www.utoledo.edu/med/fellowships/patient-safety/</a:t>
            </a:r>
          </a:p>
          <a:p>
            <a:r>
              <a:rPr lang="en-US" sz="1400" dirty="0">
                <a:ea typeface="+mn-lt"/>
                <a:cs typeface="+mn-lt"/>
              </a:rPr>
              <a:t>VA Patient Safety Fellowships - VHA National Center for Patient Safety. https://www.patientsafety.va.gov/professionals/training/fellows.asp</a:t>
            </a:r>
          </a:p>
          <a:p>
            <a:r>
              <a:rPr lang="en-US" sz="1400" dirty="0">
                <a:ea typeface="+mn-lt"/>
                <a:cs typeface="+mn-lt"/>
              </a:rPr>
              <a:t>Fischer MA, </a:t>
            </a:r>
            <a:r>
              <a:rPr lang="en-US" sz="1400" dirty="0" err="1">
                <a:ea typeface="+mn-lt"/>
                <a:cs typeface="+mn-lt"/>
              </a:rPr>
              <a:t>Mazor</a:t>
            </a:r>
            <a:r>
              <a:rPr lang="en-US" sz="1400" dirty="0">
                <a:ea typeface="+mn-lt"/>
                <a:cs typeface="+mn-lt"/>
              </a:rPr>
              <a:t> KM, </a:t>
            </a:r>
            <a:r>
              <a:rPr lang="en-US" sz="1400" dirty="0" err="1">
                <a:ea typeface="+mn-lt"/>
                <a:cs typeface="+mn-lt"/>
              </a:rPr>
              <a:t>Baril</a:t>
            </a:r>
            <a:r>
              <a:rPr lang="en-US" sz="1400" dirty="0">
                <a:ea typeface="+mn-lt"/>
                <a:cs typeface="+mn-lt"/>
              </a:rPr>
              <a:t> J, </a:t>
            </a:r>
            <a:r>
              <a:rPr lang="en-US" sz="1400" dirty="0" err="1">
                <a:ea typeface="+mn-lt"/>
                <a:cs typeface="+mn-lt"/>
              </a:rPr>
              <a:t>Alper</a:t>
            </a:r>
            <a:r>
              <a:rPr lang="en-US" sz="1400" dirty="0">
                <a:ea typeface="+mn-lt"/>
                <a:cs typeface="+mn-lt"/>
              </a:rPr>
              <a:t> E, DeMarco D, </a:t>
            </a:r>
            <a:r>
              <a:rPr lang="en-US" sz="1400" dirty="0" err="1">
                <a:ea typeface="+mn-lt"/>
                <a:cs typeface="+mn-lt"/>
              </a:rPr>
              <a:t>Pugnaire</a:t>
            </a:r>
            <a:r>
              <a:rPr lang="en-US" sz="1400" dirty="0">
                <a:ea typeface="+mn-lt"/>
                <a:cs typeface="+mn-lt"/>
              </a:rPr>
              <a:t> M. Learning from mistakes. Factors that influence how students and residents learn from medical errors. J Gen Intern Med. 2006 May;21(5):419-23.</a:t>
            </a:r>
          </a:p>
          <a:p>
            <a:r>
              <a:rPr lang="en-US" sz="1400" dirty="0">
                <a:ea typeface="+mn-lt"/>
                <a:cs typeface="+mn-lt"/>
              </a:rPr>
              <a:t>Hilfiker D. Facing our mistakes. NEJM 1984; 310: 118-122.</a:t>
            </a:r>
          </a:p>
          <a:p>
            <a:r>
              <a:rPr lang="en-US" sz="1400" dirty="0">
                <a:ea typeface="+mn-lt"/>
                <a:cs typeface="+mn-lt"/>
              </a:rPr>
              <a:t>Plews-Ogan M, May N, Owens J, </a:t>
            </a:r>
            <a:r>
              <a:rPr lang="en-US" sz="1400" dirty="0" err="1">
                <a:ea typeface="+mn-lt"/>
                <a:cs typeface="+mn-lt"/>
              </a:rPr>
              <a:t>Ardelt</a:t>
            </a:r>
            <a:r>
              <a:rPr lang="en-US" sz="1400" dirty="0">
                <a:ea typeface="+mn-lt"/>
                <a:cs typeface="+mn-lt"/>
              </a:rPr>
              <a:t> M, Shapiro J, Bell SK. Wisdom in Medicine: What Helps Physicians After a Medical Error? </a:t>
            </a:r>
            <a:r>
              <a:rPr lang="en-US" sz="1400" dirty="0" err="1">
                <a:ea typeface="+mn-lt"/>
                <a:cs typeface="+mn-lt"/>
              </a:rPr>
              <a:t>Acad</a:t>
            </a:r>
            <a:r>
              <a:rPr lang="en-US" sz="1400" dirty="0">
                <a:ea typeface="+mn-lt"/>
                <a:cs typeface="+mn-lt"/>
              </a:rPr>
              <a:t> Med. 2016 Feb</a:t>
            </a:r>
          </a:p>
          <a:p>
            <a:r>
              <a:rPr lang="en-US" sz="1400" dirty="0">
                <a:ea typeface="+mn-lt"/>
                <a:cs typeface="+mn-lt"/>
              </a:rPr>
              <a:t>Scott SD, </a:t>
            </a:r>
            <a:r>
              <a:rPr lang="en-US" sz="1400" dirty="0" err="1">
                <a:ea typeface="+mn-lt"/>
                <a:cs typeface="+mn-lt"/>
              </a:rPr>
              <a:t>Hirschinger</a:t>
            </a:r>
            <a:r>
              <a:rPr lang="en-US" sz="1400" dirty="0">
                <a:ea typeface="+mn-lt"/>
                <a:cs typeface="+mn-lt"/>
              </a:rPr>
              <a:t> LE, Cox KR, </a:t>
            </a:r>
            <a:r>
              <a:rPr lang="en-US" sz="1400" dirty="0" err="1">
                <a:ea typeface="+mn-lt"/>
                <a:cs typeface="+mn-lt"/>
              </a:rPr>
              <a:t>McCoig</a:t>
            </a:r>
            <a:r>
              <a:rPr lang="en-US" sz="1400" dirty="0">
                <a:ea typeface="+mn-lt"/>
                <a:cs typeface="+mn-lt"/>
              </a:rPr>
              <a:t> M, Brandt J, Hall LW. The natural history of recovery for the healthcare provider "second victim" after adverse patient events. Qual </a:t>
            </a:r>
            <a:r>
              <a:rPr lang="en-US" sz="1400" dirty="0" err="1">
                <a:ea typeface="+mn-lt"/>
                <a:cs typeface="+mn-lt"/>
              </a:rPr>
              <a:t>Saf</a:t>
            </a:r>
            <a:r>
              <a:rPr lang="en-US" sz="1400" dirty="0">
                <a:ea typeface="+mn-lt"/>
                <a:cs typeface="+mn-lt"/>
              </a:rPr>
              <a:t> Health Care. 2009 Oct;18(5):325-30. </a:t>
            </a:r>
          </a:p>
          <a:p>
            <a:r>
              <a:rPr lang="en-US" sz="1400" dirty="0">
                <a:ea typeface="+mn-lt"/>
                <a:cs typeface="+mn-lt"/>
              </a:rPr>
              <a:t>Integrative Health Teaching Modules &amp; Handouts - Clinician and Patient Education (wisc.edu). https://www.fammed.wisc.edu/integrative/resources/modules/</a:t>
            </a:r>
            <a:endParaRPr lang="en-US" sz="1400" dirty="0">
              <a:ea typeface="Calibri" panose="020F0502020204030204"/>
              <a:cs typeface="Calibri"/>
            </a:endParaRPr>
          </a:p>
        </p:txBody>
      </p:sp>
    </p:spTree>
    <p:extLst>
      <p:ext uri="{BB962C8B-B14F-4D97-AF65-F5344CB8AC3E}">
        <p14:creationId xmlns:p14="http://schemas.microsoft.com/office/powerpoint/2010/main" val="16880329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6"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CC610C1-D6A0-4D44-9C46-C40ED8156CE9}"/>
              </a:ext>
            </a:extLst>
          </p:cNvPr>
          <p:cNvSpPr>
            <a:spLocks noGrp="1"/>
          </p:cNvSpPr>
          <p:nvPr>
            <p:ph type="title"/>
          </p:nvPr>
        </p:nvSpPr>
        <p:spPr>
          <a:xfrm>
            <a:off x="635000" y="640823"/>
            <a:ext cx="3418659" cy="5583148"/>
          </a:xfrm>
        </p:spPr>
        <p:txBody>
          <a:bodyPr anchor="ctr">
            <a:normAutofit/>
          </a:bodyPr>
          <a:lstStyle/>
          <a:p>
            <a:r>
              <a:rPr lang="en-US" sz="5400"/>
              <a:t>Facts?</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7" name="Content Placeholder 2">
            <a:extLst>
              <a:ext uri="{FF2B5EF4-FFF2-40B4-BE49-F238E27FC236}">
                <a16:creationId xmlns:a16="http://schemas.microsoft.com/office/drawing/2014/main" id="{156A0906-41A0-8555-B59C-C39B77B947B0}"/>
              </a:ext>
            </a:extLst>
          </p:cNvPr>
          <p:cNvGraphicFramePr>
            <a:graphicFrameLocks noGrp="1"/>
          </p:cNvGraphicFramePr>
          <p:nvPr>
            <p:ph idx="1"/>
            <p:extLst>
              <p:ext uri="{D42A27DB-BD31-4B8C-83A1-F6EECF244321}">
                <p14:modId xmlns:p14="http://schemas.microsoft.com/office/powerpoint/2010/main" val="2025058760"/>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340321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9">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60841FF-E541-4661-8722-782595F3F7A7}"/>
              </a:ext>
            </a:extLst>
          </p:cNvPr>
          <p:cNvSpPr>
            <a:spLocks noGrp="1"/>
          </p:cNvSpPr>
          <p:nvPr>
            <p:ph type="title"/>
          </p:nvPr>
        </p:nvSpPr>
        <p:spPr>
          <a:xfrm>
            <a:off x="635000" y="640823"/>
            <a:ext cx="3418659" cy="5583148"/>
          </a:xfrm>
        </p:spPr>
        <p:txBody>
          <a:bodyPr anchor="ctr">
            <a:normAutofit/>
          </a:bodyPr>
          <a:lstStyle/>
          <a:p>
            <a:r>
              <a:rPr lang="en-US" sz="5400"/>
              <a:t>Local policies related to error</a:t>
            </a:r>
          </a:p>
        </p:txBody>
      </p:sp>
      <p:sp>
        <p:nvSpPr>
          <p:cNvPr id="8"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032E14EF-4141-DE29-F741-0040BD9E4401}"/>
              </a:ext>
            </a:extLst>
          </p:cNvPr>
          <p:cNvGraphicFramePr>
            <a:graphicFrameLocks noGrp="1"/>
          </p:cNvGraphicFramePr>
          <p:nvPr>
            <p:ph idx="1"/>
            <p:extLst>
              <p:ext uri="{D42A27DB-BD31-4B8C-83A1-F6EECF244321}">
                <p14:modId xmlns:p14="http://schemas.microsoft.com/office/powerpoint/2010/main" val="2935288101"/>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736448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0841FF-E541-4661-8722-782595F3F7A7}"/>
              </a:ext>
            </a:extLst>
          </p:cNvPr>
          <p:cNvSpPr>
            <a:spLocks noGrp="1"/>
          </p:cNvSpPr>
          <p:nvPr>
            <p:ph type="title"/>
          </p:nvPr>
        </p:nvSpPr>
        <p:spPr/>
        <p:txBody>
          <a:bodyPr/>
          <a:lstStyle/>
          <a:p>
            <a:r>
              <a:rPr lang="en-US"/>
              <a:t>Local policies ...</a:t>
            </a:r>
          </a:p>
        </p:txBody>
      </p:sp>
      <p:sp>
        <p:nvSpPr>
          <p:cNvPr id="3" name="Content Placeholder 2">
            <a:extLst>
              <a:ext uri="{FF2B5EF4-FFF2-40B4-BE49-F238E27FC236}">
                <a16:creationId xmlns:a16="http://schemas.microsoft.com/office/drawing/2014/main" id="{DFC27EF1-E2B6-4947-9096-799B25D40B1B}"/>
              </a:ext>
            </a:extLst>
          </p:cNvPr>
          <p:cNvSpPr>
            <a:spLocks noGrp="1"/>
          </p:cNvSpPr>
          <p:nvPr>
            <p:ph idx="1"/>
          </p:nvPr>
        </p:nvSpPr>
        <p:spPr/>
        <p:txBody>
          <a:bodyPr vert="horz" lIns="91440" tIns="45720" rIns="91440" bIns="45720" rtlCol="0" anchor="t">
            <a:normAutofit/>
          </a:bodyPr>
          <a:lstStyle/>
          <a:p>
            <a:endParaRPr lang="en-US">
              <a:cs typeface="Calibri"/>
            </a:endParaRPr>
          </a:p>
          <a:p>
            <a:endParaRPr lang="en-US"/>
          </a:p>
          <a:p>
            <a:endParaRPr lang="en-US">
              <a:cs typeface="Calibri"/>
            </a:endParaRPr>
          </a:p>
          <a:p>
            <a:pPr marL="0" indent="0">
              <a:buNone/>
            </a:pPr>
            <a:endParaRPr lang="en-US">
              <a:cs typeface="Calibri"/>
            </a:endParaRPr>
          </a:p>
        </p:txBody>
      </p:sp>
      <p:graphicFrame>
        <p:nvGraphicFramePr>
          <p:cNvPr id="5" name="Table 4">
            <a:extLst>
              <a:ext uri="{FF2B5EF4-FFF2-40B4-BE49-F238E27FC236}">
                <a16:creationId xmlns:a16="http://schemas.microsoft.com/office/drawing/2014/main" id="{BCF9D60E-535F-6DC2-BB28-B3888308394B}"/>
              </a:ext>
            </a:extLst>
          </p:cNvPr>
          <p:cNvGraphicFramePr>
            <a:graphicFrameLocks noGrp="1"/>
          </p:cNvGraphicFramePr>
          <p:nvPr>
            <p:extLst>
              <p:ext uri="{D42A27DB-BD31-4B8C-83A1-F6EECF244321}">
                <p14:modId xmlns:p14="http://schemas.microsoft.com/office/powerpoint/2010/main" val="3030545625"/>
              </p:ext>
            </p:extLst>
          </p:nvPr>
        </p:nvGraphicFramePr>
        <p:xfrm>
          <a:off x="910166" y="1651000"/>
          <a:ext cx="9598745" cy="2479294"/>
        </p:xfrm>
        <a:graphic>
          <a:graphicData uri="http://schemas.openxmlformats.org/drawingml/2006/table">
            <a:tbl>
              <a:tblPr firstRow="1" bandRow="1">
                <a:tableStyleId>{5C22544A-7EE6-4342-B048-85BDC9FD1C3A}</a:tableStyleId>
              </a:tblPr>
              <a:tblGrid>
                <a:gridCol w="1789137">
                  <a:extLst>
                    <a:ext uri="{9D8B030D-6E8A-4147-A177-3AD203B41FA5}">
                      <a16:colId xmlns:a16="http://schemas.microsoft.com/office/drawing/2014/main" val="252959959"/>
                    </a:ext>
                  </a:extLst>
                </a:gridCol>
                <a:gridCol w="1789137">
                  <a:extLst>
                    <a:ext uri="{9D8B030D-6E8A-4147-A177-3AD203B41FA5}">
                      <a16:colId xmlns:a16="http://schemas.microsoft.com/office/drawing/2014/main" val="3365324304"/>
                    </a:ext>
                  </a:extLst>
                </a:gridCol>
                <a:gridCol w="1789137">
                  <a:extLst>
                    <a:ext uri="{9D8B030D-6E8A-4147-A177-3AD203B41FA5}">
                      <a16:colId xmlns:a16="http://schemas.microsoft.com/office/drawing/2014/main" val="1586860171"/>
                    </a:ext>
                  </a:extLst>
                </a:gridCol>
                <a:gridCol w="1789137">
                  <a:extLst>
                    <a:ext uri="{9D8B030D-6E8A-4147-A177-3AD203B41FA5}">
                      <a16:colId xmlns:a16="http://schemas.microsoft.com/office/drawing/2014/main" val="2148620603"/>
                    </a:ext>
                  </a:extLst>
                </a:gridCol>
                <a:gridCol w="1789137">
                  <a:extLst>
                    <a:ext uri="{9D8B030D-6E8A-4147-A177-3AD203B41FA5}">
                      <a16:colId xmlns:a16="http://schemas.microsoft.com/office/drawing/2014/main" val="4057141560"/>
                    </a:ext>
                  </a:extLst>
                </a:gridCol>
                <a:gridCol w="653060">
                  <a:extLst>
                    <a:ext uri="{9D8B030D-6E8A-4147-A177-3AD203B41FA5}">
                      <a16:colId xmlns:a16="http://schemas.microsoft.com/office/drawing/2014/main" val="3615006504"/>
                    </a:ext>
                  </a:extLst>
                </a:gridCol>
              </a:tblGrid>
              <a:tr h="740568">
                <a:tc>
                  <a:txBody>
                    <a:bodyPr/>
                    <a:lstStyle/>
                    <a:p>
                      <a:endParaRPr lang="en-US">
                        <a:effectLst/>
                      </a:endParaRPr>
                    </a:p>
                  </a:txBody>
                  <a:tcPr marL="0" marR="0" marT="0" marB="0" anchor="ctr"/>
                </a:tc>
                <a:tc>
                  <a:txBody>
                    <a:bodyPr/>
                    <a:lstStyle/>
                    <a:p>
                      <a:r>
                        <a:rPr lang="en-US" dirty="0">
                          <a:effectLst/>
                        </a:rPr>
                        <a:t>Error/quality improvement</a:t>
                      </a:r>
                    </a:p>
                  </a:txBody>
                  <a:tcPr marL="0" marR="0" marT="0" marB="0" anchor="ctr"/>
                </a:tc>
                <a:tc>
                  <a:txBody>
                    <a:bodyPr/>
                    <a:lstStyle/>
                    <a:p>
                      <a:r>
                        <a:rPr lang="en-US" dirty="0">
                          <a:effectLst/>
                        </a:rPr>
                        <a:t>Patient disclosure</a:t>
                      </a:r>
                    </a:p>
                  </a:txBody>
                  <a:tcPr marL="0" marR="0" marT="0" marB="0" anchor="ctr"/>
                </a:tc>
                <a:tc>
                  <a:txBody>
                    <a:bodyPr/>
                    <a:lstStyle/>
                    <a:p>
                      <a:r>
                        <a:rPr lang="en-US" dirty="0">
                          <a:effectLst/>
                        </a:rPr>
                        <a:t>Physician support</a:t>
                      </a:r>
                    </a:p>
                  </a:txBody>
                  <a:tcPr marL="0" marR="0" marT="0" marB="0" anchor="ctr"/>
                </a:tc>
                <a:tc>
                  <a:txBody>
                    <a:bodyPr/>
                    <a:lstStyle/>
                    <a:p>
                      <a:r>
                        <a:rPr lang="en-US" dirty="0">
                          <a:effectLst/>
                        </a:rPr>
                        <a:t>Risk management</a:t>
                      </a:r>
                    </a:p>
                  </a:txBody>
                  <a:tcPr marL="0" marR="0" marT="0" marB="0" anchor="ctr"/>
                </a:tc>
                <a:tc>
                  <a:txBody>
                    <a:bodyPr/>
                    <a:lstStyle/>
                    <a:p>
                      <a:endParaRPr lang="en-US"/>
                    </a:p>
                  </a:txBody>
                  <a:tcPr/>
                </a:tc>
                <a:extLst>
                  <a:ext uri="{0D108BD9-81ED-4DB2-BD59-A6C34878D82A}">
                    <a16:rowId xmlns:a16="http://schemas.microsoft.com/office/drawing/2014/main" val="2076595970"/>
                  </a:ext>
                </a:extLst>
              </a:tr>
              <a:tr h="370284">
                <a:tc>
                  <a:txBody>
                    <a:bodyPr/>
                    <a:lstStyle/>
                    <a:p>
                      <a:r>
                        <a:rPr lang="en-US" dirty="0">
                          <a:effectLst/>
                        </a:rPr>
                        <a:t>Sponsoring GME</a:t>
                      </a:r>
                    </a:p>
                  </a:txBody>
                  <a:tcPr marL="0" marR="0" marT="0" marB="0" anchor="ctr"/>
                </a:tc>
                <a:tc>
                  <a:txBody>
                    <a:bodyPr/>
                    <a:lstStyle/>
                    <a:p>
                      <a:pPr lvl="0">
                        <a:buNone/>
                      </a:pPr>
                      <a:r>
                        <a:rPr lang="en-US" dirty="0">
                          <a:effectLst/>
                        </a:rPr>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endParaRPr lang="en-US"/>
                    </a:p>
                  </a:txBody>
                  <a:tcPr marL="0" marR="0" marT="0" marB="0" anchor="ctr"/>
                </a:tc>
                <a:extLst>
                  <a:ext uri="{0D108BD9-81ED-4DB2-BD59-A6C34878D82A}">
                    <a16:rowId xmlns:a16="http://schemas.microsoft.com/office/drawing/2014/main" val="2094922184"/>
                  </a:ext>
                </a:extLst>
              </a:tr>
              <a:tr h="499079">
                <a:tc>
                  <a:txBody>
                    <a:bodyPr/>
                    <a:lstStyle/>
                    <a:p>
                      <a:r>
                        <a:rPr lang="en-US" dirty="0">
                          <a:effectLst/>
                        </a:rPr>
                        <a:t>Family practice</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endParaRPr lang="en-US"/>
                    </a:p>
                  </a:txBody>
                  <a:tcPr/>
                </a:tc>
                <a:extLst>
                  <a:ext uri="{0D108BD9-81ED-4DB2-BD59-A6C34878D82A}">
                    <a16:rowId xmlns:a16="http://schemas.microsoft.com/office/drawing/2014/main" val="2769615493"/>
                  </a:ext>
                </a:extLst>
              </a:tr>
              <a:tr h="499079">
                <a:tc>
                  <a:txBody>
                    <a:bodyPr/>
                    <a:lstStyle/>
                    <a:p>
                      <a:r>
                        <a:rPr lang="en-US" dirty="0">
                          <a:effectLst/>
                        </a:rPr>
                        <a:t>Hospital</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endParaRPr lang="en-US"/>
                    </a:p>
                  </a:txBody>
                  <a:tcPr/>
                </a:tc>
                <a:extLst>
                  <a:ext uri="{0D108BD9-81ED-4DB2-BD59-A6C34878D82A}">
                    <a16:rowId xmlns:a16="http://schemas.microsoft.com/office/drawing/2014/main" val="1638548211"/>
                  </a:ext>
                </a:extLst>
              </a:tr>
              <a:tr h="370284">
                <a:tc>
                  <a:txBody>
                    <a:bodyPr/>
                    <a:lstStyle/>
                    <a:p>
                      <a:r>
                        <a:rPr lang="en-US" dirty="0">
                          <a:effectLst/>
                        </a:rPr>
                        <a:t>Childrens Hospital</a:t>
                      </a:r>
                    </a:p>
                  </a:txBody>
                  <a:tcPr marL="0" marR="0" marT="0" marB="0" anchor="ctr"/>
                </a:tc>
                <a:tc>
                  <a:txBody>
                    <a:bodyPr/>
                    <a:lstStyle/>
                    <a:p>
                      <a:pPr lvl="0">
                        <a:buNone/>
                      </a:pPr>
                      <a:r>
                        <a:rPr lang="en-US" dirty="0">
                          <a:effectLst/>
                        </a:rPr>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r>
                        <a:rPr lang="en-US" dirty="0"/>
                        <a:t>?</a:t>
                      </a:r>
                    </a:p>
                  </a:txBody>
                  <a:tcPr marL="0" marR="0" marT="0" marB="0" anchor="ctr"/>
                </a:tc>
                <a:tc>
                  <a:txBody>
                    <a:bodyPr/>
                    <a:lstStyle/>
                    <a:p>
                      <a:endParaRPr lang="en-US" dirty="0"/>
                    </a:p>
                  </a:txBody>
                  <a:tcPr marL="0" marR="0" marT="0" marB="0" anchor="ctr"/>
                </a:tc>
                <a:extLst>
                  <a:ext uri="{0D108BD9-81ED-4DB2-BD59-A6C34878D82A}">
                    <a16:rowId xmlns:a16="http://schemas.microsoft.com/office/drawing/2014/main" val="1618670021"/>
                  </a:ext>
                </a:extLst>
              </a:tr>
            </a:tbl>
          </a:graphicData>
        </a:graphic>
      </p:graphicFrame>
    </p:spTree>
    <p:extLst>
      <p:ext uri="{BB962C8B-B14F-4D97-AF65-F5344CB8AC3E}">
        <p14:creationId xmlns:p14="http://schemas.microsoft.com/office/powerpoint/2010/main" val="22041503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743AA782-23D1-4521-8CAD-47662984AA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60841FF-E541-4661-8722-782595F3F7A7}"/>
              </a:ext>
            </a:extLst>
          </p:cNvPr>
          <p:cNvSpPr>
            <a:spLocks noGrp="1"/>
          </p:cNvSpPr>
          <p:nvPr>
            <p:ph type="title"/>
          </p:nvPr>
        </p:nvSpPr>
        <p:spPr>
          <a:xfrm>
            <a:off x="630936" y="640080"/>
            <a:ext cx="4818888" cy="1481328"/>
          </a:xfrm>
        </p:spPr>
        <p:txBody>
          <a:bodyPr anchor="b">
            <a:normAutofit/>
          </a:bodyPr>
          <a:lstStyle/>
          <a:p>
            <a:r>
              <a:rPr lang="en-US" sz="5000"/>
              <a:t>Local practices related to error</a:t>
            </a:r>
          </a:p>
        </p:txBody>
      </p:sp>
      <p:sp>
        <p:nvSpPr>
          <p:cNvPr id="21" name="sketch line">
            <a:extLst>
              <a:ext uri="{FF2B5EF4-FFF2-40B4-BE49-F238E27FC236}">
                <a16:creationId xmlns:a16="http://schemas.microsoft.com/office/drawing/2014/main" id="{650D18FE-0824-4A46-B22C-A86B52E5780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2372868"/>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032E14EF-4141-DE29-F741-0040BD9E4401}"/>
              </a:ext>
            </a:extLst>
          </p:cNvPr>
          <p:cNvGraphicFramePr>
            <a:graphicFrameLocks noGrp="1"/>
          </p:cNvGraphicFramePr>
          <p:nvPr>
            <p:ph idx="1"/>
            <p:extLst>
              <p:ext uri="{D42A27DB-BD31-4B8C-83A1-F6EECF244321}">
                <p14:modId xmlns:p14="http://schemas.microsoft.com/office/powerpoint/2010/main" val="484550172"/>
              </p:ext>
            </p:extLst>
          </p:nvPr>
        </p:nvGraphicFramePr>
        <p:xfrm>
          <a:off x="630936" y="2660904"/>
          <a:ext cx="4818888" cy="354787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233232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4" name="Rectangle 9">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60841FF-E541-4661-8722-782595F3F7A7}"/>
              </a:ext>
            </a:extLst>
          </p:cNvPr>
          <p:cNvSpPr>
            <a:spLocks noGrp="1"/>
          </p:cNvSpPr>
          <p:nvPr>
            <p:ph type="title"/>
          </p:nvPr>
        </p:nvSpPr>
        <p:spPr>
          <a:xfrm>
            <a:off x="838200" y="557188"/>
            <a:ext cx="10515600" cy="1133499"/>
          </a:xfrm>
        </p:spPr>
        <p:txBody>
          <a:bodyPr>
            <a:normAutofit/>
          </a:bodyPr>
          <a:lstStyle/>
          <a:p>
            <a:pPr algn="ctr"/>
            <a:r>
              <a:rPr lang="en-US" sz="5200"/>
              <a:t>Local practices related to error</a:t>
            </a:r>
          </a:p>
        </p:txBody>
      </p:sp>
      <p:graphicFrame>
        <p:nvGraphicFramePr>
          <p:cNvPr id="5" name="Content Placeholder 2">
            <a:extLst>
              <a:ext uri="{FF2B5EF4-FFF2-40B4-BE49-F238E27FC236}">
                <a16:creationId xmlns:a16="http://schemas.microsoft.com/office/drawing/2014/main" id="{032E14EF-4141-DE29-F741-0040BD9E4401}"/>
              </a:ext>
            </a:extLst>
          </p:cNvPr>
          <p:cNvGraphicFramePr>
            <a:graphicFrameLocks noGrp="1"/>
          </p:cNvGraphicFramePr>
          <p:nvPr>
            <p:ph idx="1"/>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887490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9">
            <a:extLst>
              <a:ext uri="{FF2B5EF4-FFF2-40B4-BE49-F238E27FC236}">
                <a16:creationId xmlns:a16="http://schemas.microsoft.com/office/drawing/2014/main" id="{352BEC0E-22F8-46D0-9632-375DB541B06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60841FF-E541-4661-8722-782595F3F7A7}"/>
              </a:ext>
            </a:extLst>
          </p:cNvPr>
          <p:cNvSpPr>
            <a:spLocks noGrp="1"/>
          </p:cNvSpPr>
          <p:nvPr>
            <p:ph type="title"/>
          </p:nvPr>
        </p:nvSpPr>
        <p:spPr>
          <a:xfrm>
            <a:off x="640080" y="329184"/>
            <a:ext cx="6894576" cy="1783080"/>
          </a:xfrm>
        </p:spPr>
        <p:txBody>
          <a:bodyPr anchor="b">
            <a:normAutofit/>
          </a:bodyPr>
          <a:lstStyle/>
          <a:p>
            <a:r>
              <a:rPr lang="en-US" sz="5400"/>
              <a:t>People at rotation sites</a:t>
            </a:r>
          </a:p>
        </p:txBody>
      </p:sp>
      <p:sp>
        <p:nvSpPr>
          <p:cNvPr id="11" name="sketch line">
            <a:extLst>
              <a:ext uri="{FF2B5EF4-FFF2-40B4-BE49-F238E27FC236}">
                <a16:creationId xmlns:a16="http://schemas.microsoft.com/office/drawing/2014/main" id="{3FCFB1DE-0B7E-48CC-BA90-B2AB0889F9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8952" y="2395728"/>
            <a:ext cx="4243589" cy="18288"/>
          </a:xfrm>
          <a:custGeom>
            <a:avLst/>
            <a:gdLst>
              <a:gd name="connsiteX0" fmla="*/ 0 w 4243589"/>
              <a:gd name="connsiteY0" fmla="*/ 0 h 18288"/>
              <a:gd name="connsiteX1" fmla="*/ 478919 w 4243589"/>
              <a:gd name="connsiteY1" fmla="*/ 0 h 18288"/>
              <a:gd name="connsiteX2" fmla="*/ 957839 w 4243589"/>
              <a:gd name="connsiteY2" fmla="*/ 0 h 18288"/>
              <a:gd name="connsiteX3" fmla="*/ 1521630 w 4243589"/>
              <a:gd name="connsiteY3" fmla="*/ 0 h 18288"/>
              <a:gd name="connsiteX4" fmla="*/ 2212729 w 4243589"/>
              <a:gd name="connsiteY4" fmla="*/ 0 h 18288"/>
              <a:gd name="connsiteX5" fmla="*/ 2734084 w 4243589"/>
              <a:gd name="connsiteY5" fmla="*/ 0 h 18288"/>
              <a:gd name="connsiteX6" fmla="*/ 3255439 w 4243589"/>
              <a:gd name="connsiteY6" fmla="*/ 0 h 18288"/>
              <a:gd name="connsiteX7" fmla="*/ 4243589 w 4243589"/>
              <a:gd name="connsiteY7" fmla="*/ 0 h 18288"/>
              <a:gd name="connsiteX8" fmla="*/ 4243589 w 4243589"/>
              <a:gd name="connsiteY8" fmla="*/ 18288 h 18288"/>
              <a:gd name="connsiteX9" fmla="*/ 3594926 w 4243589"/>
              <a:gd name="connsiteY9" fmla="*/ 18288 h 18288"/>
              <a:gd name="connsiteX10" fmla="*/ 3073571 w 4243589"/>
              <a:gd name="connsiteY10" fmla="*/ 18288 h 18288"/>
              <a:gd name="connsiteX11" fmla="*/ 2552216 w 4243589"/>
              <a:gd name="connsiteY11" fmla="*/ 18288 h 18288"/>
              <a:gd name="connsiteX12" fmla="*/ 1903553 w 4243589"/>
              <a:gd name="connsiteY12" fmla="*/ 18288 h 18288"/>
              <a:gd name="connsiteX13" fmla="*/ 1212454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213395" y="-21006"/>
                  <a:pt x="307421" y="-18116"/>
                  <a:pt x="478919" y="0"/>
                </a:cubicBezTo>
                <a:cubicBezTo>
                  <a:pt x="650417" y="18116"/>
                  <a:pt x="831092" y="-21237"/>
                  <a:pt x="957839" y="0"/>
                </a:cubicBezTo>
                <a:cubicBezTo>
                  <a:pt x="1084586" y="21237"/>
                  <a:pt x="1301682" y="25124"/>
                  <a:pt x="1521630" y="0"/>
                </a:cubicBezTo>
                <a:cubicBezTo>
                  <a:pt x="1741578" y="-25124"/>
                  <a:pt x="1970269" y="-29139"/>
                  <a:pt x="2212729" y="0"/>
                </a:cubicBezTo>
                <a:cubicBezTo>
                  <a:pt x="2455189" y="29139"/>
                  <a:pt x="2558847" y="-4796"/>
                  <a:pt x="2734084" y="0"/>
                </a:cubicBezTo>
                <a:cubicBezTo>
                  <a:pt x="2909321" y="4796"/>
                  <a:pt x="3097217" y="-13409"/>
                  <a:pt x="3255439" y="0"/>
                </a:cubicBezTo>
                <a:cubicBezTo>
                  <a:pt x="3413662" y="13409"/>
                  <a:pt x="3979999" y="-10121"/>
                  <a:pt x="4243589" y="0"/>
                </a:cubicBezTo>
                <a:cubicBezTo>
                  <a:pt x="4244484" y="8974"/>
                  <a:pt x="4243043" y="9359"/>
                  <a:pt x="4243589" y="18288"/>
                </a:cubicBezTo>
                <a:cubicBezTo>
                  <a:pt x="4058777" y="31246"/>
                  <a:pt x="3910348" y="3158"/>
                  <a:pt x="3594926" y="18288"/>
                </a:cubicBezTo>
                <a:cubicBezTo>
                  <a:pt x="3279504" y="33418"/>
                  <a:pt x="3319955" y="-3977"/>
                  <a:pt x="3073571" y="18288"/>
                </a:cubicBezTo>
                <a:cubicBezTo>
                  <a:pt x="2827187" y="40553"/>
                  <a:pt x="2767387" y="1863"/>
                  <a:pt x="2552216" y="18288"/>
                </a:cubicBezTo>
                <a:cubicBezTo>
                  <a:pt x="2337046" y="34713"/>
                  <a:pt x="2181871" y="19527"/>
                  <a:pt x="1903553" y="18288"/>
                </a:cubicBezTo>
                <a:cubicBezTo>
                  <a:pt x="1625235" y="17049"/>
                  <a:pt x="1557672" y="24174"/>
                  <a:pt x="1212454" y="18288"/>
                </a:cubicBezTo>
                <a:cubicBezTo>
                  <a:pt x="867236" y="12402"/>
                  <a:pt x="874382" y="15627"/>
                  <a:pt x="733535" y="18288"/>
                </a:cubicBezTo>
                <a:cubicBezTo>
                  <a:pt x="592688" y="20949"/>
                  <a:pt x="183477" y="14753"/>
                  <a:pt x="0" y="18288"/>
                </a:cubicBezTo>
                <a:cubicBezTo>
                  <a:pt x="-229" y="14222"/>
                  <a:pt x="509" y="5816"/>
                  <a:pt x="0" y="0"/>
                </a:cubicBezTo>
                <a:close/>
              </a:path>
              <a:path w="4243589" h="18288" stroke="0" extrusionOk="0">
                <a:moveTo>
                  <a:pt x="0" y="0"/>
                </a:moveTo>
                <a:cubicBezTo>
                  <a:pt x="143690" y="16630"/>
                  <a:pt x="266667" y="14847"/>
                  <a:pt x="521355" y="0"/>
                </a:cubicBezTo>
                <a:cubicBezTo>
                  <a:pt x="776043" y="-14847"/>
                  <a:pt x="814491" y="-17363"/>
                  <a:pt x="1000275" y="0"/>
                </a:cubicBezTo>
                <a:cubicBezTo>
                  <a:pt x="1186059" y="17363"/>
                  <a:pt x="1352504" y="-23507"/>
                  <a:pt x="1521630" y="0"/>
                </a:cubicBezTo>
                <a:cubicBezTo>
                  <a:pt x="1690756" y="23507"/>
                  <a:pt x="1889525" y="5871"/>
                  <a:pt x="2127857" y="0"/>
                </a:cubicBezTo>
                <a:cubicBezTo>
                  <a:pt x="2366189" y="-5871"/>
                  <a:pt x="2620628" y="-27997"/>
                  <a:pt x="2776520" y="0"/>
                </a:cubicBezTo>
                <a:cubicBezTo>
                  <a:pt x="2932412" y="27997"/>
                  <a:pt x="3131683" y="-25073"/>
                  <a:pt x="3467618" y="0"/>
                </a:cubicBezTo>
                <a:cubicBezTo>
                  <a:pt x="3803553" y="25073"/>
                  <a:pt x="4017371" y="3071"/>
                  <a:pt x="4243589" y="0"/>
                </a:cubicBezTo>
                <a:cubicBezTo>
                  <a:pt x="4243134" y="6162"/>
                  <a:pt x="4243492" y="11775"/>
                  <a:pt x="4243589" y="18288"/>
                </a:cubicBezTo>
                <a:cubicBezTo>
                  <a:pt x="4017834" y="-5779"/>
                  <a:pt x="3834586" y="13376"/>
                  <a:pt x="3594926" y="18288"/>
                </a:cubicBezTo>
                <a:cubicBezTo>
                  <a:pt x="3355266" y="23200"/>
                  <a:pt x="3204179" y="2869"/>
                  <a:pt x="2903827" y="18288"/>
                </a:cubicBezTo>
                <a:cubicBezTo>
                  <a:pt x="2603475" y="33707"/>
                  <a:pt x="2526187" y="46187"/>
                  <a:pt x="2212729" y="18288"/>
                </a:cubicBezTo>
                <a:cubicBezTo>
                  <a:pt x="1899271" y="-9611"/>
                  <a:pt x="1966289" y="29692"/>
                  <a:pt x="1733809" y="18288"/>
                </a:cubicBezTo>
                <a:cubicBezTo>
                  <a:pt x="1501329" y="6884"/>
                  <a:pt x="1343612" y="12492"/>
                  <a:pt x="1085146" y="18288"/>
                </a:cubicBezTo>
                <a:cubicBezTo>
                  <a:pt x="826680" y="24084"/>
                  <a:pt x="778184" y="35607"/>
                  <a:pt x="521355" y="18288"/>
                </a:cubicBezTo>
                <a:cubicBezTo>
                  <a:pt x="264526" y="969"/>
                  <a:pt x="120277" y="4268"/>
                  <a:pt x="0" y="18288"/>
                </a:cubicBezTo>
                <a:cubicBezTo>
                  <a:pt x="766" y="10800"/>
                  <a:pt x="-457" y="8180"/>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FC27EF1-E2B6-4947-9096-799B25D40B1B}"/>
              </a:ext>
            </a:extLst>
          </p:cNvPr>
          <p:cNvSpPr>
            <a:spLocks noGrp="1"/>
          </p:cNvSpPr>
          <p:nvPr>
            <p:ph idx="1"/>
          </p:nvPr>
        </p:nvSpPr>
        <p:spPr>
          <a:xfrm>
            <a:off x="640080" y="2706624"/>
            <a:ext cx="6894576" cy="3483864"/>
          </a:xfrm>
        </p:spPr>
        <p:txBody>
          <a:bodyPr vert="horz" lIns="91440" tIns="45720" rIns="91440" bIns="45720" rtlCol="0" anchor="t">
            <a:normAutofit/>
          </a:bodyPr>
          <a:lstStyle/>
          <a:p>
            <a:r>
              <a:rPr lang="en-US" sz="2200" dirty="0">
                <a:ea typeface="+mn-lt"/>
                <a:cs typeface="+mn-lt"/>
              </a:rPr>
              <a:t>Sponsoring institution GME - individual and pic</a:t>
            </a:r>
          </a:p>
          <a:p>
            <a:r>
              <a:rPr lang="en-US" sz="2200" dirty="0">
                <a:ea typeface="+mn-lt"/>
                <a:cs typeface="+mn-lt"/>
              </a:rPr>
              <a:t>Family practice - individual and pic</a:t>
            </a:r>
          </a:p>
          <a:p>
            <a:r>
              <a:rPr lang="en-US" sz="2200" dirty="0">
                <a:ea typeface="+mn-lt"/>
                <a:cs typeface="+mn-lt"/>
              </a:rPr>
              <a:t>Hospital – Individual and pic</a:t>
            </a:r>
            <a:endParaRPr lang="en-US" dirty="0">
              <a:cs typeface="Calibri" panose="020F0502020204030204"/>
            </a:endParaRPr>
          </a:p>
          <a:p>
            <a:r>
              <a:rPr lang="en-US" sz="2200" dirty="0" err="1">
                <a:ea typeface="+mn-lt"/>
                <a:cs typeface="+mn-lt"/>
              </a:rPr>
              <a:t>Childrens</a:t>
            </a:r>
            <a:r>
              <a:rPr lang="en-US" sz="2200" dirty="0">
                <a:ea typeface="+mn-lt"/>
                <a:cs typeface="+mn-lt"/>
              </a:rPr>
              <a:t> Hospital – individual and pic</a:t>
            </a:r>
            <a:endParaRPr lang="en-US" sz="2200" dirty="0"/>
          </a:p>
          <a:p>
            <a:r>
              <a:rPr lang="en-US" sz="2200" dirty="0">
                <a:cs typeface="Calibri"/>
              </a:rPr>
              <a:t>First stop is always your supervisor/faculty/program director</a:t>
            </a:r>
          </a:p>
          <a:p>
            <a:endParaRPr lang="en-US" sz="2200" dirty="0"/>
          </a:p>
          <a:p>
            <a:endParaRPr lang="en-US" sz="2200" dirty="0">
              <a:cs typeface="Calibri"/>
            </a:endParaRPr>
          </a:p>
        </p:txBody>
      </p:sp>
    </p:spTree>
    <p:extLst>
      <p:ext uri="{BB962C8B-B14F-4D97-AF65-F5344CB8AC3E}">
        <p14:creationId xmlns:p14="http://schemas.microsoft.com/office/powerpoint/2010/main" val="10680998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100EDD19-6802-4EC3-95CE-CFFAB042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9582FF1-983E-4D4D-98E0-148E1CCB8262}"/>
              </a:ext>
            </a:extLst>
          </p:cNvPr>
          <p:cNvSpPr>
            <a:spLocks noGrp="1"/>
          </p:cNvSpPr>
          <p:nvPr>
            <p:ph type="title"/>
          </p:nvPr>
        </p:nvSpPr>
        <p:spPr>
          <a:xfrm>
            <a:off x="838200" y="365125"/>
            <a:ext cx="10515600" cy="1325563"/>
          </a:xfrm>
        </p:spPr>
        <p:txBody>
          <a:bodyPr>
            <a:noAutofit/>
          </a:bodyPr>
          <a:lstStyle/>
          <a:p>
            <a:r>
              <a:rPr lang="en-US" sz="4500">
                <a:cs typeface="Calibri Light"/>
              </a:rPr>
              <a:t>If you were a patient impacted by error, what would you want?</a:t>
            </a:r>
          </a:p>
        </p:txBody>
      </p:sp>
      <p:sp>
        <p:nvSpPr>
          <p:cNvPr id="10" name="sketch line">
            <a:extLst>
              <a:ext uri="{FF2B5EF4-FFF2-40B4-BE49-F238E27FC236}">
                <a16:creationId xmlns:a16="http://schemas.microsoft.com/office/drawing/2014/main" id="{DB17E863-922E-4C26-BD64-E8FD41D286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69036" y="1677373"/>
            <a:ext cx="10853928" cy="18288"/>
          </a:xfrm>
          <a:custGeom>
            <a:avLst/>
            <a:gdLst>
              <a:gd name="connsiteX0" fmla="*/ 0 w 10853928"/>
              <a:gd name="connsiteY0" fmla="*/ 0 h 18288"/>
              <a:gd name="connsiteX1" fmla="*/ 461292 w 10853928"/>
              <a:gd name="connsiteY1" fmla="*/ 0 h 18288"/>
              <a:gd name="connsiteX2" fmla="*/ 1139662 w 10853928"/>
              <a:gd name="connsiteY2" fmla="*/ 0 h 18288"/>
              <a:gd name="connsiteX3" fmla="*/ 1926572 w 10853928"/>
              <a:gd name="connsiteY3" fmla="*/ 0 h 18288"/>
              <a:gd name="connsiteX4" fmla="*/ 2279325 w 10853928"/>
              <a:gd name="connsiteY4" fmla="*/ 0 h 18288"/>
              <a:gd name="connsiteX5" fmla="*/ 2632078 w 10853928"/>
              <a:gd name="connsiteY5" fmla="*/ 0 h 18288"/>
              <a:gd name="connsiteX6" fmla="*/ 3527527 w 10853928"/>
              <a:gd name="connsiteY6" fmla="*/ 0 h 18288"/>
              <a:gd name="connsiteX7" fmla="*/ 4205897 w 10853928"/>
              <a:gd name="connsiteY7" fmla="*/ 0 h 18288"/>
              <a:gd name="connsiteX8" fmla="*/ 4558650 w 10853928"/>
              <a:gd name="connsiteY8" fmla="*/ 0 h 18288"/>
              <a:gd name="connsiteX9" fmla="*/ 5237020 w 10853928"/>
              <a:gd name="connsiteY9" fmla="*/ 0 h 18288"/>
              <a:gd name="connsiteX10" fmla="*/ 6132469 w 10853928"/>
              <a:gd name="connsiteY10" fmla="*/ 0 h 18288"/>
              <a:gd name="connsiteX11" fmla="*/ 6702301 w 10853928"/>
              <a:gd name="connsiteY11" fmla="*/ 0 h 18288"/>
              <a:gd name="connsiteX12" fmla="*/ 7272132 w 10853928"/>
              <a:gd name="connsiteY12" fmla="*/ 0 h 18288"/>
              <a:gd name="connsiteX13" fmla="*/ 7950502 w 10853928"/>
              <a:gd name="connsiteY13" fmla="*/ 0 h 18288"/>
              <a:gd name="connsiteX14" fmla="*/ 8737412 w 10853928"/>
              <a:gd name="connsiteY14" fmla="*/ 0 h 18288"/>
              <a:gd name="connsiteX15" fmla="*/ 9524322 w 10853928"/>
              <a:gd name="connsiteY15" fmla="*/ 0 h 18288"/>
              <a:gd name="connsiteX16" fmla="*/ 10853928 w 10853928"/>
              <a:gd name="connsiteY16" fmla="*/ 0 h 18288"/>
              <a:gd name="connsiteX17" fmla="*/ 10853928 w 10853928"/>
              <a:gd name="connsiteY17" fmla="*/ 18288 h 18288"/>
              <a:gd name="connsiteX18" fmla="*/ 10392636 w 10853928"/>
              <a:gd name="connsiteY18" fmla="*/ 18288 h 18288"/>
              <a:gd name="connsiteX19" fmla="*/ 9497187 w 10853928"/>
              <a:gd name="connsiteY19" fmla="*/ 18288 h 18288"/>
              <a:gd name="connsiteX20" fmla="*/ 8818817 w 10853928"/>
              <a:gd name="connsiteY20" fmla="*/ 18288 h 18288"/>
              <a:gd name="connsiteX21" fmla="*/ 8466064 w 10853928"/>
              <a:gd name="connsiteY21" fmla="*/ 18288 h 18288"/>
              <a:gd name="connsiteX22" fmla="*/ 7787693 w 10853928"/>
              <a:gd name="connsiteY22" fmla="*/ 18288 h 18288"/>
              <a:gd name="connsiteX23" fmla="*/ 7217862 w 10853928"/>
              <a:gd name="connsiteY23" fmla="*/ 18288 h 18288"/>
              <a:gd name="connsiteX24" fmla="*/ 6648031 w 10853928"/>
              <a:gd name="connsiteY24" fmla="*/ 18288 h 18288"/>
              <a:gd name="connsiteX25" fmla="*/ 6078200 w 10853928"/>
              <a:gd name="connsiteY25" fmla="*/ 18288 h 18288"/>
              <a:gd name="connsiteX26" fmla="*/ 5508368 w 10853928"/>
              <a:gd name="connsiteY26" fmla="*/ 18288 h 18288"/>
              <a:gd name="connsiteX27" fmla="*/ 4721459 w 10853928"/>
              <a:gd name="connsiteY27" fmla="*/ 18288 h 18288"/>
              <a:gd name="connsiteX28" fmla="*/ 4043088 w 10853928"/>
              <a:gd name="connsiteY28" fmla="*/ 18288 h 18288"/>
              <a:gd name="connsiteX29" fmla="*/ 3690336 w 10853928"/>
              <a:gd name="connsiteY29" fmla="*/ 18288 h 18288"/>
              <a:gd name="connsiteX30" fmla="*/ 3120504 w 10853928"/>
              <a:gd name="connsiteY30" fmla="*/ 18288 h 18288"/>
              <a:gd name="connsiteX31" fmla="*/ 2333595 w 10853928"/>
              <a:gd name="connsiteY31" fmla="*/ 18288 h 18288"/>
              <a:gd name="connsiteX32" fmla="*/ 1872303 w 10853928"/>
              <a:gd name="connsiteY32" fmla="*/ 18288 h 18288"/>
              <a:gd name="connsiteX33" fmla="*/ 976854 w 10853928"/>
              <a:gd name="connsiteY33" fmla="*/ 18288 h 18288"/>
              <a:gd name="connsiteX34" fmla="*/ 0 w 10853928"/>
              <a:gd name="connsiteY34" fmla="*/ 18288 h 18288"/>
              <a:gd name="connsiteX35" fmla="*/ 0 w 10853928"/>
              <a:gd name="connsiteY35"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10853928" h="18288" fill="none" extrusionOk="0">
                <a:moveTo>
                  <a:pt x="0" y="0"/>
                </a:moveTo>
                <a:cubicBezTo>
                  <a:pt x="146993" y="-19076"/>
                  <a:pt x="347684" y="-4790"/>
                  <a:pt x="461292" y="0"/>
                </a:cubicBezTo>
                <a:cubicBezTo>
                  <a:pt x="574900" y="4790"/>
                  <a:pt x="808367" y="19821"/>
                  <a:pt x="1139662" y="0"/>
                </a:cubicBezTo>
                <a:cubicBezTo>
                  <a:pt x="1470957" y="-19821"/>
                  <a:pt x="1627405" y="5721"/>
                  <a:pt x="1926572" y="0"/>
                </a:cubicBezTo>
                <a:cubicBezTo>
                  <a:pt x="2225739" y="-5721"/>
                  <a:pt x="2137730" y="-3235"/>
                  <a:pt x="2279325" y="0"/>
                </a:cubicBezTo>
                <a:cubicBezTo>
                  <a:pt x="2420920" y="3235"/>
                  <a:pt x="2456518" y="9685"/>
                  <a:pt x="2632078" y="0"/>
                </a:cubicBezTo>
                <a:cubicBezTo>
                  <a:pt x="2807638" y="-9685"/>
                  <a:pt x="3211516" y="-43007"/>
                  <a:pt x="3527527" y="0"/>
                </a:cubicBezTo>
                <a:cubicBezTo>
                  <a:pt x="3843538" y="43007"/>
                  <a:pt x="4058833" y="22042"/>
                  <a:pt x="4205897" y="0"/>
                </a:cubicBezTo>
                <a:cubicBezTo>
                  <a:pt x="4352961" y="-22042"/>
                  <a:pt x="4474805" y="-11846"/>
                  <a:pt x="4558650" y="0"/>
                </a:cubicBezTo>
                <a:cubicBezTo>
                  <a:pt x="4642495" y="11846"/>
                  <a:pt x="5041928" y="-6069"/>
                  <a:pt x="5237020" y="0"/>
                </a:cubicBezTo>
                <a:cubicBezTo>
                  <a:pt x="5432112" y="6069"/>
                  <a:pt x="5943266" y="-17479"/>
                  <a:pt x="6132469" y="0"/>
                </a:cubicBezTo>
                <a:cubicBezTo>
                  <a:pt x="6321672" y="17479"/>
                  <a:pt x="6483872" y="26234"/>
                  <a:pt x="6702301" y="0"/>
                </a:cubicBezTo>
                <a:cubicBezTo>
                  <a:pt x="6920730" y="-26234"/>
                  <a:pt x="6991194" y="-15156"/>
                  <a:pt x="7272132" y="0"/>
                </a:cubicBezTo>
                <a:cubicBezTo>
                  <a:pt x="7553070" y="15156"/>
                  <a:pt x="7684444" y="-32961"/>
                  <a:pt x="7950502" y="0"/>
                </a:cubicBezTo>
                <a:cubicBezTo>
                  <a:pt x="8216560" y="32961"/>
                  <a:pt x="8493290" y="-10491"/>
                  <a:pt x="8737412" y="0"/>
                </a:cubicBezTo>
                <a:cubicBezTo>
                  <a:pt x="8981534" y="10491"/>
                  <a:pt x="9191586" y="-13899"/>
                  <a:pt x="9524322" y="0"/>
                </a:cubicBezTo>
                <a:cubicBezTo>
                  <a:pt x="9857058" y="13899"/>
                  <a:pt x="10297509" y="7485"/>
                  <a:pt x="10853928" y="0"/>
                </a:cubicBezTo>
                <a:cubicBezTo>
                  <a:pt x="10854574" y="4451"/>
                  <a:pt x="10854418" y="9226"/>
                  <a:pt x="10853928" y="18288"/>
                </a:cubicBezTo>
                <a:cubicBezTo>
                  <a:pt x="10691638" y="28522"/>
                  <a:pt x="10574319" y="29578"/>
                  <a:pt x="10392636" y="18288"/>
                </a:cubicBezTo>
                <a:cubicBezTo>
                  <a:pt x="10210953" y="6998"/>
                  <a:pt x="9836277" y="-16742"/>
                  <a:pt x="9497187" y="18288"/>
                </a:cubicBezTo>
                <a:cubicBezTo>
                  <a:pt x="9158097" y="53318"/>
                  <a:pt x="9119479" y="30714"/>
                  <a:pt x="8818817" y="18288"/>
                </a:cubicBezTo>
                <a:cubicBezTo>
                  <a:pt x="8518155" y="5863"/>
                  <a:pt x="8640037" y="6483"/>
                  <a:pt x="8466064" y="18288"/>
                </a:cubicBezTo>
                <a:cubicBezTo>
                  <a:pt x="8292091" y="30093"/>
                  <a:pt x="7997656" y="18914"/>
                  <a:pt x="7787693" y="18288"/>
                </a:cubicBezTo>
                <a:cubicBezTo>
                  <a:pt x="7577730" y="17662"/>
                  <a:pt x="7412468" y="21416"/>
                  <a:pt x="7217862" y="18288"/>
                </a:cubicBezTo>
                <a:cubicBezTo>
                  <a:pt x="7023256" y="15160"/>
                  <a:pt x="6898018" y="14824"/>
                  <a:pt x="6648031" y="18288"/>
                </a:cubicBezTo>
                <a:cubicBezTo>
                  <a:pt x="6398044" y="21752"/>
                  <a:pt x="6254402" y="38625"/>
                  <a:pt x="6078200" y="18288"/>
                </a:cubicBezTo>
                <a:cubicBezTo>
                  <a:pt x="5901998" y="-2049"/>
                  <a:pt x="5622886" y="3213"/>
                  <a:pt x="5508368" y="18288"/>
                </a:cubicBezTo>
                <a:cubicBezTo>
                  <a:pt x="5393850" y="33363"/>
                  <a:pt x="5036260" y="26830"/>
                  <a:pt x="4721459" y="18288"/>
                </a:cubicBezTo>
                <a:cubicBezTo>
                  <a:pt x="4406658" y="9746"/>
                  <a:pt x="4239221" y="41551"/>
                  <a:pt x="4043088" y="18288"/>
                </a:cubicBezTo>
                <a:cubicBezTo>
                  <a:pt x="3846955" y="-4975"/>
                  <a:pt x="3818802" y="34658"/>
                  <a:pt x="3690336" y="18288"/>
                </a:cubicBezTo>
                <a:cubicBezTo>
                  <a:pt x="3561870" y="1918"/>
                  <a:pt x="3265491" y="42194"/>
                  <a:pt x="3120504" y="18288"/>
                </a:cubicBezTo>
                <a:cubicBezTo>
                  <a:pt x="2975517" y="-5618"/>
                  <a:pt x="2720254" y="36673"/>
                  <a:pt x="2333595" y="18288"/>
                </a:cubicBezTo>
                <a:cubicBezTo>
                  <a:pt x="1946936" y="-97"/>
                  <a:pt x="2097241" y="5776"/>
                  <a:pt x="1872303" y="18288"/>
                </a:cubicBezTo>
                <a:cubicBezTo>
                  <a:pt x="1647365" y="30800"/>
                  <a:pt x="1282708" y="45380"/>
                  <a:pt x="976854" y="18288"/>
                </a:cubicBezTo>
                <a:cubicBezTo>
                  <a:pt x="671000" y="-8804"/>
                  <a:pt x="408401" y="-12775"/>
                  <a:pt x="0" y="18288"/>
                </a:cubicBezTo>
                <a:cubicBezTo>
                  <a:pt x="-213" y="9468"/>
                  <a:pt x="187" y="4459"/>
                  <a:pt x="0" y="0"/>
                </a:cubicBezTo>
                <a:close/>
              </a:path>
              <a:path w="10853928" h="18288" stroke="0" extrusionOk="0">
                <a:moveTo>
                  <a:pt x="0" y="0"/>
                </a:moveTo>
                <a:cubicBezTo>
                  <a:pt x="267322" y="15284"/>
                  <a:pt x="415388" y="-21048"/>
                  <a:pt x="569831" y="0"/>
                </a:cubicBezTo>
                <a:cubicBezTo>
                  <a:pt x="724274" y="21048"/>
                  <a:pt x="769333" y="-2353"/>
                  <a:pt x="922584" y="0"/>
                </a:cubicBezTo>
                <a:cubicBezTo>
                  <a:pt x="1075835" y="2353"/>
                  <a:pt x="1399490" y="-145"/>
                  <a:pt x="1818033" y="0"/>
                </a:cubicBezTo>
                <a:cubicBezTo>
                  <a:pt x="2236576" y="145"/>
                  <a:pt x="2145330" y="5482"/>
                  <a:pt x="2387864" y="0"/>
                </a:cubicBezTo>
                <a:cubicBezTo>
                  <a:pt x="2630398" y="-5482"/>
                  <a:pt x="2793207" y="18487"/>
                  <a:pt x="2957695" y="0"/>
                </a:cubicBezTo>
                <a:cubicBezTo>
                  <a:pt x="3122183" y="-18487"/>
                  <a:pt x="3579141" y="19003"/>
                  <a:pt x="3853144" y="0"/>
                </a:cubicBezTo>
                <a:cubicBezTo>
                  <a:pt x="4127147" y="-19003"/>
                  <a:pt x="4209857" y="12211"/>
                  <a:pt x="4314436" y="0"/>
                </a:cubicBezTo>
                <a:cubicBezTo>
                  <a:pt x="4419015" y="-12211"/>
                  <a:pt x="4762459" y="-17220"/>
                  <a:pt x="5209885" y="0"/>
                </a:cubicBezTo>
                <a:cubicBezTo>
                  <a:pt x="5657311" y="17220"/>
                  <a:pt x="5692663" y="-3290"/>
                  <a:pt x="6105335" y="0"/>
                </a:cubicBezTo>
                <a:cubicBezTo>
                  <a:pt x="6518007" y="3290"/>
                  <a:pt x="6455516" y="-5124"/>
                  <a:pt x="6783705" y="0"/>
                </a:cubicBezTo>
                <a:cubicBezTo>
                  <a:pt x="7111894" y="5124"/>
                  <a:pt x="7441941" y="-17829"/>
                  <a:pt x="7679154" y="0"/>
                </a:cubicBezTo>
                <a:cubicBezTo>
                  <a:pt x="7916367" y="17829"/>
                  <a:pt x="8102967" y="-24363"/>
                  <a:pt x="8248985" y="0"/>
                </a:cubicBezTo>
                <a:cubicBezTo>
                  <a:pt x="8395003" y="24363"/>
                  <a:pt x="8552393" y="25505"/>
                  <a:pt x="8818817" y="0"/>
                </a:cubicBezTo>
                <a:cubicBezTo>
                  <a:pt x="9085241" y="-25505"/>
                  <a:pt x="9411308" y="38000"/>
                  <a:pt x="9605726" y="0"/>
                </a:cubicBezTo>
                <a:cubicBezTo>
                  <a:pt x="9800144" y="-38000"/>
                  <a:pt x="10006468" y="-25741"/>
                  <a:pt x="10175558" y="0"/>
                </a:cubicBezTo>
                <a:cubicBezTo>
                  <a:pt x="10344648" y="25741"/>
                  <a:pt x="10696282" y="695"/>
                  <a:pt x="10853928" y="0"/>
                </a:cubicBezTo>
                <a:cubicBezTo>
                  <a:pt x="10853521" y="8690"/>
                  <a:pt x="10853774" y="14141"/>
                  <a:pt x="10853928" y="18288"/>
                </a:cubicBezTo>
                <a:cubicBezTo>
                  <a:pt x="10608124" y="24255"/>
                  <a:pt x="10343415" y="22307"/>
                  <a:pt x="10067018" y="18288"/>
                </a:cubicBezTo>
                <a:cubicBezTo>
                  <a:pt x="9790621" y="14270"/>
                  <a:pt x="9843266" y="3564"/>
                  <a:pt x="9714266" y="18288"/>
                </a:cubicBezTo>
                <a:cubicBezTo>
                  <a:pt x="9585266" y="33012"/>
                  <a:pt x="9379484" y="1875"/>
                  <a:pt x="9252974" y="18288"/>
                </a:cubicBezTo>
                <a:cubicBezTo>
                  <a:pt x="9126464" y="34701"/>
                  <a:pt x="8580678" y="-4904"/>
                  <a:pt x="8357525" y="18288"/>
                </a:cubicBezTo>
                <a:cubicBezTo>
                  <a:pt x="8134372" y="41480"/>
                  <a:pt x="7903199" y="26458"/>
                  <a:pt x="7679154" y="18288"/>
                </a:cubicBezTo>
                <a:cubicBezTo>
                  <a:pt x="7455109" y="10118"/>
                  <a:pt x="7435944" y="27109"/>
                  <a:pt x="7217862" y="18288"/>
                </a:cubicBezTo>
                <a:cubicBezTo>
                  <a:pt x="6999780" y="9467"/>
                  <a:pt x="6680409" y="18985"/>
                  <a:pt x="6539492" y="18288"/>
                </a:cubicBezTo>
                <a:cubicBezTo>
                  <a:pt x="6398575" y="17592"/>
                  <a:pt x="6312077" y="33018"/>
                  <a:pt x="6186739" y="18288"/>
                </a:cubicBezTo>
                <a:cubicBezTo>
                  <a:pt x="6061401" y="3558"/>
                  <a:pt x="5947033" y="12075"/>
                  <a:pt x="5833986" y="18288"/>
                </a:cubicBezTo>
                <a:cubicBezTo>
                  <a:pt x="5720939" y="24501"/>
                  <a:pt x="5482226" y="8586"/>
                  <a:pt x="5155616" y="18288"/>
                </a:cubicBezTo>
                <a:cubicBezTo>
                  <a:pt x="4829006" y="27991"/>
                  <a:pt x="4841274" y="29316"/>
                  <a:pt x="4694324" y="18288"/>
                </a:cubicBezTo>
                <a:cubicBezTo>
                  <a:pt x="4547374" y="7260"/>
                  <a:pt x="4077675" y="7013"/>
                  <a:pt x="3907414" y="18288"/>
                </a:cubicBezTo>
                <a:cubicBezTo>
                  <a:pt x="3737153" y="29564"/>
                  <a:pt x="3538393" y="21630"/>
                  <a:pt x="3446122" y="18288"/>
                </a:cubicBezTo>
                <a:cubicBezTo>
                  <a:pt x="3353851" y="14946"/>
                  <a:pt x="2990320" y="-8091"/>
                  <a:pt x="2659212" y="18288"/>
                </a:cubicBezTo>
                <a:cubicBezTo>
                  <a:pt x="2328104" y="44667"/>
                  <a:pt x="2427653" y="9607"/>
                  <a:pt x="2306460" y="18288"/>
                </a:cubicBezTo>
                <a:cubicBezTo>
                  <a:pt x="2185267" y="26969"/>
                  <a:pt x="1719763" y="3717"/>
                  <a:pt x="1519550" y="18288"/>
                </a:cubicBezTo>
                <a:cubicBezTo>
                  <a:pt x="1319337" y="32860"/>
                  <a:pt x="1167371" y="17040"/>
                  <a:pt x="1058258" y="18288"/>
                </a:cubicBezTo>
                <a:cubicBezTo>
                  <a:pt x="949145" y="19536"/>
                  <a:pt x="780234" y="31447"/>
                  <a:pt x="705505" y="18288"/>
                </a:cubicBezTo>
                <a:cubicBezTo>
                  <a:pt x="630776" y="5129"/>
                  <a:pt x="215796" y="30056"/>
                  <a:pt x="0" y="18288"/>
                </a:cubicBezTo>
                <a:cubicBezTo>
                  <a:pt x="-53" y="11301"/>
                  <a:pt x="-649" y="7756"/>
                  <a:pt x="0" y="0"/>
                </a:cubicBezTo>
                <a:close/>
              </a:path>
            </a:pathLst>
          </a:custGeom>
          <a:solidFill>
            <a:schemeClr val="accent2"/>
          </a:solidFill>
          <a:ln w="41275" cap="rnd">
            <a:solidFill>
              <a:schemeClr val="accent2"/>
            </a:solidFill>
            <a:round/>
            <a:extLst>
              <a:ext uri="{C807C97D-BFC1-408E-A445-0C87EB9F89A2}">
                <ask:lineSketchStyleProps xmln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0FB2EB9C-1382-4DD3-8425-6057DCA19775}"/>
              </a:ext>
            </a:extLst>
          </p:cNvPr>
          <p:cNvSpPr>
            <a:spLocks noGrp="1"/>
          </p:cNvSpPr>
          <p:nvPr>
            <p:ph idx="1"/>
          </p:nvPr>
        </p:nvSpPr>
        <p:spPr>
          <a:xfrm>
            <a:off x="838200" y="1929384"/>
            <a:ext cx="10515600" cy="4251960"/>
          </a:xfrm>
        </p:spPr>
        <p:txBody>
          <a:bodyPr vert="horz" lIns="91440" tIns="45720" rIns="91440" bIns="45720" rtlCol="0" anchor="t">
            <a:normAutofit/>
          </a:bodyPr>
          <a:lstStyle/>
          <a:p>
            <a:endParaRPr lang="en-US" sz="2200">
              <a:cs typeface="Calibri"/>
            </a:endParaRPr>
          </a:p>
          <a:p>
            <a:endParaRPr lang="en-US" sz="2200">
              <a:cs typeface="Calibri"/>
            </a:endParaRPr>
          </a:p>
        </p:txBody>
      </p:sp>
    </p:spTree>
    <p:extLst>
      <p:ext uri="{BB962C8B-B14F-4D97-AF65-F5344CB8AC3E}">
        <p14:creationId xmlns:p14="http://schemas.microsoft.com/office/powerpoint/2010/main" val="29769521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3</TotalTime>
  <Words>2787</Words>
  <Application>Microsoft Office PowerPoint</Application>
  <PresentationFormat>Widescreen</PresentationFormat>
  <Paragraphs>297</Paragraphs>
  <Slides>22</Slides>
  <Notes>22</Notes>
  <HiddenSlides>0</HiddenSlides>
  <MMClips>1</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2</vt:i4>
      </vt:variant>
    </vt:vector>
  </HeadingPairs>
  <TitlesOfParts>
    <vt:vector size="27" baseType="lpstr">
      <vt:lpstr>Arial</vt:lpstr>
      <vt:lpstr>Calibri</vt:lpstr>
      <vt:lpstr>Calibri Light</vt:lpstr>
      <vt:lpstr>Courier New</vt:lpstr>
      <vt:lpstr>Office Theme</vt:lpstr>
      <vt:lpstr>Medical error 3: Practice makes better</vt:lpstr>
      <vt:lpstr>Practice!   Self awareness</vt:lpstr>
      <vt:lpstr>Facts?</vt:lpstr>
      <vt:lpstr>Local policies related to error</vt:lpstr>
      <vt:lpstr>Local policies ...</vt:lpstr>
      <vt:lpstr>Local practices related to error</vt:lpstr>
      <vt:lpstr>Local practices related to error</vt:lpstr>
      <vt:lpstr>People at rotation sites</vt:lpstr>
      <vt:lpstr>If you were a patient impacted by error, what would you want?</vt:lpstr>
      <vt:lpstr>Key principles of open disclosure</vt:lpstr>
      <vt:lpstr>Practice!  Disclosure</vt:lpstr>
      <vt:lpstr>Medical Error: A Case Based Approach to Apology and Disclosure – Brigham and Woman's Hospital 2014 (Optional) </vt:lpstr>
      <vt:lpstr>Root cause analysis, reminders </vt:lpstr>
      <vt:lpstr>Practice!   Root cause analysis </vt:lpstr>
      <vt:lpstr>Where to get emotional support</vt:lpstr>
      <vt:lpstr>Second victim trajectory of recovery</vt:lpstr>
      <vt:lpstr>Practice!   Coping </vt:lpstr>
      <vt:lpstr>Practice!   Coping    Exemplar reminders:  Talk, disclose and apologize Forgiveness Moral context Deal with imperfection Become an expert Prevent recurrence/teamwork Teach others</vt:lpstr>
      <vt:lpstr>OPTIONAL –COPING RESOURCES</vt:lpstr>
      <vt:lpstr>Medical Error</vt:lpstr>
      <vt:lpstr>PowerPoint Presentation</vt:lpstr>
      <vt:lpstr>Resour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cal error</dc:title>
  <dc:creator>Sherry Adkins</dc:creator>
  <cp:lastModifiedBy>Sherry Adkins</cp:lastModifiedBy>
  <cp:revision>621</cp:revision>
  <dcterms:created xsi:type="dcterms:W3CDTF">2022-07-16T20:29:26Z</dcterms:created>
  <dcterms:modified xsi:type="dcterms:W3CDTF">2024-05-03T23:17:43Z</dcterms:modified>
</cp:coreProperties>
</file>